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56" r:id="rId3"/>
    <p:sldId id="257" r:id="rId4"/>
    <p:sldId id="259" r:id="rId5"/>
    <p:sldId id="260" r:id="rId6"/>
    <p:sldId id="258" r:id="rId7"/>
    <p:sldId id="262" r:id="rId8"/>
    <p:sldId id="261" r:id="rId9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C7C7C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3609FAB-56D7-485F-98C0-917E13D3FFF4}" v="58" dt="2023-01-26T06:26:46.96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4" d="100"/>
          <a:sy n="84" d="100"/>
        </p:scale>
        <p:origin x="102" y="3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microsoft.com/office/2015/10/relationships/revisionInfo" Target="revisionInfo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강은정" userId="692accea-f2c5-4441-99ea-ca23b894be73" providerId="ADAL" clId="{33609FAB-56D7-485F-98C0-917E13D3FFF4}"/>
    <pc:docChg chg="custSel modSld">
      <pc:chgData name="강은정" userId="692accea-f2c5-4441-99ea-ca23b894be73" providerId="ADAL" clId="{33609FAB-56D7-485F-98C0-917E13D3FFF4}" dt="2023-01-26T06:27:28.088" v="245"/>
      <pc:docMkLst>
        <pc:docMk/>
      </pc:docMkLst>
      <pc:sldChg chg="modSp mod">
        <pc:chgData name="강은정" userId="692accea-f2c5-4441-99ea-ca23b894be73" providerId="ADAL" clId="{33609FAB-56D7-485F-98C0-917E13D3FFF4}" dt="2023-01-26T06:26:48.870" v="237" actId="20577"/>
        <pc:sldMkLst>
          <pc:docMk/>
          <pc:sldMk cId="1895520791" sldId="256"/>
        </pc:sldMkLst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2" creationId="{8BF7C0DF-84AA-4015-B4DB-EEA9401793B9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7" creationId="{32AAF501-61F0-CC74-EB69-02C8520E8E25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8" creationId="{29FC4981-6FC6-3D82-8774-B368EB934149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24" creationId="{ECFA40E7-08FD-DD10-2A36-42D6ADC7794D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25" creationId="{D8BFA2D9-69C8-4E32-5AF3-527C5A1570F9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32" creationId="{89E7B9DE-B69A-2B8E-4826-FA7D7B4D4099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33" creationId="{EA37B0F8-D74A-2AE0-3461-5D30B22F1BF0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83" creationId="{7171BB59-6EB3-4434-2312-E74AAC1B8B5F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84" creationId="{B4E789AE-A038-6985-28F1-B1286D543039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85" creationId="{57FF5CA3-0DBD-FF87-773C-550C64FBA4C7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86" creationId="{A470CA39-D29B-6129-1C85-AF43097F31D0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87" creationId="{BFDEA38B-6C98-ECD4-1407-43307A677028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88" creationId="{F9D04FC2-7D1E-9876-D7FA-7C44F19732F5}"/>
          </ac:spMkLst>
        </pc:spChg>
        <pc:spChg chg="mod">
          <ac:chgData name="강은정" userId="692accea-f2c5-4441-99ea-ca23b894be73" providerId="ADAL" clId="{33609FAB-56D7-485F-98C0-917E13D3FFF4}" dt="2023-01-26T06:26:48.870" v="237" actId="20577"/>
          <ac:spMkLst>
            <pc:docMk/>
            <pc:sldMk cId="1895520791" sldId="256"/>
            <ac:spMk id="89" creationId="{BE990ED3-3B5A-DDCA-0923-194B07943B95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90" creationId="{CFB99AFB-9B1C-0F10-CD74-D4F555E0D705}"/>
          </ac:spMkLst>
        </pc:spChg>
        <pc:spChg chg="mod">
          <ac:chgData name="강은정" userId="692accea-f2c5-4441-99ea-ca23b894be73" providerId="ADAL" clId="{33609FAB-56D7-485F-98C0-917E13D3FFF4}" dt="2023-01-26T06:22:17.346" v="227"/>
          <ac:spMkLst>
            <pc:docMk/>
            <pc:sldMk cId="1895520791" sldId="256"/>
            <ac:spMk id="91" creationId="{47DF6C86-65B5-0BCA-A5BE-D9BDDE135CB7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92" creationId="{4076A034-CBA8-6C65-105D-30B3EDD1AFCF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93" creationId="{BF8CE6D7-3855-C169-AAA8-2BB46C60612C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94" creationId="{7D020654-981D-2A0B-B41A-041F87B8D2B4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95" creationId="{E5A06917-F849-9388-AD1E-2B8C2B39B9EE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96" creationId="{71FD5DAC-7A99-E136-9971-7929D6EF46DB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97" creationId="{50CBC57B-B65E-B537-B9CB-7FD39B3AF659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98" creationId="{245F2D8C-B282-E487-0771-81AB5680B6E0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99" creationId="{B4229E27-E294-4B72-2EA9-0E14A6CA3FB3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100" creationId="{EC99C0AB-6DCE-AE95-1EED-17683F2931AE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101" creationId="{4EF48FB1-086D-D1FA-B3C7-D0695261B404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102" creationId="{EDF23037-28A6-A32F-F6F7-54D4494B0C36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103" creationId="{61FB9606-F294-F81F-81C1-FC564CB224FA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108" creationId="{104EDAAD-B345-9C2F-6F5B-69ADEE980A8D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109" creationId="{41CE151C-726F-7A1F-B9AE-D4F27020E0A3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110" creationId="{DB55AFEE-6072-E200-8589-1367BF6D50AF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111" creationId="{D491126B-EBF0-8538-5528-AD0CC52D46CC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112" creationId="{E1FAE83C-46B2-F2CD-A39E-4458839B4732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113" creationId="{40438C63-35AD-4DB7-09F7-119963ECCC03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114" creationId="{252779E5-D3FA-DF69-A83C-11AF7DFB9711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115" creationId="{0969A2B3-B9C8-D703-466E-B8F39BA1CD64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116" creationId="{EC3E0D94-FC25-62BD-6AE9-21A585F81FAF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117" creationId="{7B48254D-E55A-847C-6236-A00FE2EAAE85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118" creationId="{FC9B9FAE-B1EF-F2EE-2B63-5ECE5A46B60E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119" creationId="{A454084A-DB6D-4787-3971-7883CDCC7BA9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120" creationId="{46F630CA-6E53-EC98-1F12-0CF009CEB4F2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121" creationId="{6A289225-320F-6230-7F64-72B344583BBC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122" creationId="{2F24DDF5-B81E-2C2F-1EF0-93E3C2F8BD53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124" creationId="{106F0300-64AD-4152-9331-1DB2450BB08D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128" creationId="{1654E717-00A1-45E6-A109-5B2C3A2C67B5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129" creationId="{23EBEDEA-CE1D-43FE-960F-7CEC1A36BE91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130" creationId="{3822B87B-9FAA-4A00-9A24-272814D0359B}"/>
          </ac:spMkLst>
        </pc:spChg>
        <pc:spChg chg="mod">
          <ac:chgData name="강은정" userId="692accea-f2c5-4441-99ea-ca23b894be73" providerId="ADAL" clId="{33609FAB-56D7-485F-98C0-917E13D3FFF4}" dt="2023-01-26T06:15:50.507" v="128" actId="1076"/>
          <ac:spMkLst>
            <pc:docMk/>
            <pc:sldMk cId="1895520791" sldId="256"/>
            <ac:spMk id="131" creationId="{305B36BF-80A8-4D9C-8586-BC5D33EF5DF9}"/>
          </ac:spMkLst>
        </pc:spChg>
        <pc:grpChg chg="mod">
          <ac:chgData name="강은정" userId="692accea-f2c5-4441-99ea-ca23b894be73" providerId="ADAL" clId="{33609FAB-56D7-485F-98C0-917E13D3FFF4}" dt="2023-01-26T06:15:50.507" v="128" actId="1076"/>
          <ac:grpSpMkLst>
            <pc:docMk/>
            <pc:sldMk cId="1895520791" sldId="256"/>
            <ac:grpSpMk id="10" creationId="{C9C71562-1DED-F1B2-21C7-A69F92496AC8}"/>
          </ac:grpSpMkLst>
        </pc:grpChg>
        <pc:grpChg chg="mod">
          <ac:chgData name="강은정" userId="692accea-f2c5-4441-99ea-ca23b894be73" providerId="ADAL" clId="{33609FAB-56D7-485F-98C0-917E13D3FFF4}" dt="2023-01-26T06:15:50.507" v="128" actId="1076"/>
          <ac:grpSpMkLst>
            <pc:docMk/>
            <pc:sldMk cId="1895520791" sldId="256"/>
            <ac:grpSpMk id="11" creationId="{661F0031-CD30-9A8B-8E8E-9408FF35779D}"/>
          </ac:grpSpMkLst>
        </pc:grpChg>
        <pc:grpChg chg="mod">
          <ac:chgData name="강은정" userId="692accea-f2c5-4441-99ea-ca23b894be73" providerId="ADAL" clId="{33609FAB-56D7-485F-98C0-917E13D3FFF4}" dt="2023-01-26T06:15:50.507" v="128" actId="1076"/>
          <ac:grpSpMkLst>
            <pc:docMk/>
            <pc:sldMk cId="1895520791" sldId="256"/>
            <ac:grpSpMk id="14" creationId="{1B79C368-9617-7B0A-8AC2-5A6F71AE1468}"/>
          </ac:grpSpMkLst>
        </pc:grpChg>
        <pc:grpChg chg="mod">
          <ac:chgData name="강은정" userId="692accea-f2c5-4441-99ea-ca23b894be73" providerId="ADAL" clId="{33609FAB-56D7-485F-98C0-917E13D3FFF4}" dt="2023-01-26T06:15:50.507" v="128" actId="1076"/>
          <ac:grpSpMkLst>
            <pc:docMk/>
            <pc:sldMk cId="1895520791" sldId="256"/>
            <ac:grpSpMk id="37" creationId="{89CC3D4F-D891-F3F1-FD8B-FE065E054C80}"/>
          </ac:grpSpMkLst>
        </pc:grpChg>
        <pc:grpChg chg="mod">
          <ac:chgData name="강은정" userId="692accea-f2c5-4441-99ea-ca23b894be73" providerId="ADAL" clId="{33609FAB-56D7-485F-98C0-917E13D3FFF4}" dt="2023-01-26T06:15:50.507" v="128" actId="1076"/>
          <ac:grpSpMkLst>
            <pc:docMk/>
            <pc:sldMk cId="1895520791" sldId="256"/>
            <ac:grpSpMk id="38" creationId="{FA4B0885-4EE0-46A6-D080-4B662DCEBCE3}"/>
          </ac:grpSpMkLst>
        </pc:grpChg>
        <pc:grpChg chg="mod">
          <ac:chgData name="강은정" userId="692accea-f2c5-4441-99ea-ca23b894be73" providerId="ADAL" clId="{33609FAB-56D7-485F-98C0-917E13D3FFF4}" dt="2023-01-26T06:15:50.507" v="128" actId="1076"/>
          <ac:grpSpMkLst>
            <pc:docMk/>
            <pc:sldMk cId="1895520791" sldId="256"/>
            <ac:grpSpMk id="41" creationId="{47AA20E7-FEDF-7234-124D-E000C0399B78}"/>
          </ac:grpSpMkLst>
        </pc:grpChg>
        <pc:grpChg chg="mod">
          <ac:chgData name="강은정" userId="692accea-f2c5-4441-99ea-ca23b894be73" providerId="ADAL" clId="{33609FAB-56D7-485F-98C0-917E13D3FFF4}" dt="2023-01-26T06:15:50.507" v="128" actId="1076"/>
          <ac:grpSpMkLst>
            <pc:docMk/>
            <pc:sldMk cId="1895520791" sldId="256"/>
            <ac:grpSpMk id="44" creationId="{1A234A92-5A6F-28A6-B924-8FCFD4B61DC1}"/>
          </ac:grpSpMkLst>
        </pc:grpChg>
        <pc:grpChg chg="mod">
          <ac:chgData name="강은정" userId="692accea-f2c5-4441-99ea-ca23b894be73" providerId="ADAL" clId="{33609FAB-56D7-485F-98C0-917E13D3FFF4}" dt="2023-01-26T06:15:50.507" v="128" actId="1076"/>
          <ac:grpSpMkLst>
            <pc:docMk/>
            <pc:sldMk cId="1895520791" sldId="256"/>
            <ac:grpSpMk id="47" creationId="{20837A88-D620-F561-9A9C-98A0B1C1EEE3}"/>
          </ac:grpSpMkLst>
        </pc:grpChg>
        <pc:grpChg chg="mod">
          <ac:chgData name="강은정" userId="692accea-f2c5-4441-99ea-ca23b894be73" providerId="ADAL" clId="{33609FAB-56D7-485F-98C0-917E13D3FFF4}" dt="2023-01-26T06:15:50.507" v="128" actId="1076"/>
          <ac:grpSpMkLst>
            <pc:docMk/>
            <pc:sldMk cId="1895520791" sldId="256"/>
            <ac:grpSpMk id="50" creationId="{D56466B7-A9A0-9804-9A16-E2D72831474C}"/>
          </ac:grpSpMkLst>
        </pc:grpChg>
        <pc:grpChg chg="mod">
          <ac:chgData name="강은정" userId="692accea-f2c5-4441-99ea-ca23b894be73" providerId="ADAL" clId="{33609FAB-56D7-485F-98C0-917E13D3FFF4}" dt="2023-01-26T06:15:50.507" v="128" actId="1076"/>
          <ac:grpSpMkLst>
            <pc:docMk/>
            <pc:sldMk cId="1895520791" sldId="256"/>
            <ac:grpSpMk id="53" creationId="{07E0556E-0EC7-72DF-C3E0-83E7ED5DC7AF}"/>
          </ac:grpSpMkLst>
        </pc:grpChg>
        <pc:grpChg chg="mod">
          <ac:chgData name="강은정" userId="692accea-f2c5-4441-99ea-ca23b894be73" providerId="ADAL" clId="{33609FAB-56D7-485F-98C0-917E13D3FFF4}" dt="2023-01-26T06:15:50.507" v="128" actId="1076"/>
          <ac:grpSpMkLst>
            <pc:docMk/>
            <pc:sldMk cId="1895520791" sldId="256"/>
            <ac:grpSpMk id="56" creationId="{59967B3B-89E9-D76A-B5B0-3AD3B8172B65}"/>
          </ac:grpSpMkLst>
        </pc:grpChg>
        <pc:grpChg chg="mod">
          <ac:chgData name="강은정" userId="692accea-f2c5-4441-99ea-ca23b894be73" providerId="ADAL" clId="{33609FAB-56D7-485F-98C0-917E13D3FFF4}" dt="2023-01-26T06:15:50.507" v="128" actId="1076"/>
          <ac:grpSpMkLst>
            <pc:docMk/>
            <pc:sldMk cId="1895520791" sldId="256"/>
            <ac:grpSpMk id="59" creationId="{5C34BF12-C5AB-1A12-E726-88BF9A590343}"/>
          </ac:grpSpMkLst>
        </pc:grpChg>
        <pc:grpChg chg="mod">
          <ac:chgData name="강은정" userId="692accea-f2c5-4441-99ea-ca23b894be73" providerId="ADAL" clId="{33609FAB-56D7-485F-98C0-917E13D3FFF4}" dt="2023-01-26T06:15:50.507" v="128" actId="1076"/>
          <ac:grpSpMkLst>
            <pc:docMk/>
            <pc:sldMk cId="1895520791" sldId="256"/>
            <ac:grpSpMk id="62" creationId="{5F17EA6D-2EC3-C8AF-86A3-F9C16E0DD3F7}"/>
          </ac:grpSpMkLst>
        </pc:grpChg>
        <pc:grpChg chg="mod">
          <ac:chgData name="강은정" userId="692accea-f2c5-4441-99ea-ca23b894be73" providerId="ADAL" clId="{33609FAB-56D7-485F-98C0-917E13D3FFF4}" dt="2023-01-26T06:15:50.507" v="128" actId="1076"/>
          <ac:grpSpMkLst>
            <pc:docMk/>
            <pc:sldMk cId="1895520791" sldId="256"/>
            <ac:grpSpMk id="65" creationId="{14F01099-46CE-5571-81F0-0BD6AF2A9A8B}"/>
          </ac:grpSpMkLst>
        </pc:grpChg>
        <pc:grpChg chg="mod">
          <ac:chgData name="강은정" userId="692accea-f2c5-4441-99ea-ca23b894be73" providerId="ADAL" clId="{33609FAB-56D7-485F-98C0-917E13D3FFF4}" dt="2023-01-26T06:15:50.507" v="128" actId="1076"/>
          <ac:grpSpMkLst>
            <pc:docMk/>
            <pc:sldMk cId="1895520791" sldId="256"/>
            <ac:grpSpMk id="68" creationId="{117FA0DE-5CB4-B33A-C4D6-91EF0BB04F13}"/>
          </ac:grpSpMkLst>
        </pc:grpChg>
        <pc:grpChg chg="mod">
          <ac:chgData name="강은정" userId="692accea-f2c5-4441-99ea-ca23b894be73" providerId="ADAL" clId="{33609FAB-56D7-485F-98C0-917E13D3FFF4}" dt="2023-01-26T06:15:50.507" v="128" actId="1076"/>
          <ac:grpSpMkLst>
            <pc:docMk/>
            <pc:sldMk cId="1895520791" sldId="256"/>
            <ac:grpSpMk id="71" creationId="{E38D0688-9014-DB14-7857-FD2F9AACA8C9}"/>
          </ac:grpSpMkLst>
        </pc:grpChg>
        <pc:grpChg chg="mod">
          <ac:chgData name="강은정" userId="692accea-f2c5-4441-99ea-ca23b894be73" providerId="ADAL" clId="{33609FAB-56D7-485F-98C0-917E13D3FFF4}" dt="2023-01-26T06:15:50.507" v="128" actId="1076"/>
          <ac:grpSpMkLst>
            <pc:docMk/>
            <pc:sldMk cId="1895520791" sldId="256"/>
            <ac:grpSpMk id="74" creationId="{FBA06E23-6E68-AF6C-4639-C6A98E19075F}"/>
          </ac:grpSpMkLst>
        </pc:grpChg>
        <pc:grpChg chg="mod">
          <ac:chgData name="강은정" userId="692accea-f2c5-4441-99ea-ca23b894be73" providerId="ADAL" clId="{33609FAB-56D7-485F-98C0-917E13D3FFF4}" dt="2023-01-26T06:15:50.507" v="128" actId="1076"/>
          <ac:grpSpMkLst>
            <pc:docMk/>
            <pc:sldMk cId="1895520791" sldId="256"/>
            <ac:grpSpMk id="77" creationId="{996741AF-D559-7459-1D38-27B2A7E3F388}"/>
          </ac:grpSpMkLst>
        </pc:grpChg>
        <pc:grpChg chg="mod">
          <ac:chgData name="강은정" userId="692accea-f2c5-4441-99ea-ca23b894be73" providerId="ADAL" clId="{33609FAB-56D7-485F-98C0-917E13D3FFF4}" dt="2023-01-26T06:15:50.507" v="128" actId="1076"/>
          <ac:grpSpMkLst>
            <pc:docMk/>
            <pc:sldMk cId="1895520791" sldId="256"/>
            <ac:grpSpMk id="80" creationId="{55167D9B-5D2A-1D3B-AD95-2663083B86DC}"/>
          </ac:grpSpMkLst>
        </pc:grpChg>
        <pc:graphicFrameChg chg="mod">
          <ac:chgData name="강은정" userId="692accea-f2c5-4441-99ea-ca23b894be73" providerId="ADAL" clId="{33609FAB-56D7-485F-98C0-917E13D3FFF4}" dt="2023-01-26T06:15:50.507" v="128" actId="1076"/>
          <ac:graphicFrameMkLst>
            <pc:docMk/>
            <pc:sldMk cId="1895520791" sldId="256"/>
            <ac:graphicFrameMk id="5" creationId="{A707293B-9B94-37DB-74D3-F9F8C605DABC}"/>
          </ac:graphicFrameMkLst>
        </pc:graphicFrameChg>
        <pc:graphicFrameChg chg="mod">
          <ac:chgData name="강은정" userId="692accea-f2c5-4441-99ea-ca23b894be73" providerId="ADAL" clId="{33609FAB-56D7-485F-98C0-917E13D3FFF4}" dt="2023-01-26T06:15:50.507" v="128" actId="1076"/>
          <ac:graphicFrameMkLst>
            <pc:docMk/>
            <pc:sldMk cId="1895520791" sldId="256"/>
            <ac:graphicFrameMk id="6" creationId="{A7858E86-AC5D-B50B-59A8-0359045552A9}"/>
          </ac:graphicFrameMkLst>
        </pc:graphicFrameChg>
        <pc:graphicFrameChg chg="mod">
          <ac:chgData name="강은정" userId="692accea-f2c5-4441-99ea-ca23b894be73" providerId="ADAL" clId="{33609FAB-56D7-485F-98C0-917E13D3FFF4}" dt="2023-01-26T06:15:50.507" v="128" actId="1076"/>
          <ac:graphicFrameMkLst>
            <pc:docMk/>
            <pc:sldMk cId="1895520791" sldId="256"/>
            <ac:graphicFrameMk id="16" creationId="{FF0A5E7A-ADCE-A77E-E4D7-40B5670A7C60}"/>
          </ac:graphicFrameMkLst>
        </pc:graphicFrameChg>
        <pc:graphicFrameChg chg="mod">
          <ac:chgData name="강은정" userId="692accea-f2c5-4441-99ea-ca23b894be73" providerId="ADAL" clId="{33609FAB-56D7-485F-98C0-917E13D3FFF4}" dt="2023-01-26T06:15:50.507" v="128" actId="1076"/>
          <ac:graphicFrameMkLst>
            <pc:docMk/>
            <pc:sldMk cId="1895520791" sldId="256"/>
            <ac:graphicFrameMk id="17" creationId="{8A4E03F0-DCC8-8540-75CF-DB4FF7A459B1}"/>
          </ac:graphicFrameMkLst>
        </pc:graphicFrameChg>
        <pc:graphicFrameChg chg="mod">
          <ac:chgData name="강은정" userId="692accea-f2c5-4441-99ea-ca23b894be73" providerId="ADAL" clId="{33609FAB-56D7-485F-98C0-917E13D3FFF4}" dt="2023-01-26T06:15:50.507" v="128" actId="1076"/>
          <ac:graphicFrameMkLst>
            <pc:docMk/>
            <pc:sldMk cId="1895520791" sldId="256"/>
            <ac:graphicFrameMk id="18" creationId="{60FE2FC5-E06A-FCAA-72DD-FB9E1DC01930}"/>
          </ac:graphicFrameMkLst>
        </pc:graphicFrameChg>
        <pc:graphicFrameChg chg="mod">
          <ac:chgData name="강은정" userId="692accea-f2c5-4441-99ea-ca23b894be73" providerId="ADAL" clId="{33609FAB-56D7-485F-98C0-917E13D3FFF4}" dt="2023-01-26T06:15:50.507" v="128" actId="1076"/>
          <ac:graphicFrameMkLst>
            <pc:docMk/>
            <pc:sldMk cId="1895520791" sldId="256"/>
            <ac:graphicFrameMk id="19" creationId="{99832F47-BD39-860C-0B5B-FC21C20FE8F6}"/>
          </ac:graphicFrameMkLst>
        </pc:graphicFrameChg>
        <pc:graphicFrameChg chg="mod">
          <ac:chgData name="강은정" userId="692accea-f2c5-4441-99ea-ca23b894be73" providerId="ADAL" clId="{33609FAB-56D7-485F-98C0-917E13D3FFF4}" dt="2023-01-26T06:15:50.507" v="128" actId="1076"/>
          <ac:graphicFrameMkLst>
            <pc:docMk/>
            <pc:sldMk cId="1895520791" sldId="256"/>
            <ac:graphicFrameMk id="21" creationId="{D835AED7-494E-7D9D-83CB-92DC05F5A9FF}"/>
          </ac:graphicFrameMkLst>
        </pc:graphicFrameChg>
        <pc:graphicFrameChg chg="mod">
          <ac:chgData name="강은정" userId="692accea-f2c5-4441-99ea-ca23b894be73" providerId="ADAL" clId="{33609FAB-56D7-485F-98C0-917E13D3FFF4}" dt="2023-01-26T06:15:50.507" v="128" actId="1076"/>
          <ac:graphicFrameMkLst>
            <pc:docMk/>
            <pc:sldMk cId="1895520791" sldId="256"/>
            <ac:graphicFrameMk id="23" creationId="{EF7F075E-BE65-0838-01D8-EFE15D83857A}"/>
          </ac:graphicFrameMkLst>
        </pc:graphicFrameChg>
        <pc:graphicFrameChg chg="mod">
          <ac:chgData name="강은정" userId="692accea-f2c5-4441-99ea-ca23b894be73" providerId="ADAL" clId="{33609FAB-56D7-485F-98C0-917E13D3FFF4}" dt="2023-01-26T06:15:50.507" v="128" actId="1076"/>
          <ac:graphicFrameMkLst>
            <pc:docMk/>
            <pc:sldMk cId="1895520791" sldId="256"/>
            <ac:graphicFrameMk id="26" creationId="{446FADF0-423C-DAFD-082B-DCCDF19F6DAE}"/>
          </ac:graphicFrameMkLst>
        </pc:graphicFrameChg>
        <pc:graphicFrameChg chg="mod">
          <ac:chgData name="강은정" userId="692accea-f2c5-4441-99ea-ca23b894be73" providerId="ADAL" clId="{33609FAB-56D7-485F-98C0-917E13D3FFF4}" dt="2023-01-26T06:15:50.507" v="128" actId="1076"/>
          <ac:graphicFrameMkLst>
            <pc:docMk/>
            <pc:sldMk cId="1895520791" sldId="256"/>
            <ac:graphicFrameMk id="27" creationId="{65EDCCFA-75EB-A124-C3FC-FDB1039F87C7}"/>
          </ac:graphicFrameMkLst>
        </pc:graphicFrameChg>
        <pc:graphicFrameChg chg="mod">
          <ac:chgData name="강은정" userId="692accea-f2c5-4441-99ea-ca23b894be73" providerId="ADAL" clId="{33609FAB-56D7-485F-98C0-917E13D3FFF4}" dt="2023-01-26T06:15:50.507" v="128" actId="1076"/>
          <ac:graphicFrameMkLst>
            <pc:docMk/>
            <pc:sldMk cId="1895520791" sldId="256"/>
            <ac:graphicFrameMk id="28" creationId="{708506FD-89D7-0498-3ECD-D5493C0C09CC}"/>
          </ac:graphicFrameMkLst>
        </pc:graphicFrameChg>
        <pc:graphicFrameChg chg="mod">
          <ac:chgData name="강은정" userId="692accea-f2c5-4441-99ea-ca23b894be73" providerId="ADAL" clId="{33609FAB-56D7-485F-98C0-917E13D3FFF4}" dt="2023-01-26T06:15:50.507" v="128" actId="1076"/>
          <ac:graphicFrameMkLst>
            <pc:docMk/>
            <pc:sldMk cId="1895520791" sldId="256"/>
            <ac:graphicFrameMk id="29" creationId="{CC50E5A5-8AAA-873F-5520-C4A58E433E68}"/>
          </ac:graphicFrameMkLst>
        </pc:graphicFrameChg>
        <pc:graphicFrameChg chg="mod">
          <ac:chgData name="강은정" userId="692accea-f2c5-4441-99ea-ca23b894be73" providerId="ADAL" clId="{33609FAB-56D7-485F-98C0-917E13D3FFF4}" dt="2023-01-26T06:15:50.507" v="128" actId="1076"/>
          <ac:graphicFrameMkLst>
            <pc:docMk/>
            <pc:sldMk cId="1895520791" sldId="256"/>
            <ac:graphicFrameMk id="30" creationId="{66554259-00B4-9203-A95B-D528481E6C7D}"/>
          </ac:graphicFrameMkLst>
        </pc:graphicFrameChg>
        <pc:graphicFrameChg chg="mod">
          <ac:chgData name="강은정" userId="692accea-f2c5-4441-99ea-ca23b894be73" providerId="ADAL" clId="{33609FAB-56D7-485F-98C0-917E13D3FFF4}" dt="2023-01-26T06:15:50.507" v="128" actId="1076"/>
          <ac:graphicFrameMkLst>
            <pc:docMk/>
            <pc:sldMk cId="1895520791" sldId="256"/>
            <ac:graphicFrameMk id="31" creationId="{AF374E27-352C-741E-EE71-8DED92BA57CF}"/>
          </ac:graphicFrameMkLst>
        </pc:graphicFrameChg>
        <pc:picChg chg="mod">
          <ac:chgData name="강은정" userId="692accea-f2c5-4441-99ea-ca23b894be73" providerId="ADAL" clId="{33609FAB-56D7-485F-98C0-917E13D3FFF4}" dt="2023-01-26T06:15:50.507" v="128" actId="1076"/>
          <ac:picMkLst>
            <pc:docMk/>
            <pc:sldMk cId="1895520791" sldId="256"/>
            <ac:picMk id="3" creationId="{B2469F47-08B1-F590-7174-C742C77869A4}"/>
          </ac:picMkLst>
        </pc:picChg>
        <pc:picChg chg="mod">
          <ac:chgData name="강은정" userId="692accea-f2c5-4441-99ea-ca23b894be73" providerId="ADAL" clId="{33609FAB-56D7-485F-98C0-917E13D3FFF4}" dt="2023-01-26T06:15:50.507" v="128" actId="1076"/>
          <ac:picMkLst>
            <pc:docMk/>
            <pc:sldMk cId="1895520791" sldId="256"/>
            <ac:picMk id="125" creationId="{33A64518-D479-3A20-2ACF-4543187F07F3}"/>
          </ac:picMkLst>
        </pc:picChg>
        <pc:picChg chg="mod">
          <ac:chgData name="강은정" userId="692accea-f2c5-4441-99ea-ca23b894be73" providerId="ADAL" clId="{33609FAB-56D7-485F-98C0-917E13D3FFF4}" dt="2023-01-26T06:15:50.507" v="128" actId="1076"/>
          <ac:picMkLst>
            <pc:docMk/>
            <pc:sldMk cId="1895520791" sldId="256"/>
            <ac:picMk id="126" creationId="{87B8A5A2-9849-E8B0-9AED-244E9F195FDA}"/>
          </ac:picMkLst>
        </pc:picChg>
        <pc:picChg chg="mod">
          <ac:chgData name="강은정" userId="692accea-f2c5-4441-99ea-ca23b894be73" providerId="ADAL" clId="{33609FAB-56D7-485F-98C0-917E13D3FFF4}" dt="2023-01-26T06:15:50.507" v="128" actId="1076"/>
          <ac:picMkLst>
            <pc:docMk/>
            <pc:sldMk cId="1895520791" sldId="256"/>
            <ac:picMk id="127" creationId="{70721D3F-53E9-F3A9-8D4E-829E396C8DB9}"/>
          </ac:picMkLst>
        </pc:picChg>
        <pc:cxnChg chg="mod">
          <ac:chgData name="강은정" userId="692accea-f2c5-4441-99ea-ca23b894be73" providerId="ADAL" clId="{33609FAB-56D7-485F-98C0-917E13D3FFF4}" dt="2023-01-26T06:15:50.507" v="128" actId="1076"/>
          <ac:cxnSpMkLst>
            <pc:docMk/>
            <pc:sldMk cId="1895520791" sldId="256"/>
            <ac:cxnSpMk id="123" creationId="{548BA0B2-1DCD-7E24-5937-2F8C9CE7F60A}"/>
          </ac:cxnSpMkLst>
        </pc:cxnChg>
      </pc:sldChg>
      <pc:sldChg chg="addSp delSp modSp mod">
        <pc:chgData name="강은정" userId="692accea-f2c5-4441-99ea-ca23b894be73" providerId="ADAL" clId="{33609FAB-56D7-485F-98C0-917E13D3FFF4}" dt="2023-01-26T06:26:56.553" v="240" actId="5793"/>
        <pc:sldMkLst>
          <pc:docMk/>
          <pc:sldMk cId="8685089" sldId="257"/>
        </pc:sldMkLst>
        <pc:spChg chg="add mod">
          <ac:chgData name="강은정" userId="692accea-f2c5-4441-99ea-ca23b894be73" providerId="ADAL" clId="{33609FAB-56D7-485F-98C0-917E13D3FFF4}" dt="2023-01-26T06:26:56.553" v="240" actId="5793"/>
          <ac:spMkLst>
            <pc:docMk/>
            <pc:sldMk cId="8685089" sldId="257"/>
            <ac:spMk id="8" creationId="{200C6F97-567F-E2B3-CDC8-234D621338B7}"/>
          </ac:spMkLst>
        </pc:spChg>
        <pc:spChg chg="mod">
          <ac:chgData name="강은정" userId="692accea-f2c5-4441-99ea-ca23b894be73" providerId="ADAL" clId="{33609FAB-56D7-485F-98C0-917E13D3FFF4}" dt="2023-01-26T06:21:14.242" v="219" actId="1076"/>
          <ac:spMkLst>
            <pc:docMk/>
            <pc:sldMk cId="8685089" sldId="257"/>
            <ac:spMk id="11" creationId="{A108317B-E979-2C4A-7119-8165E288CF62}"/>
          </ac:spMkLst>
        </pc:spChg>
        <pc:spChg chg="mod">
          <ac:chgData name="강은정" userId="692accea-f2c5-4441-99ea-ca23b894be73" providerId="ADAL" clId="{33609FAB-56D7-485F-98C0-917E13D3FFF4}" dt="2023-01-26T06:21:14.242" v="219" actId="1076"/>
          <ac:spMkLst>
            <pc:docMk/>
            <pc:sldMk cId="8685089" sldId="257"/>
            <ac:spMk id="12" creationId="{437AF214-9BB0-EB44-DC34-C4733B22FFA7}"/>
          </ac:spMkLst>
        </pc:spChg>
        <pc:spChg chg="mod">
          <ac:chgData name="강은정" userId="692accea-f2c5-4441-99ea-ca23b894be73" providerId="ADAL" clId="{33609FAB-56D7-485F-98C0-917E13D3FFF4}" dt="2023-01-26T06:21:14.242" v="219" actId="1076"/>
          <ac:spMkLst>
            <pc:docMk/>
            <pc:sldMk cId="8685089" sldId="257"/>
            <ac:spMk id="50" creationId="{2F8B16BF-3D46-DDE1-0CF5-98E0A9398875}"/>
          </ac:spMkLst>
        </pc:spChg>
        <pc:spChg chg="mod">
          <ac:chgData name="강은정" userId="692accea-f2c5-4441-99ea-ca23b894be73" providerId="ADAL" clId="{33609FAB-56D7-485F-98C0-917E13D3FFF4}" dt="2023-01-26T06:21:14.242" v="219" actId="1076"/>
          <ac:spMkLst>
            <pc:docMk/>
            <pc:sldMk cId="8685089" sldId="257"/>
            <ac:spMk id="52" creationId="{7FC89351-E909-9A92-D1D4-2F783E9AEED4}"/>
          </ac:spMkLst>
        </pc:spChg>
        <pc:spChg chg="mod">
          <ac:chgData name="강은정" userId="692accea-f2c5-4441-99ea-ca23b894be73" providerId="ADAL" clId="{33609FAB-56D7-485F-98C0-917E13D3FFF4}" dt="2023-01-26T06:21:14.242" v="219" actId="1076"/>
          <ac:spMkLst>
            <pc:docMk/>
            <pc:sldMk cId="8685089" sldId="257"/>
            <ac:spMk id="54" creationId="{41C8950E-2610-7B7B-FC57-D52DB028C4A5}"/>
          </ac:spMkLst>
        </pc:spChg>
        <pc:spChg chg="mod">
          <ac:chgData name="강은정" userId="692accea-f2c5-4441-99ea-ca23b894be73" providerId="ADAL" clId="{33609FAB-56D7-485F-98C0-917E13D3FFF4}" dt="2023-01-26T06:21:14.242" v="219" actId="1076"/>
          <ac:spMkLst>
            <pc:docMk/>
            <pc:sldMk cId="8685089" sldId="257"/>
            <ac:spMk id="56" creationId="{5F6CB203-1231-B052-7F54-E9EEA57C9F4B}"/>
          </ac:spMkLst>
        </pc:spChg>
        <pc:spChg chg="mod">
          <ac:chgData name="강은정" userId="692accea-f2c5-4441-99ea-ca23b894be73" providerId="ADAL" clId="{33609FAB-56D7-485F-98C0-917E13D3FFF4}" dt="2023-01-26T06:21:14.242" v="219" actId="1076"/>
          <ac:spMkLst>
            <pc:docMk/>
            <pc:sldMk cId="8685089" sldId="257"/>
            <ac:spMk id="57" creationId="{02573DFA-999A-EC28-C028-EBB3C039C566}"/>
          </ac:spMkLst>
        </pc:spChg>
        <pc:spChg chg="mod">
          <ac:chgData name="강은정" userId="692accea-f2c5-4441-99ea-ca23b894be73" providerId="ADAL" clId="{33609FAB-56D7-485F-98C0-917E13D3FFF4}" dt="2023-01-26T06:21:14.242" v="219" actId="1076"/>
          <ac:spMkLst>
            <pc:docMk/>
            <pc:sldMk cId="8685089" sldId="257"/>
            <ac:spMk id="58" creationId="{F302B8BD-2684-CEC7-14C7-3C23A8A1BA04}"/>
          </ac:spMkLst>
        </pc:spChg>
        <pc:spChg chg="mod">
          <ac:chgData name="강은정" userId="692accea-f2c5-4441-99ea-ca23b894be73" providerId="ADAL" clId="{33609FAB-56D7-485F-98C0-917E13D3FFF4}" dt="2023-01-26T06:21:14.242" v="219" actId="1076"/>
          <ac:spMkLst>
            <pc:docMk/>
            <pc:sldMk cId="8685089" sldId="257"/>
            <ac:spMk id="59" creationId="{0018258B-1730-9286-D2C7-E2A8D55BA866}"/>
          </ac:spMkLst>
        </pc:spChg>
        <pc:spChg chg="mod">
          <ac:chgData name="강은정" userId="692accea-f2c5-4441-99ea-ca23b894be73" providerId="ADAL" clId="{33609FAB-56D7-485F-98C0-917E13D3FFF4}" dt="2023-01-26T06:21:14.242" v="219" actId="1076"/>
          <ac:spMkLst>
            <pc:docMk/>
            <pc:sldMk cId="8685089" sldId="257"/>
            <ac:spMk id="69" creationId="{430EEAF1-ADF1-2A12-9EAD-88A486D79B78}"/>
          </ac:spMkLst>
        </pc:spChg>
        <pc:spChg chg="mod">
          <ac:chgData name="강은정" userId="692accea-f2c5-4441-99ea-ca23b894be73" providerId="ADAL" clId="{33609FAB-56D7-485F-98C0-917E13D3FFF4}" dt="2023-01-26T06:21:14.242" v="219" actId="1076"/>
          <ac:spMkLst>
            <pc:docMk/>
            <pc:sldMk cId="8685089" sldId="257"/>
            <ac:spMk id="70" creationId="{1E4812D9-6694-9749-C833-E77C4C008538}"/>
          </ac:spMkLst>
        </pc:spChg>
        <pc:spChg chg="mod">
          <ac:chgData name="강은정" userId="692accea-f2c5-4441-99ea-ca23b894be73" providerId="ADAL" clId="{33609FAB-56D7-485F-98C0-917E13D3FFF4}" dt="2023-01-26T06:21:14.242" v="219" actId="1076"/>
          <ac:spMkLst>
            <pc:docMk/>
            <pc:sldMk cId="8685089" sldId="257"/>
            <ac:spMk id="71" creationId="{B3ED4403-CE6A-B7BE-C925-8ACF63226881}"/>
          </ac:spMkLst>
        </pc:spChg>
        <pc:spChg chg="mod">
          <ac:chgData name="강은정" userId="692accea-f2c5-4441-99ea-ca23b894be73" providerId="ADAL" clId="{33609FAB-56D7-485F-98C0-917E13D3FFF4}" dt="2023-01-26T06:21:14.242" v="219" actId="1076"/>
          <ac:spMkLst>
            <pc:docMk/>
            <pc:sldMk cId="8685089" sldId="257"/>
            <ac:spMk id="72" creationId="{D2B03701-4510-4109-A8F6-D7D8CDD2C964}"/>
          </ac:spMkLst>
        </pc:spChg>
        <pc:spChg chg="mod">
          <ac:chgData name="강은정" userId="692accea-f2c5-4441-99ea-ca23b894be73" providerId="ADAL" clId="{33609FAB-56D7-485F-98C0-917E13D3FFF4}" dt="2023-01-26T06:21:14.242" v="219" actId="1076"/>
          <ac:spMkLst>
            <pc:docMk/>
            <pc:sldMk cId="8685089" sldId="257"/>
            <ac:spMk id="73" creationId="{6105A8EE-5BE3-96A4-4608-E46A28F3C71E}"/>
          </ac:spMkLst>
        </pc:spChg>
        <pc:spChg chg="mod">
          <ac:chgData name="강은정" userId="692accea-f2c5-4441-99ea-ca23b894be73" providerId="ADAL" clId="{33609FAB-56D7-485F-98C0-917E13D3FFF4}" dt="2023-01-26T06:21:14.242" v="219" actId="1076"/>
          <ac:spMkLst>
            <pc:docMk/>
            <pc:sldMk cId="8685089" sldId="257"/>
            <ac:spMk id="74" creationId="{8CD58D5B-CE6F-6804-A084-8B1402BD4F76}"/>
          </ac:spMkLst>
        </pc:spChg>
        <pc:spChg chg="mod">
          <ac:chgData name="강은정" userId="692accea-f2c5-4441-99ea-ca23b894be73" providerId="ADAL" clId="{33609FAB-56D7-485F-98C0-917E13D3FFF4}" dt="2023-01-26T06:21:14.242" v="219" actId="1076"/>
          <ac:spMkLst>
            <pc:docMk/>
            <pc:sldMk cId="8685089" sldId="257"/>
            <ac:spMk id="75" creationId="{B1D0B631-93EF-FC9B-C5B9-58C24122B6D6}"/>
          </ac:spMkLst>
        </pc:spChg>
        <pc:spChg chg="mod">
          <ac:chgData name="강은정" userId="692accea-f2c5-4441-99ea-ca23b894be73" providerId="ADAL" clId="{33609FAB-56D7-485F-98C0-917E13D3FFF4}" dt="2023-01-26T06:21:14.242" v="219" actId="1076"/>
          <ac:spMkLst>
            <pc:docMk/>
            <pc:sldMk cId="8685089" sldId="257"/>
            <ac:spMk id="76" creationId="{71F3255D-DD83-209D-8736-74C640F33F2A}"/>
          </ac:spMkLst>
        </pc:spChg>
        <pc:spChg chg="mod">
          <ac:chgData name="강은정" userId="692accea-f2c5-4441-99ea-ca23b894be73" providerId="ADAL" clId="{33609FAB-56D7-485F-98C0-917E13D3FFF4}" dt="2023-01-26T06:21:14.242" v="219" actId="1076"/>
          <ac:spMkLst>
            <pc:docMk/>
            <pc:sldMk cId="8685089" sldId="257"/>
            <ac:spMk id="77" creationId="{1F63D184-6863-BFC5-A31C-DA6E173737D0}"/>
          </ac:spMkLst>
        </pc:spChg>
        <pc:spChg chg="mod">
          <ac:chgData name="강은정" userId="692accea-f2c5-4441-99ea-ca23b894be73" providerId="ADAL" clId="{33609FAB-56D7-485F-98C0-917E13D3FFF4}" dt="2023-01-26T06:21:14.242" v="219" actId="1076"/>
          <ac:spMkLst>
            <pc:docMk/>
            <pc:sldMk cId="8685089" sldId="257"/>
            <ac:spMk id="78" creationId="{A80F5E1C-B5D6-0B0A-3643-C84B800050FC}"/>
          </ac:spMkLst>
        </pc:spChg>
        <pc:spChg chg="mod">
          <ac:chgData name="강은정" userId="692accea-f2c5-4441-99ea-ca23b894be73" providerId="ADAL" clId="{33609FAB-56D7-485F-98C0-917E13D3FFF4}" dt="2023-01-26T06:21:14.242" v="219" actId="1076"/>
          <ac:spMkLst>
            <pc:docMk/>
            <pc:sldMk cId="8685089" sldId="257"/>
            <ac:spMk id="79" creationId="{42E733A6-38CE-4029-B6F8-D1D419FE7DBC}"/>
          </ac:spMkLst>
        </pc:spChg>
        <pc:spChg chg="mod">
          <ac:chgData name="강은정" userId="692accea-f2c5-4441-99ea-ca23b894be73" providerId="ADAL" clId="{33609FAB-56D7-485F-98C0-917E13D3FFF4}" dt="2023-01-26T06:21:14.242" v="219" actId="1076"/>
          <ac:spMkLst>
            <pc:docMk/>
            <pc:sldMk cId="8685089" sldId="257"/>
            <ac:spMk id="80" creationId="{B88AE4F2-41FB-E12F-6A12-213EA04F9960}"/>
          </ac:spMkLst>
        </pc:spChg>
        <pc:spChg chg="del">
          <ac:chgData name="강은정" userId="692accea-f2c5-4441-99ea-ca23b894be73" providerId="ADAL" clId="{33609FAB-56D7-485F-98C0-917E13D3FFF4}" dt="2023-01-26T06:16:34.191" v="138" actId="478"/>
          <ac:spMkLst>
            <pc:docMk/>
            <pc:sldMk cId="8685089" sldId="257"/>
            <ac:spMk id="81" creationId="{5E1699F1-40C9-4A05-F261-EF5649F2285F}"/>
          </ac:spMkLst>
        </pc:spChg>
        <pc:spChg chg="mod">
          <ac:chgData name="강은정" userId="692accea-f2c5-4441-99ea-ca23b894be73" providerId="ADAL" clId="{33609FAB-56D7-485F-98C0-917E13D3FFF4}" dt="2023-01-26T06:21:14.242" v="219" actId="1076"/>
          <ac:spMkLst>
            <pc:docMk/>
            <pc:sldMk cId="8685089" sldId="257"/>
            <ac:spMk id="82" creationId="{2016FFBA-2B7F-48B5-A765-639516742A85}"/>
          </ac:spMkLst>
        </pc:spChg>
        <pc:spChg chg="mod">
          <ac:chgData name="강은정" userId="692accea-f2c5-4441-99ea-ca23b894be73" providerId="ADAL" clId="{33609FAB-56D7-485F-98C0-917E13D3FFF4}" dt="2023-01-26T06:21:14.242" v="219" actId="1076"/>
          <ac:spMkLst>
            <pc:docMk/>
            <pc:sldMk cId="8685089" sldId="257"/>
            <ac:spMk id="85" creationId="{464C1976-98D3-466C-82B2-39541AF27297}"/>
          </ac:spMkLst>
        </pc:spChg>
        <pc:spChg chg="mod">
          <ac:chgData name="강은정" userId="692accea-f2c5-4441-99ea-ca23b894be73" providerId="ADAL" clId="{33609FAB-56D7-485F-98C0-917E13D3FFF4}" dt="2023-01-26T06:21:14.242" v="219" actId="1076"/>
          <ac:spMkLst>
            <pc:docMk/>
            <pc:sldMk cId="8685089" sldId="257"/>
            <ac:spMk id="86" creationId="{C184693E-9008-4814-9629-F37C5D264B97}"/>
          </ac:spMkLst>
        </pc:spChg>
        <pc:spChg chg="mod">
          <ac:chgData name="강은정" userId="692accea-f2c5-4441-99ea-ca23b894be73" providerId="ADAL" clId="{33609FAB-56D7-485F-98C0-917E13D3FFF4}" dt="2023-01-26T06:21:14.242" v="219" actId="1076"/>
          <ac:spMkLst>
            <pc:docMk/>
            <pc:sldMk cId="8685089" sldId="257"/>
            <ac:spMk id="87" creationId="{FF3CCD7C-5F4A-BB2E-612D-07898239F623}"/>
          </ac:spMkLst>
        </pc:spChg>
        <pc:grpChg chg="mod">
          <ac:chgData name="강은정" userId="692accea-f2c5-4441-99ea-ca23b894be73" providerId="ADAL" clId="{33609FAB-56D7-485F-98C0-917E13D3FFF4}" dt="2023-01-26T06:21:14.242" v="219" actId="1076"/>
          <ac:grpSpMkLst>
            <pc:docMk/>
            <pc:sldMk cId="8685089" sldId="257"/>
            <ac:grpSpMk id="2" creationId="{E3A699D5-E920-64D0-EB3B-5EB91C1B5AAE}"/>
          </ac:grpSpMkLst>
        </pc:grpChg>
        <pc:grpChg chg="mod">
          <ac:chgData name="강은정" userId="692accea-f2c5-4441-99ea-ca23b894be73" providerId="ADAL" clId="{33609FAB-56D7-485F-98C0-917E13D3FFF4}" dt="2023-01-26T06:21:14.242" v="219" actId="1076"/>
          <ac:grpSpMkLst>
            <pc:docMk/>
            <pc:sldMk cId="8685089" sldId="257"/>
            <ac:grpSpMk id="17" creationId="{1CDAF443-644C-A898-B664-A93F376719B5}"/>
          </ac:grpSpMkLst>
        </pc:grpChg>
        <pc:grpChg chg="mod">
          <ac:chgData name="강은정" userId="692accea-f2c5-4441-99ea-ca23b894be73" providerId="ADAL" clId="{33609FAB-56D7-485F-98C0-917E13D3FFF4}" dt="2023-01-26T06:21:14.242" v="219" actId="1076"/>
          <ac:grpSpMkLst>
            <pc:docMk/>
            <pc:sldMk cId="8685089" sldId="257"/>
            <ac:grpSpMk id="20" creationId="{B671ACF1-C513-640C-1EA1-7239215C582D}"/>
          </ac:grpSpMkLst>
        </pc:grpChg>
        <pc:grpChg chg="mod">
          <ac:chgData name="강은정" userId="692accea-f2c5-4441-99ea-ca23b894be73" providerId="ADAL" clId="{33609FAB-56D7-485F-98C0-917E13D3FFF4}" dt="2023-01-26T06:21:14.242" v="219" actId="1076"/>
          <ac:grpSpMkLst>
            <pc:docMk/>
            <pc:sldMk cId="8685089" sldId="257"/>
            <ac:grpSpMk id="23" creationId="{473D8641-B6AC-3DDF-7AD5-3085A9D06566}"/>
          </ac:grpSpMkLst>
        </pc:grpChg>
        <pc:grpChg chg="mod">
          <ac:chgData name="강은정" userId="692accea-f2c5-4441-99ea-ca23b894be73" providerId="ADAL" clId="{33609FAB-56D7-485F-98C0-917E13D3FFF4}" dt="2023-01-26T06:21:14.242" v="219" actId="1076"/>
          <ac:grpSpMkLst>
            <pc:docMk/>
            <pc:sldMk cId="8685089" sldId="257"/>
            <ac:grpSpMk id="26" creationId="{5FD102E7-7B78-31F6-BDB9-44AA0D263EA0}"/>
          </ac:grpSpMkLst>
        </pc:grpChg>
        <pc:grpChg chg="mod">
          <ac:chgData name="강은정" userId="692accea-f2c5-4441-99ea-ca23b894be73" providerId="ADAL" clId="{33609FAB-56D7-485F-98C0-917E13D3FFF4}" dt="2023-01-26T06:21:14.242" v="219" actId="1076"/>
          <ac:grpSpMkLst>
            <pc:docMk/>
            <pc:sldMk cId="8685089" sldId="257"/>
            <ac:grpSpMk id="29" creationId="{985913C1-B0D6-5D04-FE79-CD41D46E4C2B}"/>
          </ac:grpSpMkLst>
        </pc:grpChg>
        <pc:grpChg chg="mod">
          <ac:chgData name="강은정" userId="692accea-f2c5-4441-99ea-ca23b894be73" providerId="ADAL" clId="{33609FAB-56D7-485F-98C0-917E13D3FFF4}" dt="2023-01-26T06:21:14.242" v="219" actId="1076"/>
          <ac:grpSpMkLst>
            <pc:docMk/>
            <pc:sldMk cId="8685089" sldId="257"/>
            <ac:grpSpMk id="32" creationId="{C33B2831-2A6F-0F70-CD73-DA3B89B4A4F4}"/>
          </ac:grpSpMkLst>
        </pc:grpChg>
        <pc:grpChg chg="mod">
          <ac:chgData name="강은정" userId="692accea-f2c5-4441-99ea-ca23b894be73" providerId="ADAL" clId="{33609FAB-56D7-485F-98C0-917E13D3FFF4}" dt="2023-01-26T06:21:14.242" v="219" actId="1076"/>
          <ac:grpSpMkLst>
            <pc:docMk/>
            <pc:sldMk cId="8685089" sldId="257"/>
            <ac:grpSpMk id="35" creationId="{E5C92744-81B4-6B16-89EE-1684F170A7C8}"/>
          </ac:grpSpMkLst>
        </pc:grpChg>
        <pc:grpChg chg="mod">
          <ac:chgData name="강은정" userId="692accea-f2c5-4441-99ea-ca23b894be73" providerId="ADAL" clId="{33609FAB-56D7-485F-98C0-917E13D3FFF4}" dt="2023-01-26T06:21:14.242" v="219" actId="1076"/>
          <ac:grpSpMkLst>
            <pc:docMk/>
            <pc:sldMk cId="8685089" sldId="257"/>
            <ac:grpSpMk id="38" creationId="{C0E6358E-3BC6-5796-89C5-E9A3A944FA65}"/>
          </ac:grpSpMkLst>
        </pc:grpChg>
        <pc:grpChg chg="mod">
          <ac:chgData name="강은정" userId="692accea-f2c5-4441-99ea-ca23b894be73" providerId="ADAL" clId="{33609FAB-56D7-485F-98C0-917E13D3FFF4}" dt="2023-01-26T06:21:14.242" v="219" actId="1076"/>
          <ac:grpSpMkLst>
            <pc:docMk/>
            <pc:sldMk cId="8685089" sldId="257"/>
            <ac:grpSpMk id="41" creationId="{E5EFC55C-CF16-9B47-CCC6-C024CDB1E9A6}"/>
          </ac:grpSpMkLst>
        </pc:grpChg>
        <pc:grpChg chg="mod">
          <ac:chgData name="강은정" userId="692accea-f2c5-4441-99ea-ca23b894be73" providerId="ADAL" clId="{33609FAB-56D7-485F-98C0-917E13D3FFF4}" dt="2023-01-26T06:21:14.242" v="219" actId="1076"/>
          <ac:grpSpMkLst>
            <pc:docMk/>
            <pc:sldMk cId="8685089" sldId="257"/>
            <ac:grpSpMk id="44" creationId="{7AAFD186-CEB3-F5F6-6616-F7E391A47B23}"/>
          </ac:grpSpMkLst>
        </pc:grpChg>
        <pc:grpChg chg="mod">
          <ac:chgData name="강은정" userId="692accea-f2c5-4441-99ea-ca23b894be73" providerId="ADAL" clId="{33609FAB-56D7-485F-98C0-917E13D3FFF4}" dt="2023-01-26T06:21:14.242" v="219" actId="1076"/>
          <ac:grpSpMkLst>
            <pc:docMk/>
            <pc:sldMk cId="8685089" sldId="257"/>
            <ac:grpSpMk id="47" creationId="{CF037300-6AA4-182D-E53D-69DC6BCC077A}"/>
          </ac:grpSpMkLst>
        </pc:grpChg>
        <pc:graphicFrameChg chg="mod">
          <ac:chgData name="강은정" userId="692accea-f2c5-4441-99ea-ca23b894be73" providerId="ADAL" clId="{33609FAB-56D7-485F-98C0-917E13D3FFF4}" dt="2023-01-26T06:21:14.242" v="219" actId="1076"/>
          <ac:graphicFrameMkLst>
            <pc:docMk/>
            <pc:sldMk cId="8685089" sldId="257"/>
            <ac:graphicFrameMk id="4" creationId="{C643638E-7592-25D9-1BEB-DB4E37B62FBF}"/>
          </ac:graphicFrameMkLst>
        </pc:graphicFrameChg>
        <pc:graphicFrameChg chg="mod">
          <ac:chgData name="강은정" userId="692accea-f2c5-4441-99ea-ca23b894be73" providerId="ADAL" clId="{33609FAB-56D7-485F-98C0-917E13D3FFF4}" dt="2023-01-26T06:21:14.242" v="219" actId="1076"/>
          <ac:graphicFrameMkLst>
            <pc:docMk/>
            <pc:sldMk cId="8685089" sldId="257"/>
            <ac:graphicFrameMk id="5" creationId="{3CD130EE-BE91-4847-F20A-1CA3322782DC}"/>
          </ac:graphicFrameMkLst>
        </pc:graphicFrameChg>
        <pc:graphicFrameChg chg="mod">
          <ac:chgData name="강은정" userId="692accea-f2c5-4441-99ea-ca23b894be73" providerId="ADAL" clId="{33609FAB-56D7-485F-98C0-917E13D3FFF4}" dt="2023-01-26T06:21:14.242" v="219" actId="1076"/>
          <ac:graphicFrameMkLst>
            <pc:docMk/>
            <pc:sldMk cId="8685089" sldId="257"/>
            <ac:graphicFrameMk id="6" creationId="{A8827C7F-346C-54D1-D2A3-789929AF98BE}"/>
          </ac:graphicFrameMkLst>
        </pc:graphicFrameChg>
        <pc:graphicFrameChg chg="mod">
          <ac:chgData name="강은정" userId="692accea-f2c5-4441-99ea-ca23b894be73" providerId="ADAL" clId="{33609FAB-56D7-485F-98C0-917E13D3FFF4}" dt="2023-01-26T06:21:14.242" v="219" actId="1076"/>
          <ac:graphicFrameMkLst>
            <pc:docMk/>
            <pc:sldMk cId="8685089" sldId="257"/>
            <ac:graphicFrameMk id="7" creationId="{633C88A2-CB1D-BD7C-3A04-43BDDAA37E62}"/>
          </ac:graphicFrameMkLst>
        </pc:graphicFrameChg>
        <pc:graphicFrameChg chg="mod">
          <ac:chgData name="강은정" userId="692accea-f2c5-4441-99ea-ca23b894be73" providerId="ADAL" clId="{33609FAB-56D7-485F-98C0-917E13D3FFF4}" dt="2023-01-26T06:21:14.242" v="219" actId="1076"/>
          <ac:graphicFrameMkLst>
            <pc:docMk/>
            <pc:sldMk cId="8685089" sldId="257"/>
            <ac:graphicFrameMk id="14" creationId="{4BA11A08-E24E-B2BB-F853-A994A445326A}"/>
          </ac:graphicFrameMkLst>
        </pc:graphicFrameChg>
        <pc:graphicFrameChg chg="mod">
          <ac:chgData name="강은정" userId="692accea-f2c5-4441-99ea-ca23b894be73" providerId="ADAL" clId="{33609FAB-56D7-485F-98C0-917E13D3FFF4}" dt="2023-01-26T06:21:14.242" v="219" actId="1076"/>
          <ac:graphicFrameMkLst>
            <pc:docMk/>
            <pc:sldMk cId="8685089" sldId="257"/>
            <ac:graphicFrameMk id="15" creationId="{C0D29A8F-A2CE-CCB0-D105-0883C3714D51}"/>
          </ac:graphicFrameMkLst>
        </pc:graphicFrameChg>
        <pc:picChg chg="mod">
          <ac:chgData name="강은정" userId="692accea-f2c5-4441-99ea-ca23b894be73" providerId="ADAL" clId="{33609FAB-56D7-485F-98C0-917E13D3FFF4}" dt="2023-01-26T06:21:14.242" v="219" actId="1076"/>
          <ac:picMkLst>
            <pc:docMk/>
            <pc:sldMk cId="8685089" sldId="257"/>
            <ac:picMk id="9" creationId="{6C2074EB-8219-0BF4-572C-8E9661A4B6C7}"/>
          </ac:picMkLst>
        </pc:picChg>
        <pc:picChg chg="mod">
          <ac:chgData name="강은정" userId="692accea-f2c5-4441-99ea-ca23b894be73" providerId="ADAL" clId="{33609FAB-56D7-485F-98C0-917E13D3FFF4}" dt="2023-01-26T06:21:14.242" v="219" actId="1076"/>
          <ac:picMkLst>
            <pc:docMk/>
            <pc:sldMk cId="8685089" sldId="257"/>
            <ac:picMk id="83" creationId="{280C5EFC-F0D2-6232-51BD-6C17533E99F8}"/>
          </ac:picMkLst>
        </pc:picChg>
        <pc:picChg chg="mod">
          <ac:chgData name="강은정" userId="692accea-f2c5-4441-99ea-ca23b894be73" providerId="ADAL" clId="{33609FAB-56D7-485F-98C0-917E13D3FFF4}" dt="2023-01-26T06:21:14.242" v="219" actId="1076"/>
          <ac:picMkLst>
            <pc:docMk/>
            <pc:sldMk cId="8685089" sldId="257"/>
            <ac:picMk id="84" creationId="{AE656DD3-F4A3-3197-1BB4-3F5ACF7A16A6}"/>
          </ac:picMkLst>
        </pc:picChg>
        <pc:cxnChg chg="mod">
          <ac:chgData name="강은정" userId="692accea-f2c5-4441-99ea-ca23b894be73" providerId="ADAL" clId="{33609FAB-56D7-485F-98C0-917E13D3FFF4}" dt="2023-01-26T06:21:14.242" v="219" actId="1076"/>
          <ac:cxnSpMkLst>
            <pc:docMk/>
            <pc:sldMk cId="8685089" sldId="257"/>
            <ac:cxnSpMk id="51" creationId="{42449F6E-58E1-4C24-2097-4A4450401877}"/>
          </ac:cxnSpMkLst>
        </pc:cxnChg>
        <pc:cxnChg chg="mod">
          <ac:chgData name="강은정" userId="692accea-f2c5-4441-99ea-ca23b894be73" providerId="ADAL" clId="{33609FAB-56D7-485F-98C0-917E13D3FFF4}" dt="2023-01-26T06:21:14.242" v="219" actId="1076"/>
          <ac:cxnSpMkLst>
            <pc:docMk/>
            <pc:sldMk cId="8685089" sldId="257"/>
            <ac:cxnSpMk id="53" creationId="{22C37257-7A65-5637-5CA6-04A343A1386F}"/>
          </ac:cxnSpMkLst>
        </pc:cxnChg>
        <pc:cxnChg chg="mod">
          <ac:chgData name="강은정" userId="692accea-f2c5-4441-99ea-ca23b894be73" providerId="ADAL" clId="{33609FAB-56D7-485F-98C0-917E13D3FFF4}" dt="2023-01-26T06:21:14.242" v="219" actId="1076"/>
          <ac:cxnSpMkLst>
            <pc:docMk/>
            <pc:sldMk cId="8685089" sldId="257"/>
            <ac:cxnSpMk id="55" creationId="{445B5465-841F-3749-4D5A-7DD0E2CC781B}"/>
          </ac:cxnSpMkLst>
        </pc:cxnChg>
        <pc:cxnChg chg="mod">
          <ac:chgData name="강은정" userId="692accea-f2c5-4441-99ea-ca23b894be73" providerId="ADAL" clId="{33609FAB-56D7-485F-98C0-917E13D3FFF4}" dt="2023-01-26T06:21:14.242" v="219" actId="1076"/>
          <ac:cxnSpMkLst>
            <pc:docMk/>
            <pc:sldMk cId="8685089" sldId="257"/>
            <ac:cxnSpMk id="61" creationId="{767BB1DA-E381-2E05-8D57-CE25E35D9438}"/>
          </ac:cxnSpMkLst>
        </pc:cxnChg>
        <pc:cxnChg chg="mod">
          <ac:chgData name="강은정" userId="692accea-f2c5-4441-99ea-ca23b894be73" providerId="ADAL" clId="{33609FAB-56D7-485F-98C0-917E13D3FFF4}" dt="2023-01-26T06:21:14.242" v="219" actId="1076"/>
          <ac:cxnSpMkLst>
            <pc:docMk/>
            <pc:sldMk cId="8685089" sldId="257"/>
            <ac:cxnSpMk id="64" creationId="{2A917147-E430-DBAC-671E-4D37E917029E}"/>
          </ac:cxnSpMkLst>
        </pc:cxnChg>
        <pc:cxnChg chg="mod">
          <ac:chgData name="강은정" userId="692accea-f2c5-4441-99ea-ca23b894be73" providerId="ADAL" clId="{33609FAB-56D7-485F-98C0-917E13D3FFF4}" dt="2023-01-26T06:21:14.242" v="219" actId="1076"/>
          <ac:cxnSpMkLst>
            <pc:docMk/>
            <pc:sldMk cId="8685089" sldId="257"/>
            <ac:cxnSpMk id="65" creationId="{5719A8BE-7A50-9CEC-07B5-CC2F54680896}"/>
          </ac:cxnSpMkLst>
        </pc:cxnChg>
        <pc:cxnChg chg="mod">
          <ac:chgData name="강은정" userId="692accea-f2c5-4441-99ea-ca23b894be73" providerId="ADAL" clId="{33609FAB-56D7-485F-98C0-917E13D3FFF4}" dt="2023-01-26T06:21:14.242" v="219" actId="1076"/>
          <ac:cxnSpMkLst>
            <pc:docMk/>
            <pc:sldMk cId="8685089" sldId="257"/>
            <ac:cxnSpMk id="66" creationId="{BDED1238-8CB0-1AC2-6580-8CD9237DB501}"/>
          </ac:cxnSpMkLst>
        </pc:cxnChg>
        <pc:cxnChg chg="mod">
          <ac:chgData name="강은정" userId="692accea-f2c5-4441-99ea-ca23b894be73" providerId="ADAL" clId="{33609FAB-56D7-485F-98C0-917E13D3FFF4}" dt="2023-01-26T06:21:14.242" v="219" actId="1076"/>
          <ac:cxnSpMkLst>
            <pc:docMk/>
            <pc:sldMk cId="8685089" sldId="257"/>
            <ac:cxnSpMk id="67" creationId="{4A287652-BE64-0E16-86C3-0076249A28F1}"/>
          </ac:cxnSpMkLst>
        </pc:cxnChg>
        <pc:cxnChg chg="mod">
          <ac:chgData name="강은정" userId="692accea-f2c5-4441-99ea-ca23b894be73" providerId="ADAL" clId="{33609FAB-56D7-485F-98C0-917E13D3FFF4}" dt="2023-01-26T06:21:14.242" v="219" actId="1076"/>
          <ac:cxnSpMkLst>
            <pc:docMk/>
            <pc:sldMk cId="8685089" sldId="257"/>
            <ac:cxnSpMk id="68" creationId="{FF1E30EB-CCD8-7B54-517D-D398AC458DA2}"/>
          </ac:cxnSpMkLst>
        </pc:cxnChg>
      </pc:sldChg>
      <pc:sldChg chg="addSp delSp modSp mod">
        <pc:chgData name="강은정" userId="692accea-f2c5-4441-99ea-ca23b894be73" providerId="ADAL" clId="{33609FAB-56D7-485F-98C0-917E13D3FFF4}" dt="2023-01-26T06:27:18.167" v="243"/>
        <pc:sldMkLst>
          <pc:docMk/>
          <pc:sldMk cId="1717323419" sldId="258"/>
        </pc:sldMkLst>
        <pc:spChg chg="add mod">
          <ac:chgData name="강은정" userId="692accea-f2c5-4441-99ea-ca23b894be73" providerId="ADAL" clId="{33609FAB-56D7-485F-98C0-917E13D3FFF4}" dt="2023-01-26T06:27:18.167" v="243"/>
          <ac:spMkLst>
            <pc:docMk/>
            <pc:sldMk cId="1717323419" sldId="258"/>
            <ac:spMk id="2" creationId="{FFA5E4A6-384E-F1D4-0063-71DFBF9E4EC9}"/>
          </ac:spMkLst>
        </pc:spChg>
        <pc:spChg chg="del mod">
          <ac:chgData name="강은정" userId="692accea-f2c5-4441-99ea-ca23b894be73" providerId="ADAL" clId="{33609FAB-56D7-485F-98C0-917E13D3FFF4}" dt="2023-01-26T06:17:47.800" v="167" actId="478"/>
          <ac:spMkLst>
            <pc:docMk/>
            <pc:sldMk cId="1717323419" sldId="258"/>
            <ac:spMk id="43" creationId="{D08B4959-8A49-7071-6D29-C6EDF14AE985}"/>
          </ac:spMkLst>
        </pc:spChg>
        <pc:spChg chg="mod">
          <ac:chgData name="강은정" userId="692accea-f2c5-4441-99ea-ca23b894be73" providerId="ADAL" clId="{33609FAB-56D7-485F-98C0-917E13D3FFF4}" dt="2023-01-26T06:19:07.920" v="193"/>
          <ac:spMkLst>
            <pc:docMk/>
            <pc:sldMk cId="1717323419" sldId="258"/>
            <ac:spMk id="48" creationId="{3D18D640-1872-E42A-D7D9-D749FDB2833B}"/>
          </ac:spMkLst>
        </pc:spChg>
      </pc:sldChg>
      <pc:sldChg chg="addSp delSp modSp mod">
        <pc:chgData name="강은정" userId="692accea-f2c5-4441-99ea-ca23b894be73" providerId="ADAL" clId="{33609FAB-56D7-485F-98C0-917E13D3FFF4}" dt="2023-01-26T06:27:09.276" v="241"/>
        <pc:sldMkLst>
          <pc:docMk/>
          <pc:sldMk cId="4195893033" sldId="259"/>
        </pc:sldMkLst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3" creationId="{EF0521DD-3BA7-C221-EA5C-A158297523E7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16" creationId="{DE861B5A-D1EA-3A4A-10DF-9B4E70F11F9C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17" creationId="{CD97C19B-B087-A028-DDA9-EC79593E9C63}"/>
          </ac:spMkLst>
        </pc:spChg>
        <pc:spChg chg="add mod">
          <ac:chgData name="강은정" userId="692accea-f2c5-4441-99ea-ca23b894be73" providerId="ADAL" clId="{33609FAB-56D7-485F-98C0-917E13D3FFF4}" dt="2023-01-26T06:27:09.276" v="241"/>
          <ac:spMkLst>
            <pc:docMk/>
            <pc:sldMk cId="4195893033" sldId="259"/>
            <ac:spMk id="18" creationId="{17FB0E2B-A2EA-D6BA-8540-DF39AFDC2AC6}"/>
          </ac:spMkLst>
        </pc:spChg>
        <pc:spChg chg="del mod">
          <ac:chgData name="강은정" userId="692accea-f2c5-4441-99ea-ca23b894be73" providerId="ADAL" clId="{33609FAB-56D7-485F-98C0-917E13D3FFF4}" dt="2023-01-26T06:17:01.148" v="151" actId="478"/>
          <ac:spMkLst>
            <pc:docMk/>
            <pc:sldMk cId="4195893033" sldId="259"/>
            <ac:spMk id="28" creationId="{8B177D24-F1C8-752A-345D-94DD4E536729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33" creationId="{EF2EF42B-F675-2FB1-F143-693C8A86E007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34" creationId="{A2318052-37E4-4400-4C63-8BC7B11B657F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35" creationId="{47BD70E4-60BA-91FA-4AF0-821B06BFCEF5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39" creationId="{05A119B8-8CA8-3387-A1A1-A80D72A005CE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40" creationId="{88AAD68A-15EE-B33C-0C8D-0E8AC841CB05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43" creationId="{3AF6F92C-19D2-07AC-ABA5-CDC136C1CB57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44" creationId="{80C3E4DA-299D-348A-FE42-5E72F0D23540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46" creationId="{335BD7DA-BDCE-DC86-D346-538C5EA3B583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48" creationId="{D714BF06-9BE4-02B1-F73B-0DB4C3282438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50" creationId="{EA00B112-B698-23A6-230F-352A6C4693F6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59" creationId="{C858E0DF-2952-493B-2FB3-92781F055F40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60" creationId="{D3305BFF-F467-0067-701C-74F80BD1A03A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63" creationId="{6A5C11C4-A773-0BEA-2E81-5970A297248D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64" creationId="{7A77639C-8D9A-5A61-F230-6118AEBEDB1C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67" creationId="{7D1EA0BE-3F2C-8FB0-6E1E-B6D3309EE543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68" creationId="{FFB4A8DC-EA94-9C36-D3B6-B0D0BDE9964F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73" creationId="{0651D856-01E0-E3F7-0D8B-663115FAC756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76" creationId="{6588AC27-18BA-B3CA-0BC3-A77BE089395C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80" creationId="{757A9EED-BE14-79DE-AB0E-D61B490FBBA5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81" creationId="{56669195-CA8F-FE46-91CE-B13D89750B2F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82" creationId="{8CCFC2CF-E63C-4112-F41E-8EB3E23F57EC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83" creationId="{ED8D7B87-B0A5-E1EA-184B-F43EE081C00D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84" creationId="{25F1A769-28EE-BCBE-3F03-8402C25422EC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85" creationId="{27C0A36C-F76A-89F7-F8F2-F74C5FF774C8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88" creationId="{8C741468-4E23-4D17-B04E-85D8B519067A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89" creationId="{77AAAA99-F35D-3E26-AC81-012648AA4D60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90" creationId="{3FF04F54-0B5E-A9AB-E76E-7A233723B448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91" creationId="{FB0F26E5-B44F-5A9E-D702-FFCEB5680541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92" creationId="{873D77E1-E93F-A709-1C54-0D6A824255B7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93" creationId="{625A1393-684F-4773-C232-F0254F42A93D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94" creationId="{49CF2C9A-B255-D8A1-7606-DAF8DFA3F157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95" creationId="{D8540B9A-7894-AFB3-B55D-D79D0558B11E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96" creationId="{AC9A391F-A2C3-495D-E901-45D4C9EB5CDD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97" creationId="{EFCE14A4-8AAC-3AFD-9219-4B10D6FBA2EB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98" creationId="{01293076-28C7-5C3A-CE15-CB32B23A0115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99" creationId="{6CC4D6ED-6B75-705E-9EB0-07B367842C99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100" creationId="{528BB4EA-8956-4A0B-E9A6-032724D5D007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101" creationId="{A99CF40E-E4C6-200D-3153-E8FBE5CF68AE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102" creationId="{BD938A1A-377B-F7A0-7736-8DF78351F517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103" creationId="{18369708-BF3E-9E92-FACC-4632528978C5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104" creationId="{0EE37195-99B4-A0CA-214A-1012E6E967CF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105" creationId="{2D7F27B9-BE1C-5848-49C5-C22B23E8CDAB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106" creationId="{6C2A6389-03E2-EC51-5CF4-01A6B7CA712A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107" creationId="{D3F4E773-0D85-9DF8-96D1-05D3C2ADC19A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108" creationId="{83CBC990-7B13-DD96-8918-28CB46FCD0A6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109" creationId="{2B1F0A1E-4D1F-7FE8-850E-27C44464FA90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110" creationId="{68449EF5-300A-9393-648F-A8F13B6286EE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111" creationId="{C599F32E-00A7-5DDE-5EA8-EEBBDDCB7693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112" creationId="{987B2398-481E-DE49-7ED0-150D135171B4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113" creationId="{335C2A11-7648-4186-4015-C65179E04B75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114" creationId="{F046CFC9-32B1-D74E-9DC7-906C573EA28E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115" creationId="{F13BDA11-E724-4D48-83CA-E44BF17FC9E2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116" creationId="{29CCA9C2-57FF-4AC9-9CFD-31E23AE8073A}"/>
          </ac:spMkLst>
        </pc:spChg>
        <pc:spChg chg="mod">
          <ac:chgData name="강은정" userId="692accea-f2c5-4441-99ea-ca23b894be73" providerId="ADAL" clId="{33609FAB-56D7-485F-98C0-917E13D3FFF4}" dt="2023-01-26T06:16:48.611" v="145" actId="1076"/>
          <ac:spMkLst>
            <pc:docMk/>
            <pc:sldMk cId="4195893033" sldId="259"/>
            <ac:spMk id="117" creationId="{8E7FE5AC-4146-4B3C-8A0E-1DD084E2810B}"/>
          </ac:spMkLst>
        </pc:spChg>
        <pc:grpChg chg="mod">
          <ac:chgData name="강은정" userId="692accea-f2c5-4441-99ea-ca23b894be73" providerId="ADAL" clId="{33609FAB-56D7-485F-98C0-917E13D3FFF4}" dt="2023-01-26T06:16:48.611" v="145" actId="1076"/>
          <ac:grpSpMkLst>
            <pc:docMk/>
            <pc:sldMk cId="4195893033" sldId="259"/>
            <ac:grpSpMk id="14" creationId="{3D53F235-FDFD-4DEA-B8A9-AA029C6D35B1}"/>
          </ac:grpSpMkLst>
        </pc:grpChg>
        <pc:graphicFrameChg chg="mod">
          <ac:chgData name="강은정" userId="692accea-f2c5-4441-99ea-ca23b894be73" providerId="ADAL" clId="{33609FAB-56D7-485F-98C0-917E13D3FFF4}" dt="2023-01-26T06:16:48.611" v="145" actId="1076"/>
          <ac:graphicFrameMkLst>
            <pc:docMk/>
            <pc:sldMk cId="4195893033" sldId="259"/>
            <ac:graphicFrameMk id="4" creationId="{8CB7E317-9505-D243-D8E8-7DA6F29076C8}"/>
          </ac:graphicFrameMkLst>
        </pc:graphicFrameChg>
        <pc:graphicFrameChg chg="mod">
          <ac:chgData name="강은정" userId="692accea-f2c5-4441-99ea-ca23b894be73" providerId="ADAL" clId="{33609FAB-56D7-485F-98C0-917E13D3FFF4}" dt="2023-01-26T06:16:48.611" v="145" actId="1076"/>
          <ac:graphicFrameMkLst>
            <pc:docMk/>
            <pc:sldMk cId="4195893033" sldId="259"/>
            <ac:graphicFrameMk id="5" creationId="{E8670155-6467-4DBA-F524-3D1DFA2BA217}"/>
          </ac:graphicFrameMkLst>
        </pc:graphicFrameChg>
        <pc:graphicFrameChg chg="mod">
          <ac:chgData name="강은정" userId="692accea-f2c5-4441-99ea-ca23b894be73" providerId="ADAL" clId="{33609FAB-56D7-485F-98C0-917E13D3FFF4}" dt="2023-01-26T06:16:48.611" v="145" actId="1076"/>
          <ac:graphicFrameMkLst>
            <pc:docMk/>
            <pc:sldMk cId="4195893033" sldId="259"/>
            <ac:graphicFrameMk id="6" creationId="{5E1F05F0-6E91-25AF-CADF-5E30CE27C7F4}"/>
          </ac:graphicFrameMkLst>
        </pc:graphicFrameChg>
        <pc:graphicFrameChg chg="mod">
          <ac:chgData name="강은정" userId="692accea-f2c5-4441-99ea-ca23b894be73" providerId="ADAL" clId="{33609FAB-56D7-485F-98C0-917E13D3FFF4}" dt="2023-01-26T06:16:48.611" v="145" actId="1076"/>
          <ac:graphicFrameMkLst>
            <pc:docMk/>
            <pc:sldMk cId="4195893033" sldId="259"/>
            <ac:graphicFrameMk id="7" creationId="{96D5B42F-E7F2-AA5F-3471-4A2C33D71BF7}"/>
          </ac:graphicFrameMkLst>
        </pc:graphicFrameChg>
        <pc:graphicFrameChg chg="mod">
          <ac:chgData name="강은정" userId="692accea-f2c5-4441-99ea-ca23b894be73" providerId="ADAL" clId="{33609FAB-56D7-485F-98C0-917E13D3FFF4}" dt="2023-01-26T06:16:48.611" v="145" actId="1076"/>
          <ac:graphicFrameMkLst>
            <pc:docMk/>
            <pc:sldMk cId="4195893033" sldId="259"/>
            <ac:graphicFrameMk id="8" creationId="{29937395-02F4-06CD-1130-F674F6EC2215}"/>
          </ac:graphicFrameMkLst>
        </pc:graphicFrameChg>
        <pc:graphicFrameChg chg="mod">
          <ac:chgData name="강은정" userId="692accea-f2c5-4441-99ea-ca23b894be73" providerId="ADAL" clId="{33609FAB-56D7-485F-98C0-917E13D3FFF4}" dt="2023-01-26T06:16:48.611" v="145" actId="1076"/>
          <ac:graphicFrameMkLst>
            <pc:docMk/>
            <pc:sldMk cId="4195893033" sldId="259"/>
            <ac:graphicFrameMk id="9" creationId="{DB21D91D-0596-9E0A-564F-BE58A7BD48F1}"/>
          </ac:graphicFrameMkLst>
        </pc:graphicFrameChg>
        <pc:graphicFrameChg chg="mod">
          <ac:chgData name="강은정" userId="692accea-f2c5-4441-99ea-ca23b894be73" providerId="ADAL" clId="{33609FAB-56D7-485F-98C0-917E13D3FFF4}" dt="2023-01-26T06:16:48.611" v="145" actId="1076"/>
          <ac:graphicFrameMkLst>
            <pc:docMk/>
            <pc:sldMk cId="4195893033" sldId="259"/>
            <ac:graphicFrameMk id="10" creationId="{94B76007-53F2-41DA-AEB3-DB17D7C8E805}"/>
          </ac:graphicFrameMkLst>
        </pc:graphicFrameChg>
        <pc:graphicFrameChg chg="mod">
          <ac:chgData name="강은정" userId="692accea-f2c5-4441-99ea-ca23b894be73" providerId="ADAL" clId="{33609FAB-56D7-485F-98C0-917E13D3FFF4}" dt="2023-01-26T06:16:48.611" v="145" actId="1076"/>
          <ac:graphicFrameMkLst>
            <pc:docMk/>
            <pc:sldMk cId="4195893033" sldId="259"/>
            <ac:graphicFrameMk id="11" creationId="{2A5A4D9F-6D39-025C-C34E-C89D1F4B5617}"/>
          </ac:graphicFrameMkLst>
        </pc:graphicFrameChg>
        <pc:graphicFrameChg chg="mod">
          <ac:chgData name="강은정" userId="692accea-f2c5-4441-99ea-ca23b894be73" providerId="ADAL" clId="{33609FAB-56D7-485F-98C0-917E13D3FFF4}" dt="2023-01-26T06:16:48.611" v="145" actId="1076"/>
          <ac:graphicFrameMkLst>
            <pc:docMk/>
            <pc:sldMk cId="4195893033" sldId="259"/>
            <ac:graphicFrameMk id="12" creationId="{480B3A7F-3860-DEBF-643D-98F07EACC744}"/>
          </ac:graphicFrameMkLst>
        </pc:graphicFrameChg>
        <pc:graphicFrameChg chg="mod">
          <ac:chgData name="강은정" userId="692accea-f2c5-4441-99ea-ca23b894be73" providerId="ADAL" clId="{33609FAB-56D7-485F-98C0-917E13D3FFF4}" dt="2023-01-26T06:16:48.611" v="145" actId="1076"/>
          <ac:graphicFrameMkLst>
            <pc:docMk/>
            <pc:sldMk cId="4195893033" sldId="259"/>
            <ac:graphicFrameMk id="13" creationId="{B7473603-0E8A-E641-AEB2-157B44158322}"/>
          </ac:graphicFrameMkLst>
        </pc:graphicFrameChg>
        <pc:picChg chg="mod">
          <ac:chgData name="강은정" userId="692accea-f2c5-4441-99ea-ca23b894be73" providerId="ADAL" clId="{33609FAB-56D7-485F-98C0-917E13D3FFF4}" dt="2023-01-26T06:16:48.611" v="145" actId="1076"/>
          <ac:picMkLst>
            <pc:docMk/>
            <pc:sldMk cId="4195893033" sldId="259"/>
            <ac:picMk id="15" creationId="{C234BEFE-B01A-6E94-F932-9FA9AB2D6F9C}"/>
          </ac:picMkLst>
        </pc:picChg>
        <pc:picChg chg="mod">
          <ac:chgData name="강은정" userId="692accea-f2c5-4441-99ea-ca23b894be73" providerId="ADAL" clId="{33609FAB-56D7-485F-98C0-917E13D3FFF4}" dt="2023-01-26T06:16:48.611" v="145" actId="1076"/>
          <ac:picMkLst>
            <pc:docMk/>
            <pc:sldMk cId="4195893033" sldId="259"/>
            <ac:picMk id="19" creationId="{692F76FA-7B05-4DD1-4124-E400A3F3413D}"/>
          </ac:picMkLst>
        </pc:picChg>
        <pc:cxnChg chg="mod">
          <ac:chgData name="강은정" userId="692accea-f2c5-4441-99ea-ca23b894be73" providerId="ADAL" clId="{33609FAB-56D7-485F-98C0-917E13D3FFF4}" dt="2023-01-26T06:16:48.611" v="145" actId="1076"/>
          <ac:cxnSpMkLst>
            <pc:docMk/>
            <pc:sldMk cId="4195893033" sldId="259"/>
            <ac:cxnSpMk id="2" creationId="{6271CE27-2BB3-6276-53DA-F626CF0A9D82}"/>
          </ac:cxnSpMkLst>
        </pc:cxnChg>
        <pc:cxnChg chg="mod">
          <ac:chgData name="강은정" userId="692accea-f2c5-4441-99ea-ca23b894be73" providerId="ADAL" clId="{33609FAB-56D7-485F-98C0-917E13D3FFF4}" dt="2023-01-26T06:16:48.611" v="145" actId="1076"/>
          <ac:cxnSpMkLst>
            <pc:docMk/>
            <pc:sldMk cId="4195893033" sldId="259"/>
            <ac:cxnSpMk id="30" creationId="{4F1C6C17-D602-28FB-7923-8A9335EE4CFD}"/>
          </ac:cxnSpMkLst>
        </pc:cxnChg>
        <pc:cxnChg chg="mod">
          <ac:chgData name="강은정" userId="692accea-f2c5-4441-99ea-ca23b894be73" providerId="ADAL" clId="{33609FAB-56D7-485F-98C0-917E13D3FFF4}" dt="2023-01-26T06:16:48.611" v="145" actId="1076"/>
          <ac:cxnSpMkLst>
            <pc:docMk/>
            <pc:sldMk cId="4195893033" sldId="259"/>
            <ac:cxnSpMk id="31" creationId="{EBF4A857-1214-D2AD-A2EE-27BF1C0917DB}"/>
          </ac:cxnSpMkLst>
        </pc:cxnChg>
        <pc:cxnChg chg="mod">
          <ac:chgData name="강은정" userId="692accea-f2c5-4441-99ea-ca23b894be73" providerId="ADAL" clId="{33609FAB-56D7-485F-98C0-917E13D3FFF4}" dt="2023-01-26T06:16:48.611" v="145" actId="1076"/>
          <ac:cxnSpMkLst>
            <pc:docMk/>
            <pc:sldMk cId="4195893033" sldId="259"/>
            <ac:cxnSpMk id="32" creationId="{CE9542A5-90C5-449C-0A66-184E8E6E2079}"/>
          </ac:cxnSpMkLst>
        </pc:cxnChg>
        <pc:cxnChg chg="mod">
          <ac:chgData name="강은정" userId="692accea-f2c5-4441-99ea-ca23b894be73" providerId="ADAL" clId="{33609FAB-56D7-485F-98C0-917E13D3FFF4}" dt="2023-01-26T06:16:48.611" v="145" actId="1076"/>
          <ac:cxnSpMkLst>
            <pc:docMk/>
            <pc:sldMk cId="4195893033" sldId="259"/>
            <ac:cxnSpMk id="37" creationId="{16700C16-90A6-0CBC-4F6F-1014FAE84D54}"/>
          </ac:cxnSpMkLst>
        </pc:cxnChg>
        <pc:cxnChg chg="mod">
          <ac:chgData name="강은정" userId="692accea-f2c5-4441-99ea-ca23b894be73" providerId="ADAL" clId="{33609FAB-56D7-485F-98C0-917E13D3FFF4}" dt="2023-01-26T06:16:48.611" v="145" actId="1076"/>
          <ac:cxnSpMkLst>
            <pc:docMk/>
            <pc:sldMk cId="4195893033" sldId="259"/>
            <ac:cxnSpMk id="38" creationId="{8BD57AA1-CC0A-D23F-5BB3-05D7A87ACF5F}"/>
          </ac:cxnSpMkLst>
        </pc:cxnChg>
        <pc:cxnChg chg="mod">
          <ac:chgData name="강은정" userId="692accea-f2c5-4441-99ea-ca23b894be73" providerId="ADAL" clId="{33609FAB-56D7-485F-98C0-917E13D3FFF4}" dt="2023-01-26T06:16:48.611" v="145" actId="1076"/>
          <ac:cxnSpMkLst>
            <pc:docMk/>
            <pc:sldMk cId="4195893033" sldId="259"/>
            <ac:cxnSpMk id="41" creationId="{C0233842-1BDA-BB24-87D2-0A2EAA78C822}"/>
          </ac:cxnSpMkLst>
        </pc:cxnChg>
        <pc:cxnChg chg="mod">
          <ac:chgData name="강은정" userId="692accea-f2c5-4441-99ea-ca23b894be73" providerId="ADAL" clId="{33609FAB-56D7-485F-98C0-917E13D3FFF4}" dt="2023-01-26T06:16:48.611" v="145" actId="1076"/>
          <ac:cxnSpMkLst>
            <pc:docMk/>
            <pc:sldMk cId="4195893033" sldId="259"/>
            <ac:cxnSpMk id="42" creationId="{A74F4AA5-CFD5-3152-533A-E89935239AFF}"/>
          </ac:cxnSpMkLst>
        </pc:cxnChg>
        <pc:cxnChg chg="mod">
          <ac:chgData name="강은정" userId="692accea-f2c5-4441-99ea-ca23b894be73" providerId="ADAL" clId="{33609FAB-56D7-485F-98C0-917E13D3FFF4}" dt="2023-01-26T06:16:48.611" v="145" actId="1076"/>
          <ac:cxnSpMkLst>
            <pc:docMk/>
            <pc:sldMk cId="4195893033" sldId="259"/>
            <ac:cxnSpMk id="45" creationId="{BF5CE8C5-37FB-4A14-4886-5E84E3080186}"/>
          </ac:cxnSpMkLst>
        </pc:cxnChg>
        <pc:cxnChg chg="mod">
          <ac:chgData name="강은정" userId="692accea-f2c5-4441-99ea-ca23b894be73" providerId="ADAL" clId="{33609FAB-56D7-485F-98C0-917E13D3FFF4}" dt="2023-01-26T06:16:48.611" v="145" actId="1076"/>
          <ac:cxnSpMkLst>
            <pc:docMk/>
            <pc:sldMk cId="4195893033" sldId="259"/>
            <ac:cxnSpMk id="47" creationId="{DD972548-1C03-E97D-F129-179DC18DAD2A}"/>
          </ac:cxnSpMkLst>
        </pc:cxnChg>
        <pc:cxnChg chg="mod">
          <ac:chgData name="강은정" userId="692accea-f2c5-4441-99ea-ca23b894be73" providerId="ADAL" clId="{33609FAB-56D7-485F-98C0-917E13D3FFF4}" dt="2023-01-26T06:16:48.611" v="145" actId="1076"/>
          <ac:cxnSpMkLst>
            <pc:docMk/>
            <pc:sldMk cId="4195893033" sldId="259"/>
            <ac:cxnSpMk id="49" creationId="{5E570EDE-177F-F727-0A1E-40DD872C5AB5}"/>
          </ac:cxnSpMkLst>
        </pc:cxnChg>
        <pc:cxnChg chg="mod">
          <ac:chgData name="강은정" userId="692accea-f2c5-4441-99ea-ca23b894be73" providerId="ADAL" clId="{33609FAB-56D7-485F-98C0-917E13D3FFF4}" dt="2023-01-26T06:16:48.611" v="145" actId="1076"/>
          <ac:cxnSpMkLst>
            <pc:docMk/>
            <pc:sldMk cId="4195893033" sldId="259"/>
            <ac:cxnSpMk id="57" creationId="{DBC370CA-8CDB-71A1-351C-04C31FAF2AB8}"/>
          </ac:cxnSpMkLst>
        </pc:cxnChg>
        <pc:cxnChg chg="mod">
          <ac:chgData name="강은정" userId="692accea-f2c5-4441-99ea-ca23b894be73" providerId="ADAL" clId="{33609FAB-56D7-485F-98C0-917E13D3FFF4}" dt="2023-01-26T06:16:48.611" v="145" actId="1076"/>
          <ac:cxnSpMkLst>
            <pc:docMk/>
            <pc:sldMk cId="4195893033" sldId="259"/>
            <ac:cxnSpMk id="58" creationId="{7BF9339C-B846-3560-CC60-0F12E01443B1}"/>
          </ac:cxnSpMkLst>
        </pc:cxnChg>
        <pc:cxnChg chg="mod">
          <ac:chgData name="강은정" userId="692accea-f2c5-4441-99ea-ca23b894be73" providerId="ADAL" clId="{33609FAB-56D7-485F-98C0-917E13D3FFF4}" dt="2023-01-26T06:16:48.611" v="145" actId="1076"/>
          <ac:cxnSpMkLst>
            <pc:docMk/>
            <pc:sldMk cId="4195893033" sldId="259"/>
            <ac:cxnSpMk id="61" creationId="{79C96085-17B4-1C65-EA32-B66DEC7C479F}"/>
          </ac:cxnSpMkLst>
        </pc:cxnChg>
        <pc:cxnChg chg="mod">
          <ac:chgData name="강은정" userId="692accea-f2c5-4441-99ea-ca23b894be73" providerId="ADAL" clId="{33609FAB-56D7-485F-98C0-917E13D3FFF4}" dt="2023-01-26T06:16:48.611" v="145" actId="1076"/>
          <ac:cxnSpMkLst>
            <pc:docMk/>
            <pc:sldMk cId="4195893033" sldId="259"/>
            <ac:cxnSpMk id="62" creationId="{20385FC6-0855-47E5-8693-FBAE081DD62C}"/>
          </ac:cxnSpMkLst>
        </pc:cxnChg>
        <pc:cxnChg chg="mod">
          <ac:chgData name="강은정" userId="692accea-f2c5-4441-99ea-ca23b894be73" providerId="ADAL" clId="{33609FAB-56D7-485F-98C0-917E13D3FFF4}" dt="2023-01-26T06:16:48.611" v="145" actId="1076"/>
          <ac:cxnSpMkLst>
            <pc:docMk/>
            <pc:sldMk cId="4195893033" sldId="259"/>
            <ac:cxnSpMk id="65" creationId="{A38D19AE-D94C-7A67-5D55-64A82DBC0AAE}"/>
          </ac:cxnSpMkLst>
        </pc:cxnChg>
        <pc:cxnChg chg="mod">
          <ac:chgData name="강은정" userId="692accea-f2c5-4441-99ea-ca23b894be73" providerId="ADAL" clId="{33609FAB-56D7-485F-98C0-917E13D3FFF4}" dt="2023-01-26T06:16:48.611" v="145" actId="1076"/>
          <ac:cxnSpMkLst>
            <pc:docMk/>
            <pc:sldMk cId="4195893033" sldId="259"/>
            <ac:cxnSpMk id="66" creationId="{A664A914-CC43-32CA-1CCC-F8D4A8158C05}"/>
          </ac:cxnSpMkLst>
        </pc:cxnChg>
      </pc:sldChg>
      <pc:sldChg chg="addSp delSp modSp mod">
        <pc:chgData name="강은정" userId="692accea-f2c5-4441-99ea-ca23b894be73" providerId="ADAL" clId="{33609FAB-56D7-485F-98C0-917E13D3FFF4}" dt="2023-01-26T06:27:14.061" v="242"/>
        <pc:sldMkLst>
          <pc:docMk/>
          <pc:sldMk cId="2940245860" sldId="260"/>
        </pc:sldMkLst>
        <pc:spChg chg="add mod">
          <ac:chgData name="강은정" userId="692accea-f2c5-4441-99ea-ca23b894be73" providerId="ADAL" clId="{33609FAB-56D7-485F-98C0-917E13D3FFF4}" dt="2023-01-26T06:27:14.061" v="242"/>
          <ac:spMkLst>
            <pc:docMk/>
            <pc:sldMk cId="2940245860" sldId="260"/>
            <ac:spMk id="2" creationId="{C8E17352-9254-47BF-23E0-3C6ECAFA1E40}"/>
          </ac:spMkLst>
        </pc:spChg>
        <pc:spChg chg="mod">
          <ac:chgData name="강은정" userId="692accea-f2c5-4441-99ea-ca23b894be73" providerId="ADAL" clId="{33609FAB-56D7-485F-98C0-917E13D3FFF4}" dt="2023-01-26T06:17:13.154" v="152" actId="1076"/>
          <ac:spMkLst>
            <pc:docMk/>
            <pc:sldMk cId="2940245860" sldId="260"/>
            <ac:spMk id="10" creationId="{F8BAB1A0-0429-4853-570C-009752B75C19}"/>
          </ac:spMkLst>
        </pc:spChg>
        <pc:spChg chg="mod">
          <ac:chgData name="강은정" userId="692accea-f2c5-4441-99ea-ca23b894be73" providerId="ADAL" clId="{33609FAB-56D7-485F-98C0-917E13D3FFF4}" dt="2023-01-26T06:17:13.154" v="152" actId="1076"/>
          <ac:spMkLst>
            <pc:docMk/>
            <pc:sldMk cId="2940245860" sldId="260"/>
            <ac:spMk id="11" creationId="{C101B0E5-0953-7976-07F1-2539D56D970A}"/>
          </ac:spMkLst>
        </pc:spChg>
        <pc:spChg chg="mod">
          <ac:chgData name="강은정" userId="692accea-f2c5-4441-99ea-ca23b894be73" providerId="ADAL" clId="{33609FAB-56D7-485F-98C0-917E13D3FFF4}" dt="2023-01-26T06:17:13.154" v="152" actId="1076"/>
          <ac:spMkLst>
            <pc:docMk/>
            <pc:sldMk cId="2940245860" sldId="260"/>
            <ac:spMk id="12" creationId="{27962894-B9C3-E8CE-E2A4-4FB6786E4534}"/>
          </ac:spMkLst>
        </pc:spChg>
        <pc:spChg chg="mod">
          <ac:chgData name="강은정" userId="692accea-f2c5-4441-99ea-ca23b894be73" providerId="ADAL" clId="{33609FAB-56D7-485F-98C0-917E13D3FFF4}" dt="2023-01-26T06:17:13.154" v="152" actId="1076"/>
          <ac:spMkLst>
            <pc:docMk/>
            <pc:sldMk cId="2940245860" sldId="260"/>
            <ac:spMk id="13" creationId="{ACE74E92-46B9-31A9-014A-8FB73D00A78F}"/>
          </ac:spMkLst>
        </pc:spChg>
        <pc:spChg chg="mod">
          <ac:chgData name="강은정" userId="692accea-f2c5-4441-99ea-ca23b894be73" providerId="ADAL" clId="{33609FAB-56D7-485F-98C0-917E13D3FFF4}" dt="2023-01-26T06:17:13.154" v="152" actId="1076"/>
          <ac:spMkLst>
            <pc:docMk/>
            <pc:sldMk cId="2940245860" sldId="260"/>
            <ac:spMk id="14" creationId="{C184A147-D3A2-EB31-012D-AE35CECBE12F}"/>
          </ac:spMkLst>
        </pc:spChg>
        <pc:spChg chg="mod">
          <ac:chgData name="강은정" userId="692accea-f2c5-4441-99ea-ca23b894be73" providerId="ADAL" clId="{33609FAB-56D7-485F-98C0-917E13D3FFF4}" dt="2023-01-26T06:17:13.154" v="152" actId="1076"/>
          <ac:spMkLst>
            <pc:docMk/>
            <pc:sldMk cId="2940245860" sldId="260"/>
            <ac:spMk id="15" creationId="{21BA800C-C6B9-EAA0-3419-5685B67C1DC1}"/>
          </ac:spMkLst>
        </pc:spChg>
        <pc:spChg chg="mod">
          <ac:chgData name="강은정" userId="692accea-f2c5-4441-99ea-ca23b894be73" providerId="ADAL" clId="{33609FAB-56D7-485F-98C0-917E13D3FFF4}" dt="2023-01-26T06:17:13.154" v="152" actId="1076"/>
          <ac:spMkLst>
            <pc:docMk/>
            <pc:sldMk cId="2940245860" sldId="260"/>
            <ac:spMk id="16" creationId="{F57C7C83-F87A-9C51-21FC-FE79CCBD6D05}"/>
          </ac:spMkLst>
        </pc:spChg>
        <pc:spChg chg="mod">
          <ac:chgData name="강은정" userId="692accea-f2c5-4441-99ea-ca23b894be73" providerId="ADAL" clId="{33609FAB-56D7-485F-98C0-917E13D3FFF4}" dt="2023-01-26T06:17:21.743" v="159" actId="1076"/>
          <ac:spMkLst>
            <pc:docMk/>
            <pc:sldMk cId="2940245860" sldId="260"/>
            <ac:spMk id="32" creationId="{9DA4674A-C144-CA45-3843-4D7F07E65410}"/>
          </ac:spMkLst>
        </pc:spChg>
        <pc:spChg chg="mod">
          <ac:chgData name="강은정" userId="692accea-f2c5-4441-99ea-ca23b894be73" providerId="ADAL" clId="{33609FAB-56D7-485F-98C0-917E13D3FFF4}" dt="2023-01-26T06:17:13.154" v="152" actId="1076"/>
          <ac:spMkLst>
            <pc:docMk/>
            <pc:sldMk cId="2940245860" sldId="260"/>
            <ac:spMk id="33" creationId="{C0F8B997-1229-E26C-F4E9-FD0F2B12E6E8}"/>
          </ac:spMkLst>
        </pc:spChg>
        <pc:spChg chg="mod">
          <ac:chgData name="강은정" userId="692accea-f2c5-4441-99ea-ca23b894be73" providerId="ADAL" clId="{33609FAB-56D7-485F-98C0-917E13D3FFF4}" dt="2023-01-26T06:17:13.154" v="152" actId="1076"/>
          <ac:spMkLst>
            <pc:docMk/>
            <pc:sldMk cId="2940245860" sldId="260"/>
            <ac:spMk id="34" creationId="{7B427C90-61E7-77BF-FA72-F4817A327648}"/>
          </ac:spMkLst>
        </pc:spChg>
        <pc:spChg chg="mod">
          <ac:chgData name="강은정" userId="692accea-f2c5-4441-99ea-ca23b894be73" providerId="ADAL" clId="{33609FAB-56D7-485F-98C0-917E13D3FFF4}" dt="2023-01-26T06:17:13.154" v="152" actId="1076"/>
          <ac:spMkLst>
            <pc:docMk/>
            <pc:sldMk cId="2940245860" sldId="260"/>
            <ac:spMk id="35" creationId="{1A966B44-06AF-9316-D4CC-65F1429BD401}"/>
          </ac:spMkLst>
        </pc:spChg>
        <pc:spChg chg="mod">
          <ac:chgData name="강은정" userId="692accea-f2c5-4441-99ea-ca23b894be73" providerId="ADAL" clId="{33609FAB-56D7-485F-98C0-917E13D3FFF4}" dt="2023-01-26T06:17:13.154" v="152" actId="1076"/>
          <ac:spMkLst>
            <pc:docMk/>
            <pc:sldMk cId="2940245860" sldId="260"/>
            <ac:spMk id="180" creationId="{F27B979C-9E71-7C21-8931-A043171F5C6A}"/>
          </ac:spMkLst>
        </pc:spChg>
        <pc:spChg chg="mod">
          <ac:chgData name="강은정" userId="692accea-f2c5-4441-99ea-ca23b894be73" providerId="ADAL" clId="{33609FAB-56D7-485F-98C0-917E13D3FFF4}" dt="2023-01-26T06:17:13.154" v="152" actId="1076"/>
          <ac:spMkLst>
            <pc:docMk/>
            <pc:sldMk cId="2940245860" sldId="260"/>
            <ac:spMk id="181" creationId="{2D00BF7F-C853-2FE9-BBD6-6CC5B349ED29}"/>
          </ac:spMkLst>
        </pc:spChg>
        <pc:spChg chg="mod">
          <ac:chgData name="강은정" userId="692accea-f2c5-4441-99ea-ca23b894be73" providerId="ADAL" clId="{33609FAB-56D7-485F-98C0-917E13D3FFF4}" dt="2023-01-26T06:17:13.154" v="152" actId="1076"/>
          <ac:spMkLst>
            <pc:docMk/>
            <pc:sldMk cId="2940245860" sldId="260"/>
            <ac:spMk id="182" creationId="{6A57E49A-900B-BFD3-0DB5-61BF74692506}"/>
          </ac:spMkLst>
        </pc:spChg>
        <pc:spChg chg="mod">
          <ac:chgData name="강은정" userId="692accea-f2c5-4441-99ea-ca23b894be73" providerId="ADAL" clId="{33609FAB-56D7-485F-98C0-917E13D3FFF4}" dt="2023-01-26T06:17:13.154" v="152" actId="1076"/>
          <ac:spMkLst>
            <pc:docMk/>
            <pc:sldMk cId="2940245860" sldId="260"/>
            <ac:spMk id="183" creationId="{CABC43A5-A452-8E47-A1E7-4FEB3616ABC5}"/>
          </ac:spMkLst>
        </pc:spChg>
        <pc:spChg chg="mod">
          <ac:chgData name="강은정" userId="692accea-f2c5-4441-99ea-ca23b894be73" providerId="ADAL" clId="{33609FAB-56D7-485F-98C0-917E13D3FFF4}" dt="2023-01-26T06:17:13.154" v="152" actId="1076"/>
          <ac:spMkLst>
            <pc:docMk/>
            <pc:sldMk cId="2940245860" sldId="260"/>
            <ac:spMk id="184" creationId="{D8821AD0-87AF-E1F0-DB64-CC6C7EA1655A}"/>
          </ac:spMkLst>
        </pc:spChg>
        <pc:spChg chg="mod">
          <ac:chgData name="강은정" userId="692accea-f2c5-4441-99ea-ca23b894be73" providerId="ADAL" clId="{33609FAB-56D7-485F-98C0-917E13D3FFF4}" dt="2023-01-26T06:17:13.154" v="152" actId="1076"/>
          <ac:spMkLst>
            <pc:docMk/>
            <pc:sldMk cId="2940245860" sldId="260"/>
            <ac:spMk id="185" creationId="{278EDB22-6927-B40B-0198-9365ADCD6BDF}"/>
          </ac:spMkLst>
        </pc:spChg>
        <pc:spChg chg="mod">
          <ac:chgData name="강은정" userId="692accea-f2c5-4441-99ea-ca23b894be73" providerId="ADAL" clId="{33609FAB-56D7-485F-98C0-917E13D3FFF4}" dt="2023-01-26T06:17:13.154" v="152" actId="1076"/>
          <ac:spMkLst>
            <pc:docMk/>
            <pc:sldMk cId="2940245860" sldId="260"/>
            <ac:spMk id="186" creationId="{5BBC56AC-C4BE-2844-ADB0-52628C7AFCD0}"/>
          </ac:spMkLst>
        </pc:spChg>
        <pc:spChg chg="mod">
          <ac:chgData name="강은정" userId="692accea-f2c5-4441-99ea-ca23b894be73" providerId="ADAL" clId="{33609FAB-56D7-485F-98C0-917E13D3FFF4}" dt="2023-01-26T06:17:13.154" v="152" actId="1076"/>
          <ac:spMkLst>
            <pc:docMk/>
            <pc:sldMk cId="2940245860" sldId="260"/>
            <ac:spMk id="187" creationId="{CD7BA53F-4E6F-70B3-6D50-FEE54BC0B503}"/>
          </ac:spMkLst>
        </pc:spChg>
        <pc:spChg chg="mod">
          <ac:chgData name="강은정" userId="692accea-f2c5-4441-99ea-ca23b894be73" providerId="ADAL" clId="{33609FAB-56D7-485F-98C0-917E13D3FFF4}" dt="2023-01-26T06:17:13.154" v="152" actId="1076"/>
          <ac:spMkLst>
            <pc:docMk/>
            <pc:sldMk cId="2940245860" sldId="260"/>
            <ac:spMk id="188" creationId="{F4089F28-F109-AF8B-5441-D696C4EAC6A6}"/>
          </ac:spMkLst>
        </pc:spChg>
        <pc:spChg chg="mod">
          <ac:chgData name="강은정" userId="692accea-f2c5-4441-99ea-ca23b894be73" providerId="ADAL" clId="{33609FAB-56D7-485F-98C0-917E13D3FFF4}" dt="2023-01-26T06:17:13.154" v="152" actId="1076"/>
          <ac:spMkLst>
            <pc:docMk/>
            <pc:sldMk cId="2940245860" sldId="260"/>
            <ac:spMk id="189" creationId="{51DDBE6C-CDF9-0C64-C421-C09AEF8D9E17}"/>
          </ac:spMkLst>
        </pc:spChg>
        <pc:spChg chg="mod">
          <ac:chgData name="강은정" userId="692accea-f2c5-4441-99ea-ca23b894be73" providerId="ADAL" clId="{33609FAB-56D7-485F-98C0-917E13D3FFF4}" dt="2023-01-26T06:17:13.154" v="152" actId="1076"/>
          <ac:spMkLst>
            <pc:docMk/>
            <pc:sldMk cId="2940245860" sldId="260"/>
            <ac:spMk id="190" creationId="{8DF27317-24A3-9402-8F47-8334EA1FEB7E}"/>
          </ac:spMkLst>
        </pc:spChg>
        <pc:spChg chg="mod">
          <ac:chgData name="강은정" userId="692accea-f2c5-4441-99ea-ca23b894be73" providerId="ADAL" clId="{33609FAB-56D7-485F-98C0-917E13D3FFF4}" dt="2023-01-26T06:17:13.154" v="152" actId="1076"/>
          <ac:spMkLst>
            <pc:docMk/>
            <pc:sldMk cId="2940245860" sldId="260"/>
            <ac:spMk id="191" creationId="{0F4A8572-8F6D-A4A6-511A-2E6135A9E500}"/>
          </ac:spMkLst>
        </pc:spChg>
        <pc:spChg chg="del mod">
          <ac:chgData name="강은정" userId="692accea-f2c5-4441-99ea-ca23b894be73" providerId="ADAL" clId="{33609FAB-56D7-485F-98C0-917E13D3FFF4}" dt="2023-01-26T06:17:23.868" v="160" actId="478"/>
          <ac:spMkLst>
            <pc:docMk/>
            <pc:sldMk cId="2940245860" sldId="260"/>
            <ac:spMk id="202" creationId="{1C47C22B-DED4-4C1C-87EC-60BF59E8DA0F}"/>
          </ac:spMkLst>
        </pc:spChg>
        <pc:spChg chg="mod">
          <ac:chgData name="강은정" userId="692accea-f2c5-4441-99ea-ca23b894be73" providerId="ADAL" clId="{33609FAB-56D7-485F-98C0-917E13D3FFF4}" dt="2023-01-26T06:17:13.154" v="152" actId="1076"/>
          <ac:spMkLst>
            <pc:docMk/>
            <pc:sldMk cId="2940245860" sldId="260"/>
            <ac:spMk id="203" creationId="{2E65909C-50CA-4F70-BA38-E24B903E14ED}"/>
          </ac:spMkLst>
        </pc:spChg>
        <pc:spChg chg="mod">
          <ac:chgData name="강은정" userId="692accea-f2c5-4441-99ea-ca23b894be73" providerId="ADAL" clId="{33609FAB-56D7-485F-98C0-917E13D3FFF4}" dt="2023-01-26T06:17:13.154" v="152" actId="1076"/>
          <ac:spMkLst>
            <pc:docMk/>
            <pc:sldMk cId="2940245860" sldId="260"/>
            <ac:spMk id="204" creationId="{D60BDB12-F164-435D-ABBC-30AD267154A2}"/>
          </ac:spMkLst>
        </pc:spChg>
        <pc:spChg chg="mod">
          <ac:chgData name="강은정" userId="692accea-f2c5-4441-99ea-ca23b894be73" providerId="ADAL" clId="{33609FAB-56D7-485F-98C0-917E13D3FFF4}" dt="2023-01-26T06:17:13.154" v="152" actId="1076"/>
          <ac:spMkLst>
            <pc:docMk/>
            <pc:sldMk cId="2940245860" sldId="260"/>
            <ac:spMk id="205" creationId="{2BE1F4EF-D9AA-48AA-9BE3-185AF398EC45}"/>
          </ac:spMkLst>
        </pc:spChg>
        <pc:spChg chg="mod">
          <ac:chgData name="강은정" userId="692accea-f2c5-4441-99ea-ca23b894be73" providerId="ADAL" clId="{33609FAB-56D7-485F-98C0-917E13D3FFF4}" dt="2023-01-26T06:17:13.154" v="152" actId="1076"/>
          <ac:spMkLst>
            <pc:docMk/>
            <pc:sldMk cId="2940245860" sldId="260"/>
            <ac:spMk id="206" creationId="{76716A2F-C302-44BF-9153-E145E1319624}"/>
          </ac:spMkLst>
        </pc:spChg>
        <pc:spChg chg="mod">
          <ac:chgData name="강은정" userId="692accea-f2c5-4441-99ea-ca23b894be73" providerId="ADAL" clId="{33609FAB-56D7-485F-98C0-917E13D3FFF4}" dt="2023-01-26T06:17:13.154" v="152" actId="1076"/>
          <ac:spMkLst>
            <pc:docMk/>
            <pc:sldMk cId="2940245860" sldId="260"/>
            <ac:spMk id="207" creationId="{D3BA3817-8C39-4A7D-9AA7-57DAC3F00228}"/>
          </ac:spMkLst>
        </pc:spChg>
        <pc:spChg chg="mod">
          <ac:chgData name="강은정" userId="692accea-f2c5-4441-99ea-ca23b894be73" providerId="ADAL" clId="{33609FAB-56D7-485F-98C0-917E13D3FFF4}" dt="2023-01-26T06:17:13.154" v="152" actId="1076"/>
          <ac:spMkLst>
            <pc:docMk/>
            <pc:sldMk cId="2940245860" sldId="260"/>
            <ac:spMk id="210" creationId="{C8467664-08BD-484D-90C5-A22F48A825BC}"/>
          </ac:spMkLst>
        </pc:spChg>
        <pc:spChg chg="mod">
          <ac:chgData name="강은정" userId="692accea-f2c5-4441-99ea-ca23b894be73" providerId="ADAL" clId="{33609FAB-56D7-485F-98C0-917E13D3FFF4}" dt="2023-01-26T06:17:13.154" v="152" actId="1076"/>
          <ac:spMkLst>
            <pc:docMk/>
            <pc:sldMk cId="2940245860" sldId="260"/>
            <ac:spMk id="211" creationId="{E765F1B8-997B-4C6E-B1CA-512FD212EBC6}"/>
          </ac:spMkLst>
        </pc:s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36" creationId="{5F860C7D-B8EC-5D8E-DFC5-7FC798E01011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39" creationId="{EDBE80B1-A9CD-DA26-E747-F51F88EC6044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51" creationId="{9B365009-0E68-C4A2-CCFB-E2B0358A7F82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54" creationId="{F86B0BA6-056C-E080-2BB2-CA41027D0654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57" creationId="{9A426242-52B9-41DA-3DF0-879EF452BE9A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60" creationId="{A0BE1FF3-F91F-56DE-4547-ACAFDAA30182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63" creationId="{58F94C1C-20B8-A8BC-B848-8B1CB36138A0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66" creationId="{57CBB997-8741-4F3B-1EDE-81ABAAC88F33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69" creationId="{97D9E551-EC5D-12D8-A9D6-75889F728F58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72" creationId="{9BAE7D0D-F85C-C012-3CE8-31098570FCC4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81" creationId="{A7847EEA-7FD3-2C9F-FCD6-C48003F45409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84" creationId="{1482ACB7-F9D2-98F0-ABA8-B2E6C655ECAB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87" creationId="{E345B4E7-2A2E-09C6-F264-411E41E3F5A5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90" creationId="{53A32EB3-E97B-4E4E-69A4-786164AE166C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93" creationId="{C67C9C92-37E6-8019-C982-933A6042684F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96" creationId="{4D9DCD1B-3A38-A265-A76E-CC5C35963FF3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99" creationId="{A582080C-85FF-CCBC-90E0-9F34AFB42BDC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102" creationId="{4D09716A-16A8-DC55-B1E6-FAE529D013A0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107" creationId="{EBFE2D23-A5F6-2BA4-0DE2-1146C62EC9FD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110" creationId="{430D033C-9065-DB7B-7ACE-519865383FAA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113" creationId="{802533EB-AC50-3E92-E07F-D92EAE0A28E8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116" creationId="{A8465027-CAAB-5A68-D914-9F2393C8513E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119" creationId="{94468190-3E2F-78D0-FE83-115742A2CB5D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122" creationId="{C7E8A9AA-F4B3-331B-80F4-E6D7E3B8182F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125" creationId="{90A6852D-4891-26B9-0EA6-3F9C2D2663F3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128" creationId="{E5CFAB1C-7157-28D5-B92E-A0AEC607A75A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131" creationId="{74513683-CB0C-C396-FF40-3D029C44F592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134" creationId="{849BC32D-AFBF-7BC2-17B9-D530A044ED97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137" creationId="{35F3F945-482E-86E4-B0FF-1BA20971EF59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140" creationId="{064C159E-42CC-0242-48A0-E0C65CB9DA86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143" creationId="{D09B7267-4C2F-0E04-2F34-14F5E9734157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146" creationId="{A6B2DA57-D886-01EC-C326-3ED56281CC6C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149" creationId="{40EF17C9-3587-6116-B0B7-AB650905EE9B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152" creationId="{944EDB14-54FD-8606-F71E-09C7B5523B2E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155" creationId="{8A06205B-C168-E5C5-3A12-B6DD63984EED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158" creationId="{DEAD0467-BFCE-237E-72D7-DA08D308976A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161" creationId="{05E6B257-AE09-CE0A-9570-DC83E7086F26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164" creationId="{34135D44-63DF-483B-6D36-5D47F7514C0A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168" creationId="{E5795583-EAB5-BE38-D6A2-141CDBE23756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171" creationId="{81B9FD3C-8C82-DCAC-D5E3-EA65D68E4F1F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174" creationId="{7C6D5D9D-B556-5CC1-6C67-4A2399B871FA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177" creationId="{49EF3385-A9DD-F0D2-A0F0-CCA798C8A7D2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192" creationId="{E56C6044-DE6F-873E-2974-88C1313142EC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195" creationId="{456B29F0-0E17-A9A9-266C-863339D5FF73}"/>
          </ac:grpSpMkLst>
        </pc:grpChg>
        <pc:grpChg chg="mod">
          <ac:chgData name="강은정" userId="692accea-f2c5-4441-99ea-ca23b894be73" providerId="ADAL" clId="{33609FAB-56D7-485F-98C0-917E13D3FFF4}" dt="2023-01-26T06:17:13.154" v="152" actId="1076"/>
          <ac:grpSpMkLst>
            <pc:docMk/>
            <pc:sldMk cId="2940245860" sldId="260"/>
            <ac:grpSpMk id="198" creationId="{C6F3A602-BC4A-A778-1DD3-B2C9EDB7BDF5}"/>
          </ac:grpSpMkLst>
        </pc:grpChg>
        <pc:graphicFrameChg chg="mod">
          <ac:chgData name="강은정" userId="692accea-f2c5-4441-99ea-ca23b894be73" providerId="ADAL" clId="{33609FAB-56D7-485F-98C0-917E13D3FFF4}" dt="2023-01-26T06:17:13.154" v="152" actId="1076"/>
          <ac:graphicFrameMkLst>
            <pc:docMk/>
            <pc:sldMk cId="2940245860" sldId="260"/>
            <ac:graphicFrameMk id="4" creationId="{9FE0A990-3AD7-712B-55C6-1E42EA633CFC}"/>
          </ac:graphicFrameMkLst>
        </pc:graphicFrameChg>
        <pc:graphicFrameChg chg="mod">
          <ac:chgData name="강은정" userId="692accea-f2c5-4441-99ea-ca23b894be73" providerId="ADAL" clId="{33609FAB-56D7-485F-98C0-917E13D3FFF4}" dt="2023-01-26T06:17:13.154" v="152" actId="1076"/>
          <ac:graphicFrameMkLst>
            <pc:docMk/>
            <pc:sldMk cId="2940245860" sldId="260"/>
            <ac:graphicFrameMk id="5" creationId="{D6A6A671-04B1-3DF7-D4B5-6BE2A951B985}"/>
          </ac:graphicFrameMkLst>
        </pc:graphicFrameChg>
        <pc:graphicFrameChg chg="mod">
          <ac:chgData name="강은정" userId="692accea-f2c5-4441-99ea-ca23b894be73" providerId="ADAL" clId="{33609FAB-56D7-485F-98C0-917E13D3FFF4}" dt="2023-01-26T06:17:13.154" v="152" actId="1076"/>
          <ac:graphicFrameMkLst>
            <pc:docMk/>
            <pc:sldMk cId="2940245860" sldId="260"/>
            <ac:graphicFrameMk id="6" creationId="{66E661A8-6E78-DACA-40F9-B4F51ED8FFE7}"/>
          </ac:graphicFrameMkLst>
        </pc:graphicFrameChg>
        <pc:graphicFrameChg chg="mod">
          <ac:chgData name="강은정" userId="692accea-f2c5-4441-99ea-ca23b894be73" providerId="ADAL" clId="{33609FAB-56D7-485F-98C0-917E13D3FFF4}" dt="2023-01-26T06:17:13.154" v="152" actId="1076"/>
          <ac:graphicFrameMkLst>
            <pc:docMk/>
            <pc:sldMk cId="2940245860" sldId="260"/>
            <ac:graphicFrameMk id="7" creationId="{E4DC3DA8-5915-2755-FFD5-449E17F6DFC6}"/>
          </ac:graphicFrameMkLst>
        </pc:graphicFrameChg>
        <pc:graphicFrameChg chg="mod">
          <ac:chgData name="강은정" userId="692accea-f2c5-4441-99ea-ca23b894be73" providerId="ADAL" clId="{33609FAB-56D7-485F-98C0-917E13D3FFF4}" dt="2023-01-26T06:17:13.154" v="152" actId="1076"/>
          <ac:graphicFrameMkLst>
            <pc:docMk/>
            <pc:sldMk cId="2940245860" sldId="260"/>
            <ac:graphicFrameMk id="8" creationId="{E9E20DAB-DA99-4C55-4128-18F4D89E7965}"/>
          </ac:graphicFrameMkLst>
        </pc:graphicFrameChg>
        <pc:graphicFrameChg chg="mod">
          <ac:chgData name="강은정" userId="692accea-f2c5-4441-99ea-ca23b894be73" providerId="ADAL" clId="{33609FAB-56D7-485F-98C0-917E13D3FFF4}" dt="2023-01-26T06:17:13.154" v="152" actId="1076"/>
          <ac:graphicFrameMkLst>
            <pc:docMk/>
            <pc:sldMk cId="2940245860" sldId="260"/>
            <ac:graphicFrameMk id="9" creationId="{D7E3E29A-8D41-D44C-23EF-80BD84AAC07F}"/>
          </ac:graphicFrameMkLst>
        </pc:graphicFrameChg>
        <pc:graphicFrameChg chg="mod">
          <ac:chgData name="강은정" userId="692accea-f2c5-4441-99ea-ca23b894be73" providerId="ADAL" clId="{33609FAB-56D7-485F-98C0-917E13D3FFF4}" dt="2023-01-26T06:17:13.154" v="152" actId="1076"/>
          <ac:graphicFrameMkLst>
            <pc:docMk/>
            <pc:sldMk cId="2940245860" sldId="260"/>
            <ac:graphicFrameMk id="18" creationId="{36884718-33C9-0564-BC65-5004AFDB35F9}"/>
          </ac:graphicFrameMkLst>
        </pc:graphicFrameChg>
        <pc:graphicFrameChg chg="mod">
          <ac:chgData name="강은정" userId="692accea-f2c5-4441-99ea-ca23b894be73" providerId="ADAL" clId="{33609FAB-56D7-485F-98C0-917E13D3FFF4}" dt="2023-01-26T06:17:13.154" v="152" actId="1076"/>
          <ac:graphicFrameMkLst>
            <pc:docMk/>
            <pc:sldMk cId="2940245860" sldId="260"/>
            <ac:graphicFrameMk id="20" creationId="{B46E16E5-91A6-D0B5-CD50-D2E0D3EF90D9}"/>
          </ac:graphicFrameMkLst>
        </pc:graphicFrameChg>
        <pc:picChg chg="mod">
          <ac:chgData name="강은정" userId="692accea-f2c5-4441-99ea-ca23b894be73" providerId="ADAL" clId="{33609FAB-56D7-485F-98C0-917E13D3FFF4}" dt="2023-01-26T06:17:13.154" v="152" actId="1076"/>
          <ac:picMkLst>
            <pc:docMk/>
            <pc:sldMk cId="2940245860" sldId="260"/>
            <ac:picMk id="3" creationId="{BC40FC6C-76C1-C8CA-C544-FD467811B84B}"/>
          </ac:picMkLst>
        </pc:picChg>
        <pc:picChg chg="mod">
          <ac:chgData name="강은정" userId="692accea-f2c5-4441-99ea-ca23b894be73" providerId="ADAL" clId="{33609FAB-56D7-485F-98C0-917E13D3FFF4}" dt="2023-01-26T06:17:13.154" v="152" actId="1076"/>
          <ac:picMkLst>
            <pc:docMk/>
            <pc:sldMk cId="2940245860" sldId="260"/>
            <ac:picMk id="23" creationId="{9CAE05BD-6F23-8211-7DEA-675EB8DC0982}"/>
          </ac:picMkLst>
        </pc:picChg>
        <pc:picChg chg="mod">
          <ac:chgData name="강은정" userId="692accea-f2c5-4441-99ea-ca23b894be73" providerId="ADAL" clId="{33609FAB-56D7-485F-98C0-917E13D3FFF4}" dt="2023-01-26T06:17:13.154" v="152" actId="1076"/>
          <ac:picMkLst>
            <pc:docMk/>
            <pc:sldMk cId="2940245860" sldId="260"/>
            <ac:picMk id="24" creationId="{6559CE3B-FE75-4D23-3C31-C5597668D976}"/>
          </ac:picMkLst>
        </pc:picChg>
        <pc:picChg chg="mod">
          <ac:chgData name="강은정" userId="692accea-f2c5-4441-99ea-ca23b894be73" providerId="ADAL" clId="{33609FAB-56D7-485F-98C0-917E13D3FFF4}" dt="2023-01-26T06:17:13.154" v="152" actId="1076"/>
          <ac:picMkLst>
            <pc:docMk/>
            <pc:sldMk cId="2940245860" sldId="260"/>
            <ac:picMk id="25" creationId="{925BB3ED-EBDB-AF3C-95AA-B016978D6F70}"/>
          </ac:picMkLst>
        </pc:picChg>
        <pc:picChg chg="mod">
          <ac:chgData name="강은정" userId="692accea-f2c5-4441-99ea-ca23b894be73" providerId="ADAL" clId="{33609FAB-56D7-485F-98C0-917E13D3FFF4}" dt="2023-01-26T06:17:13.154" v="152" actId="1076"/>
          <ac:picMkLst>
            <pc:docMk/>
            <pc:sldMk cId="2940245860" sldId="260"/>
            <ac:picMk id="27" creationId="{0FA38827-6612-9546-CB76-1A8FDB6DCA88}"/>
          </ac:picMkLst>
        </pc:picChg>
        <pc:picChg chg="mod">
          <ac:chgData name="강은정" userId="692accea-f2c5-4441-99ea-ca23b894be73" providerId="ADAL" clId="{33609FAB-56D7-485F-98C0-917E13D3FFF4}" dt="2023-01-26T06:17:13.154" v="152" actId="1076"/>
          <ac:picMkLst>
            <pc:docMk/>
            <pc:sldMk cId="2940245860" sldId="260"/>
            <ac:picMk id="30" creationId="{FA5400F5-685D-E957-5D35-CC5AB2123EC6}"/>
          </ac:picMkLst>
        </pc:picChg>
        <pc:picChg chg="mod">
          <ac:chgData name="강은정" userId="692accea-f2c5-4441-99ea-ca23b894be73" providerId="ADAL" clId="{33609FAB-56D7-485F-98C0-917E13D3FFF4}" dt="2023-01-26T06:17:13.154" v="152" actId="1076"/>
          <ac:picMkLst>
            <pc:docMk/>
            <pc:sldMk cId="2940245860" sldId="260"/>
            <ac:picMk id="42" creationId="{638CC971-F939-E030-E6F3-143FD22DAF31}"/>
          </ac:picMkLst>
        </pc:picChg>
        <pc:picChg chg="mod">
          <ac:chgData name="강은정" userId="692accea-f2c5-4441-99ea-ca23b894be73" providerId="ADAL" clId="{33609FAB-56D7-485F-98C0-917E13D3FFF4}" dt="2023-01-26T06:17:13.154" v="152" actId="1076"/>
          <ac:picMkLst>
            <pc:docMk/>
            <pc:sldMk cId="2940245860" sldId="260"/>
            <ac:picMk id="43" creationId="{C22FB621-BA49-A6C2-AF41-4BDF87AD6A76}"/>
          </ac:picMkLst>
        </pc:picChg>
        <pc:picChg chg="mod">
          <ac:chgData name="강은정" userId="692accea-f2c5-4441-99ea-ca23b894be73" providerId="ADAL" clId="{33609FAB-56D7-485F-98C0-917E13D3FFF4}" dt="2023-01-26T06:17:13.154" v="152" actId="1076"/>
          <ac:picMkLst>
            <pc:docMk/>
            <pc:sldMk cId="2940245860" sldId="260"/>
            <ac:picMk id="44" creationId="{29C2B617-2F5B-0DB0-16DE-44D9B141D562}"/>
          </ac:picMkLst>
        </pc:picChg>
        <pc:picChg chg="mod">
          <ac:chgData name="강은정" userId="692accea-f2c5-4441-99ea-ca23b894be73" providerId="ADAL" clId="{33609FAB-56D7-485F-98C0-917E13D3FFF4}" dt="2023-01-26T06:17:13.154" v="152" actId="1076"/>
          <ac:picMkLst>
            <pc:docMk/>
            <pc:sldMk cId="2940245860" sldId="260"/>
            <ac:picMk id="45" creationId="{4E2FBCBB-22AB-B53B-5C55-869D6DEFDCD8}"/>
          </ac:picMkLst>
        </pc:picChg>
        <pc:picChg chg="mod">
          <ac:chgData name="강은정" userId="692accea-f2c5-4441-99ea-ca23b894be73" providerId="ADAL" clId="{33609FAB-56D7-485F-98C0-917E13D3FFF4}" dt="2023-01-26T06:17:13.154" v="152" actId="1076"/>
          <ac:picMkLst>
            <pc:docMk/>
            <pc:sldMk cId="2940245860" sldId="260"/>
            <ac:picMk id="46" creationId="{4E34CCA8-6A1B-0001-A013-C67F94AAF036}"/>
          </ac:picMkLst>
        </pc:picChg>
        <pc:picChg chg="mod">
          <ac:chgData name="강은정" userId="692accea-f2c5-4441-99ea-ca23b894be73" providerId="ADAL" clId="{33609FAB-56D7-485F-98C0-917E13D3FFF4}" dt="2023-01-26T06:17:13.154" v="152" actId="1076"/>
          <ac:picMkLst>
            <pc:docMk/>
            <pc:sldMk cId="2940245860" sldId="260"/>
            <ac:picMk id="47" creationId="{AF551DE1-2742-8908-24FE-853171943FA0}"/>
          </ac:picMkLst>
        </pc:picChg>
        <pc:picChg chg="mod">
          <ac:chgData name="강은정" userId="692accea-f2c5-4441-99ea-ca23b894be73" providerId="ADAL" clId="{33609FAB-56D7-485F-98C0-917E13D3FFF4}" dt="2023-01-26T06:17:13.154" v="152" actId="1076"/>
          <ac:picMkLst>
            <pc:docMk/>
            <pc:sldMk cId="2940245860" sldId="260"/>
            <ac:picMk id="201" creationId="{47049E27-4892-6795-4355-87874D44ABF6}"/>
          </ac:picMkLst>
        </pc:picChg>
      </pc:sldChg>
      <pc:sldChg chg="addSp delSp modSp mod">
        <pc:chgData name="강은정" userId="692accea-f2c5-4441-99ea-ca23b894be73" providerId="ADAL" clId="{33609FAB-56D7-485F-98C0-917E13D3FFF4}" dt="2023-01-26T06:27:28.088" v="245"/>
        <pc:sldMkLst>
          <pc:docMk/>
          <pc:sldMk cId="1756091537" sldId="261"/>
        </pc:sldMkLst>
        <pc:spChg chg="add mod">
          <ac:chgData name="강은정" userId="692accea-f2c5-4441-99ea-ca23b894be73" providerId="ADAL" clId="{33609FAB-56D7-485F-98C0-917E13D3FFF4}" dt="2023-01-26T06:27:28.088" v="245"/>
          <ac:spMkLst>
            <pc:docMk/>
            <pc:sldMk cId="1756091537" sldId="261"/>
            <ac:spMk id="2" creationId="{5285F35D-49DD-23F2-3CD5-D030983EC280}"/>
          </ac:spMkLst>
        </pc:spChg>
        <pc:spChg chg="mod">
          <ac:chgData name="강은정" userId="692accea-f2c5-4441-99ea-ca23b894be73" providerId="ADAL" clId="{33609FAB-56D7-485F-98C0-917E13D3FFF4}" dt="2023-01-26T06:23:03.289" v="228" actId="1076"/>
          <ac:spMkLst>
            <pc:docMk/>
            <pc:sldMk cId="1756091537" sldId="261"/>
            <ac:spMk id="10" creationId="{FA480F84-8B2D-4CA1-8E3D-D417E8FEF73A}"/>
          </ac:spMkLst>
        </pc:spChg>
        <pc:spChg chg="mod">
          <ac:chgData name="강은정" userId="692accea-f2c5-4441-99ea-ca23b894be73" providerId="ADAL" clId="{33609FAB-56D7-485F-98C0-917E13D3FFF4}" dt="2023-01-26T06:23:03.289" v="228" actId="1076"/>
          <ac:spMkLst>
            <pc:docMk/>
            <pc:sldMk cId="1756091537" sldId="261"/>
            <ac:spMk id="11" creationId="{1DD7335F-493F-4DB4-90EA-42E122948641}"/>
          </ac:spMkLst>
        </pc:spChg>
        <pc:spChg chg="mod">
          <ac:chgData name="강은정" userId="692accea-f2c5-4441-99ea-ca23b894be73" providerId="ADAL" clId="{33609FAB-56D7-485F-98C0-917E13D3FFF4}" dt="2023-01-26T06:23:03.289" v="228" actId="1076"/>
          <ac:spMkLst>
            <pc:docMk/>
            <pc:sldMk cId="1756091537" sldId="261"/>
            <ac:spMk id="13" creationId="{084553ED-AE32-4AB3-85FC-5CBF8AF74023}"/>
          </ac:spMkLst>
        </pc:spChg>
        <pc:spChg chg="mod">
          <ac:chgData name="강은정" userId="692accea-f2c5-4441-99ea-ca23b894be73" providerId="ADAL" clId="{33609FAB-56D7-485F-98C0-917E13D3FFF4}" dt="2023-01-26T06:23:03.289" v="228" actId="1076"/>
          <ac:spMkLst>
            <pc:docMk/>
            <pc:sldMk cId="1756091537" sldId="261"/>
            <ac:spMk id="15" creationId="{F1D56813-EC4A-4112-BAD4-6F8A313FE9FD}"/>
          </ac:spMkLst>
        </pc:spChg>
        <pc:spChg chg="mod">
          <ac:chgData name="강은정" userId="692accea-f2c5-4441-99ea-ca23b894be73" providerId="ADAL" clId="{33609FAB-56D7-485F-98C0-917E13D3FFF4}" dt="2023-01-26T06:23:03.289" v="228" actId="1076"/>
          <ac:spMkLst>
            <pc:docMk/>
            <pc:sldMk cId="1756091537" sldId="261"/>
            <ac:spMk id="17" creationId="{68F8D982-4A82-4486-94B9-5C8DE0CE54B1}"/>
          </ac:spMkLst>
        </pc:spChg>
        <pc:spChg chg="mod">
          <ac:chgData name="강은정" userId="692accea-f2c5-4441-99ea-ca23b894be73" providerId="ADAL" clId="{33609FAB-56D7-485F-98C0-917E13D3FFF4}" dt="2023-01-26T06:23:03.289" v="228" actId="1076"/>
          <ac:spMkLst>
            <pc:docMk/>
            <pc:sldMk cId="1756091537" sldId="261"/>
            <ac:spMk id="20" creationId="{8FCB2B98-0A0D-4E9B-80A6-33B4D2888DC5}"/>
          </ac:spMkLst>
        </pc:spChg>
        <pc:spChg chg="mod">
          <ac:chgData name="강은정" userId="692accea-f2c5-4441-99ea-ca23b894be73" providerId="ADAL" clId="{33609FAB-56D7-485F-98C0-917E13D3FFF4}" dt="2023-01-26T06:23:03.289" v="228" actId="1076"/>
          <ac:spMkLst>
            <pc:docMk/>
            <pc:sldMk cId="1756091537" sldId="261"/>
            <ac:spMk id="21" creationId="{6DC7D730-B102-4190-AD8E-4792AD117B7D}"/>
          </ac:spMkLst>
        </pc:spChg>
        <pc:spChg chg="mod">
          <ac:chgData name="강은정" userId="692accea-f2c5-4441-99ea-ca23b894be73" providerId="ADAL" clId="{33609FAB-56D7-485F-98C0-917E13D3FFF4}" dt="2023-01-26T06:23:03.289" v="228" actId="1076"/>
          <ac:spMkLst>
            <pc:docMk/>
            <pc:sldMk cId="1756091537" sldId="261"/>
            <ac:spMk id="23" creationId="{08FACFB2-7DB1-4C7C-9192-46041AC0EB5E}"/>
          </ac:spMkLst>
        </pc:spChg>
        <pc:spChg chg="mod">
          <ac:chgData name="강은정" userId="692accea-f2c5-4441-99ea-ca23b894be73" providerId="ADAL" clId="{33609FAB-56D7-485F-98C0-917E13D3FFF4}" dt="2023-01-26T06:23:03.289" v="228" actId="1076"/>
          <ac:spMkLst>
            <pc:docMk/>
            <pc:sldMk cId="1756091537" sldId="261"/>
            <ac:spMk id="25" creationId="{5899CE33-365F-4934-B3A7-A6D67B96263D}"/>
          </ac:spMkLst>
        </pc:spChg>
        <pc:spChg chg="mod">
          <ac:chgData name="강은정" userId="692accea-f2c5-4441-99ea-ca23b894be73" providerId="ADAL" clId="{33609FAB-56D7-485F-98C0-917E13D3FFF4}" dt="2023-01-26T06:23:03.289" v="228" actId="1076"/>
          <ac:spMkLst>
            <pc:docMk/>
            <pc:sldMk cId="1756091537" sldId="261"/>
            <ac:spMk id="27" creationId="{0037F22A-1A0C-4A08-8AFA-E45D27CC1E64}"/>
          </ac:spMkLst>
        </pc:spChg>
        <pc:spChg chg="mod">
          <ac:chgData name="강은정" userId="692accea-f2c5-4441-99ea-ca23b894be73" providerId="ADAL" clId="{33609FAB-56D7-485F-98C0-917E13D3FFF4}" dt="2023-01-26T06:23:03.289" v="228" actId="1076"/>
          <ac:spMkLst>
            <pc:docMk/>
            <pc:sldMk cId="1756091537" sldId="261"/>
            <ac:spMk id="28" creationId="{BAC29942-BB85-4740-9E8C-E8A7E6D56809}"/>
          </ac:spMkLst>
        </pc:spChg>
        <pc:spChg chg="mod">
          <ac:chgData name="강은정" userId="692accea-f2c5-4441-99ea-ca23b894be73" providerId="ADAL" clId="{33609FAB-56D7-485F-98C0-917E13D3FFF4}" dt="2023-01-26T06:23:03.289" v="228" actId="1076"/>
          <ac:spMkLst>
            <pc:docMk/>
            <pc:sldMk cId="1756091537" sldId="261"/>
            <ac:spMk id="29" creationId="{E37A695C-CC4D-49FF-8A44-DBB246AE8F9B}"/>
          </ac:spMkLst>
        </pc:spChg>
        <pc:spChg chg="mod">
          <ac:chgData name="강은정" userId="692accea-f2c5-4441-99ea-ca23b894be73" providerId="ADAL" clId="{33609FAB-56D7-485F-98C0-917E13D3FFF4}" dt="2023-01-26T06:23:03.289" v="228" actId="1076"/>
          <ac:spMkLst>
            <pc:docMk/>
            <pc:sldMk cId="1756091537" sldId="261"/>
            <ac:spMk id="30" creationId="{C8458B2E-1A00-4142-BD4D-F002552D3086}"/>
          </ac:spMkLst>
        </pc:spChg>
        <pc:spChg chg="mod">
          <ac:chgData name="강은정" userId="692accea-f2c5-4441-99ea-ca23b894be73" providerId="ADAL" clId="{33609FAB-56D7-485F-98C0-917E13D3FFF4}" dt="2023-01-26T06:23:03.289" v="228" actId="1076"/>
          <ac:spMkLst>
            <pc:docMk/>
            <pc:sldMk cId="1756091537" sldId="261"/>
            <ac:spMk id="31" creationId="{23369AE4-4883-4083-B74E-B35C1C1930FA}"/>
          </ac:spMkLst>
        </pc:spChg>
        <pc:spChg chg="mod">
          <ac:chgData name="강은정" userId="692accea-f2c5-4441-99ea-ca23b894be73" providerId="ADAL" clId="{33609FAB-56D7-485F-98C0-917E13D3FFF4}" dt="2023-01-26T06:23:03.289" v="228" actId="1076"/>
          <ac:spMkLst>
            <pc:docMk/>
            <pc:sldMk cId="1756091537" sldId="261"/>
            <ac:spMk id="32" creationId="{A38EE9CD-65DF-4B0F-B0FB-425D453C43CB}"/>
          </ac:spMkLst>
        </pc:spChg>
        <pc:spChg chg="mod">
          <ac:chgData name="강은정" userId="692accea-f2c5-4441-99ea-ca23b894be73" providerId="ADAL" clId="{33609FAB-56D7-485F-98C0-917E13D3FFF4}" dt="2023-01-26T06:23:03.289" v="228" actId="1076"/>
          <ac:spMkLst>
            <pc:docMk/>
            <pc:sldMk cId="1756091537" sldId="261"/>
            <ac:spMk id="33" creationId="{4B258029-0D4D-4AE7-A2D8-101FDB3CA444}"/>
          </ac:spMkLst>
        </pc:spChg>
        <pc:spChg chg="mod">
          <ac:chgData name="강은정" userId="692accea-f2c5-4441-99ea-ca23b894be73" providerId="ADAL" clId="{33609FAB-56D7-485F-98C0-917E13D3FFF4}" dt="2023-01-26T06:23:03.289" v="228" actId="1076"/>
          <ac:spMkLst>
            <pc:docMk/>
            <pc:sldMk cId="1756091537" sldId="261"/>
            <ac:spMk id="34" creationId="{362F797A-858E-4B5F-B62B-AB19138B0BF6}"/>
          </ac:spMkLst>
        </pc:spChg>
        <pc:spChg chg="mod">
          <ac:chgData name="강은정" userId="692accea-f2c5-4441-99ea-ca23b894be73" providerId="ADAL" clId="{33609FAB-56D7-485F-98C0-917E13D3FFF4}" dt="2023-01-26T06:23:03.289" v="228" actId="1076"/>
          <ac:spMkLst>
            <pc:docMk/>
            <pc:sldMk cId="1756091537" sldId="261"/>
            <ac:spMk id="35" creationId="{A103141D-D1AC-414B-9979-897E873A328A}"/>
          </ac:spMkLst>
        </pc:spChg>
        <pc:spChg chg="mod">
          <ac:chgData name="강은정" userId="692accea-f2c5-4441-99ea-ca23b894be73" providerId="ADAL" clId="{33609FAB-56D7-485F-98C0-917E13D3FFF4}" dt="2023-01-26T06:23:03.289" v="228" actId="1076"/>
          <ac:spMkLst>
            <pc:docMk/>
            <pc:sldMk cId="1756091537" sldId="261"/>
            <ac:spMk id="36" creationId="{B9746329-A4A1-4537-AF60-2CDC4DA4A5B0}"/>
          </ac:spMkLst>
        </pc:spChg>
        <pc:spChg chg="mod">
          <ac:chgData name="강은정" userId="692accea-f2c5-4441-99ea-ca23b894be73" providerId="ADAL" clId="{33609FAB-56D7-485F-98C0-917E13D3FFF4}" dt="2023-01-26T06:23:03.289" v="228" actId="1076"/>
          <ac:spMkLst>
            <pc:docMk/>
            <pc:sldMk cId="1756091537" sldId="261"/>
            <ac:spMk id="37" creationId="{D188F338-4514-481F-AFFC-90DBA217B097}"/>
          </ac:spMkLst>
        </pc:spChg>
        <pc:spChg chg="mod">
          <ac:chgData name="강은정" userId="692accea-f2c5-4441-99ea-ca23b894be73" providerId="ADAL" clId="{33609FAB-56D7-485F-98C0-917E13D3FFF4}" dt="2023-01-26T06:23:03.289" v="228" actId="1076"/>
          <ac:spMkLst>
            <pc:docMk/>
            <pc:sldMk cId="1756091537" sldId="261"/>
            <ac:spMk id="38" creationId="{7676DE45-0342-48D3-B9AE-4BCD9B2FF21B}"/>
          </ac:spMkLst>
        </pc:spChg>
        <pc:spChg chg="del">
          <ac:chgData name="강은정" userId="692accea-f2c5-4441-99ea-ca23b894be73" providerId="ADAL" clId="{33609FAB-56D7-485F-98C0-917E13D3FFF4}" dt="2023-01-26T06:19:13.288" v="194" actId="478"/>
          <ac:spMkLst>
            <pc:docMk/>
            <pc:sldMk cId="1756091537" sldId="261"/>
            <ac:spMk id="39" creationId="{DBDBEA89-7D8C-4E2C-8F88-C310FE35C297}"/>
          </ac:spMkLst>
        </pc:spChg>
        <pc:spChg chg="mod">
          <ac:chgData name="강은정" userId="692accea-f2c5-4441-99ea-ca23b894be73" providerId="ADAL" clId="{33609FAB-56D7-485F-98C0-917E13D3FFF4}" dt="2023-01-26T06:23:03.289" v="228" actId="1076"/>
          <ac:spMkLst>
            <pc:docMk/>
            <pc:sldMk cId="1756091537" sldId="261"/>
            <ac:spMk id="40" creationId="{52FAE5B3-FBD1-47F8-9E21-48508EFE6A9E}"/>
          </ac:spMkLst>
        </pc:spChg>
        <pc:spChg chg="mod">
          <ac:chgData name="강은정" userId="692accea-f2c5-4441-99ea-ca23b894be73" providerId="ADAL" clId="{33609FAB-56D7-485F-98C0-917E13D3FFF4}" dt="2023-01-26T06:23:03.289" v="228" actId="1076"/>
          <ac:spMkLst>
            <pc:docMk/>
            <pc:sldMk cId="1756091537" sldId="261"/>
            <ac:spMk id="43" creationId="{E97D63BA-2667-4C32-84D4-EB7AE7A66F21}"/>
          </ac:spMkLst>
        </pc:spChg>
        <pc:graphicFrameChg chg="mod">
          <ac:chgData name="강은정" userId="692accea-f2c5-4441-99ea-ca23b894be73" providerId="ADAL" clId="{33609FAB-56D7-485F-98C0-917E13D3FFF4}" dt="2023-01-26T06:23:03.289" v="228" actId="1076"/>
          <ac:graphicFrameMkLst>
            <pc:docMk/>
            <pc:sldMk cId="1756091537" sldId="261"/>
            <ac:graphicFrameMk id="4" creationId="{C7C7F4D6-4F09-4DBB-8B58-F6276E3B575D}"/>
          </ac:graphicFrameMkLst>
        </pc:graphicFrameChg>
        <pc:graphicFrameChg chg="mod">
          <ac:chgData name="강은정" userId="692accea-f2c5-4441-99ea-ca23b894be73" providerId="ADAL" clId="{33609FAB-56D7-485F-98C0-917E13D3FFF4}" dt="2023-01-26T06:23:03.289" v="228" actId="1076"/>
          <ac:graphicFrameMkLst>
            <pc:docMk/>
            <pc:sldMk cId="1756091537" sldId="261"/>
            <ac:graphicFrameMk id="5" creationId="{5A1FF5CE-C961-468F-88D5-6520DE539454}"/>
          </ac:graphicFrameMkLst>
        </pc:graphicFrameChg>
        <pc:graphicFrameChg chg="mod">
          <ac:chgData name="강은정" userId="692accea-f2c5-4441-99ea-ca23b894be73" providerId="ADAL" clId="{33609FAB-56D7-485F-98C0-917E13D3FFF4}" dt="2023-01-26T06:23:03.289" v="228" actId="1076"/>
          <ac:graphicFrameMkLst>
            <pc:docMk/>
            <pc:sldMk cId="1756091537" sldId="261"/>
            <ac:graphicFrameMk id="6" creationId="{3DDE38AB-5F01-47D6-AB31-C76E0D873C89}"/>
          </ac:graphicFrameMkLst>
        </pc:graphicFrameChg>
        <pc:graphicFrameChg chg="mod">
          <ac:chgData name="강은정" userId="692accea-f2c5-4441-99ea-ca23b894be73" providerId="ADAL" clId="{33609FAB-56D7-485F-98C0-917E13D3FFF4}" dt="2023-01-26T06:23:03.289" v="228" actId="1076"/>
          <ac:graphicFrameMkLst>
            <pc:docMk/>
            <pc:sldMk cId="1756091537" sldId="261"/>
            <ac:graphicFrameMk id="7" creationId="{EE404933-81B2-4481-AA64-91F73BA91AAB}"/>
          </ac:graphicFrameMkLst>
        </pc:graphicFrameChg>
        <pc:graphicFrameChg chg="mod">
          <ac:chgData name="강은정" userId="692accea-f2c5-4441-99ea-ca23b894be73" providerId="ADAL" clId="{33609FAB-56D7-485F-98C0-917E13D3FFF4}" dt="2023-01-26T06:23:03.289" v="228" actId="1076"/>
          <ac:graphicFrameMkLst>
            <pc:docMk/>
            <pc:sldMk cId="1756091537" sldId="261"/>
            <ac:graphicFrameMk id="8" creationId="{CA3033CC-A467-4C58-B3F1-EA2F15CE7944}"/>
          </ac:graphicFrameMkLst>
        </pc:graphicFrameChg>
        <pc:graphicFrameChg chg="mod">
          <ac:chgData name="강은정" userId="692accea-f2c5-4441-99ea-ca23b894be73" providerId="ADAL" clId="{33609FAB-56D7-485F-98C0-917E13D3FFF4}" dt="2023-01-26T06:23:03.289" v="228" actId="1076"/>
          <ac:graphicFrameMkLst>
            <pc:docMk/>
            <pc:sldMk cId="1756091537" sldId="261"/>
            <ac:graphicFrameMk id="9" creationId="{DB54A451-E0AC-475E-B795-098746A58C2D}"/>
          </ac:graphicFrameMkLst>
        </pc:graphicFrameChg>
        <pc:cxnChg chg="mod">
          <ac:chgData name="강은정" userId="692accea-f2c5-4441-99ea-ca23b894be73" providerId="ADAL" clId="{33609FAB-56D7-485F-98C0-917E13D3FFF4}" dt="2023-01-26T06:23:03.289" v="228" actId="1076"/>
          <ac:cxnSpMkLst>
            <pc:docMk/>
            <pc:sldMk cId="1756091537" sldId="261"/>
            <ac:cxnSpMk id="12" creationId="{C73B1445-E042-4528-95FA-B5E521405D8D}"/>
          </ac:cxnSpMkLst>
        </pc:cxnChg>
        <pc:cxnChg chg="mod">
          <ac:chgData name="강은정" userId="692accea-f2c5-4441-99ea-ca23b894be73" providerId="ADAL" clId="{33609FAB-56D7-485F-98C0-917E13D3FFF4}" dt="2023-01-26T06:23:03.289" v="228" actId="1076"/>
          <ac:cxnSpMkLst>
            <pc:docMk/>
            <pc:sldMk cId="1756091537" sldId="261"/>
            <ac:cxnSpMk id="14" creationId="{1D2E7208-BD6E-4D68-89D9-ABDEBCD4B15F}"/>
          </ac:cxnSpMkLst>
        </pc:cxnChg>
        <pc:cxnChg chg="mod">
          <ac:chgData name="강은정" userId="692accea-f2c5-4441-99ea-ca23b894be73" providerId="ADAL" clId="{33609FAB-56D7-485F-98C0-917E13D3FFF4}" dt="2023-01-26T06:23:03.289" v="228" actId="1076"/>
          <ac:cxnSpMkLst>
            <pc:docMk/>
            <pc:sldMk cId="1756091537" sldId="261"/>
            <ac:cxnSpMk id="16" creationId="{62FB6540-A0A8-415E-BCEA-A08845C84C22}"/>
          </ac:cxnSpMkLst>
        </pc:cxnChg>
        <pc:cxnChg chg="mod">
          <ac:chgData name="강은정" userId="692accea-f2c5-4441-99ea-ca23b894be73" providerId="ADAL" clId="{33609FAB-56D7-485F-98C0-917E13D3FFF4}" dt="2023-01-26T06:23:03.289" v="228" actId="1076"/>
          <ac:cxnSpMkLst>
            <pc:docMk/>
            <pc:sldMk cId="1756091537" sldId="261"/>
            <ac:cxnSpMk id="18" creationId="{3AA9CB92-25CC-4BAE-B658-F8C819CB579C}"/>
          </ac:cxnSpMkLst>
        </pc:cxnChg>
        <pc:cxnChg chg="mod">
          <ac:chgData name="강은정" userId="692accea-f2c5-4441-99ea-ca23b894be73" providerId="ADAL" clId="{33609FAB-56D7-485F-98C0-917E13D3FFF4}" dt="2023-01-26T06:23:03.289" v="228" actId="1076"/>
          <ac:cxnSpMkLst>
            <pc:docMk/>
            <pc:sldMk cId="1756091537" sldId="261"/>
            <ac:cxnSpMk id="19" creationId="{3B20DB4E-3BC0-4AFF-9292-4658996D502E}"/>
          </ac:cxnSpMkLst>
        </pc:cxnChg>
        <pc:cxnChg chg="mod">
          <ac:chgData name="강은정" userId="692accea-f2c5-4441-99ea-ca23b894be73" providerId="ADAL" clId="{33609FAB-56D7-485F-98C0-917E13D3FFF4}" dt="2023-01-26T06:23:03.289" v="228" actId="1076"/>
          <ac:cxnSpMkLst>
            <pc:docMk/>
            <pc:sldMk cId="1756091537" sldId="261"/>
            <ac:cxnSpMk id="22" creationId="{4854F3F1-5793-49CE-891D-3BE712018A05}"/>
          </ac:cxnSpMkLst>
        </pc:cxnChg>
        <pc:cxnChg chg="mod">
          <ac:chgData name="강은정" userId="692accea-f2c5-4441-99ea-ca23b894be73" providerId="ADAL" clId="{33609FAB-56D7-485F-98C0-917E13D3FFF4}" dt="2023-01-26T06:23:03.289" v="228" actId="1076"/>
          <ac:cxnSpMkLst>
            <pc:docMk/>
            <pc:sldMk cId="1756091537" sldId="261"/>
            <ac:cxnSpMk id="24" creationId="{B3EDED70-B634-4F7F-9EB3-E8AD10EFCAE9}"/>
          </ac:cxnSpMkLst>
        </pc:cxnChg>
      </pc:sldChg>
      <pc:sldChg chg="addSp delSp modSp mod">
        <pc:chgData name="강은정" userId="692accea-f2c5-4441-99ea-ca23b894be73" providerId="ADAL" clId="{33609FAB-56D7-485F-98C0-917E13D3FFF4}" dt="2023-01-26T06:27:23.282" v="244"/>
        <pc:sldMkLst>
          <pc:docMk/>
          <pc:sldMk cId="2033881406" sldId="262"/>
        </pc:sldMkLst>
        <pc:spChg chg="add mod">
          <ac:chgData name="강은정" userId="692accea-f2c5-4441-99ea-ca23b894be73" providerId="ADAL" clId="{33609FAB-56D7-485F-98C0-917E13D3FFF4}" dt="2023-01-26T06:27:23.282" v="244"/>
          <ac:spMkLst>
            <pc:docMk/>
            <pc:sldMk cId="2033881406" sldId="262"/>
            <ac:spMk id="2" creationId="{4CAC8DF1-8BBD-9E57-8D44-A4E9E23481FE}"/>
          </ac:spMkLst>
        </pc:spChg>
        <pc:spChg chg="del mod">
          <ac:chgData name="강은정" userId="692accea-f2c5-4441-99ea-ca23b894be73" providerId="ADAL" clId="{33609FAB-56D7-485F-98C0-917E13D3FFF4}" dt="2023-01-26T06:18:07.505" v="171" actId="478"/>
          <ac:spMkLst>
            <pc:docMk/>
            <pc:sldMk cId="2033881406" sldId="262"/>
            <ac:spMk id="4" creationId="{07C4B81D-E2F7-4D2A-8F17-75B7A29B337D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16" creationId="{6639D5B2-514D-4C11-BD27-1EE927DC6EBD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17" creationId="{29AABE49-F714-4F54-A879-687A36682180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18" creationId="{6831C146-FE05-4F31-AB24-347BD66638CB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19" creationId="{4BA4997A-599D-47E1-94DE-FCDDA54B66BB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20" creationId="{21079608-355F-46AD-A3D5-05D28F0654F1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21" creationId="{CF7BE992-47A7-4118-9351-B74D86970DF1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22" creationId="{B66665C9-7A95-4C21-BBF4-8FA7C4E53CB8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23" creationId="{FD190280-31D9-44E4-B8B2-C83E1807D372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24" creationId="{5B785225-0F50-4D46-9E70-10981A2DA21E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33" creationId="{A901FFD9-B4BB-4C5B-B302-55D3D0071094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41" creationId="{0CD5F5F5-1407-4503-BD2B-0DF68806D6E6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42" creationId="{DE21B975-0041-499F-88EA-C45F46BF15E1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43" creationId="{A08EA38E-54B4-4F38-8A20-AD5F9723D8AA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44" creationId="{3118A10F-57DA-4C08-ADDE-31ED37AD5392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45" creationId="{360EC9EF-5050-4621-812B-EFE4352E38DD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50" creationId="{EB79B205-6B0B-494F-9E7B-AFEAC0121F37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51" creationId="{D271BF81-401D-4ECA-B151-6C433C60D487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52" creationId="{658A540C-0B5A-47AD-9247-F84E3F62B029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53" creationId="{7DBE299E-BC76-42DA-B1F5-3B804687BB18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60" creationId="{4AA43AB2-06D7-4B71-BCB1-7EF9DC85A439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61" creationId="{2216BD34-84F9-429F-91B7-504AF6679256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62" creationId="{D3A90B22-53CB-45D8-94D0-893FF1C2D6C2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63" creationId="{C85654CA-5D5B-43B0-B7DA-CDB09B936F0F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64" creationId="{A8FE9B97-4436-4E7B-B930-054F0C53E804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65" creationId="{E4048734-E38F-4368-B2E9-52E61217A4D7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66" creationId="{C75D275A-6570-416E-8E16-057B2A5FC766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67" creationId="{88A3587E-A3ED-4284-8B0C-87FEAC788609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68" creationId="{8FB2EA6E-CEF2-40D1-8442-7CD164A1D81F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69" creationId="{AF965266-CD8A-4C52-9D4D-F317B9FF22F7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70" creationId="{31BA0D13-727A-49DE-8080-9D5EF3668501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71" creationId="{70BD9E26-7042-4D3E-9726-434E1BA59159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72" creationId="{9809DDC0-2B75-46FE-945A-101BC2E5D119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73" creationId="{38F2AD26-D681-4B2F-988E-94305B3D3F8B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74" creationId="{03540A90-D578-4767-A957-8AB776C7DAD9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75" creationId="{5E365A64-391E-4198-B6DE-22B4F528D46E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76" creationId="{035837C5-0987-4A58-B533-441027BD969C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77" creationId="{057D79AE-E52D-46D5-9C3F-3E84711FBEA6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78" creationId="{35A784AF-1A2D-447F-B0AB-EDD2685C1356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79" creationId="{A58491E6-E68C-441E-9B60-8B0DEF28331F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84" creationId="{ADD71F78-A01C-488A-B8D2-A71B7A160527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85" creationId="{ECA706CE-114E-4F48-A4E5-ECEF93C5C331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86" creationId="{F77CAFFC-8350-4843-A749-D852F94EE3DA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87" creationId="{369A08A4-79CD-48E3-AE7D-3BF24FA84782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88" creationId="{997A602E-7E41-497A-B7E6-EB97A5A161AC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89" creationId="{40F225B9-A54C-40FF-8CC9-40D2E3A1A14C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90" creationId="{438CAC2D-B154-4D5B-A2B3-247952748790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91" creationId="{17B069F5-C4FA-49E6-9D15-105F05A0EE1E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92" creationId="{FF4AF975-195D-43B3-B4C0-B9518125CCEA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93" creationId="{397ACEA6-7A2D-4A90-A70A-7CAD33969DD4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94" creationId="{E26A6F38-F154-44FB-80DE-D0D2EB29348A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95" creationId="{555FE7CC-838D-4613-9F2D-71D5A47F5145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96" creationId="{EB1413FD-816C-43B0-BAD7-E05A845186BA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97" creationId="{AD6405C6-904B-495A-BF1C-550821FC1D48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98" creationId="{63D6192C-FBE9-4F40-B6FC-868E829FEB02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99" creationId="{7326446D-4B7A-449B-8FC1-2A5D84FEBD72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100" creationId="{F2F8D053-E791-491C-B73C-6A039927DF69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101" creationId="{A20D1910-B271-4EF2-86A2-E6E8DD66B5F6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102" creationId="{9DE44535-F4BA-461C-80EC-AFD16BE07BEC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103" creationId="{B62170E9-11A7-4EB9-BFB7-84FC21D89DF9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104" creationId="{9FF84C2B-ECE0-4D60-B1CF-1D422D281C09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105" creationId="{52C5E03F-B2B4-446E-AC38-F0BC310F51E1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106" creationId="{C48763D1-0DE1-46F1-B297-B0E328379B8A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107" creationId="{C1A4AEF9-E9B9-43D8-B059-0A5E92D1F46D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108" creationId="{3595B43B-1E57-49CC-95D3-D7DC0698B695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109" creationId="{E0B79257-CEF2-4E70-BE25-8E8661F86209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110" creationId="{67D4EF80-9EEF-480B-A296-39D6A495FA0C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111" creationId="{1280D87C-5B7F-4B1E-8F87-4EFDD4D0BB9F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112" creationId="{691FD583-B266-4E61-A4BB-5E2122CB81FC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113" creationId="{4C9F40AA-27CE-40F7-9360-D463C6917401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114" creationId="{0D116A32-A601-4AC7-AB40-B14BFA3AA93B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115" creationId="{0048B4B9-839A-4DC7-B732-0DA425150197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116" creationId="{7F798E72-EC33-4248-9904-19AB64202220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117" creationId="{6DE95585-A5BA-490F-AE63-E2EDF91F5286}"/>
          </ac:spMkLst>
        </pc:spChg>
        <pc:spChg chg="mod">
          <ac:chgData name="강은정" userId="692accea-f2c5-4441-99ea-ca23b894be73" providerId="ADAL" clId="{33609FAB-56D7-485F-98C0-917E13D3FFF4}" dt="2023-01-26T06:18:41.020" v="189"/>
          <ac:spMkLst>
            <pc:docMk/>
            <pc:sldMk cId="2033881406" sldId="262"/>
            <ac:spMk id="166" creationId="{A9796406-B0F6-45C4-BACF-07CA647872AD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167" creationId="{E60789DE-7471-4AE9-8EB2-8D4446F40AC3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168" creationId="{B1B881F4-783F-461B-8D9D-2E8134C770AD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169" creationId="{28F8B662-0EDB-4A2A-871B-ADA9C289B56E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170" creationId="{6DE88D1C-07C9-4A02-8F3E-73C77419A58C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171" creationId="{0148184A-AEDD-4A64-BFA4-ADE0381A4940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172" creationId="{66C198CA-AF47-4108-8C0E-E2BDD577BFA6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173" creationId="{526D6F38-1F56-49E4-A720-889B70D63260}"/>
          </ac:spMkLst>
        </pc:spChg>
        <pc:spChg chg="mod">
          <ac:chgData name="강은정" userId="692accea-f2c5-4441-99ea-ca23b894be73" providerId="ADAL" clId="{33609FAB-56D7-485F-98C0-917E13D3FFF4}" dt="2023-01-26T06:17:59.605" v="168" actId="1076"/>
          <ac:spMkLst>
            <pc:docMk/>
            <pc:sldMk cId="2033881406" sldId="262"/>
            <ac:spMk id="174" creationId="{A569AAA3-CB7B-4304-84F1-806487D90257}"/>
          </ac:spMkLst>
        </pc:spChg>
        <pc:grpChg chg="mod">
          <ac:chgData name="강은정" userId="692accea-f2c5-4441-99ea-ca23b894be73" providerId="ADAL" clId="{33609FAB-56D7-485F-98C0-917E13D3FFF4}" dt="2023-01-26T06:17:59.605" v="168" actId="1076"/>
          <ac:grpSpMkLst>
            <pc:docMk/>
            <pc:sldMk cId="2033881406" sldId="262"/>
            <ac:grpSpMk id="118" creationId="{3B43B855-E210-4886-B1DF-D057DCE3C022}"/>
          </ac:grpSpMkLst>
        </pc:grpChg>
        <pc:grpChg chg="mod">
          <ac:chgData name="강은정" userId="692accea-f2c5-4441-99ea-ca23b894be73" providerId="ADAL" clId="{33609FAB-56D7-485F-98C0-917E13D3FFF4}" dt="2023-01-26T06:17:59.605" v="168" actId="1076"/>
          <ac:grpSpMkLst>
            <pc:docMk/>
            <pc:sldMk cId="2033881406" sldId="262"/>
            <ac:grpSpMk id="121" creationId="{988908CC-1EAD-43C9-A886-6CD6F6361D69}"/>
          </ac:grpSpMkLst>
        </pc:grpChg>
        <pc:grpChg chg="mod">
          <ac:chgData name="강은정" userId="692accea-f2c5-4441-99ea-ca23b894be73" providerId="ADAL" clId="{33609FAB-56D7-485F-98C0-917E13D3FFF4}" dt="2023-01-26T06:17:59.605" v="168" actId="1076"/>
          <ac:grpSpMkLst>
            <pc:docMk/>
            <pc:sldMk cId="2033881406" sldId="262"/>
            <ac:grpSpMk id="124" creationId="{BD35C3C2-1672-48F3-A051-21DA543FEC13}"/>
          </ac:grpSpMkLst>
        </pc:grpChg>
        <pc:grpChg chg="mod">
          <ac:chgData name="강은정" userId="692accea-f2c5-4441-99ea-ca23b894be73" providerId="ADAL" clId="{33609FAB-56D7-485F-98C0-917E13D3FFF4}" dt="2023-01-26T06:17:59.605" v="168" actId="1076"/>
          <ac:grpSpMkLst>
            <pc:docMk/>
            <pc:sldMk cId="2033881406" sldId="262"/>
            <ac:grpSpMk id="127" creationId="{470B834F-10DB-43F6-80E9-588DF8F26764}"/>
          </ac:grpSpMkLst>
        </pc:grpChg>
        <pc:grpChg chg="mod">
          <ac:chgData name="강은정" userId="692accea-f2c5-4441-99ea-ca23b894be73" providerId="ADAL" clId="{33609FAB-56D7-485F-98C0-917E13D3FFF4}" dt="2023-01-26T06:17:59.605" v="168" actId="1076"/>
          <ac:grpSpMkLst>
            <pc:docMk/>
            <pc:sldMk cId="2033881406" sldId="262"/>
            <ac:grpSpMk id="130" creationId="{03B00038-EE64-45F7-A3DB-BBB8050E6A8A}"/>
          </ac:grpSpMkLst>
        </pc:grpChg>
        <pc:grpChg chg="mod">
          <ac:chgData name="강은정" userId="692accea-f2c5-4441-99ea-ca23b894be73" providerId="ADAL" clId="{33609FAB-56D7-485F-98C0-917E13D3FFF4}" dt="2023-01-26T06:17:59.605" v="168" actId="1076"/>
          <ac:grpSpMkLst>
            <pc:docMk/>
            <pc:sldMk cId="2033881406" sldId="262"/>
            <ac:grpSpMk id="133" creationId="{8C2C86AD-FC11-4D7A-BD3D-AEB5D138D70E}"/>
          </ac:grpSpMkLst>
        </pc:grpChg>
        <pc:grpChg chg="mod">
          <ac:chgData name="강은정" userId="692accea-f2c5-4441-99ea-ca23b894be73" providerId="ADAL" clId="{33609FAB-56D7-485F-98C0-917E13D3FFF4}" dt="2023-01-26T06:17:59.605" v="168" actId="1076"/>
          <ac:grpSpMkLst>
            <pc:docMk/>
            <pc:sldMk cId="2033881406" sldId="262"/>
            <ac:grpSpMk id="136" creationId="{D7119146-B61A-40B8-BC76-8F6EA3297CCB}"/>
          </ac:grpSpMkLst>
        </pc:grpChg>
        <pc:grpChg chg="mod">
          <ac:chgData name="강은정" userId="692accea-f2c5-4441-99ea-ca23b894be73" providerId="ADAL" clId="{33609FAB-56D7-485F-98C0-917E13D3FFF4}" dt="2023-01-26T06:17:59.605" v="168" actId="1076"/>
          <ac:grpSpMkLst>
            <pc:docMk/>
            <pc:sldMk cId="2033881406" sldId="262"/>
            <ac:grpSpMk id="139" creationId="{2B6CF2BC-66A6-4526-9804-2B9F00B5A7D2}"/>
          </ac:grpSpMkLst>
        </pc:grpChg>
        <pc:grpChg chg="mod">
          <ac:chgData name="강은정" userId="692accea-f2c5-4441-99ea-ca23b894be73" providerId="ADAL" clId="{33609FAB-56D7-485F-98C0-917E13D3FFF4}" dt="2023-01-26T06:17:59.605" v="168" actId="1076"/>
          <ac:grpSpMkLst>
            <pc:docMk/>
            <pc:sldMk cId="2033881406" sldId="262"/>
            <ac:grpSpMk id="142" creationId="{8AF2A398-7603-4C70-9E6F-22EF70FFC437}"/>
          </ac:grpSpMkLst>
        </pc:grpChg>
        <pc:grpChg chg="mod">
          <ac:chgData name="강은정" userId="692accea-f2c5-4441-99ea-ca23b894be73" providerId="ADAL" clId="{33609FAB-56D7-485F-98C0-917E13D3FFF4}" dt="2023-01-26T06:17:59.605" v="168" actId="1076"/>
          <ac:grpSpMkLst>
            <pc:docMk/>
            <pc:sldMk cId="2033881406" sldId="262"/>
            <ac:grpSpMk id="145" creationId="{3B5F4C82-2DC2-4170-94FA-3ED8DF8ED841}"/>
          </ac:grpSpMkLst>
        </pc:grpChg>
        <pc:grpChg chg="mod">
          <ac:chgData name="강은정" userId="692accea-f2c5-4441-99ea-ca23b894be73" providerId="ADAL" clId="{33609FAB-56D7-485F-98C0-917E13D3FFF4}" dt="2023-01-26T06:17:59.605" v="168" actId="1076"/>
          <ac:grpSpMkLst>
            <pc:docMk/>
            <pc:sldMk cId="2033881406" sldId="262"/>
            <ac:grpSpMk id="148" creationId="{149AC545-5AC9-4099-A701-24228D4E7E3B}"/>
          </ac:grpSpMkLst>
        </pc:grpChg>
        <pc:grpChg chg="mod">
          <ac:chgData name="강은정" userId="692accea-f2c5-4441-99ea-ca23b894be73" providerId="ADAL" clId="{33609FAB-56D7-485F-98C0-917E13D3FFF4}" dt="2023-01-26T06:17:59.605" v="168" actId="1076"/>
          <ac:grpSpMkLst>
            <pc:docMk/>
            <pc:sldMk cId="2033881406" sldId="262"/>
            <ac:grpSpMk id="151" creationId="{5DC450EE-38ED-4EA2-AB67-B323BAD08EB1}"/>
          </ac:grpSpMkLst>
        </pc:grpChg>
        <pc:grpChg chg="mod">
          <ac:chgData name="강은정" userId="692accea-f2c5-4441-99ea-ca23b894be73" providerId="ADAL" clId="{33609FAB-56D7-485F-98C0-917E13D3FFF4}" dt="2023-01-26T06:17:59.605" v="168" actId="1076"/>
          <ac:grpSpMkLst>
            <pc:docMk/>
            <pc:sldMk cId="2033881406" sldId="262"/>
            <ac:grpSpMk id="154" creationId="{830AEFE7-4439-4AE9-BC79-DE4571307FA9}"/>
          </ac:grpSpMkLst>
        </pc:grpChg>
        <pc:grpChg chg="mod">
          <ac:chgData name="강은정" userId="692accea-f2c5-4441-99ea-ca23b894be73" providerId="ADAL" clId="{33609FAB-56D7-485F-98C0-917E13D3FFF4}" dt="2023-01-26T06:17:59.605" v="168" actId="1076"/>
          <ac:grpSpMkLst>
            <pc:docMk/>
            <pc:sldMk cId="2033881406" sldId="262"/>
            <ac:grpSpMk id="157" creationId="{6FCC1AFD-CE9A-4D4D-8236-C4DE1B8271A3}"/>
          </ac:grpSpMkLst>
        </pc:grpChg>
        <pc:grpChg chg="mod">
          <ac:chgData name="강은정" userId="692accea-f2c5-4441-99ea-ca23b894be73" providerId="ADAL" clId="{33609FAB-56D7-485F-98C0-917E13D3FFF4}" dt="2023-01-26T06:17:59.605" v="168" actId="1076"/>
          <ac:grpSpMkLst>
            <pc:docMk/>
            <pc:sldMk cId="2033881406" sldId="262"/>
            <ac:grpSpMk id="160" creationId="{2D9D52A9-421A-4A62-9812-7A143204B0EF}"/>
          </ac:grpSpMkLst>
        </pc:grpChg>
        <pc:grpChg chg="mod">
          <ac:chgData name="강은정" userId="692accea-f2c5-4441-99ea-ca23b894be73" providerId="ADAL" clId="{33609FAB-56D7-485F-98C0-917E13D3FFF4}" dt="2023-01-26T06:17:59.605" v="168" actId="1076"/>
          <ac:grpSpMkLst>
            <pc:docMk/>
            <pc:sldMk cId="2033881406" sldId="262"/>
            <ac:grpSpMk id="163" creationId="{D335BF3B-B02F-41AF-B048-25FB9AB8501C}"/>
          </ac:grpSpMkLst>
        </pc:grpChg>
        <pc:graphicFrameChg chg="mod">
          <ac:chgData name="강은정" userId="692accea-f2c5-4441-99ea-ca23b894be73" providerId="ADAL" clId="{33609FAB-56D7-485F-98C0-917E13D3FFF4}" dt="2023-01-26T06:17:59.605" v="168" actId="1076"/>
          <ac:graphicFrameMkLst>
            <pc:docMk/>
            <pc:sldMk cId="2033881406" sldId="262"/>
            <ac:graphicFrameMk id="5" creationId="{840184D4-46E4-4D3D-BF0B-7D18A42DC882}"/>
          </ac:graphicFrameMkLst>
        </pc:graphicFrameChg>
        <pc:graphicFrameChg chg="mod">
          <ac:chgData name="강은정" userId="692accea-f2c5-4441-99ea-ca23b894be73" providerId="ADAL" clId="{33609FAB-56D7-485F-98C0-917E13D3FFF4}" dt="2023-01-26T06:17:59.605" v="168" actId="1076"/>
          <ac:graphicFrameMkLst>
            <pc:docMk/>
            <pc:sldMk cId="2033881406" sldId="262"/>
            <ac:graphicFrameMk id="6" creationId="{0ABF5247-D50E-4AE3-A9C7-CEA68C33CFC5}"/>
          </ac:graphicFrameMkLst>
        </pc:graphicFrameChg>
        <pc:graphicFrameChg chg="mod">
          <ac:chgData name="강은정" userId="692accea-f2c5-4441-99ea-ca23b894be73" providerId="ADAL" clId="{33609FAB-56D7-485F-98C0-917E13D3FFF4}" dt="2023-01-26T06:17:59.605" v="168" actId="1076"/>
          <ac:graphicFrameMkLst>
            <pc:docMk/>
            <pc:sldMk cId="2033881406" sldId="262"/>
            <ac:graphicFrameMk id="34" creationId="{6383F1C3-B674-4FD0-88E9-4B6704802613}"/>
          </ac:graphicFrameMkLst>
        </pc:graphicFrameChg>
        <pc:graphicFrameChg chg="mod">
          <ac:chgData name="강은정" userId="692accea-f2c5-4441-99ea-ca23b894be73" providerId="ADAL" clId="{33609FAB-56D7-485F-98C0-917E13D3FFF4}" dt="2023-01-26T06:17:59.605" v="168" actId="1076"/>
          <ac:graphicFrameMkLst>
            <pc:docMk/>
            <pc:sldMk cId="2033881406" sldId="262"/>
            <ac:graphicFrameMk id="35" creationId="{EB4F41A9-F9E2-4F6D-8884-67B072513BA2}"/>
          </ac:graphicFrameMkLst>
        </pc:graphicFrameChg>
        <pc:graphicFrameChg chg="mod">
          <ac:chgData name="강은정" userId="692accea-f2c5-4441-99ea-ca23b894be73" providerId="ADAL" clId="{33609FAB-56D7-485F-98C0-917E13D3FFF4}" dt="2023-01-26T06:17:59.605" v="168" actId="1076"/>
          <ac:graphicFrameMkLst>
            <pc:docMk/>
            <pc:sldMk cId="2033881406" sldId="262"/>
            <ac:graphicFrameMk id="46" creationId="{5D34EFC3-9269-483D-A72E-BF20B12BBDB8}"/>
          </ac:graphicFrameMkLst>
        </pc:graphicFrameChg>
        <pc:graphicFrameChg chg="mod">
          <ac:chgData name="강은정" userId="692accea-f2c5-4441-99ea-ca23b894be73" providerId="ADAL" clId="{33609FAB-56D7-485F-98C0-917E13D3FFF4}" dt="2023-01-26T06:17:59.605" v="168" actId="1076"/>
          <ac:graphicFrameMkLst>
            <pc:docMk/>
            <pc:sldMk cId="2033881406" sldId="262"/>
            <ac:graphicFrameMk id="47" creationId="{04DCC1D6-5762-418F-8C69-51872A1BA1F1}"/>
          </ac:graphicFrameMkLst>
        </pc:graphicFrameChg>
        <pc:graphicFrameChg chg="mod">
          <ac:chgData name="강은정" userId="692accea-f2c5-4441-99ea-ca23b894be73" providerId="ADAL" clId="{33609FAB-56D7-485F-98C0-917E13D3FFF4}" dt="2023-01-26T06:17:59.605" v="168" actId="1076"/>
          <ac:graphicFrameMkLst>
            <pc:docMk/>
            <pc:sldMk cId="2033881406" sldId="262"/>
            <ac:graphicFrameMk id="48" creationId="{C6D58CBB-F56B-4708-A157-8BE9E18BDED9}"/>
          </ac:graphicFrameMkLst>
        </pc:graphicFrameChg>
        <pc:graphicFrameChg chg="mod">
          <ac:chgData name="강은정" userId="692accea-f2c5-4441-99ea-ca23b894be73" providerId="ADAL" clId="{33609FAB-56D7-485F-98C0-917E13D3FFF4}" dt="2023-01-26T06:17:59.605" v="168" actId="1076"/>
          <ac:graphicFrameMkLst>
            <pc:docMk/>
            <pc:sldMk cId="2033881406" sldId="262"/>
            <ac:graphicFrameMk id="49" creationId="{3251BFA8-8D1A-4BA2-A806-2AD988A4D673}"/>
          </ac:graphicFrameMkLst>
        </pc:graphicFrameChg>
        <pc:graphicFrameChg chg="mod">
          <ac:chgData name="강은정" userId="692accea-f2c5-4441-99ea-ca23b894be73" providerId="ADAL" clId="{33609FAB-56D7-485F-98C0-917E13D3FFF4}" dt="2023-01-26T06:17:59.605" v="168" actId="1076"/>
          <ac:graphicFrameMkLst>
            <pc:docMk/>
            <pc:sldMk cId="2033881406" sldId="262"/>
            <ac:graphicFrameMk id="54" creationId="{68BFD53F-C51A-49FA-A1B9-ACFB47242645}"/>
          </ac:graphicFrameMkLst>
        </pc:graphicFrameChg>
        <pc:graphicFrameChg chg="mod">
          <ac:chgData name="강은정" userId="692accea-f2c5-4441-99ea-ca23b894be73" providerId="ADAL" clId="{33609FAB-56D7-485F-98C0-917E13D3FFF4}" dt="2023-01-26T06:17:59.605" v="168" actId="1076"/>
          <ac:graphicFrameMkLst>
            <pc:docMk/>
            <pc:sldMk cId="2033881406" sldId="262"/>
            <ac:graphicFrameMk id="55" creationId="{18270A36-DE22-4228-8776-0B47F28B56FE}"/>
          </ac:graphicFrameMkLst>
        </pc:graphicFrameChg>
        <pc:graphicFrameChg chg="mod">
          <ac:chgData name="강은정" userId="692accea-f2c5-4441-99ea-ca23b894be73" providerId="ADAL" clId="{33609FAB-56D7-485F-98C0-917E13D3FFF4}" dt="2023-01-26T06:17:59.605" v="168" actId="1076"/>
          <ac:graphicFrameMkLst>
            <pc:docMk/>
            <pc:sldMk cId="2033881406" sldId="262"/>
            <ac:graphicFrameMk id="56" creationId="{0897EC74-A745-4CFA-B6BC-B38BF7BFBF0F}"/>
          </ac:graphicFrameMkLst>
        </pc:graphicFrameChg>
        <pc:graphicFrameChg chg="mod">
          <ac:chgData name="강은정" userId="692accea-f2c5-4441-99ea-ca23b894be73" providerId="ADAL" clId="{33609FAB-56D7-485F-98C0-917E13D3FFF4}" dt="2023-01-26T06:17:59.605" v="168" actId="1076"/>
          <ac:graphicFrameMkLst>
            <pc:docMk/>
            <pc:sldMk cId="2033881406" sldId="262"/>
            <ac:graphicFrameMk id="59" creationId="{D94A1948-5F56-4E11-BDF7-C2268F9FEBF8}"/>
          </ac:graphicFrameMkLst>
        </pc:graphicFrameChg>
        <pc:graphicFrameChg chg="mod">
          <ac:chgData name="강은정" userId="692accea-f2c5-4441-99ea-ca23b894be73" providerId="ADAL" clId="{33609FAB-56D7-485F-98C0-917E13D3FFF4}" dt="2023-01-26T06:17:59.605" v="168" actId="1076"/>
          <ac:graphicFrameMkLst>
            <pc:docMk/>
            <pc:sldMk cId="2033881406" sldId="262"/>
            <ac:graphicFrameMk id="80" creationId="{32CF3A12-61EA-409C-AC0E-967A791563C0}"/>
          </ac:graphicFrameMkLst>
        </pc:graphicFrameChg>
        <pc:graphicFrameChg chg="mod">
          <ac:chgData name="강은정" userId="692accea-f2c5-4441-99ea-ca23b894be73" providerId="ADAL" clId="{33609FAB-56D7-485F-98C0-917E13D3FFF4}" dt="2023-01-26T06:17:59.605" v="168" actId="1076"/>
          <ac:graphicFrameMkLst>
            <pc:docMk/>
            <pc:sldMk cId="2033881406" sldId="262"/>
            <ac:graphicFrameMk id="81" creationId="{4D8052F3-2BB4-4BAF-87EC-60668AB01163}"/>
          </ac:graphicFrameMkLst>
        </pc:graphicFrameChg>
        <pc:graphicFrameChg chg="mod">
          <ac:chgData name="강은정" userId="692accea-f2c5-4441-99ea-ca23b894be73" providerId="ADAL" clId="{33609FAB-56D7-485F-98C0-917E13D3FFF4}" dt="2023-01-26T06:17:59.605" v="168" actId="1076"/>
          <ac:graphicFrameMkLst>
            <pc:docMk/>
            <pc:sldMk cId="2033881406" sldId="262"/>
            <ac:graphicFrameMk id="82" creationId="{54B9CC88-9128-42B8-87A2-393B777D56FD}"/>
          </ac:graphicFrameMkLst>
        </pc:graphicFrameChg>
        <pc:graphicFrameChg chg="mod">
          <ac:chgData name="강은정" userId="692accea-f2c5-4441-99ea-ca23b894be73" providerId="ADAL" clId="{33609FAB-56D7-485F-98C0-917E13D3FFF4}" dt="2023-01-26T06:17:59.605" v="168" actId="1076"/>
          <ac:graphicFrameMkLst>
            <pc:docMk/>
            <pc:sldMk cId="2033881406" sldId="262"/>
            <ac:graphicFrameMk id="83" creationId="{4DEC6597-7FE1-4F15-8600-8401B5B999B4}"/>
          </ac:graphicFrameMkLst>
        </pc:graphicFrameChg>
      </pc:sldChg>
      <pc:sldChg chg="modSp mod">
        <pc:chgData name="강은정" userId="692accea-f2c5-4441-99ea-ca23b894be73" providerId="ADAL" clId="{33609FAB-56D7-485F-98C0-917E13D3FFF4}" dt="2023-01-26T06:21:24.728" v="221" actId="1076"/>
        <pc:sldMkLst>
          <pc:docMk/>
          <pc:sldMk cId="3930901044" sldId="263"/>
        </pc:sldMkLst>
        <pc:spChg chg="mod">
          <ac:chgData name="강은정" userId="692accea-f2c5-4441-99ea-ca23b894be73" providerId="ADAL" clId="{33609FAB-56D7-485F-98C0-917E13D3FFF4}" dt="2023-01-26T06:21:24.728" v="221" actId="1076"/>
          <ac:spMkLst>
            <pc:docMk/>
            <pc:sldMk cId="3930901044" sldId="263"/>
            <ac:spMk id="2" creationId="{24C2A687-8A97-5639-78D0-5B649D6ECC07}"/>
          </ac:spMkLst>
        </pc:sp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wmf"/><Relationship Id="rId13" Type="http://schemas.openxmlformats.org/officeDocument/2006/relationships/image" Target="../media/image13.wmf"/><Relationship Id="rId3" Type="http://schemas.openxmlformats.org/officeDocument/2006/relationships/image" Target="../media/image3.wmf"/><Relationship Id="rId7" Type="http://schemas.openxmlformats.org/officeDocument/2006/relationships/image" Target="../media/image7.wmf"/><Relationship Id="rId12" Type="http://schemas.openxmlformats.org/officeDocument/2006/relationships/image" Target="../media/image12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11" Type="http://schemas.openxmlformats.org/officeDocument/2006/relationships/image" Target="../media/image11.wmf"/><Relationship Id="rId5" Type="http://schemas.openxmlformats.org/officeDocument/2006/relationships/image" Target="../media/image5.wmf"/><Relationship Id="rId10" Type="http://schemas.openxmlformats.org/officeDocument/2006/relationships/image" Target="../media/image10.wmf"/><Relationship Id="rId4" Type="http://schemas.openxmlformats.org/officeDocument/2006/relationships/image" Target="../media/image4.wmf"/><Relationship Id="rId9" Type="http://schemas.openxmlformats.org/officeDocument/2006/relationships/image" Target="../media/image9.wmf"/><Relationship Id="rId14" Type="http://schemas.openxmlformats.org/officeDocument/2006/relationships/image" Target="../media/image14.w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7.wmf"/><Relationship Id="rId2" Type="http://schemas.openxmlformats.org/officeDocument/2006/relationships/image" Target="../media/image19.wmf"/><Relationship Id="rId1" Type="http://schemas.openxmlformats.org/officeDocument/2006/relationships/image" Target="../media/image5.wmf"/><Relationship Id="rId6" Type="http://schemas.openxmlformats.org/officeDocument/2006/relationships/image" Target="../media/image22.wmf"/><Relationship Id="rId5" Type="http://schemas.openxmlformats.org/officeDocument/2006/relationships/image" Target="../media/image21.wmf"/><Relationship Id="rId4" Type="http://schemas.openxmlformats.org/officeDocument/2006/relationships/image" Target="../media/image20.wmf"/></Relationships>
</file>

<file path=ppt/drawings/_rels/vmlDrawing3.vml.rels><?xml version="1.0" encoding="UTF-8" standalone="yes"?>
<Relationships xmlns="http://schemas.openxmlformats.org/package/2006/relationships"><Relationship Id="rId8" Type="http://schemas.openxmlformats.org/officeDocument/2006/relationships/image" Target="../media/image33.wmf"/><Relationship Id="rId3" Type="http://schemas.openxmlformats.org/officeDocument/2006/relationships/image" Target="../media/image28.wmf"/><Relationship Id="rId7" Type="http://schemas.openxmlformats.org/officeDocument/2006/relationships/image" Target="../media/image32.wmf"/><Relationship Id="rId2" Type="http://schemas.openxmlformats.org/officeDocument/2006/relationships/image" Target="../media/image27.wmf"/><Relationship Id="rId1" Type="http://schemas.openxmlformats.org/officeDocument/2006/relationships/image" Target="../media/image26.wmf"/><Relationship Id="rId6" Type="http://schemas.openxmlformats.org/officeDocument/2006/relationships/image" Target="../media/image31.wmf"/><Relationship Id="rId5" Type="http://schemas.openxmlformats.org/officeDocument/2006/relationships/image" Target="../media/image30.wmf"/><Relationship Id="rId10" Type="http://schemas.openxmlformats.org/officeDocument/2006/relationships/image" Target="../media/image35.wmf"/><Relationship Id="rId4" Type="http://schemas.openxmlformats.org/officeDocument/2006/relationships/image" Target="../media/image29.wmf"/><Relationship Id="rId9" Type="http://schemas.openxmlformats.org/officeDocument/2006/relationships/image" Target="../media/image34.wmf"/></Relationships>
</file>

<file path=ppt/drawings/_rels/vmlDrawing4.vml.rels><?xml version="1.0" encoding="UTF-8" standalone="yes"?>
<Relationships xmlns="http://schemas.openxmlformats.org/package/2006/relationships"><Relationship Id="rId8" Type="http://schemas.openxmlformats.org/officeDocument/2006/relationships/image" Target="../media/image45.wmf"/><Relationship Id="rId3" Type="http://schemas.openxmlformats.org/officeDocument/2006/relationships/image" Target="../media/image40.wmf"/><Relationship Id="rId7" Type="http://schemas.openxmlformats.org/officeDocument/2006/relationships/image" Target="../media/image44.wmf"/><Relationship Id="rId2" Type="http://schemas.openxmlformats.org/officeDocument/2006/relationships/image" Target="../media/image39.wmf"/><Relationship Id="rId1" Type="http://schemas.openxmlformats.org/officeDocument/2006/relationships/image" Target="../media/image38.wmf"/><Relationship Id="rId6" Type="http://schemas.openxmlformats.org/officeDocument/2006/relationships/image" Target="../media/image43.wmf"/><Relationship Id="rId5" Type="http://schemas.openxmlformats.org/officeDocument/2006/relationships/image" Target="../media/image42.wmf"/><Relationship Id="rId4" Type="http://schemas.openxmlformats.org/officeDocument/2006/relationships/image" Target="../media/image41.w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38.wmf"/><Relationship Id="rId2" Type="http://schemas.openxmlformats.org/officeDocument/2006/relationships/image" Target="../media/image60.wmf"/><Relationship Id="rId1" Type="http://schemas.openxmlformats.org/officeDocument/2006/relationships/image" Target="../media/image59.wmf"/><Relationship Id="rId6" Type="http://schemas.openxmlformats.org/officeDocument/2006/relationships/image" Target="../media/image62.wmf"/><Relationship Id="rId5" Type="http://schemas.openxmlformats.org/officeDocument/2006/relationships/image" Target="../media/image61.wmf"/><Relationship Id="rId4" Type="http://schemas.openxmlformats.org/officeDocument/2006/relationships/image" Target="../media/image5.wmf"/></Relationships>
</file>

<file path=ppt/drawings/_rels/vmlDrawing6.vml.rels><?xml version="1.0" encoding="UTF-8" standalone="yes"?>
<Relationships xmlns="http://schemas.openxmlformats.org/package/2006/relationships"><Relationship Id="rId8" Type="http://schemas.openxmlformats.org/officeDocument/2006/relationships/image" Target="../media/image73.wmf"/><Relationship Id="rId13" Type="http://schemas.openxmlformats.org/officeDocument/2006/relationships/image" Target="../media/image78.wmf"/><Relationship Id="rId3" Type="http://schemas.openxmlformats.org/officeDocument/2006/relationships/image" Target="../media/image68.wmf"/><Relationship Id="rId7" Type="http://schemas.openxmlformats.org/officeDocument/2006/relationships/image" Target="../media/image72.wmf"/><Relationship Id="rId12" Type="http://schemas.openxmlformats.org/officeDocument/2006/relationships/image" Target="../media/image77.wmf"/><Relationship Id="rId2" Type="http://schemas.openxmlformats.org/officeDocument/2006/relationships/image" Target="../media/image67.wmf"/><Relationship Id="rId16" Type="http://schemas.openxmlformats.org/officeDocument/2006/relationships/image" Target="../media/image81.wmf"/><Relationship Id="rId1" Type="http://schemas.openxmlformats.org/officeDocument/2006/relationships/image" Target="../media/image66.wmf"/><Relationship Id="rId6" Type="http://schemas.openxmlformats.org/officeDocument/2006/relationships/image" Target="../media/image71.wmf"/><Relationship Id="rId11" Type="http://schemas.openxmlformats.org/officeDocument/2006/relationships/image" Target="../media/image76.wmf"/><Relationship Id="rId5" Type="http://schemas.openxmlformats.org/officeDocument/2006/relationships/image" Target="../media/image70.wmf"/><Relationship Id="rId15" Type="http://schemas.openxmlformats.org/officeDocument/2006/relationships/image" Target="../media/image80.wmf"/><Relationship Id="rId10" Type="http://schemas.openxmlformats.org/officeDocument/2006/relationships/image" Target="../media/image75.wmf"/><Relationship Id="rId4" Type="http://schemas.openxmlformats.org/officeDocument/2006/relationships/image" Target="../media/image69.wmf"/><Relationship Id="rId9" Type="http://schemas.openxmlformats.org/officeDocument/2006/relationships/image" Target="../media/image74.wmf"/><Relationship Id="rId14" Type="http://schemas.openxmlformats.org/officeDocument/2006/relationships/image" Target="../media/image79.wmf"/></Relationships>
</file>

<file path=ppt/drawings/_rels/vmlDrawing7.vml.rels><?xml version="1.0" encoding="UTF-8" standalone="yes"?>
<Relationships xmlns="http://schemas.openxmlformats.org/package/2006/relationships"><Relationship Id="rId3" Type="http://schemas.openxmlformats.org/officeDocument/2006/relationships/image" Target="../media/image84.wmf"/><Relationship Id="rId2" Type="http://schemas.openxmlformats.org/officeDocument/2006/relationships/image" Target="../media/image83.wmf"/><Relationship Id="rId1" Type="http://schemas.openxmlformats.org/officeDocument/2006/relationships/image" Target="../media/image82.wmf"/><Relationship Id="rId6" Type="http://schemas.openxmlformats.org/officeDocument/2006/relationships/image" Target="../media/image87.wmf"/><Relationship Id="rId5" Type="http://schemas.openxmlformats.org/officeDocument/2006/relationships/image" Target="../media/image86.wmf"/><Relationship Id="rId4" Type="http://schemas.openxmlformats.org/officeDocument/2006/relationships/image" Target="../media/image85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D525173-3A22-8DDA-B4DC-640BD123CCE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424BF4D4-23F8-8876-687C-C9C1FDB0D73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E432609-5778-3BED-088B-DA0A198EF0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307B1-4684-4D98-90B2-DDEF43F485C5}" type="datetimeFigureOut">
              <a:rPr lang="ko-KR" altLang="en-US" smtClean="0"/>
              <a:t>2023-01-2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DC047C1-8B20-3EAF-068C-A985417627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1C2CFD9-A47C-413E-2931-CB45356C1C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B4090-94E8-48CE-91FE-9DFD7F5363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5770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92F62F6-0A43-BC14-C1F7-E37D4CC25C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75392A27-8FD7-CA37-4D5B-7AF97743CB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2DE83E0-D94E-7988-F84E-0138B97ADB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307B1-4684-4D98-90B2-DDEF43F485C5}" type="datetimeFigureOut">
              <a:rPr lang="ko-KR" altLang="en-US" smtClean="0"/>
              <a:t>2023-01-2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DE820FE-1AEE-EEE3-C3F7-81AD6FF902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FA83C2E-CFCA-3194-7105-A6A72960F2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B4090-94E8-48CE-91FE-9DFD7F5363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652524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88CA7B1F-5337-FF49-AD1C-A23836E591C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10D62A9-8D28-0BD4-6CE6-915CFB11F3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739F76A-3E27-957B-F66F-38F40085AB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307B1-4684-4D98-90B2-DDEF43F485C5}" type="datetimeFigureOut">
              <a:rPr lang="ko-KR" altLang="en-US" smtClean="0"/>
              <a:t>2023-01-2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D229131-2704-347D-E5AC-4C73567BEE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3D8D9C9-58A0-10C6-4D28-CCB41245FA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B4090-94E8-48CE-91FE-9DFD7F5363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0023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29A7731-5304-35A0-0C7A-3B5FB34415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5DE778A-7A36-293E-13F3-32E0BF469EA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53A03C3-F59C-BE87-E35D-5C2DE1ED81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307B1-4684-4D98-90B2-DDEF43F485C5}" type="datetimeFigureOut">
              <a:rPr lang="ko-KR" altLang="en-US" smtClean="0"/>
              <a:t>2023-01-2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FDF8BD8-2452-F934-1030-07502E563A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4221AB0-790E-923F-422D-4B6C51D6AD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B4090-94E8-48CE-91FE-9DFD7F5363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176360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ECB89F7-7C75-EFDC-D4D3-BE249D37BB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77DF65CC-B11F-A3BE-335F-58899B2E33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A56E00E-603F-AC2E-42D2-96F869439A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307B1-4684-4D98-90B2-DDEF43F485C5}" type="datetimeFigureOut">
              <a:rPr lang="ko-KR" altLang="en-US" smtClean="0"/>
              <a:t>2023-01-2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CB9D1BA-564A-95EC-C4AB-6EE9AABA94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61A1B3A-105F-8FD6-F716-AA6364587A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B4090-94E8-48CE-91FE-9DFD7F5363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59717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6E88D37-6097-1FC1-7210-E90A15793E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77F87314-401F-BD96-FF1B-A30CB05DB4D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B9DC949-8659-E029-EFAA-BF64ACBB4F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5B90F6F-112B-5573-A5B7-AC7DC4E94C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307B1-4684-4D98-90B2-DDEF43F485C5}" type="datetimeFigureOut">
              <a:rPr lang="ko-KR" altLang="en-US" smtClean="0"/>
              <a:t>2023-01-2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202CD92-5F80-4C00-E0CA-F2EEAF2A1B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DA94092-8E27-7FA5-1611-56CD7C02F6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B4090-94E8-48CE-91FE-9DFD7F5363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65808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D85F848-167C-EB2C-105C-5F6A84F56B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EE49155-4572-F64F-1A14-E274AC53BC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76ACACB2-27AA-FD98-7B12-28DEA90150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F91517CF-6B0F-6FB1-2C34-B7916C932A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BC86B1C3-5479-58DB-B052-C0F88F76BBD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A5611E4A-271A-6EB4-080B-FE205ADA41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307B1-4684-4D98-90B2-DDEF43F485C5}" type="datetimeFigureOut">
              <a:rPr lang="ko-KR" altLang="en-US" smtClean="0"/>
              <a:t>2023-01-26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D40CFC28-4C82-EF26-D925-CEBCD12685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4E7E34D1-C170-A704-17C4-188A52FCE7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B4090-94E8-48CE-91FE-9DFD7F5363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989732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8996FFA-FBE0-0389-260A-4E8E83E585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C2A96591-3812-9C0E-D116-C3DBC3DF74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307B1-4684-4D98-90B2-DDEF43F485C5}" type="datetimeFigureOut">
              <a:rPr lang="ko-KR" altLang="en-US" smtClean="0"/>
              <a:t>2023-01-26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163B00D0-3C3C-EA96-89F7-D4A4B20A70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534262A9-E8AF-A7CB-0E77-C7729CEF70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B4090-94E8-48CE-91FE-9DFD7F5363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66649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EDE308C9-58DB-7EC9-9633-5B1A2B1CE0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307B1-4684-4D98-90B2-DDEF43F485C5}" type="datetimeFigureOut">
              <a:rPr lang="ko-KR" altLang="en-US" smtClean="0"/>
              <a:t>2023-01-26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871212EE-AA7C-96B3-2733-FC4AF450E2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1DEA2F7E-CC87-7AB8-077E-93BD1BDC45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B4090-94E8-48CE-91FE-9DFD7F5363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48694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F9A3246-9CA1-EDD3-7640-704DC88321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7FDAF1D4-A9C2-ABAE-B1F2-55A6CC934C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9255BDDE-C58B-490F-E4F0-4DC37632D9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6241D67B-B03B-B847-AC34-AF034990D1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307B1-4684-4D98-90B2-DDEF43F485C5}" type="datetimeFigureOut">
              <a:rPr lang="ko-KR" altLang="en-US" smtClean="0"/>
              <a:t>2023-01-2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C4E5488-7605-7423-2694-FAFA71140F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9A771CB-3F08-0935-9C8B-ACB335440B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B4090-94E8-48CE-91FE-9DFD7F5363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62547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EEDAF35-E833-B87D-429D-269C92FFFE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62F21CAB-3EF0-4410-DD1E-E2FBA00E5B7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39655CBA-5F3D-BD34-5939-36308421DD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A88A47F3-45BE-D13E-C43B-18F1699623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307B1-4684-4D98-90B2-DDEF43F485C5}" type="datetimeFigureOut">
              <a:rPr lang="ko-KR" altLang="en-US" smtClean="0"/>
              <a:t>2023-01-2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3A72BDF-8971-DA18-ED98-9B74B957C3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8B89CA82-5E77-6782-CF1F-1875B29602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B4090-94E8-48CE-91FE-9DFD7F5363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922446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131AFEE3-4D7C-9017-1AB1-1757C5E9F7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D1C9ECD-E4D4-A430-8DD5-2FA78CF150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9AB9B8E-C062-AC2D-7926-02711A47A88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D307B1-4684-4D98-90B2-DDEF43F485C5}" type="datetimeFigureOut">
              <a:rPr lang="ko-KR" altLang="en-US" smtClean="0"/>
              <a:t>2023-01-2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A1CAAFC-017A-4512-2A62-063D5315BBB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CEEA594-6C93-6A59-BD80-CD7C0F75C4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7B4090-94E8-48CE-91FE-9DFD7F5363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41508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wmf"/><Relationship Id="rId26" Type="http://schemas.openxmlformats.org/officeDocument/2006/relationships/image" Target="../media/image12.w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34" Type="http://schemas.openxmlformats.org/officeDocument/2006/relationships/image" Target="../media/image18.png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wmf"/><Relationship Id="rId17" Type="http://schemas.openxmlformats.org/officeDocument/2006/relationships/oleObject" Target="../embeddings/oleObject8.bin"/><Relationship Id="rId25" Type="http://schemas.openxmlformats.org/officeDocument/2006/relationships/oleObject" Target="../embeddings/oleObject12.bin"/><Relationship Id="rId33" Type="http://schemas.openxmlformats.org/officeDocument/2006/relationships/image" Target="../media/image17.png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7.wmf"/><Relationship Id="rId20" Type="http://schemas.openxmlformats.org/officeDocument/2006/relationships/image" Target="../media/image9.wmf"/><Relationship Id="rId29" Type="http://schemas.openxmlformats.org/officeDocument/2006/relationships/oleObject" Target="../embeddings/oleObject14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1.wmf"/><Relationship Id="rId32" Type="http://schemas.openxmlformats.org/officeDocument/2006/relationships/image" Target="../media/image16.png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28" Type="http://schemas.openxmlformats.org/officeDocument/2006/relationships/image" Target="../media/image13.wmf"/><Relationship Id="rId10" Type="http://schemas.openxmlformats.org/officeDocument/2006/relationships/image" Target="../media/image4.wmf"/><Relationship Id="rId19" Type="http://schemas.openxmlformats.org/officeDocument/2006/relationships/oleObject" Target="../embeddings/oleObject9.bin"/><Relationship Id="rId31" Type="http://schemas.openxmlformats.org/officeDocument/2006/relationships/image" Target="../media/image15.png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wmf"/><Relationship Id="rId22" Type="http://schemas.openxmlformats.org/officeDocument/2006/relationships/image" Target="../media/image10.wmf"/><Relationship Id="rId27" Type="http://schemas.openxmlformats.org/officeDocument/2006/relationships/oleObject" Target="../embeddings/oleObject13.bin"/><Relationship Id="rId30" Type="http://schemas.openxmlformats.org/officeDocument/2006/relationships/image" Target="../media/image14.wmf"/><Relationship Id="rId8" Type="http://schemas.openxmlformats.org/officeDocument/2006/relationships/image" Target="../media/image3.w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wmf"/><Relationship Id="rId13" Type="http://schemas.openxmlformats.org/officeDocument/2006/relationships/oleObject" Target="../embeddings/oleObject20.bin"/><Relationship Id="rId18" Type="http://schemas.microsoft.com/office/2007/relationships/hdphoto" Target="../media/hdphoto1.wdp"/><Relationship Id="rId3" Type="http://schemas.openxmlformats.org/officeDocument/2006/relationships/oleObject" Target="../embeddings/oleObject15.bin"/><Relationship Id="rId7" Type="http://schemas.openxmlformats.org/officeDocument/2006/relationships/oleObject" Target="../embeddings/oleObject17.bin"/><Relationship Id="rId12" Type="http://schemas.openxmlformats.org/officeDocument/2006/relationships/image" Target="../media/image21.wmf"/><Relationship Id="rId17" Type="http://schemas.openxmlformats.org/officeDocument/2006/relationships/image" Target="../media/image25.png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24.png"/><Relationship Id="rId1" Type="http://schemas.openxmlformats.org/officeDocument/2006/relationships/vmlDrawing" Target="../drawings/vmlDrawing2.vml"/><Relationship Id="rId6" Type="http://schemas.openxmlformats.org/officeDocument/2006/relationships/image" Target="../media/image19.wmf"/><Relationship Id="rId11" Type="http://schemas.openxmlformats.org/officeDocument/2006/relationships/oleObject" Target="../embeddings/oleObject19.bin"/><Relationship Id="rId5" Type="http://schemas.openxmlformats.org/officeDocument/2006/relationships/oleObject" Target="../embeddings/oleObject16.bin"/><Relationship Id="rId15" Type="http://schemas.openxmlformats.org/officeDocument/2006/relationships/image" Target="../media/image23.png"/><Relationship Id="rId10" Type="http://schemas.openxmlformats.org/officeDocument/2006/relationships/image" Target="../media/image20.wmf"/><Relationship Id="rId4" Type="http://schemas.openxmlformats.org/officeDocument/2006/relationships/image" Target="../media/image5.wmf"/><Relationship Id="rId9" Type="http://schemas.openxmlformats.org/officeDocument/2006/relationships/oleObject" Target="../embeddings/oleObject18.bin"/><Relationship Id="rId14" Type="http://schemas.openxmlformats.org/officeDocument/2006/relationships/image" Target="../media/image22.w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3.bin"/><Relationship Id="rId13" Type="http://schemas.openxmlformats.org/officeDocument/2006/relationships/image" Target="../media/image30.wmf"/><Relationship Id="rId18" Type="http://schemas.openxmlformats.org/officeDocument/2006/relationships/oleObject" Target="../embeddings/oleObject28.bin"/><Relationship Id="rId3" Type="http://schemas.openxmlformats.org/officeDocument/2006/relationships/image" Target="../media/image36.png"/><Relationship Id="rId21" Type="http://schemas.openxmlformats.org/officeDocument/2006/relationships/image" Target="../media/image34.wmf"/><Relationship Id="rId7" Type="http://schemas.openxmlformats.org/officeDocument/2006/relationships/image" Target="../media/image27.wmf"/><Relationship Id="rId12" Type="http://schemas.openxmlformats.org/officeDocument/2006/relationships/oleObject" Target="../embeddings/oleObject25.bin"/><Relationship Id="rId17" Type="http://schemas.openxmlformats.org/officeDocument/2006/relationships/image" Target="../media/image32.w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27.bin"/><Relationship Id="rId20" Type="http://schemas.openxmlformats.org/officeDocument/2006/relationships/oleObject" Target="../embeddings/oleObject29.bin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22.bin"/><Relationship Id="rId11" Type="http://schemas.openxmlformats.org/officeDocument/2006/relationships/image" Target="../media/image29.wmf"/><Relationship Id="rId24" Type="http://schemas.openxmlformats.org/officeDocument/2006/relationships/image" Target="../media/image37.jpg"/><Relationship Id="rId5" Type="http://schemas.openxmlformats.org/officeDocument/2006/relationships/image" Target="../media/image26.wmf"/><Relationship Id="rId15" Type="http://schemas.openxmlformats.org/officeDocument/2006/relationships/image" Target="../media/image31.wmf"/><Relationship Id="rId23" Type="http://schemas.openxmlformats.org/officeDocument/2006/relationships/image" Target="../media/image35.wmf"/><Relationship Id="rId10" Type="http://schemas.openxmlformats.org/officeDocument/2006/relationships/oleObject" Target="../embeddings/oleObject24.bin"/><Relationship Id="rId19" Type="http://schemas.openxmlformats.org/officeDocument/2006/relationships/image" Target="../media/image33.wmf"/><Relationship Id="rId4" Type="http://schemas.openxmlformats.org/officeDocument/2006/relationships/oleObject" Target="../embeddings/oleObject21.bin"/><Relationship Id="rId9" Type="http://schemas.openxmlformats.org/officeDocument/2006/relationships/image" Target="../media/image28.wmf"/><Relationship Id="rId14" Type="http://schemas.openxmlformats.org/officeDocument/2006/relationships/oleObject" Target="../embeddings/oleObject26.bin"/><Relationship Id="rId22" Type="http://schemas.openxmlformats.org/officeDocument/2006/relationships/oleObject" Target="../embeddings/oleObject30.bin"/></Relationships>
</file>

<file path=ppt/slides/_rels/slide5.xml.rels><?xml version="1.0" encoding="UTF-8" standalone="yes"?>
<Relationships xmlns="http://schemas.openxmlformats.org/package/2006/relationships"><Relationship Id="rId13" Type="http://schemas.openxmlformats.org/officeDocument/2006/relationships/oleObject" Target="../embeddings/oleObject36.bin"/><Relationship Id="rId18" Type="http://schemas.openxmlformats.org/officeDocument/2006/relationships/image" Target="../media/image48.png"/><Relationship Id="rId26" Type="http://schemas.openxmlformats.org/officeDocument/2006/relationships/image" Target="../media/image53.png"/><Relationship Id="rId21" Type="http://schemas.microsoft.com/office/2007/relationships/hdphoto" Target="../media/hdphoto4.wdp"/><Relationship Id="rId34" Type="http://schemas.openxmlformats.org/officeDocument/2006/relationships/image" Target="../media/image58.png"/><Relationship Id="rId7" Type="http://schemas.openxmlformats.org/officeDocument/2006/relationships/oleObject" Target="../embeddings/oleObject33.bin"/><Relationship Id="rId12" Type="http://schemas.openxmlformats.org/officeDocument/2006/relationships/image" Target="../media/image42.wmf"/><Relationship Id="rId17" Type="http://schemas.microsoft.com/office/2007/relationships/hdphoto" Target="../media/hdphoto2.wdp"/><Relationship Id="rId25" Type="http://schemas.openxmlformats.org/officeDocument/2006/relationships/image" Target="../media/image52.png"/><Relationship Id="rId33" Type="http://schemas.openxmlformats.org/officeDocument/2006/relationships/image" Target="../media/image57.png"/><Relationship Id="rId38" Type="http://schemas.openxmlformats.org/officeDocument/2006/relationships/image" Target="../media/image45.wmf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47.png"/><Relationship Id="rId20" Type="http://schemas.openxmlformats.org/officeDocument/2006/relationships/image" Target="../media/image49.png"/><Relationship Id="rId29" Type="http://schemas.openxmlformats.org/officeDocument/2006/relationships/image" Target="../media/image55.png"/><Relationship Id="rId1" Type="http://schemas.openxmlformats.org/officeDocument/2006/relationships/vmlDrawing" Target="../drawings/vmlDrawing4.vml"/><Relationship Id="rId6" Type="http://schemas.openxmlformats.org/officeDocument/2006/relationships/image" Target="../media/image39.wmf"/><Relationship Id="rId11" Type="http://schemas.openxmlformats.org/officeDocument/2006/relationships/oleObject" Target="../embeddings/oleObject35.bin"/><Relationship Id="rId24" Type="http://schemas.openxmlformats.org/officeDocument/2006/relationships/image" Target="../media/image51.png"/><Relationship Id="rId32" Type="http://schemas.microsoft.com/office/2007/relationships/hdphoto" Target="../media/hdphoto8.wdp"/><Relationship Id="rId37" Type="http://schemas.openxmlformats.org/officeDocument/2006/relationships/oleObject" Target="../embeddings/oleObject38.bin"/><Relationship Id="rId5" Type="http://schemas.openxmlformats.org/officeDocument/2006/relationships/oleObject" Target="../embeddings/oleObject32.bin"/><Relationship Id="rId15" Type="http://schemas.openxmlformats.org/officeDocument/2006/relationships/image" Target="../media/image46.jpg"/><Relationship Id="rId23" Type="http://schemas.microsoft.com/office/2007/relationships/hdphoto" Target="../media/hdphoto5.wdp"/><Relationship Id="rId28" Type="http://schemas.microsoft.com/office/2007/relationships/hdphoto" Target="../media/hdphoto6.wdp"/><Relationship Id="rId36" Type="http://schemas.openxmlformats.org/officeDocument/2006/relationships/image" Target="../media/image44.wmf"/><Relationship Id="rId10" Type="http://schemas.openxmlformats.org/officeDocument/2006/relationships/image" Target="../media/image41.wmf"/><Relationship Id="rId19" Type="http://schemas.microsoft.com/office/2007/relationships/hdphoto" Target="../media/hdphoto3.wdp"/><Relationship Id="rId31" Type="http://schemas.openxmlformats.org/officeDocument/2006/relationships/image" Target="../media/image56.png"/><Relationship Id="rId4" Type="http://schemas.openxmlformats.org/officeDocument/2006/relationships/image" Target="../media/image38.wmf"/><Relationship Id="rId9" Type="http://schemas.openxmlformats.org/officeDocument/2006/relationships/oleObject" Target="../embeddings/oleObject34.bin"/><Relationship Id="rId14" Type="http://schemas.openxmlformats.org/officeDocument/2006/relationships/image" Target="../media/image43.wmf"/><Relationship Id="rId22" Type="http://schemas.openxmlformats.org/officeDocument/2006/relationships/image" Target="../media/image50.png"/><Relationship Id="rId27" Type="http://schemas.openxmlformats.org/officeDocument/2006/relationships/image" Target="../media/image54.png"/><Relationship Id="rId30" Type="http://schemas.microsoft.com/office/2007/relationships/hdphoto" Target="../media/hdphoto7.wdp"/><Relationship Id="rId35" Type="http://schemas.openxmlformats.org/officeDocument/2006/relationships/oleObject" Target="../embeddings/oleObject37.bin"/><Relationship Id="rId8" Type="http://schemas.openxmlformats.org/officeDocument/2006/relationships/image" Target="../media/image40.wmf"/><Relationship Id="rId3" Type="http://schemas.openxmlformats.org/officeDocument/2006/relationships/oleObject" Target="../embeddings/oleObject31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wmf"/><Relationship Id="rId13" Type="http://schemas.openxmlformats.org/officeDocument/2006/relationships/oleObject" Target="../embeddings/oleObject43.bin"/><Relationship Id="rId18" Type="http://schemas.openxmlformats.org/officeDocument/2006/relationships/image" Target="../media/image65.png"/><Relationship Id="rId3" Type="http://schemas.openxmlformats.org/officeDocument/2006/relationships/oleObject" Target="../embeddings/oleObject39.bin"/><Relationship Id="rId7" Type="http://schemas.openxmlformats.org/officeDocument/2006/relationships/oleObject" Target="../embeddings/oleObject41.bin"/><Relationship Id="rId12" Type="http://schemas.openxmlformats.org/officeDocument/2006/relationships/image" Target="../media/image61.wmf"/><Relationship Id="rId17" Type="http://schemas.openxmlformats.org/officeDocument/2006/relationships/image" Target="../media/image64.emf"/><Relationship Id="rId2" Type="http://schemas.openxmlformats.org/officeDocument/2006/relationships/slideLayout" Target="../slideLayouts/slideLayout2.xml"/><Relationship Id="rId16" Type="http://schemas.microsoft.com/office/2007/relationships/hdphoto" Target="../media/hdphoto9.wdp"/><Relationship Id="rId1" Type="http://schemas.openxmlformats.org/officeDocument/2006/relationships/vmlDrawing" Target="../drawings/vmlDrawing5.vml"/><Relationship Id="rId6" Type="http://schemas.openxmlformats.org/officeDocument/2006/relationships/image" Target="../media/image60.wmf"/><Relationship Id="rId11" Type="http://schemas.openxmlformats.org/officeDocument/2006/relationships/oleObject" Target="../embeddings/oleObject42.bin"/><Relationship Id="rId5" Type="http://schemas.openxmlformats.org/officeDocument/2006/relationships/oleObject" Target="../embeddings/oleObject40.bin"/><Relationship Id="rId15" Type="http://schemas.openxmlformats.org/officeDocument/2006/relationships/image" Target="../media/image63.png"/><Relationship Id="rId10" Type="http://schemas.openxmlformats.org/officeDocument/2006/relationships/image" Target="../media/image5.wmf"/><Relationship Id="rId4" Type="http://schemas.openxmlformats.org/officeDocument/2006/relationships/image" Target="../media/image59.wmf"/><Relationship Id="rId9" Type="http://schemas.openxmlformats.org/officeDocument/2006/relationships/oleObject" Target="../embeddings/oleObject5.bin"/><Relationship Id="rId14" Type="http://schemas.openxmlformats.org/officeDocument/2006/relationships/image" Target="../media/image62.wmf"/></Relationships>
</file>

<file path=ppt/slides/_rels/slide7.xml.rels><?xml version="1.0" encoding="UTF-8" standalone="yes"?>
<Relationships xmlns="http://schemas.openxmlformats.org/package/2006/relationships"><Relationship Id="rId13" Type="http://schemas.openxmlformats.org/officeDocument/2006/relationships/oleObject" Target="../embeddings/oleObject49.bin"/><Relationship Id="rId18" Type="http://schemas.openxmlformats.org/officeDocument/2006/relationships/image" Target="../media/image73.wmf"/><Relationship Id="rId26" Type="http://schemas.openxmlformats.org/officeDocument/2006/relationships/image" Target="../media/image77.wmf"/><Relationship Id="rId3" Type="http://schemas.openxmlformats.org/officeDocument/2006/relationships/oleObject" Target="../embeddings/oleObject44.bin"/><Relationship Id="rId21" Type="http://schemas.openxmlformats.org/officeDocument/2006/relationships/oleObject" Target="../embeddings/oleObject53.bin"/><Relationship Id="rId34" Type="http://schemas.openxmlformats.org/officeDocument/2006/relationships/image" Target="../media/image81.wmf"/><Relationship Id="rId7" Type="http://schemas.openxmlformats.org/officeDocument/2006/relationships/oleObject" Target="../embeddings/oleObject46.bin"/><Relationship Id="rId12" Type="http://schemas.openxmlformats.org/officeDocument/2006/relationships/image" Target="../media/image70.wmf"/><Relationship Id="rId17" Type="http://schemas.openxmlformats.org/officeDocument/2006/relationships/oleObject" Target="../embeddings/oleObject51.bin"/><Relationship Id="rId25" Type="http://schemas.openxmlformats.org/officeDocument/2006/relationships/oleObject" Target="../embeddings/oleObject55.bin"/><Relationship Id="rId33" Type="http://schemas.openxmlformats.org/officeDocument/2006/relationships/oleObject" Target="../embeddings/oleObject59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72.wmf"/><Relationship Id="rId20" Type="http://schemas.openxmlformats.org/officeDocument/2006/relationships/image" Target="../media/image74.wmf"/><Relationship Id="rId29" Type="http://schemas.openxmlformats.org/officeDocument/2006/relationships/oleObject" Target="../embeddings/oleObject57.bin"/><Relationship Id="rId1" Type="http://schemas.openxmlformats.org/officeDocument/2006/relationships/vmlDrawing" Target="../drawings/vmlDrawing6.vml"/><Relationship Id="rId6" Type="http://schemas.openxmlformats.org/officeDocument/2006/relationships/image" Target="../media/image67.wmf"/><Relationship Id="rId11" Type="http://schemas.openxmlformats.org/officeDocument/2006/relationships/oleObject" Target="../embeddings/oleObject48.bin"/><Relationship Id="rId24" Type="http://schemas.openxmlformats.org/officeDocument/2006/relationships/image" Target="../media/image76.wmf"/><Relationship Id="rId32" Type="http://schemas.openxmlformats.org/officeDocument/2006/relationships/image" Target="../media/image80.wmf"/><Relationship Id="rId5" Type="http://schemas.openxmlformats.org/officeDocument/2006/relationships/oleObject" Target="../embeddings/oleObject45.bin"/><Relationship Id="rId15" Type="http://schemas.openxmlformats.org/officeDocument/2006/relationships/oleObject" Target="../embeddings/oleObject50.bin"/><Relationship Id="rId23" Type="http://schemas.openxmlformats.org/officeDocument/2006/relationships/oleObject" Target="../embeddings/oleObject54.bin"/><Relationship Id="rId28" Type="http://schemas.openxmlformats.org/officeDocument/2006/relationships/image" Target="../media/image78.wmf"/><Relationship Id="rId10" Type="http://schemas.openxmlformats.org/officeDocument/2006/relationships/image" Target="../media/image69.wmf"/><Relationship Id="rId19" Type="http://schemas.openxmlformats.org/officeDocument/2006/relationships/oleObject" Target="../embeddings/oleObject52.bin"/><Relationship Id="rId31" Type="http://schemas.openxmlformats.org/officeDocument/2006/relationships/oleObject" Target="../embeddings/oleObject58.bin"/><Relationship Id="rId4" Type="http://schemas.openxmlformats.org/officeDocument/2006/relationships/image" Target="../media/image66.wmf"/><Relationship Id="rId9" Type="http://schemas.openxmlformats.org/officeDocument/2006/relationships/oleObject" Target="../embeddings/oleObject47.bin"/><Relationship Id="rId14" Type="http://schemas.openxmlformats.org/officeDocument/2006/relationships/image" Target="../media/image71.wmf"/><Relationship Id="rId22" Type="http://schemas.openxmlformats.org/officeDocument/2006/relationships/image" Target="../media/image75.wmf"/><Relationship Id="rId27" Type="http://schemas.openxmlformats.org/officeDocument/2006/relationships/oleObject" Target="../embeddings/oleObject56.bin"/><Relationship Id="rId30" Type="http://schemas.openxmlformats.org/officeDocument/2006/relationships/image" Target="../media/image79.wmf"/><Relationship Id="rId8" Type="http://schemas.openxmlformats.org/officeDocument/2006/relationships/image" Target="../media/image68.w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84.wmf"/><Relationship Id="rId13" Type="http://schemas.openxmlformats.org/officeDocument/2006/relationships/oleObject" Target="../embeddings/oleObject65.bin"/><Relationship Id="rId3" Type="http://schemas.openxmlformats.org/officeDocument/2006/relationships/oleObject" Target="../embeddings/oleObject60.bin"/><Relationship Id="rId7" Type="http://schemas.openxmlformats.org/officeDocument/2006/relationships/oleObject" Target="../embeddings/oleObject62.bin"/><Relationship Id="rId12" Type="http://schemas.openxmlformats.org/officeDocument/2006/relationships/image" Target="../media/image86.w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7.vml"/><Relationship Id="rId6" Type="http://schemas.openxmlformats.org/officeDocument/2006/relationships/image" Target="../media/image83.wmf"/><Relationship Id="rId11" Type="http://schemas.openxmlformats.org/officeDocument/2006/relationships/oleObject" Target="../embeddings/oleObject64.bin"/><Relationship Id="rId5" Type="http://schemas.openxmlformats.org/officeDocument/2006/relationships/oleObject" Target="../embeddings/oleObject61.bin"/><Relationship Id="rId10" Type="http://schemas.openxmlformats.org/officeDocument/2006/relationships/image" Target="../media/image85.wmf"/><Relationship Id="rId4" Type="http://schemas.openxmlformats.org/officeDocument/2006/relationships/image" Target="../media/image82.wmf"/><Relationship Id="rId9" Type="http://schemas.openxmlformats.org/officeDocument/2006/relationships/oleObject" Target="../embeddings/oleObject63.bin"/><Relationship Id="rId14" Type="http://schemas.openxmlformats.org/officeDocument/2006/relationships/image" Target="../media/image87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4C2A687-8A97-5639-78D0-5B649D6ECC0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627413"/>
            <a:ext cx="9144000" cy="2387600"/>
          </a:xfrm>
        </p:spPr>
        <p:txBody>
          <a:bodyPr>
            <a:normAutofit/>
          </a:bodyPr>
          <a:lstStyle/>
          <a:p>
            <a:r>
              <a:rPr lang="en-US" altLang="ko-KR" sz="2800" b="1" dirty="0">
                <a:latin typeface="Arial" panose="020B0604020202020204" pitchFamily="34" charset="0"/>
                <a:cs typeface="Arial" panose="020B0604020202020204" pitchFamily="34" charset="0"/>
              </a:rPr>
              <a:t>Original </a:t>
            </a:r>
            <a:r>
              <a:rPr lang="en-US" altLang="ko-KR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ncropped gel </a:t>
            </a:r>
            <a:r>
              <a:rPr lang="en-US" altLang="ko-KR" sz="2800" b="1" dirty="0">
                <a:latin typeface="Arial" panose="020B0604020202020204" pitchFamily="34" charset="0"/>
                <a:cs typeface="Arial" panose="020B0604020202020204" pitchFamily="34" charset="0"/>
              </a:rPr>
              <a:t>images</a:t>
            </a:r>
            <a:endParaRPr lang="ko-KR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12D5A5D7-0C04-2D86-ABE0-C3618F8C96D8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“Role of pelitinib in the regulation of migration and invasion of hepatocellular carcinoma cells via inhibition of Twist1”</a:t>
            </a:r>
          </a:p>
          <a:p>
            <a:r>
              <a:rPr lang="en-US" altLang="ko-KR" sz="1600" dirty="0" err="1">
                <a:latin typeface="Arial" panose="020B0604020202020204" pitchFamily="34" charset="0"/>
                <a:cs typeface="Arial" panose="020B0604020202020204" pitchFamily="34" charset="0"/>
              </a:rPr>
              <a:t>Sewoong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 Lee†, </a:t>
            </a:r>
            <a:r>
              <a:rPr lang="en-US" altLang="ko-KR" sz="1600" dirty="0" err="1">
                <a:latin typeface="Arial" panose="020B0604020202020204" pitchFamily="34" charset="0"/>
                <a:cs typeface="Arial" panose="020B0604020202020204" pitchFamily="34" charset="0"/>
              </a:rPr>
              <a:t>Eunjeong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 Kang†, </a:t>
            </a:r>
            <a:r>
              <a:rPr lang="en-US" altLang="ko-KR" sz="1600" dirty="0" err="1">
                <a:latin typeface="Arial" panose="020B0604020202020204" pitchFamily="34" charset="0"/>
                <a:cs typeface="Arial" panose="020B0604020202020204" pitchFamily="34" charset="0"/>
              </a:rPr>
              <a:t>Unju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 Lee, </a:t>
            </a:r>
            <a:r>
              <a:rPr lang="en-US" altLang="ko-KR" sz="1600" dirty="0" err="1">
                <a:latin typeface="Arial" panose="020B0604020202020204" pitchFamily="34" charset="0"/>
                <a:cs typeface="Arial" panose="020B0604020202020204" pitchFamily="34" charset="0"/>
              </a:rPr>
              <a:t>Sayeon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 Cho*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09010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개체 4">
            <a:extLst>
              <a:ext uri="{FF2B5EF4-FFF2-40B4-BE49-F238E27FC236}">
                <a16:creationId xmlns:a16="http://schemas.microsoft.com/office/drawing/2014/main" id="{A707293B-9B94-37DB-74D3-F9F8C605DAB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32482790"/>
              </p:ext>
            </p:extLst>
          </p:nvPr>
        </p:nvGraphicFramePr>
        <p:xfrm>
          <a:off x="5544252" y="1465365"/>
          <a:ext cx="865920" cy="5525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4" name="Image" r:id="rId3" imgW="1929960" imgH="1231560" progId="Photoshop.Image.13">
                  <p:embed/>
                </p:oleObj>
              </mc:Choice>
              <mc:Fallback>
                <p:oleObj name="Image" r:id="rId3" imgW="1929960" imgH="1231560" progId="Photoshop.Image.13">
                  <p:embed/>
                  <p:pic>
                    <p:nvPicPr>
                      <p:cNvPr id="5" name="개체 4">
                        <a:extLst>
                          <a:ext uri="{FF2B5EF4-FFF2-40B4-BE49-F238E27FC236}">
                            <a16:creationId xmlns:a16="http://schemas.microsoft.com/office/drawing/2014/main" id="{A707293B-9B94-37DB-74D3-F9F8C605DAB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544252" y="1465365"/>
                        <a:ext cx="865920" cy="5525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개체 5">
            <a:extLst>
              <a:ext uri="{FF2B5EF4-FFF2-40B4-BE49-F238E27FC236}">
                <a16:creationId xmlns:a16="http://schemas.microsoft.com/office/drawing/2014/main" id="{A7858E86-AC5D-B50B-59A8-0359045552A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8295805"/>
              </p:ext>
            </p:extLst>
          </p:nvPr>
        </p:nvGraphicFramePr>
        <p:xfrm>
          <a:off x="5544252" y="2455922"/>
          <a:ext cx="865921" cy="31084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5" name="Image" r:id="rId5" imgW="1980720" imgH="711000" progId="Photoshop.Image.13">
                  <p:embed/>
                </p:oleObj>
              </mc:Choice>
              <mc:Fallback>
                <p:oleObj name="Image" r:id="rId5" imgW="1980720" imgH="711000" progId="Photoshop.Image.13">
                  <p:embed/>
                  <p:pic>
                    <p:nvPicPr>
                      <p:cNvPr id="6" name="개체 5">
                        <a:extLst>
                          <a:ext uri="{FF2B5EF4-FFF2-40B4-BE49-F238E27FC236}">
                            <a16:creationId xmlns:a16="http://schemas.microsoft.com/office/drawing/2014/main" id="{A7858E86-AC5D-B50B-59A8-0359045552A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544252" y="2455922"/>
                        <a:ext cx="865921" cy="31084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32AAF501-61F0-CC74-EB69-02C8520E8E25}"/>
              </a:ext>
            </a:extLst>
          </p:cNvPr>
          <p:cNvSpPr txBox="1"/>
          <p:nvPr/>
        </p:nvSpPr>
        <p:spPr>
          <a:xfrm>
            <a:off x="3662863" y="1626246"/>
            <a:ext cx="12779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nail1 (29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9FC4981-6FC6-3D82-8774-B368EB934149}"/>
              </a:ext>
            </a:extLst>
          </p:cNvPr>
          <p:cNvSpPr txBox="1"/>
          <p:nvPr/>
        </p:nvSpPr>
        <p:spPr>
          <a:xfrm>
            <a:off x="3638819" y="2495927"/>
            <a:ext cx="13019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ZEB1 (123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graphicFrame>
        <p:nvGraphicFramePr>
          <p:cNvPr id="16" name="개체 15">
            <a:extLst>
              <a:ext uri="{FF2B5EF4-FFF2-40B4-BE49-F238E27FC236}">
                <a16:creationId xmlns:a16="http://schemas.microsoft.com/office/drawing/2014/main" id="{FF0A5E7A-ADCE-A77E-E4D7-40B5670A7C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63436710"/>
              </p:ext>
            </p:extLst>
          </p:nvPr>
        </p:nvGraphicFramePr>
        <p:xfrm>
          <a:off x="7269378" y="2385624"/>
          <a:ext cx="864001" cy="6494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6" name="Image" r:id="rId7" imgW="1841040" imgH="1383840" progId="Photoshop.Image.13">
                  <p:embed/>
                </p:oleObj>
              </mc:Choice>
              <mc:Fallback>
                <p:oleObj name="Image" r:id="rId7" imgW="1841040" imgH="1383840" progId="Photoshop.Image.13">
                  <p:embed/>
                  <p:pic>
                    <p:nvPicPr>
                      <p:cNvPr id="16" name="개체 15">
                        <a:extLst>
                          <a:ext uri="{FF2B5EF4-FFF2-40B4-BE49-F238E27FC236}">
                            <a16:creationId xmlns:a16="http://schemas.microsoft.com/office/drawing/2014/main" id="{FF0A5E7A-ADCE-A77E-E4D7-40B5670A7C6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269378" y="2385624"/>
                        <a:ext cx="864001" cy="6494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개체 16">
            <a:extLst>
              <a:ext uri="{FF2B5EF4-FFF2-40B4-BE49-F238E27FC236}">
                <a16:creationId xmlns:a16="http://schemas.microsoft.com/office/drawing/2014/main" id="{8A4E03F0-DCC8-8540-75CF-DB4FF7A459B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35857803"/>
              </p:ext>
            </p:extLst>
          </p:nvPr>
        </p:nvGraphicFramePr>
        <p:xfrm>
          <a:off x="7269377" y="1491905"/>
          <a:ext cx="864001" cy="5011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7" name="Image" r:id="rId9" imgW="1904760" imgH="1104480" progId="Photoshop.Image.13">
                  <p:embed/>
                </p:oleObj>
              </mc:Choice>
              <mc:Fallback>
                <p:oleObj name="Image" r:id="rId9" imgW="1904760" imgH="1104480" progId="Photoshop.Image.13">
                  <p:embed/>
                  <p:pic>
                    <p:nvPicPr>
                      <p:cNvPr id="17" name="개체 16">
                        <a:extLst>
                          <a:ext uri="{FF2B5EF4-FFF2-40B4-BE49-F238E27FC236}">
                            <a16:creationId xmlns:a16="http://schemas.microsoft.com/office/drawing/2014/main" id="{8A4E03F0-DCC8-8540-75CF-DB4FF7A459B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7269377" y="1491905"/>
                        <a:ext cx="864001" cy="5011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개체 17">
            <a:extLst>
              <a:ext uri="{FF2B5EF4-FFF2-40B4-BE49-F238E27FC236}">
                <a16:creationId xmlns:a16="http://schemas.microsoft.com/office/drawing/2014/main" id="{60FE2FC5-E06A-FCAA-72DD-FB9E1DC0193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70144619"/>
              </p:ext>
            </p:extLst>
          </p:nvPr>
        </p:nvGraphicFramePr>
        <p:xfrm>
          <a:off x="5534649" y="3384857"/>
          <a:ext cx="864001" cy="5709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8" name="Image" r:id="rId11" imgW="2171160" imgH="1434600" progId="Photoshop.Image.13">
                  <p:embed/>
                </p:oleObj>
              </mc:Choice>
              <mc:Fallback>
                <p:oleObj name="Image" r:id="rId11" imgW="2171160" imgH="1434600" progId="Photoshop.Image.13">
                  <p:embed/>
                  <p:pic>
                    <p:nvPicPr>
                      <p:cNvPr id="18" name="개체 17">
                        <a:extLst>
                          <a:ext uri="{FF2B5EF4-FFF2-40B4-BE49-F238E27FC236}">
                            <a16:creationId xmlns:a16="http://schemas.microsoft.com/office/drawing/2014/main" id="{60FE2FC5-E06A-FCAA-72DD-FB9E1DC0193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5534649" y="3384857"/>
                        <a:ext cx="864001" cy="5709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개체 18">
            <a:extLst>
              <a:ext uri="{FF2B5EF4-FFF2-40B4-BE49-F238E27FC236}">
                <a16:creationId xmlns:a16="http://schemas.microsoft.com/office/drawing/2014/main" id="{99832F47-BD39-860C-0B5B-FC21C20FE8F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17992059"/>
              </p:ext>
            </p:extLst>
          </p:nvPr>
        </p:nvGraphicFramePr>
        <p:xfrm>
          <a:off x="5534649" y="620078"/>
          <a:ext cx="865920" cy="4557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9" name="Image" r:id="rId13" imgW="1841040" imgH="1269720" progId="Photoshop.Image.13">
                  <p:embed/>
                </p:oleObj>
              </mc:Choice>
              <mc:Fallback>
                <p:oleObj name="Image" r:id="rId13" imgW="1841040" imgH="1269720" progId="Photoshop.Image.13">
                  <p:embed/>
                  <p:pic>
                    <p:nvPicPr>
                      <p:cNvPr id="19" name="개체 18">
                        <a:extLst>
                          <a:ext uri="{FF2B5EF4-FFF2-40B4-BE49-F238E27FC236}">
                            <a16:creationId xmlns:a16="http://schemas.microsoft.com/office/drawing/2014/main" id="{99832F47-BD39-860C-0B5B-FC21C20FE8F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5534649" y="620078"/>
                        <a:ext cx="865920" cy="4557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개체 20">
            <a:extLst>
              <a:ext uri="{FF2B5EF4-FFF2-40B4-BE49-F238E27FC236}">
                <a16:creationId xmlns:a16="http://schemas.microsoft.com/office/drawing/2014/main" id="{D835AED7-494E-7D9D-83CB-92DC05F5A9F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55103189"/>
              </p:ext>
            </p:extLst>
          </p:nvPr>
        </p:nvGraphicFramePr>
        <p:xfrm>
          <a:off x="7267026" y="3427508"/>
          <a:ext cx="864000" cy="4856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0" name="Image" r:id="rId15" imgW="1942560" imgH="1091880" progId="Photoshop.Image.13">
                  <p:embed/>
                </p:oleObj>
              </mc:Choice>
              <mc:Fallback>
                <p:oleObj name="Image" r:id="rId15" imgW="1942560" imgH="1091880" progId="Photoshop.Image.13">
                  <p:embed/>
                  <p:pic>
                    <p:nvPicPr>
                      <p:cNvPr id="21" name="개체 20">
                        <a:extLst>
                          <a:ext uri="{FF2B5EF4-FFF2-40B4-BE49-F238E27FC236}">
                            <a16:creationId xmlns:a16="http://schemas.microsoft.com/office/drawing/2014/main" id="{D835AED7-494E-7D9D-83CB-92DC05F5A9F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7267026" y="3427508"/>
                        <a:ext cx="864000" cy="4856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개체 22">
            <a:extLst>
              <a:ext uri="{FF2B5EF4-FFF2-40B4-BE49-F238E27FC236}">
                <a16:creationId xmlns:a16="http://schemas.microsoft.com/office/drawing/2014/main" id="{EF7F075E-BE65-0838-01D8-EFE15D83857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72921253"/>
              </p:ext>
            </p:extLst>
          </p:nvPr>
        </p:nvGraphicFramePr>
        <p:xfrm>
          <a:off x="7257473" y="637238"/>
          <a:ext cx="883105" cy="4385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1" name="Image" r:id="rId17" imgW="1891800" imgH="939600" progId="Photoshop.Image.13">
                  <p:embed/>
                </p:oleObj>
              </mc:Choice>
              <mc:Fallback>
                <p:oleObj name="Image" r:id="rId17" imgW="1891800" imgH="939600" progId="Photoshop.Image.13">
                  <p:embed/>
                  <p:pic>
                    <p:nvPicPr>
                      <p:cNvPr id="23" name="개체 22">
                        <a:extLst>
                          <a:ext uri="{FF2B5EF4-FFF2-40B4-BE49-F238E27FC236}">
                            <a16:creationId xmlns:a16="http://schemas.microsoft.com/office/drawing/2014/main" id="{EF7F075E-BE65-0838-01D8-EFE15D83857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7257473" y="637238"/>
                        <a:ext cx="883105" cy="4385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TextBox 23">
            <a:extLst>
              <a:ext uri="{FF2B5EF4-FFF2-40B4-BE49-F238E27FC236}">
                <a16:creationId xmlns:a16="http://schemas.microsoft.com/office/drawing/2014/main" id="{ECFA40E7-08FD-DD10-2A36-42D6ADC7794D}"/>
              </a:ext>
            </a:extLst>
          </p:cNvPr>
          <p:cNvSpPr txBox="1"/>
          <p:nvPr/>
        </p:nvSpPr>
        <p:spPr>
          <a:xfrm>
            <a:off x="3648629" y="741116"/>
            <a:ext cx="12921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Twist1 (21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8BFA2D9-69C8-4E32-5AF3-527C5A1570F9}"/>
              </a:ext>
            </a:extLst>
          </p:cNvPr>
          <p:cNvSpPr txBox="1"/>
          <p:nvPr/>
        </p:nvSpPr>
        <p:spPr>
          <a:xfrm>
            <a:off x="3611568" y="3554915"/>
            <a:ext cx="1329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 (41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graphicFrame>
        <p:nvGraphicFramePr>
          <p:cNvPr id="26" name="개체 25">
            <a:extLst>
              <a:ext uri="{FF2B5EF4-FFF2-40B4-BE49-F238E27FC236}">
                <a16:creationId xmlns:a16="http://schemas.microsoft.com/office/drawing/2014/main" id="{446FADF0-423C-DAFD-082B-DCCDF19F6DA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58623084"/>
              </p:ext>
            </p:extLst>
          </p:nvPr>
        </p:nvGraphicFramePr>
        <p:xfrm>
          <a:off x="7276578" y="5140746"/>
          <a:ext cx="864000" cy="5031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2" name="Image" r:id="rId19" imgW="2158560" imgH="1257120" progId="Photoshop.Image.13">
                  <p:embed/>
                </p:oleObj>
              </mc:Choice>
              <mc:Fallback>
                <p:oleObj name="Image" r:id="rId19" imgW="2158560" imgH="1257120" progId="Photoshop.Image.13">
                  <p:embed/>
                  <p:pic>
                    <p:nvPicPr>
                      <p:cNvPr id="26" name="개체 25">
                        <a:extLst>
                          <a:ext uri="{FF2B5EF4-FFF2-40B4-BE49-F238E27FC236}">
                            <a16:creationId xmlns:a16="http://schemas.microsoft.com/office/drawing/2014/main" id="{446FADF0-423C-DAFD-082B-DCCDF19F6DA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7276578" y="5140746"/>
                        <a:ext cx="864000" cy="5031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개체 26">
            <a:extLst>
              <a:ext uri="{FF2B5EF4-FFF2-40B4-BE49-F238E27FC236}">
                <a16:creationId xmlns:a16="http://schemas.microsoft.com/office/drawing/2014/main" id="{65EDCCFA-75EB-A124-C3FC-FDB1039F87C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0979348"/>
              </p:ext>
            </p:extLst>
          </p:nvPr>
        </p:nvGraphicFramePr>
        <p:xfrm>
          <a:off x="5534697" y="5125383"/>
          <a:ext cx="864000" cy="5352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3" name="Image" r:id="rId21" imgW="2133000" imgH="1257120" progId="Photoshop.Image.13">
                  <p:embed/>
                </p:oleObj>
              </mc:Choice>
              <mc:Fallback>
                <p:oleObj name="Image" r:id="rId21" imgW="2133000" imgH="1257120" progId="Photoshop.Image.13">
                  <p:embed/>
                  <p:pic>
                    <p:nvPicPr>
                      <p:cNvPr id="27" name="개체 26">
                        <a:extLst>
                          <a:ext uri="{FF2B5EF4-FFF2-40B4-BE49-F238E27FC236}">
                            <a16:creationId xmlns:a16="http://schemas.microsoft.com/office/drawing/2014/main" id="{65EDCCFA-75EB-A124-C3FC-FDB1039F87C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5534697" y="5125383"/>
                        <a:ext cx="864000" cy="5352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개체 27">
            <a:extLst>
              <a:ext uri="{FF2B5EF4-FFF2-40B4-BE49-F238E27FC236}">
                <a16:creationId xmlns:a16="http://schemas.microsoft.com/office/drawing/2014/main" id="{708506FD-89D7-0498-3ECD-D5493C0C09C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46385033"/>
              </p:ext>
            </p:extLst>
          </p:nvPr>
        </p:nvGraphicFramePr>
        <p:xfrm>
          <a:off x="9138588" y="5137868"/>
          <a:ext cx="864000" cy="4892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4" name="Image" r:id="rId23" imgW="2107800" imgH="1193400" progId="Photoshop.Image.13">
                  <p:embed/>
                </p:oleObj>
              </mc:Choice>
              <mc:Fallback>
                <p:oleObj name="Image" r:id="rId23" imgW="2107800" imgH="1193400" progId="Photoshop.Image.13">
                  <p:embed/>
                  <p:pic>
                    <p:nvPicPr>
                      <p:cNvPr id="28" name="개체 27">
                        <a:extLst>
                          <a:ext uri="{FF2B5EF4-FFF2-40B4-BE49-F238E27FC236}">
                            <a16:creationId xmlns:a16="http://schemas.microsoft.com/office/drawing/2014/main" id="{708506FD-89D7-0498-3ECD-D5493C0C09C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9138588" y="5137868"/>
                        <a:ext cx="864000" cy="4892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개체 28">
            <a:extLst>
              <a:ext uri="{FF2B5EF4-FFF2-40B4-BE49-F238E27FC236}">
                <a16:creationId xmlns:a16="http://schemas.microsoft.com/office/drawing/2014/main" id="{CC50E5A5-8AAA-873F-5520-C4A58E433E6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13060075"/>
              </p:ext>
            </p:extLst>
          </p:nvPr>
        </p:nvGraphicFramePr>
        <p:xfrm>
          <a:off x="5525094" y="5814263"/>
          <a:ext cx="864000" cy="517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5" name="Image" r:id="rId25" imgW="2539440" imgH="1345680" progId="Photoshop.Image.13">
                  <p:embed/>
                </p:oleObj>
              </mc:Choice>
              <mc:Fallback>
                <p:oleObj name="Image" r:id="rId25" imgW="2539440" imgH="1345680" progId="Photoshop.Image.13">
                  <p:embed/>
                  <p:pic>
                    <p:nvPicPr>
                      <p:cNvPr id="29" name="개체 28">
                        <a:extLst>
                          <a:ext uri="{FF2B5EF4-FFF2-40B4-BE49-F238E27FC236}">
                            <a16:creationId xmlns:a16="http://schemas.microsoft.com/office/drawing/2014/main" id="{CC50E5A5-8AAA-873F-5520-C4A58E433E6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5525094" y="5814263"/>
                        <a:ext cx="864000" cy="517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개체 29">
            <a:extLst>
              <a:ext uri="{FF2B5EF4-FFF2-40B4-BE49-F238E27FC236}">
                <a16:creationId xmlns:a16="http://schemas.microsoft.com/office/drawing/2014/main" id="{66554259-00B4-9203-A95B-D528481E6C7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67897502"/>
              </p:ext>
            </p:extLst>
          </p:nvPr>
        </p:nvGraphicFramePr>
        <p:xfrm>
          <a:off x="7266975" y="5814263"/>
          <a:ext cx="864000" cy="3527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6" name="Image" r:id="rId27" imgW="2145960" imgH="875880" progId="Photoshop.Image.13">
                  <p:embed/>
                </p:oleObj>
              </mc:Choice>
              <mc:Fallback>
                <p:oleObj name="Image" r:id="rId27" imgW="2145960" imgH="875880" progId="Photoshop.Image.13">
                  <p:embed/>
                  <p:pic>
                    <p:nvPicPr>
                      <p:cNvPr id="30" name="개체 29">
                        <a:extLst>
                          <a:ext uri="{FF2B5EF4-FFF2-40B4-BE49-F238E27FC236}">
                            <a16:creationId xmlns:a16="http://schemas.microsoft.com/office/drawing/2014/main" id="{66554259-00B4-9203-A95B-D528481E6C7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7266975" y="5814263"/>
                        <a:ext cx="864000" cy="3527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개체 30">
            <a:extLst>
              <a:ext uri="{FF2B5EF4-FFF2-40B4-BE49-F238E27FC236}">
                <a16:creationId xmlns:a16="http://schemas.microsoft.com/office/drawing/2014/main" id="{AF374E27-352C-741E-EE71-8DED92BA57C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5819492"/>
              </p:ext>
            </p:extLst>
          </p:nvPr>
        </p:nvGraphicFramePr>
        <p:xfrm>
          <a:off x="9128985" y="5814263"/>
          <a:ext cx="864000" cy="429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7" name="Image" r:id="rId29" imgW="2298240" imgH="1142640" progId="Photoshop.Image.13">
                  <p:embed/>
                </p:oleObj>
              </mc:Choice>
              <mc:Fallback>
                <p:oleObj name="Image" r:id="rId29" imgW="2298240" imgH="1142640" progId="Photoshop.Image.13">
                  <p:embed/>
                  <p:pic>
                    <p:nvPicPr>
                      <p:cNvPr id="31" name="개체 30">
                        <a:extLst>
                          <a:ext uri="{FF2B5EF4-FFF2-40B4-BE49-F238E27FC236}">
                            <a16:creationId xmlns:a16="http://schemas.microsoft.com/office/drawing/2014/main" id="{AF374E27-352C-741E-EE71-8DED92BA57C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9128985" y="5814263"/>
                        <a:ext cx="864000" cy="429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2" name="TextBox 31">
            <a:extLst>
              <a:ext uri="{FF2B5EF4-FFF2-40B4-BE49-F238E27FC236}">
                <a16:creationId xmlns:a16="http://schemas.microsoft.com/office/drawing/2014/main" id="{89E7B9DE-B69A-2B8E-4826-FA7D7B4D4099}"/>
              </a:ext>
            </a:extLst>
          </p:cNvPr>
          <p:cNvSpPr txBox="1"/>
          <p:nvPr/>
        </p:nvSpPr>
        <p:spPr>
          <a:xfrm>
            <a:off x="3552589" y="5924945"/>
            <a:ext cx="1329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 (41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A37B0F8-D74A-2AE0-3461-5D30B22F1BF0}"/>
              </a:ext>
            </a:extLst>
          </p:cNvPr>
          <p:cNvSpPr txBox="1"/>
          <p:nvPr/>
        </p:nvSpPr>
        <p:spPr>
          <a:xfrm>
            <a:off x="3575225" y="5250704"/>
            <a:ext cx="12921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Twist1 (21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그룹 9">
            <a:extLst>
              <a:ext uri="{FF2B5EF4-FFF2-40B4-BE49-F238E27FC236}">
                <a16:creationId xmlns:a16="http://schemas.microsoft.com/office/drawing/2014/main" id="{C9C71562-1DED-F1B2-21C7-A69F92496AC8}"/>
              </a:ext>
            </a:extLst>
          </p:cNvPr>
          <p:cNvGrpSpPr/>
          <p:nvPr/>
        </p:nvGrpSpPr>
        <p:grpSpPr>
          <a:xfrm>
            <a:off x="4942161" y="5269987"/>
            <a:ext cx="601796" cy="230832"/>
            <a:chOff x="748831" y="5499416"/>
            <a:chExt cx="601796" cy="230832"/>
          </a:xfrm>
        </p:grpSpPr>
        <p:cxnSp>
          <p:nvCxnSpPr>
            <p:cNvPr id="4" name="직선 연결선 3">
              <a:extLst>
                <a:ext uri="{FF2B5EF4-FFF2-40B4-BE49-F238E27FC236}">
                  <a16:creationId xmlns:a16="http://schemas.microsoft.com/office/drawing/2014/main" id="{617B4C85-BAC5-1E18-DE28-538B4655F365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91C1AF5-6D6D-A76C-6A9A-22D64BC963B1}"/>
                </a:ext>
              </a:extLst>
            </p:cNvPr>
            <p:cNvSpPr txBox="1"/>
            <p:nvPr/>
          </p:nvSpPr>
          <p:spPr>
            <a:xfrm>
              <a:off x="748831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그룹 10">
            <a:extLst>
              <a:ext uri="{FF2B5EF4-FFF2-40B4-BE49-F238E27FC236}">
                <a16:creationId xmlns:a16="http://schemas.microsoft.com/office/drawing/2014/main" id="{661F0031-CD30-9A8B-8E8E-9408FF35779D}"/>
              </a:ext>
            </a:extLst>
          </p:cNvPr>
          <p:cNvGrpSpPr/>
          <p:nvPr/>
        </p:nvGrpSpPr>
        <p:grpSpPr>
          <a:xfrm>
            <a:off x="6674782" y="5269987"/>
            <a:ext cx="601796" cy="230832"/>
            <a:chOff x="748831" y="5499416"/>
            <a:chExt cx="601796" cy="230832"/>
          </a:xfrm>
        </p:grpSpPr>
        <p:cxnSp>
          <p:nvCxnSpPr>
            <p:cNvPr id="12" name="직선 연결선 11">
              <a:extLst>
                <a:ext uri="{FF2B5EF4-FFF2-40B4-BE49-F238E27FC236}">
                  <a16:creationId xmlns:a16="http://schemas.microsoft.com/office/drawing/2014/main" id="{4B5B6321-ECBA-E1E7-DE66-1BEEEF4E05B9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947CD9B-E5CE-08DC-1207-E244280FA89B}"/>
                </a:ext>
              </a:extLst>
            </p:cNvPr>
            <p:cNvSpPr txBox="1"/>
            <p:nvPr/>
          </p:nvSpPr>
          <p:spPr>
            <a:xfrm>
              <a:off x="748831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" name="그룹 13">
            <a:extLst>
              <a:ext uri="{FF2B5EF4-FFF2-40B4-BE49-F238E27FC236}">
                <a16:creationId xmlns:a16="http://schemas.microsoft.com/office/drawing/2014/main" id="{1B79C368-9617-7B0A-8AC2-5A6F71AE1468}"/>
              </a:ext>
            </a:extLst>
          </p:cNvPr>
          <p:cNvGrpSpPr/>
          <p:nvPr/>
        </p:nvGrpSpPr>
        <p:grpSpPr>
          <a:xfrm>
            <a:off x="8536792" y="5269987"/>
            <a:ext cx="601796" cy="230832"/>
            <a:chOff x="748831" y="5499416"/>
            <a:chExt cx="601796" cy="230832"/>
          </a:xfrm>
        </p:grpSpPr>
        <p:cxnSp>
          <p:nvCxnSpPr>
            <p:cNvPr id="15" name="직선 연결선 14">
              <a:extLst>
                <a:ext uri="{FF2B5EF4-FFF2-40B4-BE49-F238E27FC236}">
                  <a16:creationId xmlns:a16="http://schemas.microsoft.com/office/drawing/2014/main" id="{946F31D0-FF46-9BF3-B095-94EFCF822C82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4DC0F2B6-70E8-DBBC-CE8E-9681B5B4601D}"/>
                </a:ext>
              </a:extLst>
            </p:cNvPr>
            <p:cNvSpPr txBox="1"/>
            <p:nvPr/>
          </p:nvSpPr>
          <p:spPr>
            <a:xfrm>
              <a:off x="748831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7" name="그룹 36">
            <a:extLst>
              <a:ext uri="{FF2B5EF4-FFF2-40B4-BE49-F238E27FC236}">
                <a16:creationId xmlns:a16="http://schemas.microsoft.com/office/drawing/2014/main" id="{89CC3D4F-D891-F3F1-FD8B-FE065E054C80}"/>
              </a:ext>
            </a:extLst>
          </p:cNvPr>
          <p:cNvGrpSpPr/>
          <p:nvPr/>
        </p:nvGrpSpPr>
        <p:grpSpPr>
          <a:xfrm>
            <a:off x="4924302" y="5971112"/>
            <a:ext cx="601796" cy="230832"/>
            <a:chOff x="1151503" y="6192152"/>
            <a:chExt cx="601796" cy="230832"/>
          </a:xfrm>
        </p:grpSpPr>
        <p:cxnSp>
          <p:nvCxnSpPr>
            <p:cNvPr id="22" name="직선 연결선 21">
              <a:extLst>
                <a:ext uri="{FF2B5EF4-FFF2-40B4-BE49-F238E27FC236}">
                  <a16:creationId xmlns:a16="http://schemas.microsoft.com/office/drawing/2014/main" id="{F6726F37-A739-CC99-D755-78BF3EF854F2}"/>
                </a:ext>
              </a:extLst>
            </p:cNvPr>
            <p:cNvCxnSpPr/>
            <p:nvPr/>
          </p:nvCxnSpPr>
          <p:spPr>
            <a:xfrm>
              <a:off x="1627464" y="6331697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68BAA081-E1A6-A7A6-61A4-06006747C13B}"/>
                </a:ext>
              </a:extLst>
            </p:cNvPr>
            <p:cNvSpPr txBox="1"/>
            <p:nvPr/>
          </p:nvSpPr>
          <p:spPr>
            <a:xfrm>
              <a:off x="1151503" y="6192152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8" name="그룹 37">
            <a:extLst>
              <a:ext uri="{FF2B5EF4-FFF2-40B4-BE49-F238E27FC236}">
                <a16:creationId xmlns:a16="http://schemas.microsoft.com/office/drawing/2014/main" id="{FA4B0885-4EE0-46A6-D080-4B662DCEBCE3}"/>
              </a:ext>
            </a:extLst>
          </p:cNvPr>
          <p:cNvGrpSpPr/>
          <p:nvPr/>
        </p:nvGrpSpPr>
        <p:grpSpPr>
          <a:xfrm>
            <a:off x="6666393" y="5903371"/>
            <a:ext cx="601796" cy="230832"/>
            <a:chOff x="1151503" y="6192152"/>
            <a:chExt cx="601796" cy="230832"/>
          </a:xfrm>
        </p:grpSpPr>
        <p:cxnSp>
          <p:nvCxnSpPr>
            <p:cNvPr id="39" name="직선 연결선 38">
              <a:extLst>
                <a:ext uri="{FF2B5EF4-FFF2-40B4-BE49-F238E27FC236}">
                  <a16:creationId xmlns:a16="http://schemas.microsoft.com/office/drawing/2014/main" id="{09B0BA2F-083D-B53C-9897-9796EB939A37}"/>
                </a:ext>
              </a:extLst>
            </p:cNvPr>
            <p:cNvCxnSpPr/>
            <p:nvPr/>
          </p:nvCxnSpPr>
          <p:spPr>
            <a:xfrm>
              <a:off x="1627464" y="6331697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214466AB-1792-01C6-42FF-4ABDF2157C54}"/>
                </a:ext>
              </a:extLst>
            </p:cNvPr>
            <p:cNvSpPr txBox="1"/>
            <p:nvPr/>
          </p:nvSpPr>
          <p:spPr>
            <a:xfrm>
              <a:off x="1151503" y="6192152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1" name="그룹 40">
            <a:extLst>
              <a:ext uri="{FF2B5EF4-FFF2-40B4-BE49-F238E27FC236}">
                <a16:creationId xmlns:a16="http://schemas.microsoft.com/office/drawing/2014/main" id="{47AA20E7-FEDF-7234-124D-E000C0399B78}"/>
              </a:ext>
            </a:extLst>
          </p:cNvPr>
          <p:cNvGrpSpPr/>
          <p:nvPr/>
        </p:nvGrpSpPr>
        <p:grpSpPr>
          <a:xfrm>
            <a:off x="8542349" y="5943130"/>
            <a:ext cx="601796" cy="230832"/>
            <a:chOff x="1151503" y="6192152"/>
            <a:chExt cx="601796" cy="230832"/>
          </a:xfrm>
        </p:grpSpPr>
        <p:cxnSp>
          <p:nvCxnSpPr>
            <p:cNvPr id="42" name="직선 연결선 41">
              <a:extLst>
                <a:ext uri="{FF2B5EF4-FFF2-40B4-BE49-F238E27FC236}">
                  <a16:creationId xmlns:a16="http://schemas.microsoft.com/office/drawing/2014/main" id="{4CE3B875-D449-A53F-7CDB-060850507E84}"/>
                </a:ext>
              </a:extLst>
            </p:cNvPr>
            <p:cNvCxnSpPr/>
            <p:nvPr/>
          </p:nvCxnSpPr>
          <p:spPr>
            <a:xfrm>
              <a:off x="1627464" y="6331697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860A79DD-D4CD-9A44-9F6D-EC8061F3B0D4}"/>
                </a:ext>
              </a:extLst>
            </p:cNvPr>
            <p:cNvSpPr txBox="1"/>
            <p:nvPr/>
          </p:nvSpPr>
          <p:spPr>
            <a:xfrm>
              <a:off x="1151503" y="6192152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4" name="그룹 43">
            <a:extLst>
              <a:ext uri="{FF2B5EF4-FFF2-40B4-BE49-F238E27FC236}">
                <a16:creationId xmlns:a16="http://schemas.microsoft.com/office/drawing/2014/main" id="{1A234A92-5A6F-28A6-B924-8FCFD4B61DC1}"/>
              </a:ext>
            </a:extLst>
          </p:cNvPr>
          <p:cNvGrpSpPr/>
          <p:nvPr/>
        </p:nvGrpSpPr>
        <p:grpSpPr>
          <a:xfrm>
            <a:off x="4926184" y="732536"/>
            <a:ext cx="601796" cy="230832"/>
            <a:chOff x="748831" y="5499416"/>
            <a:chExt cx="601796" cy="230832"/>
          </a:xfrm>
        </p:grpSpPr>
        <p:cxnSp>
          <p:nvCxnSpPr>
            <p:cNvPr id="45" name="직선 연결선 44">
              <a:extLst>
                <a:ext uri="{FF2B5EF4-FFF2-40B4-BE49-F238E27FC236}">
                  <a16:creationId xmlns:a16="http://schemas.microsoft.com/office/drawing/2014/main" id="{12A2769C-A2BB-2704-83CA-E19EDAA7DB2A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E299D727-892A-5FF0-A231-3A531EF36C6D}"/>
                </a:ext>
              </a:extLst>
            </p:cNvPr>
            <p:cNvSpPr txBox="1"/>
            <p:nvPr/>
          </p:nvSpPr>
          <p:spPr>
            <a:xfrm>
              <a:off x="748831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7" name="그룹 46">
            <a:extLst>
              <a:ext uri="{FF2B5EF4-FFF2-40B4-BE49-F238E27FC236}">
                <a16:creationId xmlns:a16="http://schemas.microsoft.com/office/drawing/2014/main" id="{20837A88-D620-F561-9A9C-98A0B1C1EEE3}"/>
              </a:ext>
            </a:extLst>
          </p:cNvPr>
          <p:cNvGrpSpPr/>
          <p:nvPr/>
        </p:nvGrpSpPr>
        <p:grpSpPr>
          <a:xfrm>
            <a:off x="6658789" y="731857"/>
            <a:ext cx="601796" cy="230832"/>
            <a:chOff x="748831" y="5499416"/>
            <a:chExt cx="601796" cy="230832"/>
          </a:xfrm>
        </p:grpSpPr>
        <p:cxnSp>
          <p:nvCxnSpPr>
            <p:cNvPr id="48" name="직선 연결선 47">
              <a:extLst>
                <a:ext uri="{FF2B5EF4-FFF2-40B4-BE49-F238E27FC236}">
                  <a16:creationId xmlns:a16="http://schemas.microsoft.com/office/drawing/2014/main" id="{F6C45402-5F12-95E8-BCCE-9FAC123B2890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FE928AB5-18FE-0A4B-67BF-B27157B9B184}"/>
                </a:ext>
              </a:extLst>
            </p:cNvPr>
            <p:cNvSpPr txBox="1"/>
            <p:nvPr/>
          </p:nvSpPr>
          <p:spPr>
            <a:xfrm>
              <a:off x="748831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그룹 49">
            <a:extLst>
              <a:ext uri="{FF2B5EF4-FFF2-40B4-BE49-F238E27FC236}">
                <a16:creationId xmlns:a16="http://schemas.microsoft.com/office/drawing/2014/main" id="{D56466B7-A9A0-9804-9A16-E2D72831474C}"/>
              </a:ext>
            </a:extLst>
          </p:cNvPr>
          <p:cNvGrpSpPr/>
          <p:nvPr/>
        </p:nvGrpSpPr>
        <p:grpSpPr>
          <a:xfrm>
            <a:off x="8577307" y="699906"/>
            <a:ext cx="601796" cy="230832"/>
            <a:chOff x="748831" y="5499416"/>
            <a:chExt cx="601796" cy="230832"/>
          </a:xfrm>
        </p:grpSpPr>
        <p:cxnSp>
          <p:nvCxnSpPr>
            <p:cNvPr id="51" name="직선 연결선 50">
              <a:extLst>
                <a:ext uri="{FF2B5EF4-FFF2-40B4-BE49-F238E27FC236}">
                  <a16:creationId xmlns:a16="http://schemas.microsoft.com/office/drawing/2014/main" id="{CB7FFD77-7D88-3BDC-4F00-E715446131E7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BC97FC4A-0071-8554-9632-043475A5C82C}"/>
                </a:ext>
              </a:extLst>
            </p:cNvPr>
            <p:cNvSpPr txBox="1"/>
            <p:nvPr/>
          </p:nvSpPr>
          <p:spPr>
            <a:xfrm>
              <a:off x="748831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3" name="그룹 52">
            <a:extLst>
              <a:ext uri="{FF2B5EF4-FFF2-40B4-BE49-F238E27FC236}">
                <a16:creationId xmlns:a16="http://schemas.microsoft.com/office/drawing/2014/main" id="{07E0556E-0EC7-72DF-C3E0-83E7ED5DC7AF}"/>
              </a:ext>
            </a:extLst>
          </p:cNvPr>
          <p:cNvGrpSpPr/>
          <p:nvPr/>
        </p:nvGrpSpPr>
        <p:grpSpPr>
          <a:xfrm>
            <a:off x="4866853" y="2505052"/>
            <a:ext cx="669516" cy="230832"/>
            <a:chOff x="681111" y="5499416"/>
            <a:chExt cx="669516" cy="230832"/>
          </a:xfrm>
        </p:grpSpPr>
        <p:cxnSp>
          <p:nvCxnSpPr>
            <p:cNvPr id="54" name="직선 연결선 53">
              <a:extLst>
                <a:ext uri="{FF2B5EF4-FFF2-40B4-BE49-F238E27FC236}">
                  <a16:creationId xmlns:a16="http://schemas.microsoft.com/office/drawing/2014/main" id="{88E269A5-7E6C-9EE5-4383-0306411D7014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9EF02D52-0909-853A-4130-97193B3C2E7F}"/>
                </a:ext>
              </a:extLst>
            </p:cNvPr>
            <p:cNvSpPr txBox="1"/>
            <p:nvPr/>
          </p:nvSpPr>
          <p:spPr>
            <a:xfrm>
              <a:off x="681111" y="5499416"/>
              <a:ext cx="6142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6" name="그룹 55">
            <a:extLst>
              <a:ext uri="{FF2B5EF4-FFF2-40B4-BE49-F238E27FC236}">
                <a16:creationId xmlns:a16="http://schemas.microsoft.com/office/drawing/2014/main" id="{59967B3B-89E9-D76A-B5B0-3AD3B8172B65}"/>
              </a:ext>
            </a:extLst>
          </p:cNvPr>
          <p:cNvGrpSpPr/>
          <p:nvPr/>
        </p:nvGrpSpPr>
        <p:grpSpPr>
          <a:xfrm>
            <a:off x="6587957" y="2488274"/>
            <a:ext cx="669516" cy="230832"/>
            <a:chOff x="681111" y="5499416"/>
            <a:chExt cx="669516" cy="230832"/>
          </a:xfrm>
        </p:grpSpPr>
        <p:cxnSp>
          <p:nvCxnSpPr>
            <p:cNvPr id="57" name="직선 연결선 56">
              <a:extLst>
                <a:ext uri="{FF2B5EF4-FFF2-40B4-BE49-F238E27FC236}">
                  <a16:creationId xmlns:a16="http://schemas.microsoft.com/office/drawing/2014/main" id="{18A4192E-7DAD-7AAF-A3C0-AB2B0C09DCD6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A2686F89-FAA1-48BC-2D67-3064D1193862}"/>
                </a:ext>
              </a:extLst>
            </p:cNvPr>
            <p:cNvSpPr txBox="1"/>
            <p:nvPr/>
          </p:nvSpPr>
          <p:spPr>
            <a:xfrm>
              <a:off x="681111" y="5499416"/>
              <a:ext cx="6142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9" name="그룹 58">
            <a:extLst>
              <a:ext uri="{FF2B5EF4-FFF2-40B4-BE49-F238E27FC236}">
                <a16:creationId xmlns:a16="http://schemas.microsoft.com/office/drawing/2014/main" id="{5C34BF12-C5AB-1A12-E726-88BF9A590343}"/>
              </a:ext>
            </a:extLst>
          </p:cNvPr>
          <p:cNvGrpSpPr/>
          <p:nvPr/>
        </p:nvGrpSpPr>
        <p:grpSpPr>
          <a:xfrm>
            <a:off x="8483596" y="2529313"/>
            <a:ext cx="669516" cy="230832"/>
            <a:chOff x="681111" y="5499416"/>
            <a:chExt cx="669516" cy="230832"/>
          </a:xfrm>
        </p:grpSpPr>
        <p:cxnSp>
          <p:nvCxnSpPr>
            <p:cNvPr id="60" name="직선 연결선 59">
              <a:extLst>
                <a:ext uri="{FF2B5EF4-FFF2-40B4-BE49-F238E27FC236}">
                  <a16:creationId xmlns:a16="http://schemas.microsoft.com/office/drawing/2014/main" id="{6CD33981-704A-6364-8537-CE799A611ADA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C32089C6-63AB-C552-DCB5-B2D773B319BB}"/>
                </a:ext>
              </a:extLst>
            </p:cNvPr>
            <p:cNvSpPr txBox="1"/>
            <p:nvPr/>
          </p:nvSpPr>
          <p:spPr>
            <a:xfrm>
              <a:off x="681111" y="5499416"/>
              <a:ext cx="6142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2" name="그룹 61">
            <a:extLst>
              <a:ext uri="{FF2B5EF4-FFF2-40B4-BE49-F238E27FC236}">
                <a16:creationId xmlns:a16="http://schemas.microsoft.com/office/drawing/2014/main" id="{5F17EA6D-2EC3-C8AF-86A3-F9C16E0DD3F7}"/>
              </a:ext>
            </a:extLst>
          </p:cNvPr>
          <p:cNvGrpSpPr/>
          <p:nvPr/>
        </p:nvGrpSpPr>
        <p:grpSpPr>
          <a:xfrm>
            <a:off x="4926183" y="1582169"/>
            <a:ext cx="609834" cy="230832"/>
            <a:chOff x="740793" y="5499416"/>
            <a:chExt cx="609834" cy="230832"/>
          </a:xfrm>
        </p:grpSpPr>
        <p:cxnSp>
          <p:nvCxnSpPr>
            <p:cNvPr id="63" name="직선 연결선 62">
              <a:extLst>
                <a:ext uri="{FF2B5EF4-FFF2-40B4-BE49-F238E27FC236}">
                  <a16:creationId xmlns:a16="http://schemas.microsoft.com/office/drawing/2014/main" id="{DEE3A3D1-2FB1-BA43-A577-BFFED986B94F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D239BF71-0048-A405-E82A-5B3BD4425B53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5" name="그룹 64">
            <a:extLst>
              <a:ext uri="{FF2B5EF4-FFF2-40B4-BE49-F238E27FC236}">
                <a16:creationId xmlns:a16="http://schemas.microsoft.com/office/drawing/2014/main" id="{14F01099-46CE-5571-81F0-0BD6AF2A9A8B}"/>
              </a:ext>
            </a:extLst>
          </p:cNvPr>
          <p:cNvGrpSpPr/>
          <p:nvPr/>
        </p:nvGrpSpPr>
        <p:grpSpPr>
          <a:xfrm>
            <a:off x="6648161" y="1590782"/>
            <a:ext cx="609834" cy="230832"/>
            <a:chOff x="740793" y="5499416"/>
            <a:chExt cx="609834" cy="230832"/>
          </a:xfrm>
        </p:grpSpPr>
        <p:cxnSp>
          <p:nvCxnSpPr>
            <p:cNvPr id="66" name="직선 연결선 65">
              <a:extLst>
                <a:ext uri="{FF2B5EF4-FFF2-40B4-BE49-F238E27FC236}">
                  <a16:creationId xmlns:a16="http://schemas.microsoft.com/office/drawing/2014/main" id="{E2DE143C-75C4-125C-13A9-DB6C56EDF1C6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0462CB61-355F-F6C9-EADD-545A89D78EBC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8" name="그룹 67">
            <a:extLst>
              <a:ext uri="{FF2B5EF4-FFF2-40B4-BE49-F238E27FC236}">
                <a16:creationId xmlns:a16="http://schemas.microsoft.com/office/drawing/2014/main" id="{117FA0DE-5CB4-B33A-C4D6-91EF0BB04F13}"/>
              </a:ext>
            </a:extLst>
          </p:cNvPr>
          <p:cNvGrpSpPr/>
          <p:nvPr/>
        </p:nvGrpSpPr>
        <p:grpSpPr>
          <a:xfrm>
            <a:off x="8547465" y="1549095"/>
            <a:ext cx="609834" cy="230832"/>
            <a:chOff x="740793" y="5499416"/>
            <a:chExt cx="609834" cy="230832"/>
          </a:xfrm>
        </p:grpSpPr>
        <p:cxnSp>
          <p:nvCxnSpPr>
            <p:cNvPr id="69" name="직선 연결선 68">
              <a:extLst>
                <a:ext uri="{FF2B5EF4-FFF2-40B4-BE49-F238E27FC236}">
                  <a16:creationId xmlns:a16="http://schemas.microsoft.com/office/drawing/2014/main" id="{8963CC7B-2E0D-0F72-602C-F50273B83E18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9C1BC150-4759-B2EB-60D1-A78C61BAD5CC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1" name="그룹 70">
            <a:extLst>
              <a:ext uri="{FF2B5EF4-FFF2-40B4-BE49-F238E27FC236}">
                <a16:creationId xmlns:a16="http://schemas.microsoft.com/office/drawing/2014/main" id="{E38D0688-9014-DB14-7857-FD2F9AACA8C9}"/>
              </a:ext>
            </a:extLst>
          </p:cNvPr>
          <p:cNvGrpSpPr/>
          <p:nvPr/>
        </p:nvGrpSpPr>
        <p:grpSpPr>
          <a:xfrm>
            <a:off x="4930062" y="3620811"/>
            <a:ext cx="601796" cy="230832"/>
            <a:chOff x="1151503" y="6192152"/>
            <a:chExt cx="601796" cy="230832"/>
          </a:xfrm>
        </p:grpSpPr>
        <p:cxnSp>
          <p:nvCxnSpPr>
            <p:cNvPr id="72" name="직선 연결선 71">
              <a:extLst>
                <a:ext uri="{FF2B5EF4-FFF2-40B4-BE49-F238E27FC236}">
                  <a16:creationId xmlns:a16="http://schemas.microsoft.com/office/drawing/2014/main" id="{E9D25CA5-D5EB-C4F4-CEAD-90A50C5C51CE}"/>
                </a:ext>
              </a:extLst>
            </p:cNvPr>
            <p:cNvCxnSpPr/>
            <p:nvPr/>
          </p:nvCxnSpPr>
          <p:spPr>
            <a:xfrm>
              <a:off x="1627464" y="6331697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3AF17A3D-ED89-8E3B-CDB2-8E40D3C8D877}"/>
                </a:ext>
              </a:extLst>
            </p:cNvPr>
            <p:cNvSpPr txBox="1"/>
            <p:nvPr/>
          </p:nvSpPr>
          <p:spPr>
            <a:xfrm>
              <a:off x="1151503" y="6192152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4" name="그룹 73">
            <a:extLst>
              <a:ext uri="{FF2B5EF4-FFF2-40B4-BE49-F238E27FC236}">
                <a16:creationId xmlns:a16="http://schemas.microsoft.com/office/drawing/2014/main" id="{FBA06E23-6E68-AF6C-4639-C6A98E19075F}"/>
              </a:ext>
            </a:extLst>
          </p:cNvPr>
          <p:cNvGrpSpPr/>
          <p:nvPr/>
        </p:nvGrpSpPr>
        <p:grpSpPr>
          <a:xfrm>
            <a:off x="6665228" y="3628959"/>
            <a:ext cx="601796" cy="230832"/>
            <a:chOff x="1151503" y="6192152"/>
            <a:chExt cx="601796" cy="230832"/>
          </a:xfrm>
        </p:grpSpPr>
        <p:cxnSp>
          <p:nvCxnSpPr>
            <p:cNvPr id="75" name="직선 연결선 74">
              <a:extLst>
                <a:ext uri="{FF2B5EF4-FFF2-40B4-BE49-F238E27FC236}">
                  <a16:creationId xmlns:a16="http://schemas.microsoft.com/office/drawing/2014/main" id="{78F3DB74-27C6-A72B-D7FB-8E951E3EA1E0}"/>
                </a:ext>
              </a:extLst>
            </p:cNvPr>
            <p:cNvCxnSpPr/>
            <p:nvPr/>
          </p:nvCxnSpPr>
          <p:spPr>
            <a:xfrm>
              <a:off x="1627464" y="6331697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5CA4D7F3-9762-296C-876F-89E1F4149D93}"/>
                </a:ext>
              </a:extLst>
            </p:cNvPr>
            <p:cNvSpPr txBox="1"/>
            <p:nvPr/>
          </p:nvSpPr>
          <p:spPr>
            <a:xfrm>
              <a:off x="1151503" y="6192152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7" name="그룹 76">
            <a:extLst>
              <a:ext uri="{FF2B5EF4-FFF2-40B4-BE49-F238E27FC236}">
                <a16:creationId xmlns:a16="http://schemas.microsoft.com/office/drawing/2014/main" id="{996741AF-D559-7459-1D38-27B2A7E3F388}"/>
              </a:ext>
            </a:extLst>
          </p:cNvPr>
          <p:cNvGrpSpPr/>
          <p:nvPr/>
        </p:nvGrpSpPr>
        <p:grpSpPr>
          <a:xfrm>
            <a:off x="8483596" y="2370745"/>
            <a:ext cx="669516" cy="230832"/>
            <a:chOff x="681111" y="5499416"/>
            <a:chExt cx="669516" cy="230832"/>
          </a:xfrm>
        </p:grpSpPr>
        <p:cxnSp>
          <p:nvCxnSpPr>
            <p:cNvPr id="78" name="직선 연결선 77">
              <a:extLst>
                <a:ext uri="{FF2B5EF4-FFF2-40B4-BE49-F238E27FC236}">
                  <a16:creationId xmlns:a16="http://schemas.microsoft.com/office/drawing/2014/main" id="{6778A245-E167-92C9-A835-DF9A865BA83A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E3B85EFA-FF35-90B4-6FD4-3AD1A0A230F4}"/>
                </a:ext>
              </a:extLst>
            </p:cNvPr>
            <p:cNvSpPr txBox="1"/>
            <p:nvPr/>
          </p:nvSpPr>
          <p:spPr>
            <a:xfrm>
              <a:off x="681111" y="5499416"/>
              <a:ext cx="6142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80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0" name="그룹 79">
            <a:extLst>
              <a:ext uri="{FF2B5EF4-FFF2-40B4-BE49-F238E27FC236}">
                <a16:creationId xmlns:a16="http://schemas.microsoft.com/office/drawing/2014/main" id="{55167D9B-5D2A-1D3B-AD95-2663083B86DC}"/>
              </a:ext>
            </a:extLst>
          </p:cNvPr>
          <p:cNvGrpSpPr/>
          <p:nvPr/>
        </p:nvGrpSpPr>
        <p:grpSpPr>
          <a:xfrm>
            <a:off x="8536792" y="3568907"/>
            <a:ext cx="601796" cy="230832"/>
            <a:chOff x="1151503" y="6192152"/>
            <a:chExt cx="601796" cy="230832"/>
          </a:xfrm>
        </p:grpSpPr>
        <p:cxnSp>
          <p:nvCxnSpPr>
            <p:cNvPr id="81" name="직선 연결선 80">
              <a:extLst>
                <a:ext uri="{FF2B5EF4-FFF2-40B4-BE49-F238E27FC236}">
                  <a16:creationId xmlns:a16="http://schemas.microsoft.com/office/drawing/2014/main" id="{9F386AC2-6087-84FD-0821-D0DB4484ACDF}"/>
                </a:ext>
              </a:extLst>
            </p:cNvPr>
            <p:cNvCxnSpPr/>
            <p:nvPr/>
          </p:nvCxnSpPr>
          <p:spPr>
            <a:xfrm>
              <a:off x="1627464" y="6331697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BC290D44-FA30-C8D5-D8CE-6C0F3835E771}"/>
                </a:ext>
              </a:extLst>
            </p:cNvPr>
            <p:cNvSpPr txBox="1"/>
            <p:nvPr/>
          </p:nvSpPr>
          <p:spPr>
            <a:xfrm>
              <a:off x="1151503" y="6192152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3" name="TextBox 82">
            <a:extLst>
              <a:ext uri="{FF2B5EF4-FFF2-40B4-BE49-F238E27FC236}">
                <a16:creationId xmlns:a16="http://schemas.microsoft.com/office/drawing/2014/main" id="{7171BB59-6EB3-4434-2312-E74AAC1B8B5F}"/>
              </a:ext>
            </a:extLst>
          </p:cNvPr>
          <p:cNvSpPr txBox="1"/>
          <p:nvPr/>
        </p:nvSpPr>
        <p:spPr>
          <a:xfrm>
            <a:off x="5563048" y="230399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1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B4E789AE-A038-6985-28F1-B1286D543039}"/>
              </a:ext>
            </a:extLst>
          </p:cNvPr>
          <p:cNvSpPr txBox="1"/>
          <p:nvPr/>
        </p:nvSpPr>
        <p:spPr>
          <a:xfrm>
            <a:off x="7275594" y="230399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2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57FF5CA3-0DBD-FF87-773C-550C64FBA4C7}"/>
              </a:ext>
            </a:extLst>
          </p:cNvPr>
          <p:cNvSpPr txBox="1"/>
          <p:nvPr/>
        </p:nvSpPr>
        <p:spPr>
          <a:xfrm>
            <a:off x="9188673" y="236856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3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A470CA39-D29B-6129-1C85-AF43097F31D0}"/>
              </a:ext>
            </a:extLst>
          </p:cNvPr>
          <p:cNvSpPr txBox="1"/>
          <p:nvPr/>
        </p:nvSpPr>
        <p:spPr>
          <a:xfrm>
            <a:off x="5563048" y="4735066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1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BFDEA38B-6C98-ECD4-1407-43307A677028}"/>
              </a:ext>
            </a:extLst>
          </p:cNvPr>
          <p:cNvSpPr txBox="1"/>
          <p:nvPr/>
        </p:nvSpPr>
        <p:spPr>
          <a:xfrm>
            <a:off x="7275594" y="4735066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2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F9D04FC2-7D1E-9876-D7FA-7C44F19732F5}"/>
              </a:ext>
            </a:extLst>
          </p:cNvPr>
          <p:cNvSpPr txBox="1"/>
          <p:nvPr/>
        </p:nvSpPr>
        <p:spPr>
          <a:xfrm>
            <a:off x="9188673" y="4741523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3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BE990ED3-3B5A-DDCA-0923-194B07943B95}"/>
              </a:ext>
            </a:extLst>
          </p:cNvPr>
          <p:cNvSpPr txBox="1"/>
          <p:nvPr/>
        </p:nvSpPr>
        <p:spPr>
          <a:xfrm>
            <a:off x="34924" y="41837"/>
            <a:ext cx="3268678" cy="14157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Arial" panose="020B0604020202020204" pitchFamily="34" charset="0"/>
                <a:cs typeface="Arial" panose="020B0604020202020204" pitchFamily="34" charset="0"/>
              </a:rPr>
              <a:t>Original gel images of Figure 3</a:t>
            </a:r>
            <a:r>
              <a:rPr lang="en-US" altLang="ko-KR" sz="1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endParaRPr lang="en-US" altLang="ko-KR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ll experiments were performed in triplicates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The red boxes indicate the figures in the main text.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CFB99AFB-9B1C-0F10-CD74-D4F555E0D705}"/>
              </a:ext>
            </a:extLst>
          </p:cNvPr>
          <p:cNvSpPr txBox="1"/>
          <p:nvPr/>
        </p:nvSpPr>
        <p:spPr>
          <a:xfrm>
            <a:off x="3740331" y="241594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47DF6C86-65B5-0BCA-A5BE-D9BDDE135CB7}"/>
              </a:ext>
            </a:extLst>
          </p:cNvPr>
          <p:cNvSpPr txBox="1"/>
          <p:nvPr/>
        </p:nvSpPr>
        <p:spPr>
          <a:xfrm>
            <a:off x="3740331" y="4576231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4076A034-CBA8-6C65-105D-30B3EDD1AFCF}"/>
              </a:ext>
            </a:extLst>
          </p:cNvPr>
          <p:cNvSpPr txBox="1"/>
          <p:nvPr/>
        </p:nvSpPr>
        <p:spPr>
          <a:xfrm>
            <a:off x="4698652" y="3986280"/>
            <a:ext cx="9348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litinib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BF8CE6D7-3855-C169-AAA8-2BB46C60612C}"/>
              </a:ext>
            </a:extLst>
          </p:cNvPr>
          <p:cNvSpPr txBox="1"/>
          <p:nvPr/>
        </p:nvSpPr>
        <p:spPr>
          <a:xfrm>
            <a:off x="5618406" y="3986280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7D020654-981D-2A0B-B41A-041F87B8D2B4}"/>
              </a:ext>
            </a:extLst>
          </p:cNvPr>
          <p:cNvSpPr txBox="1"/>
          <p:nvPr/>
        </p:nvSpPr>
        <p:spPr>
          <a:xfrm>
            <a:off x="5787798" y="398628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E5A06917-F849-9388-AD1E-2B8C2B39B9EE}"/>
              </a:ext>
            </a:extLst>
          </p:cNvPr>
          <p:cNvSpPr txBox="1"/>
          <p:nvPr/>
        </p:nvSpPr>
        <p:spPr>
          <a:xfrm>
            <a:off x="6047870" y="3986280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71FD5DAC-7A99-E136-9971-7929D6EF46DB}"/>
              </a:ext>
            </a:extLst>
          </p:cNvPr>
          <p:cNvSpPr txBox="1"/>
          <p:nvPr/>
        </p:nvSpPr>
        <p:spPr>
          <a:xfrm>
            <a:off x="6463312" y="3986280"/>
            <a:ext cx="9348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litinib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50CBC57B-B65E-B537-B9CB-7FD39B3AF659}"/>
              </a:ext>
            </a:extLst>
          </p:cNvPr>
          <p:cNvSpPr txBox="1"/>
          <p:nvPr/>
        </p:nvSpPr>
        <p:spPr>
          <a:xfrm>
            <a:off x="7383066" y="3986280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245F2D8C-B282-E487-0771-81AB5680B6E0}"/>
              </a:ext>
            </a:extLst>
          </p:cNvPr>
          <p:cNvSpPr txBox="1"/>
          <p:nvPr/>
        </p:nvSpPr>
        <p:spPr>
          <a:xfrm>
            <a:off x="7552458" y="398628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B4229E27-E294-4B72-2EA9-0E14A6CA3FB3}"/>
              </a:ext>
            </a:extLst>
          </p:cNvPr>
          <p:cNvSpPr txBox="1"/>
          <p:nvPr/>
        </p:nvSpPr>
        <p:spPr>
          <a:xfrm>
            <a:off x="7812530" y="3986280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EC99C0AB-6DCE-AE95-1EED-17683F2931AE}"/>
              </a:ext>
            </a:extLst>
          </p:cNvPr>
          <p:cNvSpPr txBox="1"/>
          <p:nvPr/>
        </p:nvSpPr>
        <p:spPr>
          <a:xfrm>
            <a:off x="8314760" y="3986280"/>
            <a:ext cx="9348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litinib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4EF48FB1-086D-D1FA-B3C7-D0695261B404}"/>
              </a:ext>
            </a:extLst>
          </p:cNvPr>
          <p:cNvSpPr txBox="1"/>
          <p:nvPr/>
        </p:nvSpPr>
        <p:spPr>
          <a:xfrm>
            <a:off x="9234514" y="3986280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EDF23037-28A6-A32F-F6F7-54D4494B0C36}"/>
              </a:ext>
            </a:extLst>
          </p:cNvPr>
          <p:cNvSpPr txBox="1"/>
          <p:nvPr/>
        </p:nvSpPr>
        <p:spPr>
          <a:xfrm>
            <a:off x="9403906" y="398628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61FB9606-F294-F81F-81C1-FC564CB224FA}"/>
              </a:ext>
            </a:extLst>
          </p:cNvPr>
          <p:cNvSpPr txBox="1"/>
          <p:nvPr/>
        </p:nvSpPr>
        <p:spPr>
          <a:xfrm>
            <a:off x="9663978" y="3986280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104EDAAD-B345-9C2F-6F5B-69ADEE980A8D}"/>
              </a:ext>
            </a:extLst>
          </p:cNvPr>
          <p:cNvSpPr txBox="1"/>
          <p:nvPr/>
        </p:nvSpPr>
        <p:spPr>
          <a:xfrm>
            <a:off x="5621578" y="6308877"/>
            <a:ext cx="2279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41CE151C-726F-7A1F-B9AE-D4F27020E0A3}"/>
              </a:ext>
            </a:extLst>
          </p:cNvPr>
          <p:cNvSpPr txBox="1"/>
          <p:nvPr/>
        </p:nvSpPr>
        <p:spPr>
          <a:xfrm>
            <a:off x="5761707" y="6309267"/>
            <a:ext cx="2600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DB55AFEE-6072-E200-8589-1367BF6D50AF}"/>
              </a:ext>
            </a:extLst>
          </p:cNvPr>
          <p:cNvSpPr txBox="1"/>
          <p:nvPr/>
        </p:nvSpPr>
        <p:spPr>
          <a:xfrm>
            <a:off x="5909538" y="6309382"/>
            <a:ext cx="2600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D491126B-EBF0-8538-5528-AD0CC52D46CC}"/>
              </a:ext>
            </a:extLst>
          </p:cNvPr>
          <p:cNvSpPr txBox="1"/>
          <p:nvPr/>
        </p:nvSpPr>
        <p:spPr>
          <a:xfrm>
            <a:off x="4575054" y="6319483"/>
            <a:ext cx="108234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litinib (1 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G132 (10 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E1FAE83C-46B2-F2CD-A39E-4458839B4732}"/>
              </a:ext>
            </a:extLst>
          </p:cNvPr>
          <p:cNvSpPr txBox="1"/>
          <p:nvPr/>
        </p:nvSpPr>
        <p:spPr>
          <a:xfrm>
            <a:off x="6071735" y="6308877"/>
            <a:ext cx="2600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40438C63-35AD-4DB7-09F7-119963ECCC03}"/>
              </a:ext>
            </a:extLst>
          </p:cNvPr>
          <p:cNvSpPr txBox="1"/>
          <p:nvPr/>
        </p:nvSpPr>
        <p:spPr>
          <a:xfrm>
            <a:off x="7386044" y="6308877"/>
            <a:ext cx="2279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252779E5-D3FA-DF69-A83C-11AF7DFB9711}"/>
              </a:ext>
            </a:extLst>
          </p:cNvPr>
          <p:cNvSpPr txBox="1"/>
          <p:nvPr/>
        </p:nvSpPr>
        <p:spPr>
          <a:xfrm>
            <a:off x="7526173" y="6309267"/>
            <a:ext cx="2600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0969A2B3-B9C8-D703-466E-B8F39BA1CD64}"/>
              </a:ext>
            </a:extLst>
          </p:cNvPr>
          <p:cNvSpPr txBox="1"/>
          <p:nvPr/>
        </p:nvSpPr>
        <p:spPr>
          <a:xfrm>
            <a:off x="7674004" y="6309382"/>
            <a:ext cx="2600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EC3E0D94-FC25-62BD-6AE9-21A585F81FAF}"/>
              </a:ext>
            </a:extLst>
          </p:cNvPr>
          <p:cNvSpPr txBox="1"/>
          <p:nvPr/>
        </p:nvSpPr>
        <p:spPr>
          <a:xfrm>
            <a:off x="6339520" y="6319483"/>
            <a:ext cx="108234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litinib (1 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G132 (10 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7B48254D-E55A-847C-6236-A00FE2EAAE85}"/>
              </a:ext>
            </a:extLst>
          </p:cNvPr>
          <p:cNvSpPr txBox="1"/>
          <p:nvPr/>
        </p:nvSpPr>
        <p:spPr>
          <a:xfrm>
            <a:off x="7836201" y="6308877"/>
            <a:ext cx="2600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FC9B9FAE-B1EF-F2EE-2B63-5ECE5A46B60E}"/>
              </a:ext>
            </a:extLst>
          </p:cNvPr>
          <p:cNvSpPr txBox="1"/>
          <p:nvPr/>
        </p:nvSpPr>
        <p:spPr>
          <a:xfrm>
            <a:off x="9253079" y="6308877"/>
            <a:ext cx="2279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A454084A-DB6D-4787-3971-7883CDCC7BA9}"/>
              </a:ext>
            </a:extLst>
          </p:cNvPr>
          <p:cNvSpPr txBox="1"/>
          <p:nvPr/>
        </p:nvSpPr>
        <p:spPr>
          <a:xfrm>
            <a:off x="9393208" y="6309267"/>
            <a:ext cx="2600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46F630CA-6E53-EC98-1F12-0CF009CEB4F2}"/>
              </a:ext>
            </a:extLst>
          </p:cNvPr>
          <p:cNvSpPr txBox="1"/>
          <p:nvPr/>
        </p:nvSpPr>
        <p:spPr>
          <a:xfrm>
            <a:off x="9541039" y="6309382"/>
            <a:ext cx="2600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6A289225-320F-6230-7F64-72B344583BBC}"/>
              </a:ext>
            </a:extLst>
          </p:cNvPr>
          <p:cNvSpPr txBox="1"/>
          <p:nvPr/>
        </p:nvSpPr>
        <p:spPr>
          <a:xfrm>
            <a:off x="8206555" y="6319483"/>
            <a:ext cx="108234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litinib (1 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G132 (10 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2F24DDF5-B81E-2C2F-1EF0-93E3C2F8BD53}"/>
              </a:ext>
            </a:extLst>
          </p:cNvPr>
          <p:cNvSpPr txBox="1"/>
          <p:nvPr/>
        </p:nvSpPr>
        <p:spPr>
          <a:xfrm>
            <a:off x="9703236" y="6308877"/>
            <a:ext cx="2600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123" name="직선 화살표 연결선 122">
            <a:extLst>
              <a:ext uri="{FF2B5EF4-FFF2-40B4-BE49-F238E27FC236}">
                <a16:creationId xmlns:a16="http://schemas.microsoft.com/office/drawing/2014/main" id="{548BA0B2-1DCD-7E24-5937-2F8C9CE7F60A}"/>
              </a:ext>
            </a:extLst>
          </p:cNvPr>
          <p:cNvCxnSpPr>
            <a:cxnSpLocks/>
          </p:cNvCxnSpPr>
          <p:nvPr/>
        </p:nvCxnSpPr>
        <p:spPr>
          <a:xfrm flipH="1">
            <a:off x="8116408" y="1726275"/>
            <a:ext cx="12044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5" name="그림 124">
            <a:extLst>
              <a:ext uri="{FF2B5EF4-FFF2-40B4-BE49-F238E27FC236}">
                <a16:creationId xmlns:a16="http://schemas.microsoft.com/office/drawing/2014/main" id="{33A64518-D479-3A20-2ACF-4543187F07F3}"/>
              </a:ext>
            </a:extLst>
          </p:cNvPr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9179103" y="494805"/>
            <a:ext cx="865707" cy="707197"/>
          </a:xfrm>
          <a:prstGeom prst="rect">
            <a:avLst/>
          </a:prstGeom>
        </p:spPr>
      </p:pic>
      <p:pic>
        <p:nvPicPr>
          <p:cNvPr id="126" name="그림 125">
            <a:extLst>
              <a:ext uri="{FF2B5EF4-FFF2-40B4-BE49-F238E27FC236}">
                <a16:creationId xmlns:a16="http://schemas.microsoft.com/office/drawing/2014/main" id="{87B8A5A2-9849-E8B0-9AED-244E9F195FDA}"/>
              </a:ext>
            </a:extLst>
          </p:cNvPr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9159368" y="1419664"/>
            <a:ext cx="865707" cy="609653"/>
          </a:xfrm>
          <a:prstGeom prst="rect">
            <a:avLst/>
          </a:prstGeom>
        </p:spPr>
      </p:pic>
      <p:pic>
        <p:nvPicPr>
          <p:cNvPr id="127" name="그림 126">
            <a:extLst>
              <a:ext uri="{FF2B5EF4-FFF2-40B4-BE49-F238E27FC236}">
                <a16:creationId xmlns:a16="http://schemas.microsoft.com/office/drawing/2014/main" id="{70721D3F-53E9-F3A9-8D4E-829E396C8DB9}"/>
              </a:ext>
            </a:extLst>
          </p:cNvPr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9173666" y="2177237"/>
            <a:ext cx="859611" cy="883997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B2469F47-08B1-F590-7174-C742C77869A4}"/>
              </a:ext>
            </a:extLst>
          </p:cNvPr>
          <p:cNvPicPr>
            <a:picLocks noChangeAspect="1"/>
          </p:cNvPicPr>
          <p:nvPr/>
        </p:nvPicPr>
        <p:blipFill>
          <a:blip r:embed="rId34"/>
          <a:stretch>
            <a:fillRect/>
          </a:stretch>
        </p:blipFill>
        <p:spPr>
          <a:xfrm>
            <a:off x="9170617" y="3242511"/>
            <a:ext cx="865707" cy="713294"/>
          </a:xfrm>
          <a:prstGeom prst="rect">
            <a:avLst/>
          </a:prstGeom>
        </p:spPr>
      </p:pic>
      <p:sp>
        <p:nvSpPr>
          <p:cNvPr id="2" name="직사각형 1">
            <a:extLst>
              <a:ext uri="{FF2B5EF4-FFF2-40B4-BE49-F238E27FC236}">
                <a16:creationId xmlns:a16="http://schemas.microsoft.com/office/drawing/2014/main" id="{8BF7C0DF-84AA-4015-B4DB-EEA9401793B9}"/>
              </a:ext>
            </a:extLst>
          </p:cNvPr>
          <p:cNvSpPr/>
          <p:nvPr/>
        </p:nvSpPr>
        <p:spPr>
          <a:xfrm>
            <a:off x="5586294" y="741116"/>
            <a:ext cx="753226" cy="221571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4" name="직사각형 123">
            <a:extLst>
              <a:ext uri="{FF2B5EF4-FFF2-40B4-BE49-F238E27FC236}">
                <a16:creationId xmlns:a16="http://schemas.microsoft.com/office/drawing/2014/main" id="{106F0300-64AD-4152-9331-1DB2450BB08D}"/>
              </a:ext>
            </a:extLst>
          </p:cNvPr>
          <p:cNvSpPr/>
          <p:nvPr/>
        </p:nvSpPr>
        <p:spPr>
          <a:xfrm>
            <a:off x="5633523" y="1655089"/>
            <a:ext cx="705997" cy="166525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8" name="직사각형 127">
            <a:extLst>
              <a:ext uri="{FF2B5EF4-FFF2-40B4-BE49-F238E27FC236}">
                <a16:creationId xmlns:a16="http://schemas.microsoft.com/office/drawing/2014/main" id="{1654E717-00A1-45E6-A109-5B2C3A2C67B5}"/>
              </a:ext>
            </a:extLst>
          </p:cNvPr>
          <p:cNvSpPr/>
          <p:nvPr/>
        </p:nvSpPr>
        <p:spPr>
          <a:xfrm>
            <a:off x="5657404" y="2524228"/>
            <a:ext cx="645666" cy="166525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9" name="직사각형 128">
            <a:extLst>
              <a:ext uri="{FF2B5EF4-FFF2-40B4-BE49-F238E27FC236}">
                <a16:creationId xmlns:a16="http://schemas.microsoft.com/office/drawing/2014/main" id="{23EBEDEA-CE1D-43FE-960F-7CEC1A36BE91}"/>
              </a:ext>
            </a:extLst>
          </p:cNvPr>
          <p:cNvSpPr/>
          <p:nvPr/>
        </p:nvSpPr>
        <p:spPr>
          <a:xfrm>
            <a:off x="5614701" y="3583635"/>
            <a:ext cx="705997" cy="166525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0" name="직사각형 129">
            <a:extLst>
              <a:ext uri="{FF2B5EF4-FFF2-40B4-BE49-F238E27FC236}">
                <a16:creationId xmlns:a16="http://schemas.microsoft.com/office/drawing/2014/main" id="{3822B87B-9FAA-4A00-9A24-272814D0359B}"/>
              </a:ext>
            </a:extLst>
          </p:cNvPr>
          <p:cNvSpPr/>
          <p:nvPr/>
        </p:nvSpPr>
        <p:spPr>
          <a:xfrm>
            <a:off x="5556539" y="5299231"/>
            <a:ext cx="813654" cy="179150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1" name="직사각형 130">
            <a:extLst>
              <a:ext uri="{FF2B5EF4-FFF2-40B4-BE49-F238E27FC236}">
                <a16:creationId xmlns:a16="http://schemas.microsoft.com/office/drawing/2014/main" id="{305B36BF-80A8-4D9C-8586-BC5D33EF5DF9}"/>
              </a:ext>
            </a:extLst>
          </p:cNvPr>
          <p:cNvSpPr/>
          <p:nvPr/>
        </p:nvSpPr>
        <p:spPr>
          <a:xfrm>
            <a:off x="5595355" y="5967689"/>
            <a:ext cx="707714" cy="187589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55207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개체 3">
            <a:extLst>
              <a:ext uri="{FF2B5EF4-FFF2-40B4-BE49-F238E27FC236}">
                <a16:creationId xmlns:a16="http://schemas.microsoft.com/office/drawing/2014/main" id="{C643638E-7592-25D9-1BEB-DB4E37B62FB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71215773"/>
              </p:ext>
            </p:extLst>
          </p:nvPr>
        </p:nvGraphicFramePr>
        <p:xfrm>
          <a:off x="3857809" y="3281379"/>
          <a:ext cx="864001" cy="5709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2" name="Image" r:id="rId3" imgW="2171160" imgH="1434600" progId="Photoshop.Image.13">
                  <p:embed/>
                </p:oleObj>
              </mc:Choice>
              <mc:Fallback>
                <p:oleObj name="Image" r:id="rId3" imgW="2171160" imgH="1434600" progId="Photoshop.Image.13">
                  <p:embed/>
                  <p:pic>
                    <p:nvPicPr>
                      <p:cNvPr id="4" name="개체 3">
                        <a:extLst>
                          <a:ext uri="{FF2B5EF4-FFF2-40B4-BE49-F238E27FC236}">
                            <a16:creationId xmlns:a16="http://schemas.microsoft.com/office/drawing/2014/main" id="{C643638E-7592-25D9-1BEB-DB4E37B62FB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857809" y="3281379"/>
                        <a:ext cx="864001" cy="5709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개체 4">
            <a:extLst>
              <a:ext uri="{FF2B5EF4-FFF2-40B4-BE49-F238E27FC236}">
                <a16:creationId xmlns:a16="http://schemas.microsoft.com/office/drawing/2014/main" id="{3CD130EE-BE91-4847-F20A-1CA3322782D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76385470"/>
              </p:ext>
            </p:extLst>
          </p:nvPr>
        </p:nvGraphicFramePr>
        <p:xfrm>
          <a:off x="3857809" y="2670488"/>
          <a:ext cx="864000" cy="5412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3" name="Image" r:id="rId5" imgW="1663200" imgH="711000" progId="Photoshop.Image.13">
                  <p:embed/>
                </p:oleObj>
              </mc:Choice>
              <mc:Fallback>
                <p:oleObj name="Image" r:id="rId5" imgW="1663200" imgH="711000" progId="Photoshop.Image.13">
                  <p:embed/>
                  <p:pic>
                    <p:nvPicPr>
                      <p:cNvPr id="5" name="개체 4">
                        <a:extLst>
                          <a:ext uri="{FF2B5EF4-FFF2-40B4-BE49-F238E27FC236}">
                            <a16:creationId xmlns:a16="http://schemas.microsoft.com/office/drawing/2014/main" id="{3CD130EE-BE91-4847-F20A-1CA3322782D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857809" y="2670488"/>
                        <a:ext cx="864000" cy="5412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개체 5">
            <a:extLst>
              <a:ext uri="{FF2B5EF4-FFF2-40B4-BE49-F238E27FC236}">
                <a16:creationId xmlns:a16="http://schemas.microsoft.com/office/drawing/2014/main" id="{A8827C7F-346C-54D1-D2A3-789929AF98B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01289448"/>
              </p:ext>
            </p:extLst>
          </p:nvPr>
        </p:nvGraphicFramePr>
        <p:xfrm>
          <a:off x="5518499" y="3281379"/>
          <a:ext cx="864000" cy="4856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4" name="Image" r:id="rId7" imgW="1942560" imgH="1091880" progId="Photoshop.Image.13">
                  <p:embed/>
                </p:oleObj>
              </mc:Choice>
              <mc:Fallback>
                <p:oleObj name="Image" r:id="rId7" imgW="1942560" imgH="1091880" progId="Photoshop.Image.13">
                  <p:embed/>
                  <p:pic>
                    <p:nvPicPr>
                      <p:cNvPr id="6" name="개체 5">
                        <a:extLst>
                          <a:ext uri="{FF2B5EF4-FFF2-40B4-BE49-F238E27FC236}">
                            <a16:creationId xmlns:a16="http://schemas.microsoft.com/office/drawing/2014/main" id="{A8827C7F-346C-54D1-D2A3-789929AF98B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518499" y="3281379"/>
                        <a:ext cx="864000" cy="4856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개체 6">
            <a:extLst>
              <a:ext uri="{FF2B5EF4-FFF2-40B4-BE49-F238E27FC236}">
                <a16:creationId xmlns:a16="http://schemas.microsoft.com/office/drawing/2014/main" id="{633C88A2-CB1D-BD7C-3A04-43BDDAA37E6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99677456"/>
              </p:ext>
            </p:extLst>
          </p:nvPr>
        </p:nvGraphicFramePr>
        <p:xfrm>
          <a:off x="5510485" y="2564244"/>
          <a:ext cx="864000" cy="4017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5" name="Image" r:id="rId9" imgW="1993320" imgH="926640" progId="Photoshop.Image.13">
                  <p:embed/>
                </p:oleObj>
              </mc:Choice>
              <mc:Fallback>
                <p:oleObj name="Image" r:id="rId9" imgW="1993320" imgH="926640" progId="Photoshop.Image.13">
                  <p:embed/>
                  <p:pic>
                    <p:nvPicPr>
                      <p:cNvPr id="7" name="개체 6">
                        <a:extLst>
                          <a:ext uri="{FF2B5EF4-FFF2-40B4-BE49-F238E27FC236}">
                            <a16:creationId xmlns:a16="http://schemas.microsoft.com/office/drawing/2014/main" id="{633C88A2-CB1D-BD7C-3A04-43BDDAA37E6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510485" y="2564244"/>
                        <a:ext cx="864000" cy="4017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A108317B-E979-2C4A-7119-8165E288CF62}"/>
              </a:ext>
            </a:extLst>
          </p:cNvPr>
          <p:cNvSpPr txBox="1"/>
          <p:nvPr/>
        </p:nvSpPr>
        <p:spPr>
          <a:xfrm>
            <a:off x="1856665" y="1971470"/>
            <a:ext cx="129833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E-cadherin (135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37AF214-9BB0-EB44-DC34-C4733B22FFA7}"/>
              </a:ext>
            </a:extLst>
          </p:cNvPr>
          <p:cNvSpPr txBox="1"/>
          <p:nvPr/>
        </p:nvSpPr>
        <p:spPr>
          <a:xfrm>
            <a:off x="1856664" y="2633342"/>
            <a:ext cx="129833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N-cadherin (140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graphicFrame>
        <p:nvGraphicFramePr>
          <p:cNvPr id="14" name="개체 13">
            <a:extLst>
              <a:ext uri="{FF2B5EF4-FFF2-40B4-BE49-F238E27FC236}">
                <a16:creationId xmlns:a16="http://schemas.microsoft.com/office/drawing/2014/main" id="{4BA11A08-E24E-B2BB-F853-A994A445326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38439429"/>
              </p:ext>
            </p:extLst>
          </p:nvPr>
        </p:nvGraphicFramePr>
        <p:xfrm>
          <a:off x="5517235" y="1971470"/>
          <a:ext cx="857250" cy="469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6" name="Image" r:id="rId11" imgW="1713960" imgH="939600" progId="Photoshop.Image.13">
                  <p:embed/>
                </p:oleObj>
              </mc:Choice>
              <mc:Fallback>
                <p:oleObj name="Image" r:id="rId11" imgW="1713960" imgH="939600" progId="Photoshop.Image.13">
                  <p:embed/>
                  <p:pic>
                    <p:nvPicPr>
                      <p:cNvPr id="14" name="개체 13">
                        <a:extLst>
                          <a:ext uri="{FF2B5EF4-FFF2-40B4-BE49-F238E27FC236}">
                            <a16:creationId xmlns:a16="http://schemas.microsoft.com/office/drawing/2014/main" id="{4BA11A08-E24E-B2BB-F853-A994A445326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5517235" y="1971470"/>
                        <a:ext cx="857250" cy="469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개체 14">
            <a:extLst>
              <a:ext uri="{FF2B5EF4-FFF2-40B4-BE49-F238E27FC236}">
                <a16:creationId xmlns:a16="http://schemas.microsoft.com/office/drawing/2014/main" id="{C0D29A8F-A2CE-CCB0-D105-0883C3714D5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02661489"/>
              </p:ext>
            </p:extLst>
          </p:nvPr>
        </p:nvGraphicFramePr>
        <p:xfrm>
          <a:off x="3854354" y="1902586"/>
          <a:ext cx="857250" cy="6912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7" name="Image" r:id="rId13" imgW="1574280" imgH="964800" progId="Photoshop.Image.13">
                  <p:embed/>
                </p:oleObj>
              </mc:Choice>
              <mc:Fallback>
                <p:oleObj name="Image" r:id="rId13" imgW="1574280" imgH="964800" progId="Photoshop.Image.13">
                  <p:embed/>
                  <p:pic>
                    <p:nvPicPr>
                      <p:cNvPr id="15" name="개체 14">
                        <a:extLst>
                          <a:ext uri="{FF2B5EF4-FFF2-40B4-BE49-F238E27FC236}">
                            <a16:creationId xmlns:a16="http://schemas.microsoft.com/office/drawing/2014/main" id="{C0D29A8F-A2CE-CCB0-D105-0883C3714D5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854354" y="1902586"/>
                        <a:ext cx="857250" cy="6912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" name="그룹 1">
            <a:extLst>
              <a:ext uri="{FF2B5EF4-FFF2-40B4-BE49-F238E27FC236}">
                <a16:creationId xmlns:a16="http://schemas.microsoft.com/office/drawing/2014/main" id="{E3A699D5-E920-64D0-EB3B-5EB91C1B5AAE}"/>
              </a:ext>
            </a:extLst>
          </p:cNvPr>
          <p:cNvGrpSpPr/>
          <p:nvPr/>
        </p:nvGrpSpPr>
        <p:grpSpPr>
          <a:xfrm>
            <a:off x="6643173" y="2529905"/>
            <a:ext cx="677189" cy="230832"/>
            <a:chOff x="673438" y="5499416"/>
            <a:chExt cx="677189" cy="230832"/>
          </a:xfrm>
        </p:grpSpPr>
        <p:cxnSp>
          <p:nvCxnSpPr>
            <p:cNvPr id="3" name="직선 연결선 2">
              <a:extLst>
                <a:ext uri="{FF2B5EF4-FFF2-40B4-BE49-F238E27FC236}">
                  <a16:creationId xmlns:a16="http://schemas.microsoft.com/office/drawing/2014/main" id="{A3D0933A-3B24-01B8-B718-F1F43A303293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D92B7872-186B-5375-1FBE-CFFBC75E5C65}"/>
                </a:ext>
              </a:extLst>
            </p:cNvPr>
            <p:cNvSpPr txBox="1"/>
            <p:nvPr/>
          </p:nvSpPr>
          <p:spPr>
            <a:xfrm>
              <a:off x="673438" y="5499416"/>
              <a:ext cx="6142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그룹 16">
            <a:extLst>
              <a:ext uri="{FF2B5EF4-FFF2-40B4-BE49-F238E27FC236}">
                <a16:creationId xmlns:a16="http://schemas.microsoft.com/office/drawing/2014/main" id="{1CDAF443-644C-A898-B664-A93F376719B5}"/>
              </a:ext>
            </a:extLst>
          </p:cNvPr>
          <p:cNvGrpSpPr/>
          <p:nvPr/>
        </p:nvGrpSpPr>
        <p:grpSpPr>
          <a:xfrm>
            <a:off x="6643173" y="2645260"/>
            <a:ext cx="677189" cy="230832"/>
            <a:chOff x="673438" y="5499416"/>
            <a:chExt cx="677189" cy="230832"/>
          </a:xfrm>
        </p:grpSpPr>
        <p:cxnSp>
          <p:nvCxnSpPr>
            <p:cNvPr id="18" name="직선 연결선 17">
              <a:extLst>
                <a:ext uri="{FF2B5EF4-FFF2-40B4-BE49-F238E27FC236}">
                  <a16:creationId xmlns:a16="http://schemas.microsoft.com/office/drawing/2014/main" id="{CB12CDB4-90B5-B7F2-0E7F-1E539580FF64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9646F2E-0CCD-FF43-86EB-D871A05397C7}"/>
                </a:ext>
              </a:extLst>
            </p:cNvPr>
            <p:cNvSpPr txBox="1"/>
            <p:nvPr/>
          </p:nvSpPr>
          <p:spPr>
            <a:xfrm>
              <a:off x="673438" y="5499416"/>
              <a:ext cx="6142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" name="그룹 19">
            <a:extLst>
              <a:ext uri="{FF2B5EF4-FFF2-40B4-BE49-F238E27FC236}">
                <a16:creationId xmlns:a16="http://schemas.microsoft.com/office/drawing/2014/main" id="{B671ACF1-C513-640C-1EA1-7239215C582D}"/>
              </a:ext>
            </a:extLst>
          </p:cNvPr>
          <p:cNvGrpSpPr/>
          <p:nvPr/>
        </p:nvGrpSpPr>
        <p:grpSpPr>
          <a:xfrm>
            <a:off x="6643173" y="2078147"/>
            <a:ext cx="677189" cy="230832"/>
            <a:chOff x="673438" y="5499416"/>
            <a:chExt cx="677189" cy="230832"/>
          </a:xfrm>
        </p:grpSpPr>
        <p:cxnSp>
          <p:nvCxnSpPr>
            <p:cNvPr id="21" name="직선 연결선 20">
              <a:extLst>
                <a:ext uri="{FF2B5EF4-FFF2-40B4-BE49-F238E27FC236}">
                  <a16:creationId xmlns:a16="http://schemas.microsoft.com/office/drawing/2014/main" id="{90175B06-F815-65CF-5FCC-AD9A5CED2D88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278062D0-7643-363A-875F-D5A0E8226ADC}"/>
                </a:ext>
              </a:extLst>
            </p:cNvPr>
            <p:cNvSpPr txBox="1"/>
            <p:nvPr/>
          </p:nvSpPr>
          <p:spPr>
            <a:xfrm>
              <a:off x="673438" y="5499416"/>
              <a:ext cx="6142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" name="그룹 22">
            <a:extLst>
              <a:ext uri="{FF2B5EF4-FFF2-40B4-BE49-F238E27FC236}">
                <a16:creationId xmlns:a16="http://schemas.microsoft.com/office/drawing/2014/main" id="{473D8641-B6AC-3DDF-7AD5-3085A9D06566}"/>
              </a:ext>
            </a:extLst>
          </p:cNvPr>
          <p:cNvGrpSpPr/>
          <p:nvPr/>
        </p:nvGrpSpPr>
        <p:grpSpPr>
          <a:xfrm>
            <a:off x="6643173" y="2185113"/>
            <a:ext cx="677189" cy="230832"/>
            <a:chOff x="673438" y="5499416"/>
            <a:chExt cx="677189" cy="230832"/>
          </a:xfrm>
        </p:grpSpPr>
        <p:cxnSp>
          <p:nvCxnSpPr>
            <p:cNvPr id="24" name="직선 연결선 23">
              <a:extLst>
                <a:ext uri="{FF2B5EF4-FFF2-40B4-BE49-F238E27FC236}">
                  <a16:creationId xmlns:a16="http://schemas.microsoft.com/office/drawing/2014/main" id="{01149FC4-70AF-99D7-A351-791B83DD27B0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9FA45E48-E28D-DA74-B8BE-78D2CEA351F4}"/>
                </a:ext>
              </a:extLst>
            </p:cNvPr>
            <p:cNvSpPr txBox="1"/>
            <p:nvPr/>
          </p:nvSpPr>
          <p:spPr>
            <a:xfrm>
              <a:off x="673438" y="5499416"/>
              <a:ext cx="6142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" name="그룹 25">
            <a:extLst>
              <a:ext uri="{FF2B5EF4-FFF2-40B4-BE49-F238E27FC236}">
                <a16:creationId xmlns:a16="http://schemas.microsoft.com/office/drawing/2014/main" id="{5FD102E7-7B78-31F6-BDB9-44AA0D263EA0}"/>
              </a:ext>
            </a:extLst>
          </p:cNvPr>
          <p:cNvGrpSpPr/>
          <p:nvPr/>
        </p:nvGrpSpPr>
        <p:grpSpPr>
          <a:xfrm>
            <a:off x="4840046" y="2077916"/>
            <a:ext cx="677189" cy="230832"/>
            <a:chOff x="673438" y="5499416"/>
            <a:chExt cx="677189" cy="230832"/>
          </a:xfrm>
        </p:grpSpPr>
        <p:cxnSp>
          <p:nvCxnSpPr>
            <p:cNvPr id="27" name="직선 연결선 26">
              <a:extLst>
                <a:ext uri="{FF2B5EF4-FFF2-40B4-BE49-F238E27FC236}">
                  <a16:creationId xmlns:a16="http://schemas.microsoft.com/office/drawing/2014/main" id="{D6A1243F-498A-5102-7B68-AF8811B9BC0C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574C371E-7F01-8E09-0278-61168B7CD678}"/>
                </a:ext>
              </a:extLst>
            </p:cNvPr>
            <p:cNvSpPr txBox="1"/>
            <p:nvPr/>
          </p:nvSpPr>
          <p:spPr>
            <a:xfrm>
              <a:off x="673438" y="5499416"/>
              <a:ext cx="6142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" name="그룹 28">
            <a:extLst>
              <a:ext uri="{FF2B5EF4-FFF2-40B4-BE49-F238E27FC236}">
                <a16:creationId xmlns:a16="http://schemas.microsoft.com/office/drawing/2014/main" id="{985913C1-B0D6-5D04-FE79-CD41D46E4C2B}"/>
              </a:ext>
            </a:extLst>
          </p:cNvPr>
          <p:cNvGrpSpPr/>
          <p:nvPr/>
        </p:nvGrpSpPr>
        <p:grpSpPr>
          <a:xfrm>
            <a:off x="4840046" y="2184882"/>
            <a:ext cx="677189" cy="230832"/>
            <a:chOff x="673438" y="5499416"/>
            <a:chExt cx="677189" cy="230832"/>
          </a:xfrm>
        </p:grpSpPr>
        <p:cxnSp>
          <p:nvCxnSpPr>
            <p:cNvPr id="30" name="직선 연결선 29">
              <a:extLst>
                <a:ext uri="{FF2B5EF4-FFF2-40B4-BE49-F238E27FC236}">
                  <a16:creationId xmlns:a16="http://schemas.microsoft.com/office/drawing/2014/main" id="{1A279404-F7AD-E0B9-8983-F74315D1106A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1B3256C1-769F-A2AB-F29F-D101D5690E7A}"/>
                </a:ext>
              </a:extLst>
            </p:cNvPr>
            <p:cNvSpPr txBox="1"/>
            <p:nvPr/>
          </p:nvSpPr>
          <p:spPr>
            <a:xfrm>
              <a:off x="673438" y="5499416"/>
              <a:ext cx="6142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2" name="그룹 31">
            <a:extLst>
              <a:ext uri="{FF2B5EF4-FFF2-40B4-BE49-F238E27FC236}">
                <a16:creationId xmlns:a16="http://schemas.microsoft.com/office/drawing/2014/main" id="{C33B2831-2A6F-0F70-CD73-DA3B89B4A4F4}"/>
              </a:ext>
            </a:extLst>
          </p:cNvPr>
          <p:cNvGrpSpPr/>
          <p:nvPr/>
        </p:nvGrpSpPr>
        <p:grpSpPr>
          <a:xfrm>
            <a:off x="3179026" y="2069527"/>
            <a:ext cx="677189" cy="230832"/>
            <a:chOff x="673438" y="5499416"/>
            <a:chExt cx="677189" cy="230832"/>
          </a:xfrm>
        </p:grpSpPr>
        <p:cxnSp>
          <p:nvCxnSpPr>
            <p:cNvPr id="33" name="직선 연결선 32">
              <a:extLst>
                <a:ext uri="{FF2B5EF4-FFF2-40B4-BE49-F238E27FC236}">
                  <a16:creationId xmlns:a16="http://schemas.microsoft.com/office/drawing/2014/main" id="{6590CCFD-16F2-E54C-E53E-968842481D4F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D6674E14-FBA5-D415-2573-77D3B62F70B9}"/>
                </a:ext>
              </a:extLst>
            </p:cNvPr>
            <p:cNvSpPr txBox="1"/>
            <p:nvPr/>
          </p:nvSpPr>
          <p:spPr>
            <a:xfrm>
              <a:off x="673438" y="5499416"/>
              <a:ext cx="6142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5" name="그룹 34">
            <a:extLst>
              <a:ext uri="{FF2B5EF4-FFF2-40B4-BE49-F238E27FC236}">
                <a16:creationId xmlns:a16="http://schemas.microsoft.com/office/drawing/2014/main" id="{E5C92744-81B4-6B16-89EE-1684F170A7C8}"/>
              </a:ext>
            </a:extLst>
          </p:cNvPr>
          <p:cNvGrpSpPr/>
          <p:nvPr/>
        </p:nvGrpSpPr>
        <p:grpSpPr>
          <a:xfrm>
            <a:off x="3179026" y="2176493"/>
            <a:ext cx="677189" cy="230832"/>
            <a:chOff x="673438" y="5499416"/>
            <a:chExt cx="677189" cy="230832"/>
          </a:xfrm>
        </p:grpSpPr>
        <p:cxnSp>
          <p:nvCxnSpPr>
            <p:cNvPr id="36" name="직선 연결선 35">
              <a:extLst>
                <a:ext uri="{FF2B5EF4-FFF2-40B4-BE49-F238E27FC236}">
                  <a16:creationId xmlns:a16="http://schemas.microsoft.com/office/drawing/2014/main" id="{921731EC-8566-D910-3C97-B347E59372A4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D563F31F-63FB-6AED-7F98-45A634D34E5C}"/>
                </a:ext>
              </a:extLst>
            </p:cNvPr>
            <p:cNvSpPr txBox="1"/>
            <p:nvPr/>
          </p:nvSpPr>
          <p:spPr>
            <a:xfrm>
              <a:off x="673438" y="5499416"/>
              <a:ext cx="6142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8" name="그룹 37">
            <a:extLst>
              <a:ext uri="{FF2B5EF4-FFF2-40B4-BE49-F238E27FC236}">
                <a16:creationId xmlns:a16="http://schemas.microsoft.com/office/drawing/2014/main" id="{C0E6358E-3BC6-5796-89C5-E9A3A944FA65}"/>
              </a:ext>
            </a:extLst>
          </p:cNvPr>
          <p:cNvGrpSpPr/>
          <p:nvPr/>
        </p:nvGrpSpPr>
        <p:grpSpPr>
          <a:xfrm>
            <a:off x="4840046" y="2526022"/>
            <a:ext cx="677189" cy="230832"/>
            <a:chOff x="673438" y="5499416"/>
            <a:chExt cx="677189" cy="230832"/>
          </a:xfrm>
        </p:grpSpPr>
        <p:cxnSp>
          <p:nvCxnSpPr>
            <p:cNvPr id="39" name="직선 연결선 38">
              <a:extLst>
                <a:ext uri="{FF2B5EF4-FFF2-40B4-BE49-F238E27FC236}">
                  <a16:creationId xmlns:a16="http://schemas.microsoft.com/office/drawing/2014/main" id="{FFFB7D67-BA1F-4F21-FD6C-A97A0CE1B207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381288B4-683C-F5E8-6810-6385F558D208}"/>
                </a:ext>
              </a:extLst>
            </p:cNvPr>
            <p:cNvSpPr txBox="1"/>
            <p:nvPr/>
          </p:nvSpPr>
          <p:spPr>
            <a:xfrm>
              <a:off x="673438" y="5499416"/>
              <a:ext cx="6142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1" name="그룹 40">
            <a:extLst>
              <a:ext uri="{FF2B5EF4-FFF2-40B4-BE49-F238E27FC236}">
                <a16:creationId xmlns:a16="http://schemas.microsoft.com/office/drawing/2014/main" id="{E5EFC55C-CF16-9B47-CCC6-C024CDB1E9A6}"/>
              </a:ext>
            </a:extLst>
          </p:cNvPr>
          <p:cNvGrpSpPr/>
          <p:nvPr/>
        </p:nvGrpSpPr>
        <p:grpSpPr>
          <a:xfrm>
            <a:off x="4840046" y="2641377"/>
            <a:ext cx="677189" cy="230832"/>
            <a:chOff x="673438" y="5499416"/>
            <a:chExt cx="677189" cy="230832"/>
          </a:xfrm>
        </p:grpSpPr>
        <p:cxnSp>
          <p:nvCxnSpPr>
            <p:cNvPr id="42" name="직선 연결선 41">
              <a:extLst>
                <a:ext uri="{FF2B5EF4-FFF2-40B4-BE49-F238E27FC236}">
                  <a16:creationId xmlns:a16="http://schemas.microsoft.com/office/drawing/2014/main" id="{12BA8AFC-7AA3-D898-E0AD-FE1776E29A33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F95B49B1-CFE0-1D90-0C8D-37976C6491EF}"/>
                </a:ext>
              </a:extLst>
            </p:cNvPr>
            <p:cNvSpPr txBox="1"/>
            <p:nvPr/>
          </p:nvSpPr>
          <p:spPr>
            <a:xfrm>
              <a:off x="673438" y="5499416"/>
              <a:ext cx="6142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4" name="그룹 43">
            <a:extLst>
              <a:ext uri="{FF2B5EF4-FFF2-40B4-BE49-F238E27FC236}">
                <a16:creationId xmlns:a16="http://schemas.microsoft.com/office/drawing/2014/main" id="{7AAFD186-CEB3-F5F6-6616-F7E391A47B23}"/>
              </a:ext>
            </a:extLst>
          </p:cNvPr>
          <p:cNvGrpSpPr/>
          <p:nvPr/>
        </p:nvGrpSpPr>
        <p:grpSpPr>
          <a:xfrm>
            <a:off x="3179026" y="2693802"/>
            <a:ext cx="677189" cy="230832"/>
            <a:chOff x="673438" y="5499416"/>
            <a:chExt cx="677189" cy="230832"/>
          </a:xfrm>
        </p:grpSpPr>
        <p:cxnSp>
          <p:nvCxnSpPr>
            <p:cNvPr id="45" name="직선 연결선 44">
              <a:extLst>
                <a:ext uri="{FF2B5EF4-FFF2-40B4-BE49-F238E27FC236}">
                  <a16:creationId xmlns:a16="http://schemas.microsoft.com/office/drawing/2014/main" id="{874D9009-8085-D3A8-F0BB-838F87CA9D01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6C36FDF1-FC85-F9E9-312B-202FE5DE50CA}"/>
                </a:ext>
              </a:extLst>
            </p:cNvPr>
            <p:cNvSpPr txBox="1"/>
            <p:nvPr/>
          </p:nvSpPr>
          <p:spPr>
            <a:xfrm>
              <a:off x="673438" y="5499416"/>
              <a:ext cx="6142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7" name="그룹 46">
            <a:extLst>
              <a:ext uri="{FF2B5EF4-FFF2-40B4-BE49-F238E27FC236}">
                <a16:creationId xmlns:a16="http://schemas.microsoft.com/office/drawing/2014/main" id="{CF037300-6AA4-182D-E53D-69DC6BCC077A}"/>
              </a:ext>
            </a:extLst>
          </p:cNvPr>
          <p:cNvGrpSpPr/>
          <p:nvPr/>
        </p:nvGrpSpPr>
        <p:grpSpPr>
          <a:xfrm>
            <a:off x="3179026" y="2809157"/>
            <a:ext cx="677189" cy="230832"/>
            <a:chOff x="673438" y="5499416"/>
            <a:chExt cx="677189" cy="230832"/>
          </a:xfrm>
        </p:grpSpPr>
        <p:cxnSp>
          <p:nvCxnSpPr>
            <p:cNvPr id="48" name="직선 연결선 47">
              <a:extLst>
                <a:ext uri="{FF2B5EF4-FFF2-40B4-BE49-F238E27FC236}">
                  <a16:creationId xmlns:a16="http://schemas.microsoft.com/office/drawing/2014/main" id="{55C607E4-50AC-24C8-3BD7-C5AD473D3419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FA6299BB-D836-C1A1-3CB0-C78B2CCFABD8}"/>
                </a:ext>
              </a:extLst>
            </p:cNvPr>
            <p:cNvSpPr txBox="1"/>
            <p:nvPr/>
          </p:nvSpPr>
          <p:spPr>
            <a:xfrm>
              <a:off x="673438" y="5499416"/>
              <a:ext cx="6142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0" name="TextBox 49">
            <a:extLst>
              <a:ext uri="{FF2B5EF4-FFF2-40B4-BE49-F238E27FC236}">
                <a16:creationId xmlns:a16="http://schemas.microsoft.com/office/drawing/2014/main" id="{2F8B16BF-3D46-DDE1-0CF5-98E0A9398875}"/>
              </a:ext>
            </a:extLst>
          </p:cNvPr>
          <p:cNvSpPr txBox="1"/>
          <p:nvPr/>
        </p:nvSpPr>
        <p:spPr>
          <a:xfrm>
            <a:off x="1825785" y="3428353"/>
            <a:ext cx="1329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 (41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id="{42449F6E-58E1-4C24-2097-4A4450401877}"/>
              </a:ext>
            </a:extLst>
          </p:cNvPr>
          <p:cNvCxnSpPr/>
          <p:nvPr/>
        </p:nvCxnSpPr>
        <p:spPr>
          <a:xfrm>
            <a:off x="3734257" y="3660472"/>
            <a:ext cx="12583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7FC89351-E909-9A92-D1D4-2F783E9AEED4}"/>
              </a:ext>
            </a:extLst>
          </p:cNvPr>
          <p:cNvSpPr txBox="1"/>
          <p:nvPr/>
        </p:nvSpPr>
        <p:spPr>
          <a:xfrm>
            <a:off x="3258296" y="3520927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직선 연결선 52">
            <a:extLst>
              <a:ext uri="{FF2B5EF4-FFF2-40B4-BE49-F238E27FC236}">
                <a16:creationId xmlns:a16="http://schemas.microsoft.com/office/drawing/2014/main" id="{22C37257-7A65-5637-5CA6-04A343A1386F}"/>
              </a:ext>
            </a:extLst>
          </p:cNvPr>
          <p:cNvCxnSpPr/>
          <p:nvPr/>
        </p:nvCxnSpPr>
        <p:spPr>
          <a:xfrm>
            <a:off x="5386888" y="3584971"/>
            <a:ext cx="12583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41C8950E-2610-7B7B-FC57-D52DB028C4A5}"/>
              </a:ext>
            </a:extLst>
          </p:cNvPr>
          <p:cNvSpPr txBox="1"/>
          <p:nvPr/>
        </p:nvSpPr>
        <p:spPr>
          <a:xfrm>
            <a:off x="4910927" y="3445426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직선 연결선 54">
            <a:extLst>
              <a:ext uri="{FF2B5EF4-FFF2-40B4-BE49-F238E27FC236}">
                <a16:creationId xmlns:a16="http://schemas.microsoft.com/office/drawing/2014/main" id="{445B5465-841F-3749-4D5A-7DD0E2CC781B}"/>
              </a:ext>
            </a:extLst>
          </p:cNvPr>
          <p:cNvCxnSpPr/>
          <p:nvPr/>
        </p:nvCxnSpPr>
        <p:spPr>
          <a:xfrm>
            <a:off x="7215688" y="3836641"/>
            <a:ext cx="12583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5F6CB203-1231-B052-7F54-E9EEA57C9F4B}"/>
              </a:ext>
            </a:extLst>
          </p:cNvPr>
          <p:cNvSpPr txBox="1"/>
          <p:nvPr/>
        </p:nvSpPr>
        <p:spPr>
          <a:xfrm>
            <a:off x="6739727" y="3697096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02573DFA-999A-EC28-C028-EBB3C039C566}"/>
              </a:ext>
            </a:extLst>
          </p:cNvPr>
          <p:cNvSpPr txBox="1"/>
          <p:nvPr/>
        </p:nvSpPr>
        <p:spPr>
          <a:xfrm>
            <a:off x="3930620" y="1561447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1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F302B8BD-2684-CEC7-14C7-3C23A8A1BA04}"/>
              </a:ext>
            </a:extLst>
          </p:cNvPr>
          <p:cNvSpPr txBox="1"/>
          <p:nvPr/>
        </p:nvSpPr>
        <p:spPr>
          <a:xfrm>
            <a:off x="5560007" y="1561447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2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0018258B-1730-9286-D2C7-E2A8D55BA866}"/>
              </a:ext>
            </a:extLst>
          </p:cNvPr>
          <p:cNvSpPr txBox="1"/>
          <p:nvPr/>
        </p:nvSpPr>
        <p:spPr>
          <a:xfrm>
            <a:off x="7381627" y="1567904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3</a:t>
            </a:r>
          </a:p>
        </p:txBody>
      </p:sp>
      <p:cxnSp>
        <p:nvCxnSpPr>
          <p:cNvPr id="61" name="직선 화살표 연결선 60">
            <a:extLst>
              <a:ext uri="{FF2B5EF4-FFF2-40B4-BE49-F238E27FC236}">
                <a16:creationId xmlns:a16="http://schemas.microsoft.com/office/drawing/2014/main" id="{767BB1DA-E381-2E05-8D57-CE25E35D9438}"/>
              </a:ext>
            </a:extLst>
          </p:cNvPr>
          <p:cNvCxnSpPr>
            <a:cxnSpLocks/>
          </p:cNvCxnSpPr>
          <p:nvPr/>
        </p:nvCxnSpPr>
        <p:spPr>
          <a:xfrm flipH="1">
            <a:off x="4664279" y="2189526"/>
            <a:ext cx="12044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직선 화살표 연결선 63">
            <a:extLst>
              <a:ext uri="{FF2B5EF4-FFF2-40B4-BE49-F238E27FC236}">
                <a16:creationId xmlns:a16="http://schemas.microsoft.com/office/drawing/2014/main" id="{2A917147-E430-DBAC-671E-4D37E917029E}"/>
              </a:ext>
            </a:extLst>
          </p:cNvPr>
          <p:cNvCxnSpPr>
            <a:cxnSpLocks/>
          </p:cNvCxnSpPr>
          <p:nvPr/>
        </p:nvCxnSpPr>
        <p:spPr>
          <a:xfrm flipH="1">
            <a:off x="4657929" y="2805476"/>
            <a:ext cx="12044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직선 화살표 연결선 64">
            <a:extLst>
              <a:ext uri="{FF2B5EF4-FFF2-40B4-BE49-F238E27FC236}">
                <a16:creationId xmlns:a16="http://schemas.microsoft.com/office/drawing/2014/main" id="{5719A8BE-7A50-9CEC-07B5-CC2F54680896}"/>
              </a:ext>
            </a:extLst>
          </p:cNvPr>
          <p:cNvCxnSpPr>
            <a:cxnSpLocks/>
          </p:cNvCxnSpPr>
          <p:nvPr/>
        </p:nvCxnSpPr>
        <p:spPr>
          <a:xfrm flipH="1">
            <a:off x="6321629" y="2208576"/>
            <a:ext cx="12044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직선 화살표 연결선 65">
            <a:extLst>
              <a:ext uri="{FF2B5EF4-FFF2-40B4-BE49-F238E27FC236}">
                <a16:creationId xmlns:a16="http://schemas.microsoft.com/office/drawing/2014/main" id="{BDED1238-8CB0-1AC2-6580-8CD9237DB501}"/>
              </a:ext>
            </a:extLst>
          </p:cNvPr>
          <p:cNvCxnSpPr>
            <a:cxnSpLocks/>
          </p:cNvCxnSpPr>
          <p:nvPr/>
        </p:nvCxnSpPr>
        <p:spPr>
          <a:xfrm flipH="1">
            <a:off x="6334329" y="2640376"/>
            <a:ext cx="12044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직선 화살표 연결선 66">
            <a:extLst>
              <a:ext uri="{FF2B5EF4-FFF2-40B4-BE49-F238E27FC236}">
                <a16:creationId xmlns:a16="http://schemas.microsoft.com/office/drawing/2014/main" id="{4A287652-BE64-0E16-86C3-0076249A28F1}"/>
              </a:ext>
            </a:extLst>
          </p:cNvPr>
          <p:cNvCxnSpPr>
            <a:cxnSpLocks/>
          </p:cNvCxnSpPr>
          <p:nvPr/>
        </p:nvCxnSpPr>
        <p:spPr>
          <a:xfrm flipH="1">
            <a:off x="8201229" y="2240326"/>
            <a:ext cx="12044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직선 화살표 연결선 67">
            <a:extLst>
              <a:ext uri="{FF2B5EF4-FFF2-40B4-BE49-F238E27FC236}">
                <a16:creationId xmlns:a16="http://schemas.microsoft.com/office/drawing/2014/main" id="{FF1E30EB-CCD8-7B54-517D-D398AC458DA2}"/>
              </a:ext>
            </a:extLst>
          </p:cNvPr>
          <p:cNvCxnSpPr>
            <a:cxnSpLocks/>
          </p:cNvCxnSpPr>
          <p:nvPr/>
        </p:nvCxnSpPr>
        <p:spPr>
          <a:xfrm flipH="1">
            <a:off x="8188529" y="2602276"/>
            <a:ext cx="12044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>
            <a:extLst>
              <a:ext uri="{FF2B5EF4-FFF2-40B4-BE49-F238E27FC236}">
                <a16:creationId xmlns:a16="http://schemas.microsoft.com/office/drawing/2014/main" id="{430EEAF1-ADF1-2A12-9EAD-88A486D79B78}"/>
              </a:ext>
            </a:extLst>
          </p:cNvPr>
          <p:cNvSpPr txBox="1"/>
          <p:nvPr/>
        </p:nvSpPr>
        <p:spPr>
          <a:xfrm>
            <a:off x="3036420" y="3880876"/>
            <a:ext cx="9348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litinib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1E4812D9-6694-9749-C833-E77C4C008538}"/>
              </a:ext>
            </a:extLst>
          </p:cNvPr>
          <p:cNvSpPr txBox="1"/>
          <p:nvPr/>
        </p:nvSpPr>
        <p:spPr>
          <a:xfrm>
            <a:off x="3956174" y="3880876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B3ED4403-CE6A-B7BE-C925-8ACF63226881}"/>
              </a:ext>
            </a:extLst>
          </p:cNvPr>
          <p:cNvSpPr txBox="1"/>
          <p:nvPr/>
        </p:nvSpPr>
        <p:spPr>
          <a:xfrm>
            <a:off x="4125566" y="3880876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D2B03701-4510-4109-A8F6-D7D8CDD2C964}"/>
              </a:ext>
            </a:extLst>
          </p:cNvPr>
          <p:cNvSpPr txBox="1"/>
          <p:nvPr/>
        </p:nvSpPr>
        <p:spPr>
          <a:xfrm>
            <a:off x="4385638" y="3880876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6105A8EE-5BE3-96A4-4608-E46A28F3C71E}"/>
              </a:ext>
            </a:extLst>
          </p:cNvPr>
          <p:cNvSpPr txBox="1"/>
          <p:nvPr/>
        </p:nvSpPr>
        <p:spPr>
          <a:xfrm>
            <a:off x="4705107" y="3880876"/>
            <a:ext cx="9348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litinib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8CD58D5B-CE6F-6804-A084-8B1402BD4F76}"/>
              </a:ext>
            </a:extLst>
          </p:cNvPr>
          <p:cNvSpPr txBox="1"/>
          <p:nvPr/>
        </p:nvSpPr>
        <p:spPr>
          <a:xfrm>
            <a:off x="5624861" y="3880876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B1D0B631-93EF-FC9B-C5B9-58C24122B6D6}"/>
              </a:ext>
            </a:extLst>
          </p:cNvPr>
          <p:cNvSpPr txBox="1"/>
          <p:nvPr/>
        </p:nvSpPr>
        <p:spPr>
          <a:xfrm>
            <a:off x="5794253" y="3880876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71F3255D-DD83-209D-8736-74C640F33F2A}"/>
              </a:ext>
            </a:extLst>
          </p:cNvPr>
          <p:cNvSpPr txBox="1"/>
          <p:nvPr/>
        </p:nvSpPr>
        <p:spPr>
          <a:xfrm>
            <a:off x="6054325" y="3880876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1F63D184-6863-BFC5-A31C-DA6E173737D0}"/>
              </a:ext>
            </a:extLst>
          </p:cNvPr>
          <p:cNvSpPr txBox="1"/>
          <p:nvPr/>
        </p:nvSpPr>
        <p:spPr>
          <a:xfrm>
            <a:off x="6596812" y="4321642"/>
            <a:ext cx="9348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litinib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A80F5E1C-B5D6-0B0A-3643-C84B800050FC}"/>
              </a:ext>
            </a:extLst>
          </p:cNvPr>
          <p:cNvSpPr txBox="1"/>
          <p:nvPr/>
        </p:nvSpPr>
        <p:spPr>
          <a:xfrm>
            <a:off x="7516566" y="4321642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42E733A6-38CE-4029-B6F8-D1D419FE7DBC}"/>
              </a:ext>
            </a:extLst>
          </p:cNvPr>
          <p:cNvSpPr txBox="1"/>
          <p:nvPr/>
        </p:nvSpPr>
        <p:spPr>
          <a:xfrm>
            <a:off x="7685958" y="4321642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B88AE4F2-41FB-E12F-6A12-213EA04F9960}"/>
              </a:ext>
            </a:extLst>
          </p:cNvPr>
          <p:cNvSpPr txBox="1"/>
          <p:nvPr/>
        </p:nvSpPr>
        <p:spPr>
          <a:xfrm>
            <a:off x="7946030" y="4321642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pic>
        <p:nvPicPr>
          <p:cNvPr id="83" name="그림 82">
            <a:extLst>
              <a:ext uri="{FF2B5EF4-FFF2-40B4-BE49-F238E27FC236}">
                <a16:creationId xmlns:a16="http://schemas.microsoft.com/office/drawing/2014/main" id="{280C5EFC-F0D2-6232-51BD-6C17533E99F8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7320362" y="2486276"/>
            <a:ext cx="883997" cy="573074"/>
          </a:xfrm>
          <a:prstGeom prst="rect">
            <a:avLst/>
          </a:prstGeom>
        </p:spPr>
      </p:pic>
      <p:pic>
        <p:nvPicPr>
          <p:cNvPr id="84" name="그림 83">
            <a:extLst>
              <a:ext uri="{FF2B5EF4-FFF2-40B4-BE49-F238E27FC236}">
                <a16:creationId xmlns:a16="http://schemas.microsoft.com/office/drawing/2014/main" id="{AE656DD3-F4A3-3197-1BB4-3F5ACF7A16A6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7332486" y="1890858"/>
            <a:ext cx="883997" cy="512108"/>
          </a:xfrm>
          <a:prstGeom prst="rect">
            <a:avLst/>
          </a:prstGeom>
        </p:spPr>
      </p:pic>
      <p:sp>
        <p:nvSpPr>
          <p:cNvPr id="87" name="TextBox 86">
            <a:extLst>
              <a:ext uri="{FF2B5EF4-FFF2-40B4-BE49-F238E27FC236}">
                <a16:creationId xmlns:a16="http://schemas.microsoft.com/office/drawing/2014/main" id="{FF3CCD7C-5F4A-BB2E-612D-07898239F623}"/>
              </a:ext>
            </a:extLst>
          </p:cNvPr>
          <p:cNvSpPr txBox="1"/>
          <p:nvPr/>
        </p:nvSpPr>
        <p:spPr>
          <a:xfrm>
            <a:off x="1569406" y="1212251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그림 8">
            <a:extLst>
              <a:ext uri="{FF2B5EF4-FFF2-40B4-BE49-F238E27FC236}">
                <a16:creationId xmlns:a16="http://schemas.microsoft.com/office/drawing/2014/main" id="{6C2074EB-8219-0BF4-572C-8E9661A4B6C7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890" t="30991" r="69420" b="47285"/>
          <a:stretch/>
        </p:blipFill>
        <p:spPr>
          <a:xfrm>
            <a:off x="7320362" y="3326260"/>
            <a:ext cx="876740" cy="677726"/>
          </a:xfrm>
          <a:prstGeom prst="rect">
            <a:avLst/>
          </a:prstGeom>
          <a:ln>
            <a:noFill/>
          </a:ln>
        </p:spPr>
      </p:pic>
      <p:sp>
        <p:nvSpPr>
          <p:cNvPr id="82" name="직사각형 81">
            <a:extLst>
              <a:ext uri="{FF2B5EF4-FFF2-40B4-BE49-F238E27FC236}">
                <a16:creationId xmlns:a16="http://schemas.microsoft.com/office/drawing/2014/main" id="{2016FFBA-2B7F-48B5-A765-639516742A85}"/>
              </a:ext>
            </a:extLst>
          </p:cNvPr>
          <p:cNvSpPr/>
          <p:nvPr/>
        </p:nvSpPr>
        <p:spPr>
          <a:xfrm>
            <a:off x="3881742" y="2109379"/>
            <a:ext cx="816134" cy="182530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5" name="직사각형 84">
            <a:extLst>
              <a:ext uri="{FF2B5EF4-FFF2-40B4-BE49-F238E27FC236}">
                <a16:creationId xmlns:a16="http://schemas.microsoft.com/office/drawing/2014/main" id="{464C1976-98D3-466C-82B2-39541AF27297}"/>
              </a:ext>
            </a:extLst>
          </p:cNvPr>
          <p:cNvSpPr/>
          <p:nvPr/>
        </p:nvSpPr>
        <p:spPr>
          <a:xfrm>
            <a:off x="3889568" y="2703422"/>
            <a:ext cx="791489" cy="200915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6" name="직사각형 85">
            <a:extLst>
              <a:ext uri="{FF2B5EF4-FFF2-40B4-BE49-F238E27FC236}">
                <a16:creationId xmlns:a16="http://schemas.microsoft.com/office/drawing/2014/main" id="{C184693E-9008-4814-9629-F37C5D264B97}"/>
              </a:ext>
            </a:extLst>
          </p:cNvPr>
          <p:cNvSpPr/>
          <p:nvPr/>
        </p:nvSpPr>
        <p:spPr>
          <a:xfrm>
            <a:off x="3920116" y="3458649"/>
            <a:ext cx="730462" cy="200069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00C6F97-567F-E2B3-CDC8-234D621338B7}"/>
              </a:ext>
            </a:extLst>
          </p:cNvPr>
          <p:cNvSpPr txBox="1"/>
          <p:nvPr/>
        </p:nvSpPr>
        <p:spPr>
          <a:xfrm>
            <a:off x="34923" y="41837"/>
            <a:ext cx="514108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Arial" panose="020B0604020202020204" pitchFamily="34" charset="0"/>
                <a:cs typeface="Arial" panose="020B0604020202020204" pitchFamily="34" charset="0"/>
              </a:rPr>
              <a:t>Original gel images of Figure 4</a:t>
            </a:r>
            <a:r>
              <a:rPr lang="en-US" altLang="ko-KR" sz="1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endParaRPr lang="en-US" altLang="ko-KR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ll experiments were performed in triplicates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The red boxes indicate the figures in the main text.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6850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그림 18">
            <a:extLst>
              <a:ext uri="{FF2B5EF4-FFF2-40B4-BE49-F238E27FC236}">
                <a16:creationId xmlns:a16="http://schemas.microsoft.com/office/drawing/2014/main" id="{692F76FA-7B05-4DD1-4124-E400A3F3413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15716" y="2728813"/>
            <a:ext cx="1182727" cy="780356"/>
          </a:xfrm>
          <a:prstGeom prst="rect">
            <a:avLst/>
          </a:prstGeom>
        </p:spPr>
      </p:pic>
      <p:graphicFrame>
        <p:nvGraphicFramePr>
          <p:cNvPr id="4" name="개체 3">
            <a:extLst>
              <a:ext uri="{FF2B5EF4-FFF2-40B4-BE49-F238E27FC236}">
                <a16:creationId xmlns:a16="http://schemas.microsoft.com/office/drawing/2014/main" id="{8CB7E317-9505-D243-D8E8-7DA6F29076C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92890966"/>
              </p:ext>
            </p:extLst>
          </p:nvPr>
        </p:nvGraphicFramePr>
        <p:xfrm>
          <a:off x="4397911" y="4456467"/>
          <a:ext cx="1224136" cy="5531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4" name="Image" r:id="rId4" imgW="1713960" imgH="774360" progId="Photoshop.Image.13">
                  <p:embed/>
                </p:oleObj>
              </mc:Choice>
              <mc:Fallback>
                <p:oleObj name="Image" r:id="rId4" imgW="1713960" imgH="774360" progId="Photoshop.Image.13">
                  <p:embed/>
                  <p:pic>
                    <p:nvPicPr>
                      <p:cNvPr id="4" name="개체 3">
                        <a:extLst>
                          <a:ext uri="{FF2B5EF4-FFF2-40B4-BE49-F238E27FC236}">
                            <a16:creationId xmlns:a16="http://schemas.microsoft.com/office/drawing/2014/main" id="{8CB7E317-9505-D243-D8E8-7DA6F29076C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397911" y="4456467"/>
                        <a:ext cx="1224136" cy="5531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개체 4">
            <a:extLst>
              <a:ext uri="{FF2B5EF4-FFF2-40B4-BE49-F238E27FC236}">
                <a16:creationId xmlns:a16="http://schemas.microsoft.com/office/drawing/2014/main" id="{E8670155-6467-4DBA-F524-3D1DFA2BA21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66183677"/>
              </p:ext>
            </p:extLst>
          </p:nvPr>
        </p:nvGraphicFramePr>
        <p:xfrm>
          <a:off x="6398644" y="4560209"/>
          <a:ext cx="1224136" cy="4493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5" name="Image" r:id="rId6" imgW="1853640" imgH="914040" progId="Photoshop.Image.13">
                  <p:embed/>
                </p:oleObj>
              </mc:Choice>
              <mc:Fallback>
                <p:oleObj name="Image" r:id="rId6" imgW="1853640" imgH="914040" progId="Photoshop.Image.13">
                  <p:embed/>
                  <p:pic>
                    <p:nvPicPr>
                      <p:cNvPr id="5" name="개체 4">
                        <a:extLst>
                          <a:ext uri="{FF2B5EF4-FFF2-40B4-BE49-F238E27FC236}">
                            <a16:creationId xmlns:a16="http://schemas.microsoft.com/office/drawing/2014/main" id="{E8670155-6467-4DBA-F524-3D1DFA2BA21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398644" y="4560209"/>
                        <a:ext cx="1224136" cy="4493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개체 5">
            <a:extLst>
              <a:ext uri="{FF2B5EF4-FFF2-40B4-BE49-F238E27FC236}">
                <a16:creationId xmlns:a16="http://schemas.microsoft.com/office/drawing/2014/main" id="{5E1F05F0-6E91-25AF-CADF-5E30CE27C7F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19839682"/>
              </p:ext>
            </p:extLst>
          </p:nvPr>
        </p:nvGraphicFramePr>
        <p:xfrm>
          <a:off x="8366101" y="4398664"/>
          <a:ext cx="1224136" cy="6361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6" name="Image" r:id="rId8" imgW="1612440" imgH="838080" progId="Photoshop.Image.13">
                  <p:embed/>
                </p:oleObj>
              </mc:Choice>
              <mc:Fallback>
                <p:oleObj name="Image" r:id="rId8" imgW="1612440" imgH="838080" progId="Photoshop.Image.13">
                  <p:embed/>
                  <p:pic>
                    <p:nvPicPr>
                      <p:cNvPr id="6" name="개체 5">
                        <a:extLst>
                          <a:ext uri="{FF2B5EF4-FFF2-40B4-BE49-F238E27FC236}">
                            <a16:creationId xmlns:a16="http://schemas.microsoft.com/office/drawing/2014/main" id="{5E1F05F0-6E91-25AF-CADF-5E30CE27C7F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8366101" y="4398664"/>
                        <a:ext cx="1224136" cy="6361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개체 6">
            <a:extLst>
              <a:ext uri="{FF2B5EF4-FFF2-40B4-BE49-F238E27FC236}">
                <a16:creationId xmlns:a16="http://schemas.microsoft.com/office/drawing/2014/main" id="{96D5B42F-E7F2-AA5F-3471-4A2C33D71BF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80091508"/>
              </p:ext>
            </p:extLst>
          </p:nvPr>
        </p:nvGraphicFramePr>
        <p:xfrm>
          <a:off x="6398644" y="5211554"/>
          <a:ext cx="1224136" cy="583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7" name="Image" r:id="rId10" imgW="1891800" imgH="901440" progId="Photoshop.Image.13">
                  <p:embed/>
                </p:oleObj>
              </mc:Choice>
              <mc:Fallback>
                <p:oleObj name="Image" r:id="rId10" imgW="1891800" imgH="901440" progId="Photoshop.Image.13">
                  <p:embed/>
                  <p:pic>
                    <p:nvPicPr>
                      <p:cNvPr id="7" name="개체 6">
                        <a:extLst>
                          <a:ext uri="{FF2B5EF4-FFF2-40B4-BE49-F238E27FC236}">
                            <a16:creationId xmlns:a16="http://schemas.microsoft.com/office/drawing/2014/main" id="{96D5B42F-E7F2-AA5F-3471-4A2C33D71BF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6398644" y="5211554"/>
                        <a:ext cx="1224136" cy="583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개체 7">
            <a:extLst>
              <a:ext uri="{FF2B5EF4-FFF2-40B4-BE49-F238E27FC236}">
                <a16:creationId xmlns:a16="http://schemas.microsoft.com/office/drawing/2014/main" id="{29937395-02F4-06CD-1130-F674F6EC221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76757053"/>
              </p:ext>
            </p:extLst>
          </p:nvPr>
        </p:nvGraphicFramePr>
        <p:xfrm>
          <a:off x="4397911" y="5211554"/>
          <a:ext cx="1224136" cy="5670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8" name="Image" r:id="rId12" imgW="1726920" imgH="799920" progId="Photoshop.Image.13">
                  <p:embed/>
                </p:oleObj>
              </mc:Choice>
              <mc:Fallback>
                <p:oleObj name="Image" r:id="rId12" imgW="1726920" imgH="799920" progId="Photoshop.Image.13">
                  <p:embed/>
                  <p:pic>
                    <p:nvPicPr>
                      <p:cNvPr id="8" name="개체 7">
                        <a:extLst>
                          <a:ext uri="{FF2B5EF4-FFF2-40B4-BE49-F238E27FC236}">
                            <a16:creationId xmlns:a16="http://schemas.microsoft.com/office/drawing/2014/main" id="{29937395-02F4-06CD-1130-F674F6EC221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4397911" y="5211554"/>
                        <a:ext cx="1224136" cy="5670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개체 8">
            <a:extLst>
              <a:ext uri="{FF2B5EF4-FFF2-40B4-BE49-F238E27FC236}">
                <a16:creationId xmlns:a16="http://schemas.microsoft.com/office/drawing/2014/main" id="{DB21D91D-0596-9E0A-564F-BE58A7BD48F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63984699"/>
              </p:ext>
            </p:extLst>
          </p:nvPr>
        </p:nvGraphicFramePr>
        <p:xfrm>
          <a:off x="8366101" y="5236788"/>
          <a:ext cx="1224136" cy="570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9" name="Image" r:id="rId14" imgW="1688760" imgH="786960" progId="Photoshop.Image.13">
                  <p:embed/>
                </p:oleObj>
              </mc:Choice>
              <mc:Fallback>
                <p:oleObj name="Image" r:id="rId14" imgW="1688760" imgH="786960" progId="Photoshop.Image.13">
                  <p:embed/>
                  <p:pic>
                    <p:nvPicPr>
                      <p:cNvPr id="9" name="개체 8">
                        <a:extLst>
                          <a:ext uri="{FF2B5EF4-FFF2-40B4-BE49-F238E27FC236}">
                            <a16:creationId xmlns:a16="http://schemas.microsoft.com/office/drawing/2014/main" id="{DB21D91D-0596-9E0A-564F-BE58A7BD48F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8366101" y="5236788"/>
                        <a:ext cx="1224136" cy="570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개체 9">
            <a:extLst>
              <a:ext uri="{FF2B5EF4-FFF2-40B4-BE49-F238E27FC236}">
                <a16:creationId xmlns:a16="http://schemas.microsoft.com/office/drawing/2014/main" id="{94B76007-53F2-41DA-AEB3-DB17D7C8E80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53010885"/>
              </p:ext>
            </p:extLst>
          </p:nvPr>
        </p:nvGraphicFramePr>
        <p:xfrm>
          <a:off x="4397911" y="2823077"/>
          <a:ext cx="1224136" cy="6942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0" name="Image" r:id="rId16" imgW="1701360" imgH="964800" progId="Photoshop.Image.13">
                  <p:embed/>
                </p:oleObj>
              </mc:Choice>
              <mc:Fallback>
                <p:oleObj name="Image" r:id="rId16" imgW="1701360" imgH="964800" progId="Photoshop.Image.13">
                  <p:embed/>
                  <p:pic>
                    <p:nvPicPr>
                      <p:cNvPr id="10" name="개체 9">
                        <a:extLst>
                          <a:ext uri="{FF2B5EF4-FFF2-40B4-BE49-F238E27FC236}">
                            <a16:creationId xmlns:a16="http://schemas.microsoft.com/office/drawing/2014/main" id="{94B76007-53F2-41DA-AEB3-DB17D7C8E80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4397911" y="2823077"/>
                        <a:ext cx="1224136" cy="6942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개체 10">
            <a:extLst>
              <a:ext uri="{FF2B5EF4-FFF2-40B4-BE49-F238E27FC236}">
                <a16:creationId xmlns:a16="http://schemas.microsoft.com/office/drawing/2014/main" id="{2A5A4D9F-6D39-025C-C34E-C89D1F4B561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07185228"/>
              </p:ext>
            </p:extLst>
          </p:nvPr>
        </p:nvGraphicFramePr>
        <p:xfrm>
          <a:off x="6388918" y="2823077"/>
          <a:ext cx="1224136" cy="5906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1" name="Image" r:id="rId18" imgW="1815840" imgH="875880" progId="Photoshop.Image.13">
                  <p:embed/>
                </p:oleObj>
              </mc:Choice>
              <mc:Fallback>
                <p:oleObj name="Image" r:id="rId18" imgW="1815840" imgH="875880" progId="Photoshop.Image.13">
                  <p:embed/>
                  <p:pic>
                    <p:nvPicPr>
                      <p:cNvPr id="11" name="개체 10">
                        <a:extLst>
                          <a:ext uri="{FF2B5EF4-FFF2-40B4-BE49-F238E27FC236}">
                            <a16:creationId xmlns:a16="http://schemas.microsoft.com/office/drawing/2014/main" id="{2A5A4D9F-6D39-025C-C34E-C89D1F4B561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6388918" y="2823077"/>
                        <a:ext cx="1224136" cy="5906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개체 11">
            <a:extLst>
              <a:ext uri="{FF2B5EF4-FFF2-40B4-BE49-F238E27FC236}">
                <a16:creationId xmlns:a16="http://schemas.microsoft.com/office/drawing/2014/main" id="{480B3A7F-3860-DEBF-643D-98F07EACC74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41045141"/>
              </p:ext>
            </p:extLst>
          </p:nvPr>
        </p:nvGraphicFramePr>
        <p:xfrm>
          <a:off x="4397911" y="1927173"/>
          <a:ext cx="1224136" cy="6295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2" name="Image" r:id="rId20" imgW="1777680" imgH="914040" progId="Photoshop.Image.13">
                  <p:embed/>
                </p:oleObj>
              </mc:Choice>
              <mc:Fallback>
                <p:oleObj name="Image" r:id="rId20" imgW="1777680" imgH="914040" progId="Photoshop.Image.13">
                  <p:embed/>
                  <p:pic>
                    <p:nvPicPr>
                      <p:cNvPr id="12" name="개체 11">
                        <a:extLst>
                          <a:ext uri="{FF2B5EF4-FFF2-40B4-BE49-F238E27FC236}">
                            <a16:creationId xmlns:a16="http://schemas.microsoft.com/office/drawing/2014/main" id="{480B3A7F-3860-DEBF-643D-98F07EACC74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4397911" y="1927173"/>
                        <a:ext cx="1224136" cy="6295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개체 12">
            <a:extLst>
              <a:ext uri="{FF2B5EF4-FFF2-40B4-BE49-F238E27FC236}">
                <a16:creationId xmlns:a16="http://schemas.microsoft.com/office/drawing/2014/main" id="{B7473603-0E8A-E641-AEB2-157B4415832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92994016"/>
              </p:ext>
            </p:extLst>
          </p:nvPr>
        </p:nvGraphicFramePr>
        <p:xfrm>
          <a:off x="6388918" y="1927173"/>
          <a:ext cx="1224136" cy="6295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3" name="Image" r:id="rId22" imgW="1777680" imgH="914040" progId="Photoshop.Image.13">
                  <p:embed/>
                </p:oleObj>
              </mc:Choice>
              <mc:Fallback>
                <p:oleObj name="Image" r:id="rId22" imgW="1777680" imgH="914040" progId="Photoshop.Image.13">
                  <p:embed/>
                  <p:pic>
                    <p:nvPicPr>
                      <p:cNvPr id="13" name="개체 12">
                        <a:extLst>
                          <a:ext uri="{FF2B5EF4-FFF2-40B4-BE49-F238E27FC236}">
                            <a16:creationId xmlns:a16="http://schemas.microsoft.com/office/drawing/2014/main" id="{B7473603-0E8A-E641-AEB2-157B4415832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6388918" y="1927173"/>
                        <a:ext cx="1224136" cy="6295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5" name="그림 14" descr="텍스트이(가) 표시된 사진&#10;&#10;자동 생성된 설명">
            <a:extLst>
              <a:ext uri="{FF2B5EF4-FFF2-40B4-BE49-F238E27FC236}">
                <a16:creationId xmlns:a16="http://schemas.microsoft.com/office/drawing/2014/main" id="{C234BEFE-B01A-6E94-F932-9FA9AB2D6F9C}"/>
              </a:ext>
            </a:extLst>
          </p:cNvPr>
          <p:cNvPicPr>
            <a:picLocks noChangeAspect="1"/>
          </p:cNvPicPr>
          <p:nvPr/>
        </p:nvPicPr>
        <p:blipFill rotWithShape="1"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163" t="59615" r="7558" b="19973"/>
          <a:stretch/>
        </p:blipFill>
        <p:spPr>
          <a:xfrm>
            <a:off x="8408189" y="1942465"/>
            <a:ext cx="1182048" cy="671970"/>
          </a:xfrm>
          <a:prstGeom prst="rect">
            <a:avLst/>
          </a:prstGeom>
          <a:ln>
            <a:noFill/>
          </a:ln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DE861B5A-D1EA-3A4A-10DF-9B4E70F11F9C}"/>
              </a:ext>
            </a:extLst>
          </p:cNvPr>
          <p:cNvSpPr txBox="1"/>
          <p:nvPr/>
        </p:nvSpPr>
        <p:spPr>
          <a:xfrm>
            <a:off x="2427268" y="2070402"/>
            <a:ext cx="12921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Twist1 (21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D97C19B-B087-A028-DDA9-EC79593E9C63}"/>
              </a:ext>
            </a:extLst>
          </p:cNvPr>
          <p:cNvSpPr txBox="1"/>
          <p:nvPr/>
        </p:nvSpPr>
        <p:spPr>
          <a:xfrm>
            <a:off x="2392245" y="3048559"/>
            <a:ext cx="1329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 (41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30" name="직선 연결선 29">
            <a:extLst>
              <a:ext uri="{FF2B5EF4-FFF2-40B4-BE49-F238E27FC236}">
                <a16:creationId xmlns:a16="http://schemas.microsoft.com/office/drawing/2014/main" id="{4F1C6C17-D602-28FB-7923-8A9335EE4CFD}"/>
              </a:ext>
            </a:extLst>
          </p:cNvPr>
          <p:cNvCxnSpPr/>
          <p:nvPr/>
        </p:nvCxnSpPr>
        <p:spPr>
          <a:xfrm>
            <a:off x="8337546" y="2983527"/>
            <a:ext cx="12583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연결선 30">
            <a:extLst>
              <a:ext uri="{FF2B5EF4-FFF2-40B4-BE49-F238E27FC236}">
                <a16:creationId xmlns:a16="http://schemas.microsoft.com/office/drawing/2014/main" id="{EBF4A857-1214-D2AD-A2EE-27BF1C0917DB}"/>
              </a:ext>
            </a:extLst>
          </p:cNvPr>
          <p:cNvCxnSpPr/>
          <p:nvPr/>
        </p:nvCxnSpPr>
        <p:spPr>
          <a:xfrm>
            <a:off x="8337546" y="3327475"/>
            <a:ext cx="12583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연결선 31">
            <a:extLst>
              <a:ext uri="{FF2B5EF4-FFF2-40B4-BE49-F238E27FC236}">
                <a16:creationId xmlns:a16="http://schemas.microsoft.com/office/drawing/2014/main" id="{CE9542A5-90C5-449C-0A66-184E8E6E2079}"/>
              </a:ext>
            </a:extLst>
          </p:cNvPr>
          <p:cNvCxnSpPr/>
          <p:nvPr/>
        </p:nvCxnSpPr>
        <p:spPr>
          <a:xfrm>
            <a:off x="8337546" y="2228464"/>
            <a:ext cx="12583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EF2EF42B-F675-2FB1-F143-693C8A86E007}"/>
              </a:ext>
            </a:extLst>
          </p:cNvPr>
          <p:cNvSpPr txBox="1"/>
          <p:nvPr/>
        </p:nvSpPr>
        <p:spPr>
          <a:xfrm>
            <a:off x="7861585" y="2109247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2318052-37E4-4400-4C63-8BC7B11B657F}"/>
              </a:ext>
            </a:extLst>
          </p:cNvPr>
          <p:cNvSpPr txBox="1"/>
          <p:nvPr/>
        </p:nvSpPr>
        <p:spPr>
          <a:xfrm>
            <a:off x="7861585" y="3187930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47BD70E4-60BA-91FA-4AF0-821B06BFCEF5}"/>
              </a:ext>
            </a:extLst>
          </p:cNvPr>
          <p:cNvSpPr txBox="1"/>
          <p:nvPr/>
        </p:nvSpPr>
        <p:spPr>
          <a:xfrm>
            <a:off x="7861585" y="2885098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48 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" name="직선 연결선 1">
            <a:extLst>
              <a:ext uri="{FF2B5EF4-FFF2-40B4-BE49-F238E27FC236}">
                <a16:creationId xmlns:a16="http://schemas.microsoft.com/office/drawing/2014/main" id="{6271CE27-2BB3-6276-53DA-F626CF0A9D82}"/>
              </a:ext>
            </a:extLst>
          </p:cNvPr>
          <p:cNvCxnSpPr/>
          <p:nvPr/>
        </p:nvCxnSpPr>
        <p:spPr>
          <a:xfrm>
            <a:off x="6263083" y="2229481"/>
            <a:ext cx="12583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EF0521DD-3BA7-C221-EA5C-A158297523E7}"/>
              </a:ext>
            </a:extLst>
          </p:cNvPr>
          <p:cNvSpPr txBox="1"/>
          <p:nvPr/>
        </p:nvSpPr>
        <p:spPr>
          <a:xfrm>
            <a:off x="5787122" y="2110264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" name="그룹 13">
            <a:extLst>
              <a:ext uri="{FF2B5EF4-FFF2-40B4-BE49-F238E27FC236}">
                <a16:creationId xmlns:a16="http://schemas.microsoft.com/office/drawing/2014/main" id="{3D53F235-FDFD-4DEA-B8A9-AA029C6D35B1}"/>
              </a:ext>
            </a:extLst>
          </p:cNvPr>
          <p:cNvGrpSpPr/>
          <p:nvPr/>
        </p:nvGrpSpPr>
        <p:grpSpPr>
          <a:xfrm>
            <a:off x="3796636" y="2093486"/>
            <a:ext cx="601796" cy="230832"/>
            <a:chOff x="3173250" y="902249"/>
            <a:chExt cx="601796" cy="230832"/>
          </a:xfrm>
        </p:grpSpPr>
        <p:cxnSp>
          <p:nvCxnSpPr>
            <p:cNvPr id="29" name="직선 연결선 28">
              <a:extLst>
                <a:ext uri="{FF2B5EF4-FFF2-40B4-BE49-F238E27FC236}">
                  <a16:creationId xmlns:a16="http://schemas.microsoft.com/office/drawing/2014/main" id="{7AC82C84-7A49-E946-7C50-445C520A46BB}"/>
                </a:ext>
              </a:extLst>
            </p:cNvPr>
            <p:cNvCxnSpPr/>
            <p:nvPr/>
          </p:nvCxnSpPr>
          <p:spPr>
            <a:xfrm>
              <a:off x="3649211" y="1021466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38659745-8583-AEE6-2C1A-9CC7C637707D}"/>
                </a:ext>
              </a:extLst>
            </p:cNvPr>
            <p:cNvSpPr txBox="1"/>
            <p:nvPr/>
          </p:nvSpPr>
          <p:spPr>
            <a:xfrm>
              <a:off x="3173250" y="902249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37" name="직선 연결선 36">
            <a:extLst>
              <a:ext uri="{FF2B5EF4-FFF2-40B4-BE49-F238E27FC236}">
                <a16:creationId xmlns:a16="http://schemas.microsoft.com/office/drawing/2014/main" id="{16700C16-90A6-0CBC-4F6F-1014FAE84D54}"/>
              </a:ext>
            </a:extLst>
          </p:cNvPr>
          <p:cNvCxnSpPr/>
          <p:nvPr/>
        </p:nvCxnSpPr>
        <p:spPr>
          <a:xfrm>
            <a:off x="6263083" y="2900601"/>
            <a:ext cx="12583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직선 연결선 37">
            <a:extLst>
              <a:ext uri="{FF2B5EF4-FFF2-40B4-BE49-F238E27FC236}">
                <a16:creationId xmlns:a16="http://schemas.microsoft.com/office/drawing/2014/main" id="{8BD57AA1-CC0A-D23F-5BB3-05D7A87ACF5F}"/>
              </a:ext>
            </a:extLst>
          </p:cNvPr>
          <p:cNvCxnSpPr/>
          <p:nvPr/>
        </p:nvCxnSpPr>
        <p:spPr>
          <a:xfrm>
            <a:off x="6263083" y="3244549"/>
            <a:ext cx="12583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05A119B8-8CA8-3387-A1A1-A80D72A005CE}"/>
              </a:ext>
            </a:extLst>
          </p:cNvPr>
          <p:cNvSpPr txBox="1"/>
          <p:nvPr/>
        </p:nvSpPr>
        <p:spPr>
          <a:xfrm>
            <a:off x="5787122" y="3105004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8AAD68A-15EE-B33C-0C8D-0E8AC841CB05}"/>
              </a:ext>
            </a:extLst>
          </p:cNvPr>
          <p:cNvSpPr txBox="1"/>
          <p:nvPr/>
        </p:nvSpPr>
        <p:spPr>
          <a:xfrm>
            <a:off x="5787122" y="2802172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48 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직선 연결선 40">
            <a:extLst>
              <a:ext uri="{FF2B5EF4-FFF2-40B4-BE49-F238E27FC236}">
                <a16:creationId xmlns:a16="http://schemas.microsoft.com/office/drawing/2014/main" id="{C0233842-1BDA-BB24-87D2-0A2EAA78C822}"/>
              </a:ext>
            </a:extLst>
          </p:cNvPr>
          <p:cNvCxnSpPr/>
          <p:nvPr/>
        </p:nvCxnSpPr>
        <p:spPr>
          <a:xfrm>
            <a:off x="4280986" y="2942546"/>
            <a:ext cx="12583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직선 연결선 41">
            <a:extLst>
              <a:ext uri="{FF2B5EF4-FFF2-40B4-BE49-F238E27FC236}">
                <a16:creationId xmlns:a16="http://schemas.microsoft.com/office/drawing/2014/main" id="{A74F4AA5-CFD5-3152-533A-E89935239AFF}"/>
              </a:ext>
            </a:extLst>
          </p:cNvPr>
          <p:cNvCxnSpPr/>
          <p:nvPr/>
        </p:nvCxnSpPr>
        <p:spPr>
          <a:xfrm>
            <a:off x="4280986" y="3286494"/>
            <a:ext cx="12583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3AF6F92C-19D2-07AC-ABA5-CDC136C1CB57}"/>
              </a:ext>
            </a:extLst>
          </p:cNvPr>
          <p:cNvSpPr txBox="1"/>
          <p:nvPr/>
        </p:nvSpPr>
        <p:spPr>
          <a:xfrm>
            <a:off x="3805025" y="3146949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0C3E4DA-299D-348A-FE42-5E72F0D23540}"/>
              </a:ext>
            </a:extLst>
          </p:cNvPr>
          <p:cNvSpPr txBox="1"/>
          <p:nvPr/>
        </p:nvSpPr>
        <p:spPr>
          <a:xfrm>
            <a:off x="3805025" y="2844117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48 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직선 연결선 44">
            <a:extLst>
              <a:ext uri="{FF2B5EF4-FFF2-40B4-BE49-F238E27FC236}">
                <a16:creationId xmlns:a16="http://schemas.microsoft.com/office/drawing/2014/main" id="{BF5CE8C5-37FB-4A14-4886-5E84E3080186}"/>
              </a:ext>
            </a:extLst>
          </p:cNvPr>
          <p:cNvCxnSpPr/>
          <p:nvPr/>
        </p:nvCxnSpPr>
        <p:spPr>
          <a:xfrm>
            <a:off x="4272597" y="4738744"/>
            <a:ext cx="12583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335BD7DA-BDCE-DC86-D346-538C5EA3B583}"/>
              </a:ext>
            </a:extLst>
          </p:cNvPr>
          <p:cNvSpPr txBox="1"/>
          <p:nvPr/>
        </p:nvSpPr>
        <p:spPr>
          <a:xfrm>
            <a:off x="3796636" y="4619527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직선 연결선 46">
            <a:extLst>
              <a:ext uri="{FF2B5EF4-FFF2-40B4-BE49-F238E27FC236}">
                <a16:creationId xmlns:a16="http://schemas.microsoft.com/office/drawing/2014/main" id="{DD972548-1C03-E97D-F129-179DC18DAD2A}"/>
              </a:ext>
            </a:extLst>
          </p:cNvPr>
          <p:cNvCxnSpPr/>
          <p:nvPr/>
        </p:nvCxnSpPr>
        <p:spPr>
          <a:xfrm>
            <a:off x="6281198" y="4789078"/>
            <a:ext cx="12583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D714BF06-9BE4-02B1-F73B-0DB4C3282438}"/>
              </a:ext>
            </a:extLst>
          </p:cNvPr>
          <p:cNvSpPr txBox="1"/>
          <p:nvPr/>
        </p:nvSpPr>
        <p:spPr>
          <a:xfrm>
            <a:off x="5805237" y="4669861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직선 연결선 48">
            <a:extLst>
              <a:ext uri="{FF2B5EF4-FFF2-40B4-BE49-F238E27FC236}">
                <a16:creationId xmlns:a16="http://schemas.microsoft.com/office/drawing/2014/main" id="{5E570EDE-177F-F727-0A1E-40DD872C5AB5}"/>
              </a:ext>
            </a:extLst>
          </p:cNvPr>
          <p:cNvCxnSpPr/>
          <p:nvPr/>
        </p:nvCxnSpPr>
        <p:spPr>
          <a:xfrm>
            <a:off x="8236735" y="4722033"/>
            <a:ext cx="12583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EA00B112-B698-23A6-230F-352A6C4693F6}"/>
              </a:ext>
            </a:extLst>
          </p:cNvPr>
          <p:cNvSpPr txBox="1"/>
          <p:nvPr/>
        </p:nvSpPr>
        <p:spPr>
          <a:xfrm>
            <a:off x="7760774" y="4602816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직선 연결선 56">
            <a:extLst>
              <a:ext uri="{FF2B5EF4-FFF2-40B4-BE49-F238E27FC236}">
                <a16:creationId xmlns:a16="http://schemas.microsoft.com/office/drawing/2014/main" id="{DBC370CA-8CDB-71A1-351C-04C31FAF2AB8}"/>
              </a:ext>
            </a:extLst>
          </p:cNvPr>
          <p:cNvCxnSpPr/>
          <p:nvPr/>
        </p:nvCxnSpPr>
        <p:spPr>
          <a:xfrm>
            <a:off x="4264208" y="5242084"/>
            <a:ext cx="12583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직선 연결선 57">
            <a:extLst>
              <a:ext uri="{FF2B5EF4-FFF2-40B4-BE49-F238E27FC236}">
                <a16:creationId xmlns:a16="http://schemas.microsoft.com/office/drawing/2014/main" id="{7BF9339C-B846-3560-CC60-0F12E01443B1}"/>
              </a:ext>
            </a:extLst>
          </p:cNvPr>
          <p:cNvCxnSpPr/>
          <p:nvPr/>
        </p:nvCxnSpPr>
        <p:spPr>
          <a:xfrm>
            <a:off x="4264208" y="5586032"/>
            <a:ext cx="12583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C858E0DF-2952-493B-2FB3-92781F055F40}"/>
              </a:ext>
            </a:extLst>
          </p:cNvPr>
          <p:cNvSpPr txBox="1"/>
          <p:nvPr/>
        </p:nvSpPr>
        <p:spPr>
          <a:xfrm>
            <a:off x="3788247" y="5446487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D3305BFF-F467-0067-701C-74F80BD1A03A}"/>
              </a:ext>
            </a:extLst>
          </p:cNvPr>
          <p:cNvSpPr txBox="1"/>
          <p:nvPr/>
        </p:nvSpPr>
        <p:spPr>
          <a:xfrm>
            <a:off x="3788247" y="5143655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48 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직선 연결선 60">
            <a:extLst>
              <a:ext uri="{FF2B5EF4-FFF2-40B4-BE49-F238E27FC236}">
                <a16:creationId xmlns:a16="http://schemas.microsoft.com/office/drawing/2014/main" id="{79C96085-17B4-1C65-EA32-B66DEC7C479F}"/>
              </a:ext>
            </a:extLst>
          </p:cNvPr>
          <p:cNvCxnSpPr/>
          <p:nvPr/>
        </p:nvCxnSpPr>
        <p:spPr>
          <a:xfrm>
            <a:off x="6272809" y="5242084"/>
            <a:ext cx="12583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직선 연결선 61">
            <a:extLst>
              <a:ext uri="{FF2B5EF4-FFF2-40B4-BE49-F238E27FC236}">
                <a16:creationId xmlns:a16="http://schemas.microsoft.com/office/drawing/2014/main" id="{20385FC6-0855-47E5-8693-FBAE081DD62C}"/>
              </a:ext>
            </a:extLst>
          </p:cNvPr>
          <p:cNvCxnSpPr/>
          <p:nvPr/>
        </p:nvCxnSpPr>
        <p:spPr>
          <a:xfrm>
            <a:off x="6272809" y="5586032"/>
            <a:ext cx="12583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6A5C11C4-A773-0BEA-2E81-5970A297248D}"/>
              </a:ext>
            </a:extLst>
          </p:cNvPr>
          <p:cNvSpPr txBox="1"/>
          <p:nvPr/>
        </p:nvSpPr>
        <p:spPr>
          <a:xfrm>
            <a:off x="5796848" y="5446487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7A77639C-8D9A-5A61-F230-6118AEBEDB1C}"/>
              </a:ext>
            </a:extLst>
          </p:cNvPr>
          <p:cNvSpPr txBox="1"/>
          <p:nvPr/>
        </p:nvSpPr>
        <p:spPr>
          <a:xfrm>
            <a:off x="5796848" y="5143655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48 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" name="직선 연결선 64">
            <a:extLst>
              <a:ext uri="{FF2B5EF4-FFF2-40B4-BE49-F238E27FC236}">
                <a16:creationId xmlns:a16="http://schemas.microsoft.com/office/drawing/2014/main" id="{A38D19AE-D94C-7A67-5D55-64A82DBC0AAE}"/>
              </a:ext>
            </a:extLst>
          </p:cNvPr>
          <p:cNvCxnSpPr/>
          <p:nvPr/>
        </p:nvCxnSpPr>
        <p:spPr>
          <a:xfrm>
            <a:off x="8245124" y="5267318"/>
            <a:ext cx="12583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직선 연결선 65">
            <a:extLst>
              <a:ext uri="{FF2B5EF4-FFF2-40B4-BE49-F238E27FC236}">
                <a16:creationId xmlns:a16="http://schemas.microsoft.com/office/drawing/2014/main" id="{A664A914-CC43-32CA-1CCC-F8D4A8158C05}"/>
              </a:ext>
            </a:extLst>
          </p:cNvPr>
          <p:cNvCxnSpPr/>
          <p:nvPr/>
        </p:nvCxnSpPr>
        <p:spPr>
          <a:xfrm>
            <a:off x="8245124" y="5611266"/>
            <a:ext cx="12583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7D1EA0BE-3F2C-8FB0-6E1E-B6D3309EE543}"/>
              </a:ext>
            </a:extLst>
          </p:cNvPr>
          <p:cNvSpPr txBox="1"/>
          <p:nvPr/>
        </p:nvSpPr>
        <p:spPr>
          <a:xfrm>
            <a:off x="7769163" y="5471721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FFB4A8DC-EA94-9C36-D3B6-B0D0BDE9964F}"/>
              </a:ext>
            </a:extLst>
          </p:cNvPr>
          <p:cNvSpPr txBox="1"/>
          <p:nvPr/>
        </p:nvSpPr>
        <p:spPr>
          <a:xfrm>
            <a:off x="7769163" y="5168889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48 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0651D856-01E0-E3F7-0D8B-663115FAC756}"/>
              </a:ext>
            </a:extLst>
          </p:cNvPr>
          <p:cNvSpPr txBox="1"/>
          <p:nvPr/>
        </p:nvSpPr>
        <p:spPr>
          <a:xfrm>
            <a:off x="2006410" y="1623149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6588AC27-18BA-B3CA-0BC3-A77BE089395C}"/>
              </a:ext>
            </a:extLst>
          </p:cNvPr>
          <p:cNvSpPr txBox="1"/>
          <p:nvPr/>
        </p:nvSpPr>
        <p:spPr>
          <a:xfrm>
            <a:off x="2006410" y="4055201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757A9EED-BE14-79DE-AB0E-D61B490FBBA5}"/>
              </a:ext>
            </a:extLst>
          </p:cNvPr>
          <p:cNvSpPr txBox="1"/>
          <p:nvPr/>
        </p:nvSpPr>
        <p:spPr>
          <a:xfrm>
            <a:off x="4609303" y="1611954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1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56669195-CA8F-FE46-91CE-B13D89750B2F}"/>
              </a:ext>
            </a:extLst>
          </p:cNvPr>
          <p:cNvSpPr txBox="1"/>
          <p:nvPr/>
        </p:nvSpPr>
        <p:spPr>
          <a:xfrm>
            <a:off x="6575814" y="1611954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2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8CCFC2CF-E63C-4112-F41E-8EB3E23F57EC}"/>
              </a:ext>
            </a:extLst>
          </p:cNvPr>
          <p:cNvSpPr txBox="1"/>
          <p:nvPr/>
        </p:nvSpPr>
        <p:spPr>
          <a:xfrm>
            <a:off x="8608721" y="1618411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3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ED8D7B87-B0A5-E1EA-184B-F43EE081C00D}"/>
              </a:ext>
            </a:extLst>
          </p:cNvPr>
          <p:cNvSpPr txBox="1"/>
          <p:nvPr/>
        </p:nvSpPr>
        <p:spPr>
          <a:xfrm>
            <a:off x="4609303" y="4054513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1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25F1A769-28EE-BCBE-3F03-8402C25422EC}"/>
              </a:ext>
            </a:extLst>
          </p:cNvPr>
          <p:cNvSpPr txBox="1"/>
          <p:nvPr/>
        </p:nvSpPr>
        <p:spPr>
          <a:xfrm>
            <a:off x="6585540" y="4054513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2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27C0A36C-F76A-89F7-F8F2-F74C5FF774C8}"/>
              </a:ext>
            </a:extLst>
          </p:cNvPr>
          <p:cNvSpPr txBox="1"/>
          <p:nvPr/>
        </p:nvSpPr>
        <p:spPr>
          <a:xfrm>
            <a:off x="8566633" y="4086204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3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77AAAA99-F35D-3E26-AC81-012648AA4D60}"/>
              </a:ext>
            </a:extLst>
          </p:cNvPr>
          <p:cNvSpPr txBox="1"/>
          <p:nvPr/>
        </p:nvSpPr>
        <p:spPr>
          <a:xfrm>
            <a:off x="2462346" y="4642742"/>
            <a:ext cx="12921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Twist1 (21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3FF04F54-0B5E-A9AB-E76E-7A233723B448}"/>
              </a:ext>
            </a:extLst>
          </p:cNvPr>
          <p:cNvSpPr txBox="1"/>
          <p:nvPr/>
        </p:nvSpPr>
        <p:spPr>
          <a:xfrm>
            <a:off x="2427269" y="5409000"/>
            <a:ext cx="1329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 (41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FB0F26E5-B44F-5A9E-D702-FFCEB5680541}"/>
              </a:ext>
            </a:extLst>
          </p:cNvPr>
          <p:cNvSpPr txBox="1"/>
          <p:nvPr/>
        </p:nvSpPr>
        <p:spPr>
          <a:xfrm>
            <a:off x="3593862" y="3541842"/>
            <a:ext cx="931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litinib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873D77E1-E93F-A709-1C54-0D6A824255B7}"/>
              </a:ext>
            </a:extLst>
          </p:cNvPr>
          <p:cNvSpPr txBox="1"/>
          <p:nvPr/>
        </p:nvSpPr>
        <p:spPr>
          <a:xfrm>
            <a:off x="4592468" y="3541842"/>
            <a:ext cx="266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625A1393-684F-4773-C232-F0254F42A93D}"/>
              </a:ext>
            </a:extLst>
          </p:cNvPr>
          <p:cNvSpPr txBox="1"/>
          <p:nvPr/>
        </p:nvSpPr>
        <p:spPr>
          <a:xfrm>
            <a:off x="4800439" y="3541842"/>
            <a:ext cx="4381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49CF2C9A-B255-D8A1-7606-DAF8DFA3F157}"/>
              </a:ext>
            </a:extLst>
          </p:cNvPr>
          <p:cNvSpPr txBox="1"/>
          <p:nvPr/>
        </p:nvSpPr>
        <p:spPr>
          <a:xfrm>
            <a:off x="5179861" y="3541842"/>
            <a:ext cx="266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D8540B9A-7894-AFB3-B55D-D79D0558B11E}"/>
              </a:ext>
            </a:extLst>
          </p:cNvPr>
          <p:cNvSpPr txBox="1"/>
          <p:nvPr/>
        </p:nvSpPr>
        <p:spPr>
          <a:xfrm>
            <a:off x="5644252" y="3541842"/>
            <a:ext cx="931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litinib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AC9A391F-A2C3-495D-E901-45D4C9EB5CDD}"/>
              </a:ext>
            </a:extLst>
          </p:cNvPr>
          <p:cNvSpPr txBox="1"/>
          <p:nvPr/>
        </p:nvSpPr>
        <p:spPr>
          <a:xfrm>
            <a:off x="6642858" y="3541842"/>
            <a:ext cx="266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EFCE14A4-8AAC-3AFD-9219-4B10D6FBA2EB}"/>
              </a:ext>
            </a:extLst>
          </p:cNvPr>
          <p:cNvSpPr txBox="1"/>
          <p:nvPr/>
        </p:nvSpPr>
        <p:spPr>
          <a:xfrm>
            <a:off x="6850829" y="3541842"/>
            <a:ext cx="4381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01293076-28C7-5C3A-CE15-CB32B23A0115}"/>
              </a:ext>
            </a:extLst>
          </p:cNvPr>
          <p:cNvSpPr txBox="1"/>
          <p:nvPr/>
        </p:nvSpPr>
        <p:spPr>
          <a:xfrm>
            <a:off x="7230251" y="3541842"/>
            <a:ext cx="266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6CC4D6ED-6B75-705E-9EB0-07B367842C99}"/>
              </a:ext>
            </a:extLst>
          </p:cNvPr>
          <p:cNvSpPr txBox="1"/>
          <p:nvPr/>
        </p:nvSpPr>
        <p:spPr>
          <a:xfrm>
            <a:off x="7672913" y="3541842"/>
            <a:ext cx="931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litinib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528BB4EA-8956-4A0B-E9A6-032724D5D007}"/>
              </a:ext>
            </a:extLst>
          </p:cNvPr>
          <p:cNvSpPr txBox="1"/>
          <p:nvPr/>
        </p:nvSpPr>
        <p:spPr>
          <a:xfrm>
            <a:off x="8671519" y="3541842"/>
            <a:ext cx="266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A99CF40E-E4C6-200D-3153-E8FBE5CF68AE}"/>
              </a:ext>
            </a:extLst>
          </p:cNvPr>
          <p:cNvSpPr txBox="1"/>
          <p:nvPr/>
        </p:nvSpPr>
        <p:spPr>
          <a:xfrm>
            <a:off x="8879490" y="3541842"/>
            <a:ext cx="4381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BD938A1A-377B-F7A0-7736-8DF78351F517}"/>
              </a:ext>
            </a:extLst>
          </p:cNvPr>
          <p:cNvSpPr txBox="1"/>
          <p:nvPr/>
        </p:nvSpPr>
        <p:spPr>
          <a:xfrm>
            <a:off x="9258912" y="3541842"/>
            <a:ext cx="266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18369708-BF3E-9E92-FACC-4632528978C5}"/>
              </a:ext>
            </a:extLst>
          </p:cNvPr>
          <p:cNvSpPr txBox="1"/>
          <p:nvPr/>
        </p:nvSpPr>
        <p:spPr>
          <a:xfrm>
            <a:off x="3593862" y="5781468"/>
            <a:ext cx="931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litinib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0EE37195-99B4-A0CA-214A-1012E6E967CF}"/>
              </a:ext>
            </a:extLst>
          </p:cNvPr>
          <p:cNvSpPr txBox="1"/>
          <p:nvPr/>
        </p:nvSpPr>
        <p:spPr>
          <a:xfrm>
            <a:off x="4592468" y="5781468"/>
            <a:ext cx="266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2D7F27B9-BE1C-5848-49C5-C22B23E8CDAB}"/>
              </a:ext>
            </a:extLst>
          </p:cNvPr>
          <p:cNvSpPr txBox="1"/>
          <p:nvPr/>
        </p:nvSpPr>
        <p:spPr>
          <a:xfrm>
            <a:off x="4800439" y="5781468"/>
            <a:ext cx="4381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6C2A6389-03E2-EC51-5CF4-01A6B7CA712A}"/>
              </a:ext>
            </a:extLst>
          </p:cNvPr>
          <p:cNvSpPr txBox="1"/>
          <p:nvPr/>
        </p:nvSpPr>
        <p:spPr>
          <a:xfrm>
            <a:off x="5179861" y="5781468"/>
            <a:ext cx="266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D3F4E773-0D85-9DF8-96D1-05D3C2ADC19A}"/>
              </a:ext>
            </a:extLst>
          </p:cNvPr>
          <p:cNvSpPr txBox="1"/>
          <p:nvPr/>
        </p:nvSpPr>
        <p:spPr>
          <a:xfrm>
            <a:off x="5644252" y="5781468"/>
            <a:ext cx="931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litinib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83CBC990-7B13-DD96-8918-28CB46FCD0A6}"/>
              </a:ext>
            </a:extLst>
          </p:cNvPr>
          <p:cNvSpPr txBox="1"/>
          <p:nvPr/>
        </p:nvSpPr>
        <p:spPr>
          <a:xfrm>
            <a:off x="6642858" y="5781468"/>
            <a:ext cx="266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2B1F0A1E-4D1F-7FE8-850E-27C44464FA90}"/>
              </a:ext>
            </a:extLst>
          </p:cNvPr>
          <p:cNvSpPr txBox="1"/>
          <p:nvPr/>
        </p:nvSpPr>
        <p:spPr>
          <a:xfrm>
            <a:off x="6850829" y="5781468"/>
            <a:ext cx="4381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68449EF5-300A-9393-648F-A8F13B6286EE}"/>
              </a:ext>
            </a:extLst>
          </p:cNvPr>
          <p:cNvSpPr txBox="1"/>
          <p:nvPr/>
        </p:nvSpPr>
        <p:spPr>
          <a:xfrm>
            <a:off x="7230251" y="5781468"/>
            <a:ext cx="266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C599F32E-00A7-5DDE-5EA8-EEBBDDCB7693}"/>
              </a:ext>
            </a:extLst>
          </p:cNvPr>
          <p:cNvSpPr txBox="1"/>
          <p:nvPr/>
        </p:nvSpPr>
        <p:spPr>
          <a:xfrm>
            <a:off x="7672913" y="5781468"/>
            <a:ext cx="931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litinib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987B2398-481E-DE49-7ED0-150D135171B4}"/>
              </a:ext>
            </a:extLst>
          </p:cNvPr>
          <p:cNvSpPr txBox="1"/>
          <p:nvPr/>
        </p:nvSpPr>
        <p:spPr>
          <a:xfrm>
            <a:off x="8671519" y="5781468"/>
            <a:ext cx="266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335C2A11-7648-4186-4015-C65179E04B75}"/>
              </a:ext>
            </a:extLst>
          </p:cNvPr>
          <p:cNvSpPr txBox="1"/>
          <p:nvPr/>
        </p:nvSpPr>
        <p:spPr>
          <a:xfrm>
            <a:off x="8879490" y="5781468"/>
            <a:ext cx="4381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F046CFC9-32B1-D74E-9DC7-906C573EA28E}"/>
              </a:ext>
            </a:extLst>
          </p:cNvPr>
          <p:cNvSpPr txBox="1"/>
          <p:nvPr/>
        </p:nvSpPr>
        <p:spPr>
          <a:xfrm>
            <a:off x="9258912" y="5781468"/>
            <a:ext cx="266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직사각형 87">
            <a:extLst>
              <a:ext uri="{FF2B5EF4-FFF2-40B4-BE49-F238E27FC236}">
                <a16:creationId xmlns:a16="http://schemas.microsoft.com/office/drawing/2014/main" id="{8C741468-4E23-4D17-B04E-85D8B519067A}"/>
              </a:ext>
            </a:extLst>
          </p:cNvPr>
          <p:cNvSpPr/>
          <p:nvPr/>
        </p:nvSpPr>
        <p:spPr>
          <a:xfrm>
            <a:off x="4449556" y="2084388"/>
            <a:ext cx="1113828" cy="314647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5" name="직사각형 114">
            <a:extLst>
              <a:ext uri="{FF2B5EF4-FFF2-40B4-BE49-F238E27FC236}">
                <a16:creationId xmlns:a16="http://schemas.microsoft.com/office/drawing/2014/main" id="{F13BDA11-E724-4D48-83CA-E44BF17FC9E2}"/>
              </a:ext>
            </a:extLst>
          </p:cNvPr>
          <p:cNvSpPr/>
          <p:nvPr/>
        </p:nvSpPr>
        <p:spPr>
          <a:xfrm>
            <a:off x="4457237" y="3007394"/>
            <a:ext cx="1106147" cy="318164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6" name="직사각형 115">
            <a:extLst>
              <a:ext uri="{FF2B5EF4-FFF2-40B4-BE49-F238E27FC236}">
                <a16:creationId xmlns:a16="http://schemas.microsoft.com/office/drawing/2014/main" id="{29CCA9C2-57FF-4AC9-9CFD-31E23AE8073A}"/>
              </a:ext>
            </a:extLst>
          </p:cNvPr>
          <p:cNvSpPr/>
          <p:nvPr/>
        </p:nvSpPr>
        <p:spPr>
          <a:xfrm>
            <a:off x="4473545" y="4582529"/>
            <a:ext cx="1089840" cy="318162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7" name="직사각형 116">
            <a:extLst>
              <a:ext uri="{FF2B5EF4-FFF2-40B4-BE49-F238E27FC236}">
                <a16:creationId xmlns:a16="http://schemas.microsoft.com/office/drawing/2014/main" id="{8E7FE5AC-4146-4B3C-8A0E-1DD084E2810B}"/>
              </a:ext>
            </a:extLst>
          </p:cNvPr>
          <p:cNvSpPr/>
          <p:nvPr/>
        </p:nvSpPr>
        <p:spPr>
          <a:xfrm>
            <a:off x="4457191" y="5336004"/>
            <a:ext cx="1089840" cy="318162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7FB0E2B-A2EA-D6BA-8540-DF39AFDC2AC6}"/>
              </a:ext>
            </a:extLst>
          </p:cNvPr>
          <p:cNvSpPr txBox="1"/>
          <p:nvPr/>
        </p:nvSpPr>
        <p:spPr>
          <a:xfrm>
            <a:off x="34923" y="41837"/>
            <a:ext cx="4696467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Arial" panose="020B0604020202020204" pitchFamily="34" charset="0"/>
                <a:cs typeface="Arial" panose="020B0604020202020204" pitchFamily="34" charset="0"/>
              </a:rPr>
              <a:t>Original gel images of Supplementary Figure 2</a:t>
            </a:r>
            <a:r>
              <a:rPr lang="en-US" altLang="ko-KR" sz="1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endParaRPr lang="en-US" altLang="ko-KR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ll experiments were performed in triplicates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The red boxes indicate the figures in the main text.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958930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개체 3">
            <a:extLst>
              <a:ext uri="{FF2B5EF4-FFF2-40B4-BE49-F238E27FC236}">
                <a16:creationId xmlns:a16="http://schemas.microsoft.com/office/drawing/2014/main" id="{9FE0A990-3AD7-712B-55C6-1E42EA633CF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76185726"/>
              </p:ext>
            </p:extLst>
          </p:nvPr>
        </p:nvGraphicFramePr>
        <p:xfrm>
          <a:off x="7224849" y="5359459"/>
          <a:ext cx="864096" cy="7341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4" name="Image" r:id="rId3" imgW="1688760" imgH="1434600" progId="Photoshop.Image.13">
                  <p:embed/>
                </p:oleObj>
              </mc:Choice>
              <mc:Fallback>
                <p:oleObj name="Image" r:id="rId3" imgW="1688760" imgH="1434600" progId="Photoshop.Image.13">
                  <p:embed/>
                  <p:pic>
                    <p:nvPicPr>
                      <p:cNvPr id="4" name="개체 3">
                        <a:extLst>
                          <a:ext uri="{FF2B5EF4-FFF2-40B4-BE49-F238E27FC236}">
                            <a16:creationId xmlns:a16="http://schemas.microsoft.com/office/drawing/2014/main" id="{9FE0A990-3AD7-712B-55C6-1E42EA633CF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224849" y="5359459"/>
                        <a:ext cx="864096" cy="734157"/>
                      </a:xfrm>
                      <a:prstGeom prst="rect">
                        <a:avLst/>
                      </a:prstGeom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개체 4">
            <a:extLst>
              <a:ext uri="{FF2B5EF4-FFF2-40B4-BE49-F238E27FC236}">
                <a16:creationId xmlns:a16="http://schemas.microsoft.com/office/drawing/2014/main" id="{D6A6A671-04B1-3DF7-D4B5-6BE2A951B98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28075076"/>
              </p:ext>
            </p:extLst>
          </p:nvPr>
        </p:nvGraphicFramePr>
        <p:xfrm>
          <a:off x="7241541" y="1555746"/>
          <a:ext cx="864096" cy="5612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5" name="Image" r:id="rId5" imgW="2298240" imgH="3009240" progId="Photoshop.Image.13">
                  <p:embed/>
                </p:oleObj>
              </mc:Choice>
              <mc:Fallback>
                <p:oleObj name="Image" r:id="rId5" imgW="2298240" imgH="3009240" progId="Photoshop.Image.13">
                  <p:embed/>
                  <p:pic>
                    <p:nvPicPr>
                      <p:cNvPr id="5" name="개체 4">
                        <a:extLst>
                          <a:ext uri="{FF2B5EF4-FFF2-40B4-BE49-F238E27FC236}">
                            <a16:creationId xmlns:a16="http://schemas.microsoft.com/office/drawing/2014/main" id="{D6A6A671-04B1-3DF7-D4B5-6BE2A951B98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241541" y="1555746"/>
                        <a:ext cx="864096" cy="561259"/>
                      </a:xfrm>
                      <a:prstGeom prst="rect">
                        <a:avLst/>
                      </a:prstGeom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개체 5">
            <a:extLst>
              <a:ext uri="{FF2B5EF4-FFF2-40B4-BE49-F238E27FC236}">
                <a16:creationId xmlns:a16="http://schemas.microsoft.com/office/drawing/2014/main" id="{66E661A8-6E78-DACA-40F9-B4F51ED8FFE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89396480"/>
              </p:ext>
            </p:extLst>
          </p:nvPr>
        </p:nvGraphicFramePr>
        <p:xfrm>
          <a:off x="7241543" y="876978"/>
          <a:ext cx="864096" cy="540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6" name="Image" r:id="rId7" imgW="1955520" imgH="1815840" progId="Photoshop.Image.13">
                  <p:embed/>
                </p:oleObj>
              </mc:Choice>
              <mc:Fallback>
                <p:oleObj name="Image" r:id="rId7" imgW="1955520" imgH="1815840" progId="Photoshop.Image.13">
                  <p:embed/>
                  <p:pic>
                    <p:nvPicPr>
                      <p:cNvPr id="6" name="개체 5">
                        <a:extLst>
                          <a:ext uri="{FF2B5EF4-FFF2-40B4-BE49-F238E27FC236}">
                            <a16:creationId xmlns:a16="http://schemas.microsoft.com/office/drawing/2014/main" id="{66E661A8-6E78-DACA-40F9-B4F51ED8FFE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241543" y="876978"/>
                        <a:ext cx="864096" cy="540225"/>
                      </a:xfrm>
                      <a:prstGeom prst="rect">
                        <a:avLst/>
                      </a:prstGeom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개체 6">
            <a:extLst>
              <a:ext uri="{FF2B5EF4-FFF2-40B4-BE49-F238E27FC236}">
                <a16:creationId xmlns:a16="http://schemas.microsoft.com/office/drawing/2014/main" id="{E4DC3DA8-5915-2755-FFD5-449E17F6DFC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8661549"/>
              </p:ext>
            </p:extLst>
          </p:nvPr>
        </p:nvGraphicFramePr>
        <p:xfrm>
          <a:off x="7224853" y="4726986"/>
          <a:ext cx="864096" cy="3790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7" name="Image" r:id="rId9" imgW="1917360" imgH="977760" progId="Photoshop.Image.13">
                  <p:embed/>
                </p:oleObj>
              </mc:Choice>
              <mc:Fallback>
                <p:oleObj name="Image" r:id="rId9" imgW="1917360" imgH="977760" progId="Photoshop.Image.13">
                  <p:embed/>
                  <p:pic>
                    <p:nvPicPr>
                      <p:cNvPr id="7" name="개체 6">
                        <a:extLst>
                          <a:ext uri="{FF2B5EF4-FFF2-40B4-BE49-F238E27FC236}">
                            <a16:creationId xmlns:a16="http://schemas.microsoft.com/office/drawing/2014/main" id="{E4DC3DA8-5915-2755-FFD5-449E17F6DFC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7224853" y="4726986"/>
                        <a:ext cx="864096" cy="379099"/>
                      </a:xfrm>
                      <a:prstGeom prst="rect">
                        <a:avLst/>
                      </a:prstGeom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개체 7">
            <a:extLst>
              <a:ext uri="{FF2B5EF4-FFF2-40B4-BE49-F238E27FC236}">
                <a16:creationId xmlns:a16="http://schemas.microsoft.com/office/drawing/2014/main" id="{E9E20DAB-DA99-4C55-4128-18F4D89E796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45669945"/>
              </p:ext>
            </p:extLst>
          </p:nvPr>
        </p:nvGraphicFramePr>
        <p:xfrm>
          <a:off x="7224855" y="3985141"/>
          <a:ext cx="879101" cy="4705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8" name="Image" r:id="rId11" imgW="2158560" imgH="1155240" progId="Photoshop.Image.13">
                  <p:embed/>
                </p:oleObj>
              </mc:Choice>
              <mc:Fallback>
                <p:oleObj name="Image" r:id="rId11" imgW="2158560" imgH="1155240" progId="Photoshop.Image.13">
                  <p:embed/>
                  <p:pic>
                    <p:nvPicPr>
                      <p:cNvPr id="8" name="개체 7">
                        <a:extLst>
                          <a:ext uri="{FF2B5EF4-FFF2-40B4-BE49-F238E27FC236}">
                            <a16:creationId xmlns:a16="http://schemas.microsoft.com/office/drawing/2014/main" id="{E9E20DAB-DA99-4C55-4128-18F4D89E796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7224855" y="3985141"/>
                        <a:ext cx="879101" cy="470577"/>
                      </a:xfrm>
                      <a:prstGeom prst="rect">
                        <a:avLst/>
                      </a:prstGeom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개체 8">
            <a:extLst>
              <a:ext uri="{FF2B5EF4-FFF2-40B4-BE49-F238E27FC236}">
                <a16:creationId xmlns:a16="http://schemas.microsoft.com/office/drawing/2014/main" id="{D7E3E29A-8D41-D44C-23EF-80BD84AAC07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1116625"/>
              </p:ext>
            </p:extLst>
          </p:nvPr>
        </p:nvGraphicFramePr>
        <p:xfrm>
          <a:off x="10906330" y="3205858"/>
          <a:ext cx="879101" cy="5426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9" name="Image" r:id="rId13" imgW="2057040" imgH="1269720" progId="Photoshop.Image.13">
                  <p:embed/>
                </p:oleObj>
              </mc:Choice>
              <mc:Fallback>
                <p:oleObj name="Image" r:id="rId13" imgW="2057040" imgH="1269720" progId="Photoshop.Image.13">
                  <p:embed/>
                  <p:pic>
                    <p:nvPicPr>
                      <p:cNvPr id="9" name="개체 8">
                        <a:extLst>
                          <a:ext uri="{FF2B5EF4-FFF2-40B4-BE49-F238E27FC236}">
                            <a16:creationId xmlns:a16="http://schemas.microsoft.com/office/drawing/2014/main" id="{D7E3E29A-8D41-D44C-23EF-80BD84AAC07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0906330" y="3205858"/>
                        <a:ext cx="879101" cy="542654"/>
                      </a:xfrm>
                      <a:prstGeom prst="rect">
                        <a:avLst/>
                      </a:prstGeom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F8BAB1A0-0429-4853-570C-009752B75C19}"/>
              </a:ext>
            </a:extLst>
          </p:cNvPr>
          <p:cNvSpPr txBox="1"/>
          <p:nvPr/>
        </p:nvSpPr>
        <p:spPr>
          <a:xfrm>
            <a:off x="5267333" y="4715707"/>
            <a:ext cx="1404552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ERK (42, 44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101B0E5-0953-7976-07F1-2539D56D970A}"/>
              </a:ext>
            </a:extLst>
          </p:cNvPr>
          <p:cNvSpPr txBox="1"/>
          <p:nvPr/>
        </p:nvSpPr>
        <p:spPr>
          <a:xfrm>
            <a:off x="5301659" y="1697875"/>
            <a:ext cx="1386918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JNK (44, 48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7962894-B9C3-E8CE-E2A4-4FB6786E4534}"/>
              </a:ext>
            </a:extLst>
          </p:cNvPr>
          <p:cNvSpPr txBox="1"/>
          <p:nvPr/>
        </p:nvSpPr>
        <p:spPr>
          <a:xfrm>
            <a:off x="5575110" y="3423843"/>
            <a:ext cx="1096775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p38 (38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CE74E92-46B9-31A9-014A-8FB73D00A78F}"/>
              </a:ext>
            </a:extLst>
          </p:cNvPr>
          <p:cNvSpPr txBox="1"/>
          <p:nvPr/>
        </p:nvSpPr>
        <p:spPr>
          <a:xfrm>
            <a:off x="5121460" y="4045160"/>
            <a:ext cx="1550425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p-ERK (42, 44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184A147-D3A2-EB31-012D-AE35CECBE12F}"/>
              </a:ext>
            </a:extLst>
          </p:cNvPr>
          <p:cNvSpPr txBox="1"/>
          <p:nvPr/>
        </p:nvSpPr>
        <p:spPr>
          <a:xfrm>
            <a:off x="5155785" y="1021554"/>
            <a:ext cx="1532792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p-JNK (44, 48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1BA800C-C6B9-EAA0-3419-5685B67C1DC1}"/>
              </a:ext>
            </a:extLst>
          </p:cNvPr>
          <p:cNvSpPr txBox="1"/>
          <p:nvPr/>
        </p:nvSpPr>
        <p:spPr>
          <a:xfrm>
            <a:off x="5422887" y="2552553"/>
            <a:ext cx="1248998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p-p38</a:t>
            </a:r>
            <a:r>
              <a: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38</a:t>
            </a:r>
            <a:r>
              <a: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57C7C83-F87A-9C51-21FC-FE79CCBD6D05}"/>
              </a:ext>
            </a:extLst>
          </p:cNvPr>
          <p:cNvSpPr txBox="1"/>
          <p:nvPr/>
        </p:nvSpPr>
        <p:spPr>
          <a:xfrm>
            <a:off x="5342675" y="5622681"/>
            <a:ext cx="1329210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r"/>
            <a:r>
              <a:rPr lang="el-GR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 (41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그림 22">
            <a:extLst>
              <a:ext uri="{FF2B5EF4-FFF2-40B4-BE49-F238E27FC236}">
                <a16:creationId xmlns:a16="http://schemas.microsoft.com/office/drawing/2014/main" id="{9CAE05BD-6F23-8211-7DEA-675EB8DC0982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294" t="35791" r="62451" b="40266"/>
          <a:stretch/>
        </p:blipFill>
        <p:spPr>
          <a:xfrm>
            <a:off x="8999411" y="5354612"/>
            <a:ext cx="879101" cy="779346"/>
          </a:xfrm>
          <a:prstGeom prst="rect">
            <a:avLst/>
          </a:prstGeom>
          <a:ln>
            <a:noFill/>
          </a:ln>
        </p:spPr>
      </p:pic>
      <p:pic>
        <p:nvPicPr>
          <p:cNvPr id="24" name="그림 23" descr="텍스트이(가) 표시된 사진&#10;&#10;자동 생성된 설명">
            <a:extLst>
              <a:ext uri="{FF2B5EF4-FFF2-40B4-BE49-F238E27FC236}">
                <a16:creationId xmlns:a16="http://schemas.microsoft.com/office/drawing/2014/main" id="{6559CE3B-FE75-4D23-3C31-C5597668D976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33740"/>
          <a:stretch/>
        </p:blipFill>
        <p:spPr>
          <a:xfrm>
            <a:off x="7224855" y="2410441"/>
            <a:ext cx="879101" cy="751216"/>
          </a:xfrm>
          <a:prstGeom prst="rect">
            <a:avLst/>
          </a:prstGeom>
          <a:ln>
            <a:noFill/>
          </a:ln>
        </p:spPr>
      </p:pic>
      <p:pic>
        <p:nvPicPr>
          <p:cNvPr id="25" name="그림 24" descr="텍스트이(가) 표시된 사진&#10;&#10;자동 생성된 설명">
            <a:extLst>
              <a:ext uri="{FF2B5EF4-FFF2-40B4-BE49-F238E27FC236}">
                <a16:creationId xmlns:a16="http://schemas.microsoft.com/office/drawing/2014/main" id="{925BB3ED-EBDB-AF3C-95AA-B016978D6F70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6790" b="11611"/>
          <a:stretch/>
        </p:blipFill>
        <p:spPr>
          <a:xfrm>
            <a:off x="7224855" y="3199828"/>
            <a:ext cx="879101" cy="668127"/>
          </a:xfrm>
          <a:prstGeom prst="rect">
            <a:avLst/>
          </a:prstGeom>
          <a:ln>
            <a:noFill/>
          </a:ln>
        </p:spPr>
      </p:pic>
      <p:pic>
        <p:nvPicPr>
          <p:cNvPr id="27" name="그림 26" descr="텍스트, 영수증이(가) 표시된 사진&#10;&#10;자동 생성된 설명">
            <a:extLst>
              <a:ext uri="{FF2B5EF4-FFF2-40B4-BE49-F238E27FC236}">
                <a16:creationId xmlns:a16="http://schemas.microsoft.com/office/drawing/2014/main" id="{0FA38827-6612-9546-CB76-1A8FDB6DCA8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226" t="1012" r="65" b="-1062"/>
          <a:stretch/>
        </p:blipFill>
        <p:spPr>
          <a:xfrm>
            <a:off x="10947739" y="1708741"/>
            <a:ext cx="888496" cy="598633"/>
          </a:xfrm>
          <a:prstGeom prst="rect">
            <a:avLst/>
          </a:prstGeom>
          <a:ln w="19050">
            <a:noFill/>
          </a:ln>
        </p:spPr>
      </p:pic>
      <p:pic>
        <p:nvPicPr>
          <p:cNvPr id="30" name="그림 29" descr="텍스트, 스크린샷이(가) 표시된 사진&#10;&#10;자동 생성된 설명">
            <a:extLst>
              <a:ext uri="{FF2B5EF4-FFF2-40B4-BE49-F238E27FC236}">
                <a16:creationId xmlns:a16="http://schemas.microsoft.com/office/drawing/2014/main" id="{FA5400F5-685D-E957-5D35-CC5AB2123EC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-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4331" t="17101" r="37304" b="57316"/>
          <a:stretch/>
        </p:blipFill>
        <p:spPr>
          <a:xfrm>
            <a:off x="10901256" y="2410441"/>
            <a:ext cx="884175" cy="762066"/>
          </a:xfrm>
          <a:prstGeom prst="rect">
            <a:avLst/>
          </a:prstGeom>
          <a:ln>
            <a:noFill/>
          </a:ln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9DA4674A-C144-CA45-3843-4D7F07E65410}"/>
              </a:ext>
            </a:extLst>
          </p:cNvPr>
          <p:cNvSpPr txBox="1"/>
          <p:nvPr/>
        </p:nvSpPr>
        <p:spPr>
          <a:xfrm>
            <a:off x="4868527" y="692276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0F8B997-1229-E26C-F4E9-FD0F2B12E6E8}"/>
              </a:ext>
            </a:extLst>
          </p:cNvPr>
          <p:cNvSpPr txBox="1"/>
          <p:nvPr/>
        </p:nvSpPr>
        <p:spPr>
          <a:xfrm>
            <a:off x="7195821" y="353975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B427C90-61E7-77BF-FA72-F4817A327648}"/>
              </a:ext>
            </a:extLst>
          </p:cNvPr>
          <p:cNvSpPr txBox="1"/>
          <p:nvPr/>
        </p:nvSpPr>
        <p:spPr>
          <a:xfrm>
            <a:off x="8908367" y="353975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A966B44-06AF-9316-D4CC-65F1429BD401}"/>
              </a:ext>
            </a:extLst>
          </p:cNvPr>
          <p:cNvSpPr txBox="1"/>
          <p:nvPr/>
        </p:nvSpPr>
        <p:spPr>
          <a:xfrm>
            <a:off x="10821446" y="360432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3</a:t>
            </a:r>
          </a:p>
        </p:txBody>
      </p:sp>
      <p:grpSp>
        <p:nvGrpSpPr>
          <p:cNvPr id="36" name="그룹 35">
            <a:extLst>
              <a:ext uri="{FF2B5EF4-FFF2-40B4-BE49-F238E27FC236}">
                <a16:creationId xmlns:a16="http://schemas.microsoft.com/office/drawing/2014/main" id="{5F860C7D-B8EC-5D8E-DFC5-7FC798E01011}"/>
              </a:ext>
            </a:extLst>
          </p:cNvPr>
          <p:cNvGrpSpPr/>
          <p:nvPr/>
        </p:nvGrpSpPr>
        <p:grpSpPr>
          <a:xfrm>
            <a:off x="6615015" y="5645765"/>
            <a:ext cx="609834" cy="230832"/>
            <a:chOff x="740793" y="5499416"/>
            <a:chExt cx="609834" cy="230832"/>
          </a:xfrm>
        </p:grpSpPr>
        <p:cxnSp>
          <p:nvCxnSpPr>
            <p:cNvPr id="37" name="직선 연결선 36">
              <a:extLst>
                <a:ext uri="{FF2B5EF4-FFF2-40B4-BE49-F238E27FC236}">
                  <a16:creationId xmlns:a16="http://schemas.microsoft.com/office/drawing/2014/main" id="{C9A00B5D-58BF-2A76-6EE0-6052E2C03A16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DE444FB3-C9A1-A135-00CE-02166FE15B4D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9" name="그룹 38">
            <a:extLst>
              <a:ext uri="{FF2B5EF4-FFF2-40B4-BE49-F238E27FC236}">
                <a16:creationId xmlns:a16="http://schemas.microsoft.com/office/drawing/2014/main" id="{EDBE80B1-A9CD-DA26-E747-F51F88EC6044}"/>
              </a:ext>
            </a:extLst>
          </p:cNvPr>
          <p:cNvGrpSpPr/>
          <p:nvPr/>
        </p:nvGrpSpPr>
        <p:grpSpPr>
          <a:xfrm>
            <a:off x="6631707" y="1670365"/>
            <a:ext cx="609834" cy="230832"/>
            <a:chOff x="740793" y="5499416"/>
            <a:chExt cx="609834" cy="230832"/>
          </a:xfrm>
        </p:grpSpPr>
        <p:cxnSp>
          <p:nvCxnSpPr>
            <p:cNvPr id="40" name="직선 연결선 39">
              <a:extLst>
                <a:ext uri="{FF2B5EF4-FFF2-40B4-BE49-F238E27FC236}">
                  <a16:creationId xmlns:a16="http://schemas.microsoft.com/office/drawing/2014/main" id="{38CCA742-3898-C1A4-4F77-A7FFB028ECB4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C65C20F8-8595-094C-A657-DD8F8846748E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42" name="그림 41">
            <a:extLst>
              <a:ext uri="{FF2B5EF4-FFF2-40B4-BE49-F238E27FC236}">
                <a16:creationId xmlns:a16="http://schemas.microsoft.com/office/drawing/2014/main" id="{638CC971-F939-E030-E6F3-143FD22DAF31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8957384" y="2410441"/>
            <a:ext cx="883997" cy="762066"/>
          </a:xfrm>
          <a:prstGeom prst="rect">
            <a:avLst/>
          </a:prstGeom>
        </p:spPr>
      </p:pic>
      <p:pic>
        <p:nvPicPr>
          <p:cNvPr id="43" name="그림 42">
            <a:extLst>
              <a:ext uri="{FF2B5EF4-FFF2-40B4-BE49-F238E27FC236}">
                <a16:creationId xmlns:a16="http://schemas.microsoft.com/office/drawing/2014/main" id="{C22FB621-BA49-A6C2-AF41-4BDF87AD6A76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8957384" y="3212394"/>
            <a:ext cx="883997" cy="469433"/>
          </a:xfrm>
          <a:prstGeom prst="rect">
            <a:avLst/>
          </a:prstGeom>
        </p:spPr>
      </p:pic>
      <p:pic>
        <p:nvPicPr>
          <p:cNvPr id="44" name="그림 43">
            <a:extLst>
              <a:ext uri="{FF2B5EF4-FFF2-40B4-BE49-F238E27FC236}">
                <a16:creationId xmlns:a16="http://schemas.microsoft.com/office/drawing/2014/main" id="{29C2B617-2F5B-0DB0-16DE-44D9B141D562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8967922" y="3887297"/>
            <a:ext cx="890093" cy="560881"/>
          </a:xfrm>
          <a:prstGeom prst="rect">
            <a:avLst/>
          </a:prstGeom>
        </p:spPr>
      </p:pic>
      <p:pic>
        <p:nvPicPr>
          <p:cNvPr id="45" name="그림 44">
            <a:extLst>
              <a:ext uri="{FF2B5EF4-FFF2-40B4-BE49-F238E27FC236}">
                <a16:creationId xmlns:a16="http://schemas.microsoft.com/office/drawing/2014/main" id="{4E2FBCBB-22AB-B53B-5C55-869D6DEFDCD8}"/>
              </a:ext>
            </a:extLst>
          </p:cNvPr>
          <p:cNvPicPr>
            <a:picLocks noChangeAspect="1"/>
          </p:cNvPicPr>
          <p:nvPr/>
        </p:nvPicPr>
        <p:blipFill>
          <a:blip r:embed="rId27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8988177" y="4573506"/>
            <a:ext cx="877900" cy="676715"/>
          </a:xfrm>
          <a:prstGeom prst="rect">
            <a:avLst/>
          </a:prstGeom>
        </p:spPr>
      </p:pic>
      <p:pic>
        <p:nvPicPr>
          <p:cNvPr id="46" name="그림 45">
            <a:extLst>
              <a:ext uri="{FF2B5EF4-FFF2-40B4-BE49-F238E27FC236}">
                <a16:creationId xmlns:a16="http://schemas.microsoft.com/office/drawing/2014/main" id="{4E34CCA8-6A1B-0001-A013-C67F94AAF036}"/>
              </a:ext>
            </a:extLst>
          </p:cNvPr>
          <p:cNvPicPr>
            <a:picLocks noChangeAspect="1"/>
          </p:cNvPicPr>
          <p:nvPr/>
        </p:nvPicPr>
        <p:blipFill>
          <a:blip r:embed="rId29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004869" y="897338"/>
            <a:ext cx="883997" cy="560881"/>
          </a:xfrm>
          <a:prstGeom prst="rect">
            <a:avLst/>
          </a:prstGeom>
        </p:spPr>
      </p:pic>
      <p:pic>
        <p:nvPicPr>
          <p:cNvPr id="47" name="그림 46">
            <a:extLst>
              <a:ext uri="{FF2B5EF4-FFF2-40B4-BE49-F238E27FC236}">
                <a16:creationId xmlns:a16="http://schemas.microsoft.com/office/drawing/2014/main" id="{AF551DE1-2742-8908-24FE-853171943FA0}"/>
              </a:ext>
            </a:extLst>
          </p:cNvPr>
          <p:cNvPicPr>
            <a:picLocks noChangeAspect="1"/>
          </p:cNvPicPr>
          <p:nvPr/>
        </p:nvPicPr>
        <p:blipFill>
          <a:blip r:embed="rId31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004869" y="1588733"/>
            <a:ext cx="877900" cy="560881"/>
          </a:xfrm>
          <a:prstGeom prst="rect">
            <a:avLst/>
          </a:prstGeom>
        </p:spPr>
      </p:pic>
      <p:grpSp>
        <p:nvGrpSpPr>
          <p:cNvPr id="51" name="그룹 50">
            <a:extLst>
              <a:ext uri="{FF2B5EF4-FFF2-40B4-BE49-F238E27FC236}">
                <a16:creationId xmlns:a16="http://schemas.microsoft.com/office/drawing/2014/main" id="{9B365009-0E68-C4A2-CCFB-E2B0358A7F82}"/>
              </a:ext>
            </a:extLst>
          </p:cNvPr>
          <p:cNvGrpSpPr/>
          <p:nvPr/>
        </p:nvGrpSpPr>
        <p:grpSpPr>
          <a:xfrm>
            <a:off x="6615015" y="2734782"/>
            <a:ext cx="609834" cy="230832"/>
            <a:chOff x="740793" y="5499416"/>
            <a:chExt cx="609834" cy="230832"/>
          </a:xfrm>
        </p:grpSpPr>
        <p:cxnSp>
          <p:nvCxnSpPr>
            <p:cNvPr id="52" name="직선 연결선 51">
              <a:extLst>
                <a:ext uri="{FF2B5EF4-FFF2-40B4-BE49-F238E27FC236}">
                  <a16:creationId xmlns:a16="http://schemas.microsoft.com/office/drawing/2014/main" id="{A21A591F-01AE-1EAE-4D5F-A2142757D44D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67ED6D31-D785-A321-4D79-725637B21E02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4" name="그룹 53">
            <a:extLst>
              <a:ext uri="{FF2B5EF4-FFF2-40B4-BE49-F238E27FC236}">
                <a16:creationId xmlns:a16="http://schemas.microsoft.com/office/drawing/2014/main" id="{F86B0BA6-056C-E080-2BB2-CA41027D0654}"/>
              </a:ext>
            </a:extLst>
          </p:cNvPr>
          <p:cNvGrpSpPr/>
          <p:nvPr/>
        </p:nvGrpSpPr>
        <p:grpSpPr>
          <a:xfrm>
            <a:off x="6615015" y="2475465"/>
            <a:ext cx="609834" cy="230832"/>
            <a:chOff x="740793" y="5499416"/>
            <a:chExt cx="609834" cy="230832"/>
          </a:xfrm>
        </p:grpSpPr>
        <p:cxnSp>
          <p:nvCxnSpPr>
            <p:cNvPr id="55" name="직선 연결선 54">
              <a:extLst>
                <a:ext uri="{FF2B5EF4-FFF2-40B4-BE49-F238E27FC236}">
                  <a16:creationId xmlns:a16="http://schemas.microsoft.com/office/drawing/2014/main" id="{33083262-E9F8-1B0A-55A2-D0C88AB86870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90E509B1-F3F9-14D5-B30A-DFDE3FEA593F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7" name="그룹 56">
            <a:extLst>
              <a:ext uri="{FF2B5EF4-FFF2-40B4-BE49-F238E27FC236}">
                <a16:creationId xmlns:a16="http://schemas.microsoft.com/office/drawing/2014/main" id="{9A426242-52B9-41DA-3DF0-879EF452BE9A}"/>
              </a:ext>
            </a:extLst>
          </p:cNvPr>
          <p:cNvGrpSpPr/>
          <p:nvPr/>
        </p:nvGrpSpPr>
        <p:grpSpPr>
          <a:xfrm>
            <a:off x="8395035" y="1717159"/>
            <a:ext cx="609834" cy="230832"/>
            <a:chOff x="740793" y="5499416"/>
            <a:chExt cx="609834" cy="230832"/>
          </a:xfrm>
        </p:grpSpPr>
        <p:cxnSp>
          <p:nvCxnSpPr>
            <p:cNvPr id="58" name="직선 연결선 57">
              <a:extLst>
                <a:ext uri="{FF2B5EF4-FFF2-40B4-BE49-F238E27FC236}">
                  <a16:creationId xmlns:a16="http://schemas.microsoft.com/office/drawing/2014/main" id="{573D97AE-4059-EE99-1DEB-5AEFB59B1F9E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D352E7FA-0DC7-F063-B328-B5036D5CF105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0" name="그룹 59">
            <a:extLst>
              <a:ext uri="{FF2B5EF4-FFF2-40B4-BE49-F238E27FC236}">
                <a16:creationId xmlns:a16="http://schemas.microsoft.com/office/drawing/2014/main" id="{A0BE1FF3-F91F-56DE-4547-ACAFDAA30182}"/>
              </a:ext>
            </a:extLst>
          </p:cNvPr>
          <p:cNvGrpSpPr/>
          <p:nvPr/>
        </p:nvGrpSpPr>
        <p:grpSpPr>
          <a:xfrm>
            <a:off x="8395035" y="1522925"/>
            <a:ext cx="609834" cy="230832"/>
            <a:chOff x="740793" y="5499416"/>
            <a:chExt cx="609834" cy="230832"/>
          </a:xfrm>
        </p:grpSpPr>
        <p:cxnSp>
          <p:nvCxnSpPr>
            <p:cNvPr id="61" name="직선 연결선 60">
              <a:extLst>
                <a:ext uri="{FF2B5EF4-FFF2-40B4-BE49-F238E27FC236}">
                  <a16:creationId xmlns:a16="http://schemas.microsoft.com/office/drawing/2014/main" id="{9B91A4D0-D3A1-5284-1DE0-458588F42F19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76002AAB-8AE7-03E4-9316-7C45F45BB48F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63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3" name="그룹 62">
            <a:extLst>
              <a:ext uri="{FF2B5EF4-FFF2-40B4-BE49-F238E27FC236}">
                <a16:creationId xmlns:a16="http://schemas.microsoft.com/office/drawing/2014/main" id="{58F94C1C-20B8-A8BC-B848-8B1CB36138A0}"/>
              </a:ext>
            </a:extLst>
          </p:cNvPr>
          <p:cNvGrpSpPr/>
          <p:nvPr/>
        </p:nvGrpSpPr>
        <p:grpSpPr>
          <a:xfrm>
            <a:off x="8395035" y="993244"/>
            <a:ext cx="609834" cy="230832"/>
            <a:chOff x="740793" y="5499416"/>
            <a:chExt cx="609834" cy="230832"/>
          </a:xfrm>
        </p:grpSpPr>
        <p:cxnSp>
          <p:nvCxnSpPr>
            <p:cNvPr id="64" name="직선 연결선 63">
              <a:extLst>
                <a:ext uri="{FF2B5EF4-FFF2-40B4-BE49-F238E27FC236}">
                  <a16:creationId xmlns:a16="http://schemas.microsoft.com/office/drawing/2014/main" id="{20428865-E195-224D-5AD0-63AA921CE5CF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FCB186B0-7832-0FAA-2A62-6B2279065A04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6" name="그룹 65">
            <a:extLst>
              <a:ext uri="{FF2B5EF4-FFF2-40B4-BE49-F238E27FC236}">
                <a16:creationId xmlns:a16="http://schemas.microsoft.com/office/drawing/2014/main" id="{57CBB997-8741-4F3B-1EDE-81ABAAC88F33}"/>
              </a:ext>
            </a:extLst>
          </p:cNvPr>
          <p:cNvGrpSpPr/>
          <p:nvPr/>
        </p:nvGrpSpPr>
        <p:grpSpPr>
          <a:xfrm>
            <a:off x="8395035" y="863641"/>
            <a:ext cx="609834" cy="230832"/>
            <a:chOff x="740793" y="5499416"/>
            <a:chExt cx="609834" cy="230832"/>
          </a:xfrm>
        </p:grpSpPr>
        <p:cxnSp>
          <p:nvCxnSpPr>
            <p:cNvPr id="67" name="직선 연결선 66">
              <a:extLst>
                <a:ext uri="{FF2B5EF4-FFF2-40B4-BE49-F238E27FC236}">
                  <a16:creationId xmlns:a16="http://schemas.microsoft.com/office/drawing/2014/main" id="{673CD273-047E-1AA3-E565-EE10C5DF1F58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491D11AD-84DD-596B-1162-81A2523732C1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63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9" name="그룹 68">
            <a:extLst>
              <a:ext uri="{FF2B5EF4-FFF2-40B4-BE49-F238E27FC236}">
                <a16:creationId xmlns:a16="http://schemas.microsoft.com/office/drawing/2014/main" id="{97D9E551-EC5D-12D8-A9D6-75889F728F58}"/>
              </a:ext>
            </a:extLst>
          </p:cNvPr>
          <p:cNvGrpSpPr/>
          <p:nvPr/>
        </p:nvGrpSpPr>
        <p:grpSpPr>
          <a:xfrm>
            <a:off x="8378343" y="4254854"/>
            <a:ext cx="609834" cy="230832"/>
            <a:chOff x="740793" y="5499416"/>
            <a:chExt cx="609834" cy="230832"/>
          </a:xfrm>
        </p:grpSpPr>
        <p:cxnSp>
          <p:nvCxnSpPr>
            <p:cNvPr id="70" name="직선 연결선 69">
              <a:extLst>
                <a:ext uri="{FF2B5EF4-FFF2-40B4-BE49-F238E27FC236}">
                  <a16:creationId xmlns:a16="http://schemas.microsoft.com/office/drawing/2014/main" id="{7362BE73-FD8F-1697-C4FA-7FDB8F676514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E4370470-75FD-62A8-594A-3A4F38C2197A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2" name="그룹 71">
            <a:extLst>
              <a:ext uri="{FF2B5EF4-FFF2-40B4-BE49-F238E27FC236}">
                <a16:creationId xmlns:a16="http://schemas.microsoft.com/office/drawing/2014/main" id="{9BAE7D0D-F85C-C012-3CE8-31098570FCC4}"/>
              </a:ext>
            </a:extLst>
          </p:cNvPr>
          <p:cNvGrpSpPr/>
          <p:nvPr/>
        </p:nvGrpSpPr>
        <p:grpSpPr>
          <a:xfrm>
            <a:off x="8378343" y="4038932"/>
            <a:ext cx="609834" cy="230832"/>
            <a:chOff x="740793" y="5499416"/>
            <a:chExt cx="609834" cy="230832"/>
          </a:xfrm>
        </p:grpSpPr>
        <p:cxnSp>
          <p:nvCxnSpPr>
            <p:cNvPr id="73" name="직선 연결선 72">
              <a:extLst>
                <a:ext uri="{FF2B5EF4-FFF2-40B4-BE49-F238E27FC236}">
                  <a16:creationId xmlns:a16="http://schemas.microsoft.com/office/drawing/2014/main" id="{90B12590-9DF5-4FA1-606B-A481ED991FA5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BDEDD8AB-2FF0-3E4E-85C1-01D64D30C571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1" name="그룹 80">
            <a:extLst>
              <a:ext uri="{FF2B5EF4-FFF2-40B4-BE49-F238E27FC236}">
                <a16:creationId xmlns:a16="http://schemas.microsoft.com/office/drawing/2014/main" id="{A7847EEA-7FD3-2C9F-FCD6-C48003F45409}"/>
              </a:ext>
            </a:extLst>
          </p:cNvPr>
          <p:cNvGrpSpPr/>
          <p:nvPr/>
        </p:nvGrpSpPr>
        <p:grpSpPr>
          <a:xfrm>
            <a:off x="8378343" y="3432696"/>
            <a:ext cx="609834" cy="230832"/>
            <a:chOff x="740793" y="5499416"/>
            <a:chExt cx="609834" cy="230832"/>
          </a:xfrm>
        </p:grpSpPr>
        <p:cxnSp>
          <p:nvCxnSpPr>
            <p:cNvPr id="82" name="직선 연결선 81">
              <a:extLst>
                <a:ext uri="{FF2B5EF4-FFF2-40B4-BE49-F238E27FC236}">
                  <a16:creationId xmlns:a16="http://schemas.microsoft.com/office/drawing/2014/main" id="{FDD080AA-6CF8-A5AA-2D5B-F3DB7F719712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E2492CBA-CBEA-C3AE-DF20-3C4A62E44A3D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4" name="그룹 83">
            <a:extLst>
              <a:ext uri="{FF2B5EF4-FFF2-40B4-BE49-F238E27FC236}">
                <a16:creationId xmlns:a16="http://schemas.microsoft.com/office/drawing/2014/main" id="{1482ACB7-F9D2-98F0-ABA8-B2E6C655ECAB}"/>
              </a:ext>
            </a:extLst>
          </p:cNvPr>
          <p:cNvGrpSpPr/>
          <p:nvPr/>
        </p:nvGrpSpPr>
        <p:grpSpPr>
          <a:xfrm>
            <a:off x="8378343" y="3234855"/>
            <a:ext cx="609834" cy="230832"/>
            <a:chOff x="740793" y="5499416"/>
            <a:chExt cx="609834" cy="230832"/>
          </a:xfrm>
        </p:grpSpPr>
        <p:cxnSp>
          <p:nvCxnSpPr>
            <p:cNvPr id="85" name="직선 연결선 84">
              <a:extLst>
                <a:ext uri="{FF2B5EF4-FFF2-40B4-BE49-F238E27FC236}">
                  <a16:creationId xmlns:a16="http://schemas.microsoft.com/office/drawing/2014/main" id="{9FF5D85C-F436-D0A0-9974-2204028DBB98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3BF78D80-45F1-51C2-3AF6-CBC211FB25E0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7" name="그룹 86">
            <a:extLst>
              <a:ext uri="{FF2B5EF4-FFF2-40B4-BE49-F238E27FC236}">
                <a16:creationId xmlns:a16="http://schemas.microsoft.com/office/drawing/2014/main" id="{E345B4E7-2A2E-09C6-F264-411E41E3F5A5}"/>
              </a:ext>
            </a:extLst>
          </p:cNvPr>
          <p:cNvGrpSpPr/>
          <p:nvPr/>
        </p:nvGrpSpPr>
        <p:grpSpPr>
          <a:xfrm>
            <a:off x="8352295" y="2810951"/>
            <a:ext cx="609834" cy="230832"/>
            <a:chOff x="740793" y="5499416"/>
            <a:chExt cx="609834" cy="230832"/>
          </a:xfrm>
        </p:grpSpPr>
        <p:cxnSp>
          <p:nvCxnSpPr>
            <p:cNvPr id="88" name="직선 연결선 87">
              <a:extLst>
                <a:ext uri="{FF2B5EF4-FFF2-40B4-BE49-F238E27FC236}">
                  <a16:creationId xmlns:a16="http://schemas.microsoft.com/office/drawing/2014/main" id="{2082D4E7-175C-B39C-0EF1-6E1290AF92C5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231E4BD2-DDC7-53D1-FD3E-48FC7845BFEB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0" name="그룹 89">
            <a:extLst>
              <a:ext uri="{FF2B5EF4-FFF2-40B4-BE49-F238E27FC236}">
                <a16:creationId xmlns:a16="http://schemas.microsoft.com/office/drawing/2014/main" id="{53A32EB3-E97B-4E4E-69A4-786164AE166C}"/>
              </a:ext>
            </a:extLst>
          </p:cNvPr>
          <p:cNvGrpSpPr/>
          <p:nvPr/>
        </p:nvGrpSpPr>
        <p:grpSpPr>
          <a:xfrm>
            <a:off x="8352295" y="2551634"/>
            <a:ext cx="609834" cy="230832"/>
            <a:chOff x="740793" y="5499416"/>
            <a:chExt cx="609834" cy="230832"/>
          </a:xfrm>
        </p:grpSpPr>
        <p:cxnSp>
          <p:nvCxnSpPr>
            <p:cNvPr id="91" name="직선 연결선 90">
              <a:extLst>
                <a:ext uri="{FF2B5EF4-FFF2-40B4-BE49-F238E27FC236}">
                  <a16:creationId xmlns:a16="http://schemas.microsoft.com/office/drawing/2014/main" id="{E356245D-3039-4F60-3C09-C5CCDE574FAE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210135DE-D482-8BDD-DCD4-F8EE626EB990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3" name="그룹 92">
            <a:extLst>
              <a:ext uri="{FF2B5EF4-FFF2-40B4-BE49-F238E27FC236}">
                <a16:creationId xmlns:a16="http://schemas.microsoft.com/office/drawing/2014/main" id="{C67C9C92-37E6-8019-C982-933A6042684F}"/>
              </a:ext>
            </a:extLst>
          </p:cNvPr>
          <p:cNvGrpSpPr/>
          <p:nvPr/>
        </p:nvGrpSpPr>
        <p:grpSpPr>
          <a:xfrm>
            <a:off x="8389577" y="4956935"/>
            <a:ext cx="609834" cy="230832"/>
            <a:chOff x="740793" y="5499416"/>
            <a:chExt cx="609834" cy="230832"/>
          </a:xfrm>
        </p:grpSpPr>
        <p:cxnSp>
          <p:nvCxnSpPr>
            <p:cNvPr id="94" name="직선 연결선 93">
              <a:extLst>
                <a:ext uri="{FF2B5EF4-FFF2-40B4-BE49-F238E27FC236}">
                  <a16:creationId xmlns:a16="http://schemas.microsoft.com/office/drawing/2014/main" id="{B71FAC4C-05E4-EE04-FD23-7F7A5A992F54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13C983CA-A0A3-631A-19E0-C1F6F234E6FE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6" name="그룹 95">
            <a:extLst>
              <a:ext uri="{FF2B5EF4-FFF2-40B4-BE49-F238E27FC236}">
                <a16:creationId xmlns:a16="http://schemas.microsoft.com/office/drawing/2014/main" id="{4D9DCD1B-3A38-A265-A76E-CC5C35963FF3}"/>
              </a:ext>
            </a:extLst>
          </p:cNvPr>
          <p:cNvGrpSpPr/>
          <p:nvPr/>
        </p:nvGrpSpPr>
        <p:grpSpPr>
          <a:xfrm>
            <a:off x="8389577" y="4677207"/>
            <a:ext cx="609834" cy="230832"/>
            <a:chOff x="740793" y="5499416"/>
            <a:chExt cx="609834" cy="230832"/>
          </a:xfrm>
        </p:grpSpPr>
        <p:cxnSp>
          <p:nvCxnSpPr>
            <p:cNvPr id="97" name="직선 연결선 96">
              <a:extLst>
                <a:ext uri="{FF2B5EF4-FFF2-40B4-BE49-F238E27FC236}">
                  <a16:creationId xmlns:a16="http://schemas.microsoft.com/office/drawing/2014/main" id="{4628E87B-7100-401E-C879-1198591EDE37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A96A9809-02AB-6538-8F2D-72A4A2A28B7A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9" name="그룹 98">
            <a:extLst>
              <a:ext uri="{FF2B5EF4-FFF2-40B4-BE49-F238E27FC236}">
                <a16:creationId xmlns:a16="http://schemas.microsoft.com/office/drawing/2014/main" id="{A582080C-85FF-CCBC-90E0-9F34AFB42BDC}"/>
              </a:ext>
            </a:extLst>
          </p:cNvPr>
          <p:cNvGrpSpPr/>
          <p:nvPr/>
        </p:nvGrpSpPr>
        <p:grpSpPr>
          <a:xfrm>
            <a:off x="8390475" y="5708175"/>
            <a:ext cx="609834" cy="230832"/>
            <a:chOff x="740793" y="5499416"/>
            <a:chExt cx="609834" cy="230832"/>
          </a:xfrm>
        </p:grpSpPr>
        <p:cxnSp>
          <p:nvCxnSpPr>
            <p:cNvPr id="100" name="직선 연결선 99">
              <a:extLst>
                <a:ext uri="{FF2B5EF4-FFF2-40B4-BE49-F238E27FC236}">
                  <a16:creationId xmlns:a16="http://schemas.microsoft.com/office/drawing/2014/main" id="{FF3006F1-9A81-4489-FB03-93B7E2054339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515E0DD5-8E0E-11D4-1B06-9E7B94E915AB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2" name="그룹 101">
            <a:extLst>
              <a:ext uri="{FF2B5EF4-FFF2-40B4-BE49-F238E27FC236}">
                <a16:creationId xmlns:a16="http://schemas.microsoft.com/office/drawing/2014/main" id="{4D09716A-16A8-DC55-B1E6-FAE529D013A0}"/>
              </a:ext>
            </a:extLst>
          </p:cNvPr>
          <p:cNvGrpSpPr/>
          <p:nvPr/>
        </p:nvGrpSpPr>
        <p:grpSpPr>
          <a:xfrm>
            <a:off x="8405715" y="5487195"/>
            <a:ext cx="609834" cy="230832"/>
            <a:chOff x="740793" y="5499416"/>
            <a:chExt cx="609834" cy="230832"/>
          </a:xfrm>
        </p:grpSpPr>
        <p:cxnSp>
          <p:nvCxnSpPr>
            <p:cNvPr id="103" name="직선 연결선 102">
              <a:extLst>
                <a:ext uri="{FF2B5EF4-FFF2-40B4-BE49-F238E27FC236}">
                  <a16:creationId xmlns:a16="http://schemas.microsoft.com/office/drawing/2014/main" id="{7AF4FBFB-749E-C090-BF07-99CBFB4E8E34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FD73E5B0-9590-B818-E0EE-9E02E56DDF34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7" name="그룹 106">
            <a:extLst>
              <a:ext uri="{FF2B5EF4-FFF2-40B4-BE49-F238E27FC236}">
                <a16:creationId xmlns:a16="http://schemas.microsoft.com/office/drawing/2014/main" id="{EBFE2D23-A5F6-2BA4-0DE2-1146C62EC9FD}"/>
              </a:ext>
            </a:extLst>
          </p:cNvPr>
          <p:cNvGrpSpPr/>
          <p:nvPr/>
        </p:nvGrpSpPr>
        <p:grpSpPr>
          <a:xfrm>
            <a:off x="10328332" y="5744881"/>
            <a:ext cx="609834" cy="230832"/>
            <a:chOff x="740793" y="5499416"/>
            <a:chExt cx="609834" cy="230832"/>
          </a:xfrm>
        </p:grpSpPr>
        <p:cxnSp>
          <p:nvCxnSpPr>
            <p:cNvPr id="108" name="직선 연결선 107">
              <a:extLst>
                <a:ext uri="{FF2B5EF4-FFF2-40B4-BE49-F238E27FC236}">
                  <a16:creationId xmlns:a16="http://schemas.microsoft.com/office/drawing/2014/main" id="{E45D7C8F-B895-2ADF-1B38-3F0B4B3B264A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76A131E3-10D0-21D1-0A17-674F0BFFFA45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0" name="그룹 109">
            <a:extLst>
              <a:ext uri="{FF2B5EF4-FFF2-40B4-BE49-F238E27FC236}">
                <a16:creationId xmlns:a16="http://schemas.microsoft.com/office/drawing/2014/main" id="{430D033C-9065-DB7B-7ACE-519865383FAA}"/>
              </a:ext>
            </a:extLst>
          </p:cNvPr>
          <p:cNvGrpSpPr/>
          <p:nvPr/>
        </p:nvGrpSpPr>
        <p:grpSpPr>
          <a:xfrm>
            <a:off x="10343572" y="5574235"/>
            <a:ext cx="609834" cy="230832"/>
            <a:chOff x="740793" y="5499416"/>
            <a:chExt cx="609834" cy="230832"/>
          </a:xfrm>
        </p:grpSpPr>
        <p:cxnSp>
          <p:nvCxnSpPr>
            <p:cNvPr id="111" name="직선 연결선 110">
              <a:extLst>
                <a:ext uri="{FF2B5EF4-FFF2-40B4-BE49-F238E27FC236}">
                  <a16:creationId xmlns:a16="http://schemas.microsoft.com/office/drawing/2014/main" id="{01E6B864-08DE-3352-71D1-52CC05A76FE4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409E68D0-F131-462D-ADD0-C2C12DE89007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3" name="그룹 112">
            <a:extLst>
              <a:ext uri="{FF2B5EF4-FFF2-40B4-BE49-F238E27FC236}">
                <a16:creationId xmlns:a16="http://schemas.microsoft.com/office/drawing/2014/main" id="{802533EB-AC50-3E92-E07F-D92EAE0A28E8}"/>
              </a:ext>
            </a:extLst>
          </p:cNvPr>
          <p:cNvGrpSpPr/>
          <p:nvPr/>
        </p:nvGrpSpPr>
        <p:grpSpPr>
          <a:xfrm>
            <a:off x="6625044" y="3549715"/>
            <a:ext cx="609834" cy="230832"/>
            <a:chOff x="740793" y="5499416"/>
            <a:chExt cx="609834" cy="230832"/>
          </a:xfrm>
        </p:grpSpPr>
        <p:cxnSp>
          <p:nvCxnSpPr>
            <p:cNvPr id="114" name="직선 연결선 113">
              <a:extLst>
                <a:ext uri="{FF2B5EF4-FFF2-40B4-BE49-F238E27FC236}">
                  <a16:creationId xmlns:a16="http://schemas.microsoft.com/office/drawing/2014/main" id="{D774BD94-8700-A101-116D-29204C5A921E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EF724491-A402-4752-7520-70CC74557B2C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6" name="그룹 115">
            <a:extLst>
              <a:ext uri="{FF2B5EF4-FFF2-40B4-BE49-F238E27FC236}">
                <a16:creationId xmlns:a16="http://schemas.microsoft.com/office/drawing/2014/main" id="{A8465027-CAAB-5A68-D914-9F2393C8513E}"/>
              </a:ext>
            </a:extLst>
          </p:cNvPr>
          <p:cNvGrpSpPr/>
          <p:nvPr/>
        </p:nvGrpSpPr>
        <p:grpSpPr>
          <a:xfrm>
            <a:off x="6625044" y="3293565"/>
            <a:ext cx="609834" cy="230832"/>
            <a:chOff x="740793" y="5499416"/>
            <a:chExt cx="609834" cy="230832"/>
          </a:xfrm>
        </p:grpSpPr>
        <p:cxnSp>
          <p:nvCxnSpPr>
            <p:cNvPr id="117" name="직선 연결선 116">
              <a:extLst>
                <a:ext uri="{FF2B5EF4-FFF2-40B4-BE49-F238E27FC236}">
                  <a16:creationId xmlns:a16="http://schemas.microsoft.com/office/drawing/2014/main" id="{95F094AF-EFD3-9AC4-39A3-34C568535912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E9E4291C-942B-2017-E821-4322589A215D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9" name="그룹 118">
            <a:extLst>
              <a:ext uri="{FF2B5EF4-FFF2-40B4-BE49-F238E27FC236}">
                <a16:creationId xmlns:a16="http://schemas.microsoft.com/office/drawing/2014/main" id="{94468190-3E2F-78D0-FE83-115742A2CB5D}"/>
              </a:ext>
            </a:extLst>
          </p:cNvPr>
          <p:cNvGrpSpPr/>
          <p:nvPr/>
        </p:nvGrpSpPr>
        <p:grpSpPr>
          <a:xfrm>
            <a:off x="6619308" y="4210701"/>
            <a:ext cx="609834" cy="230832"/>
            <a:chOff x="740793" y="5499416"/>
            <a:chExt cx="609834" cy="230832"/>
          </a:xfrm>
        </p:grpSpPr>
        <p:cxnSp>
          <p:nvCxnSpPr>
            <p:cNvPr id="120" name="직선 연결선 119">
              <a:extLst>
                <a:ext uri="{FF2B5EF4-FFF2-40B4-BE49-F238E27FC236}">
                  <a16:creationId xmlns:a16="http://schemas.microsoft.com/office/drawing/2014/main" id="{0331D8B7-00AB-F8DF-2E05-15123C031F22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4E7C8ECE-899A-33DA-0901-93F6C54E967A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2" name="그룹 121">
            <a:extLst>
              <a:ext uri="{FF2B5EF4-FFF2-40B4-BE49-F238E27FC236}">
                <a16:creationId xmlns:a16="http://schemas.microsoft.com/office/drawing/2014/main" id="{C7E8A9AA-F4B3-331B-80F4-E6D7E3B8182F}"/>
              </a:ext>
            </a:extLst>
          </p:cNvPr>
          <p:cNvGrpSpPr/>
          <p:nvPr/>
        </p:nvGrpSpPr>
        <p:grpSpPr>
          <a:xfrm>
            <a:off x="6619308" y="4046830"/>
            <a:ext cx="609834" cy="230832"/>
            <a:chOff x="740793" y="5499416"/>
            <a:chExt cx="609834" cy="230832"/>
          </a:xfrm>
        </p:grpSpPr>
        <p:cxnSp>
          <p:nvCxnSpPr>
            <p:cNvPr id="123" name="직선 연결선 122">
              <a:extLst>
                <a:ext uri="{FF2B5EF4-FFF2-40B4-BE49-F238E27FC236}">
                  <a16:creationId xmlns:a16="http://schemas.microsoft.com/office/drawing/2014/main" id="{E5F44B07-4F9C-B2BD-5CD5-750A3234CE95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D9E48782-2D5C-5005-BD64-6821037AFC46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5" name="그룹 124">
            <a:extLst>
              <a:ext uri="{FF2B5EF4-FFF2-40B4-BE49-F238E27FC236}">
                <a16:creationId xmlns:a16="http://schemas.microsoft.com/office/drawing/2014/main" id="{90A6852D-4891-26B9-0EA6-3F9C2D2663F3}"/>
              </a:ext>
            </a:extLst>
          </p:cNvPr>
          <p:cNvGrpSpPr/>
          <p:nvPr/>
        </p:nvGrpSpPr>
        <p:grpSpPr>
          <a:xfrm>
            <a:off x="6627697" y="4747720"/>
            <a:ext cx="609834" cy="230832"/>
            <a:chOff x="740793" y="5499416"/>
            <a:chExt cx="609834" cy="230832"/>
          </a:xfrm>
        </p:grpSpPr>
        <p:cxnSp>
          <p:nvCxnSpPr>
            <p:cNvPr id="126" name="직선 연결선 125">
              <a:extLst>
                <a:ext uri="{FF2B5EF4-FFF2-40B4-BE49-F238E27FC236}">
                  <a16:creationId xmlns:a16="http://schemas.microsoft.com/office/drawing/2014/main" id="{4A0F6570-32AE-92F6-F601-CC344CB57E7D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6647D436-8741-F039-CCD1-FAA39E67A923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8" name="그룹 127">
            <a:extLst>
              <a:ext uri="{FF2B5EF4-FFF2-40B4-BE49-F238E27FC236}">
                <a16:creationId xmlns:a16="http://schemas.microsoft.com/office/drawing/2014/main" id="{E5CFAB1C-7157-28D5-B92E-A0AEC607A75A}"/>
              </a:ext>
            </a:extLst>
          </p:cNvPr>
          <p:cNvGrpSpPr/>
          <p:nvPr/>
        </p:nvGrpSpPr>
        <p:grpSpPr>
          <a:xfrm>
            <a:off x="6633347" y="976003"/>
            <a:ext cx="609834" cy="230832"/>
            <a:chOff x="740793" y="5499416"/>
            <a:chExt cx="609834" cy="230832"/>
          </a:xfrm>
        </p:grpSpPr>
        <p:cxnSp>
          <p:nvCxnSpPr>
            <p:cNvPr id="129" name="직선 연결선 128">
              <a:extLst>
                <a:ext uri="{FF2B5EF4-FFF2-40B4-BE49-F238E27FC236}">
                  <a16:creationId xmlns:a16="http://schemas.microsoft.com/office/drawing/2014/main" id="{ECE207F9-F538-297D-3836-B91DE56CEA45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3C9ACEFF-890B-2A49-CD2B-2D59EE463536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1" name="그룹 130">
            <a:extLst>
              <a:ext uri="{FF2B5EF4-FFF2-40B4-BE49-F238E27FC236}">
                <a16:creationId xmlns:a16="http://schemas.microsoft.com/office/drawing/2014/main" id="{74513683-CB0C-C396-FF40-3D029C44F592}"/>
              </a:ext>
            </a:extLst>
          </p:cNvPr>
          <p:cNvGrpSpPr/>
          <p:nvPr/>
        </p:nvGrpSpPr>
        <p:grpSpPr>
          <a:xfrm>
            <a:off x="6633347" y="846400"/>
            <a:ext cx="609834" cy="230832"/>
            <a:chOff x="740793" y="5499416"/>
            <a:chExt cx="609834" cy="230832"/>
          </a:xfrm>
        </p:grpSpPr>
        <p:cxnSp>
          <p:nvCxnSpPr>
            <p:cNvPr id="132" name="직선 연결선 131">
              <a:extLst>
                <a:ext uri="{FF2B5EF4-FFF2-40B4-BE49-F238E27FC236}">
                  <a16:creationId xmlns:a16="http://schemas.microsoft.com/office/drawing/2014/main" id="{61D89A64-1C05-ED2A-5C9E-F5F40B66D58F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6DE34B3C-CCF2-CF2D-0802-0592E7BF0D19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63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4" name="그룹 133">
            <a:extLst>
              <a:ext uri="{FF2B5EF4-FFF2-40B4-BE49-F238E27FC236}">
                <a16:creationId xmlns:a16="http://schemas.microsoft.com/office/drawing/2014/main" id="{849BC32D-AFBF-7BC2-17B9-D530A044ED97}"/>
              </a:ext>
            </a:extLst>
          </p:cNvPr>
          <p:cNvGrpSpPr/>
          <p:nvPr/>
        </p:nvGrpSpPr>
        <p:grpSpPr>
          <a:xfrm>
            <a:off x="8395035" y="1228136"/>
            <a:ext cx="609834" cy="230832"/>
            <a:chOff x="740793" y="5499416"/>
            <a:chExt cx="609834" cy="230832"/>
          </a:xfrm>
        </p:grpSpPr>
        <p:cxnSp>
          <p:nvCxnSpPr>
            <p:cNvPr id="135" name="직선 연결선 134">
              <a:extLst>
                <a:ext uri="{FF2B5EF4-FFF2-40B4-BE49-F238E27FC236}">
                  <a16:creationId xmlns:a16="http://schemas.microsoft.com/office/drawing/2014/main" id="{455F436A-DFB5-F6EE-CA8A-7C9330EEB5C1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48AAEBC8-A1B7-0E44-142E-7EFC96F89087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7" name="그룹 136">
            <a:extLst>
              <a:ext uri="{FF2B5EF4-FFF2-40B4-BE49-F238E27FC236}">
                <a16:creationId xmlns:a16="http://schemas.microsoft.com/office/drawing/2014/main" id="{35F3F945-482E-86E4-B0FF-1BA20971EF59}"/>
              </a:ext>
            </a:extLst>
          </p:cNvPr>
          <p:cNvGrpSpPr/>
          <p:nvPr/>
        </p:nvGrpSpPr>
        <p:grpSpPr>
          <a:xfrm>
            <a:off x="6616569" y="1168950"/>
            <a:ext cx="609834" cy="230832"/>
            <a:chOff x="740793" y="5499416"/>
            <a:chExt cx="609834" cy="230832"/>
          </a:xfrm>
        </p:grpSpPr>
        <p:cxnSp>
          <p:nvCxnSpPr>
            <p:cNvPr id="138" name="직선 연결선 137">
              <a:extLst>
                <a:ext uri="{FF2B5EF4-FFF2-40B4-BE49-F238E27FC236}">
                  <a16:creationId xmlns:a16="http://schemas.microsoft.com/office/drawing/2014/main" id="{5350C1B7-FE7F-6CBB-0902-6B0F6F6810E1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46CDD14C-4AC3-F094-0B4A-CCEA7D316B60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0" name="그룹 139">
            <a:extLst>
              <a:ext uri="{FF2B5EF4-FFF2-40B4-BE49-F238E27FC236}">
                <a16:creationId xmlns:a16="http://schemas.microsoft.com/office/drawing/2014/main" id="{064C159E-42CC-0242-48A0-E0C65CB9DA86}"/>
              </a:ext>
            </a:extLst>
          </p:cNvPr>
          <p:cNvGrpSpPr/>
          <p:nvPr/>
        </p:nvGrpSpPr>
        <p:grpSpPr>
          <a:xfrm>
            <a:off x="10273374" y="2827729"/>
            <a:ext cx="609834" cy="230832"/>
            <a:chOff x="740793" y="5499416"/>
            <a:chExt cx="609834" cy="230832"/>
          </a:xfrm>
        </p:grpSpPr>
        <p:cxnSp>
          <p:nvCxnSpPr>
            <p:cNvPr id="141" name="직선 연결선 140">
              <a:extLst>
                <a:ext uri="{FF2B5EF4-FFF2-40B4-BE49-F238E27FC236}">
                  <a16:creationId xmlns:a16="http://schemas.microsoft.com/office/drawing/2014/main" id="{738DC2F2-42BD-F710-ED8B-58BB94A94A97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8668CC28-2D59-DE56-92B0-170FB0BD7B88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3" name="그룹 142">
            <a:extLst>
              <a:ext uri="{FF2B5EF4-FFF2-40B4-BE49-F238E27FC236}">
                <a16:creationId xmlns:a16="http://schemas.microsoft.com/office/drawing/2014/main" id="{D09B7267-4C2F-0E04-2F34-14F5E9734157}"/>
              </a:ext>
            </a:extLst>
          </p:cNvPr>
          <p:cNvGrpSpPr/>
          <p:nvPr/>
        </p:nvGrpSpPr>
        <p:grpSpPr>
          <a:xfrm>
            <a:off x="10273374" y="2560023"/>
            <a:ext cx="609834" cy="230832"/>
            <a:chOff x="740793" y="5499416"/>
            <a:chExt cx="609834" cy="230832"/>
          </a:xfrm>
        </p:grpSpPr>
        <p:cxnSp>
          <p:nvCxnSpPr>
            <p:cNvPr id="144" name="직선 연결선 143">
              <a:extLst>
                <a:ext uri="{FF2B5EF4-FFF2-40B4-BE49-F238E27FC236}">
                  <a16:creationId xmlns:a16="http://schemas.microsoft.com/office/drawing/2014/main" id="{5F6E57DC-4F5B-D72E-7804-969E8275F269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3648A0FF-826D-467C-7271-AD33337ABC6C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6" name="그룹 145">
            <a:extLst>
              <a:ext uri="{FF2B5EF4-FFF2-40B4-BE49-F238E27FC236}">
                <a16:creationId xmlns:a16="http://schemas.microsoft.com/office/drawing/2014/main" id="{A6B2DA57-D886-01EC-C326-3ED56281CC6C}"/>
              </a:ext>
            </a:extLst>
          </p:cNvPr>
          <p:cNvGrpSpPr/>
          <p:nvPr/>
        </p:nvGrpSpPr>
        <p:grpSpPr>
          <a:xfrm>
            <a:off x="10273374" y="4202107"/>
            <a:ext cx="609834" cy="230832"/>
            <a:chOff x="740793" y="5499416"/>
            <a:chExt cx="609834" cy="230832"/>
          </a:xfrm>
        </p:grpSpPr>
        <p:cxnSp>
          <p:nvCxnSpPr>
            <p:cNvPr id="147" name="직선 연결선 146">
              <a:extLst>
                <a:ext uri="{FF2B5EF4-FFF2-40B4-BE49-F238E27FC236}">
                  <a16:creationId xmlns:a16="http://schemas.microsoft.com/office/drawing/2014/main" id="{88275589-AFE4-7DDF-6291-044907CB547B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9B6AF8E7-EB93-C309-2057-7AD35D28CD21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9" name="그룹 148">
            <a:extLst>
              <a:ext uri="{FF2B5EF4-FFF2-40B4-BE49-F238E27FC236}">
                <a16:creationId xmlns:a16="http://schemas.microsoft.com/office/drawing/2014/main" id="{40EF17C9-3587-6116-B0B7-AB650905EE9B}"/>
              </a:ext>
            </a:extLst>
          </p:cNvPr>
          <p:cNvGrpSpPr/>
          <p:nvPr/>
        </p:nvGrpSpPr>
        <p:grpSpPr>
          <a:xfrm>
            <a:off x="10273374" y="3934401"/>
            <a:ext cx="609834" cy="230832"/>
            <a:chOff x="740793" y="5499416"/>
            <a:chExt cx="609834" cy="230832"/>
          </a:xfrm>
        </p:grpSpPr>
        <p:cxnSp>
          <p:nvCxnSpPr>
            <p:cNvPr id="150" name="직선 연결선 149">
              <a:extLst>
                <a:ext uri="{FF2B5EF4-FFF2-40B4-BE49-F238E27FC236}">
                  <a16:creationId xmlns:a16="http://schemas.microsoft.com/office/drawing/2014/main" id="{DC44C1C9-5884-EDF9-1305-DBC2C97A3D4B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7B359033-18EF-40F9-13D6-A763BD47C461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2" name="그룹 151">
            <a:extLst>
              <a:ext uri="{FF2B5EF4-FFF2-40B4-BE49-F238E27FC236}">
                <a16:creationId xmlns:a16="http://schemas.microsoft.com/office/drawing/2014/main" id="{944EDB14-54FD-8606-F71E-09C7B5523B2E}"/>
              </a:ext>
            </a:extLst>
          </p:cNvPr>
          <p:cNvGrpSpPr/>
          <p:nvPr/>
        </p:nvGrpSpPr>
        <p:grpSpPr>
          <a:xfrm>
            <a:off x="10345024" y="1958621"/>
            <a:ext cx="609834" cy="230832"/>
            <a:chOff x="740793" y="5499416"/>
            <a:chExt cx="609834" cy="230832"/>
          </a:xfrm>
        </p:grpSpPr>
        <p:cxnSp>
          <p:nvCxnSpPr>
            <p:cNvPr id="153" name="직선 연결선 152">
              <a:extLst>
                <a:ext uri="{FF2B5EF4-FFF2-40B4-BE49-F238E27FC236}">
                  <a16:creationId xmlns:a16="http://schemas.microsoft.com/office/drawing/2014/main" id="{0AA0E68E-72F4-0FEF-3D76-6F0C7ABA94A5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BBFEA665-BE3E-D413-22F8-A5956B0338AA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5" name="그룹 154">
            <a:extLst>
              <a:ext uri="{FF2B5EF4-FFF2-40B4-BE49-F238E27FC236}">
                <a16:creationId xmlns:a16="http://schemas.microsoft.com/office/drawing/2014/main" id="{8A06205B-C168-E5C5-3A12-B6DD63984EED}"/>
              </a:ext>
            </a:extLst>
          </p:cNvPr>
          <p:cNvGrpSpPr/>
          <p:nvPr/>
        </p:nvGrpSpPr>
        <p:grpSpPr>
          <a:xfrm>
            <a:off x="10345024" y="1665748"/>
            <a:ext cx="609834" cy="230832"/>
            <a:chOff x="740793" y="5499416"/>
            <a:chExt cx="609834" cy="230832"/>
          </a:xfrm>
        </p:grpSpPr>
        <p:cxnSp>
          <p:nvCxnSpPr>
            <p:cNvPr id="156" name="직선 연결선 155">
              <a:extLst>
                <a:ext uri="{FF2B5EF4-FFF2-40B4-BE49-F238E27FC236}">
                  <a16:creationId xmlns:a16="http://schemas.microsoft.com/office/drawing/2014/main" id="{5CA5F70A-2EEE-3EC9-4CD2-FE521B1271B3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7" name="TextBox 156">
              <a:extLst>
                <a:ext uri="{FF2B5EF4-FFF2-40B4-BE49-F238E27FC236}">
                  <a16:creationId xmlns:a16="http://schemas.microsoft.com/office/drawing/2014/main" id="{A93FC740-DB8B-C425-CF6F-B55D921DA748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63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8" name="그룹 157">
            <a:extLst>
              <a:ext uri="{FF2B5EF4-FFF2-40B4-BE49-F238E27FC236}">
                <a16:creationId xmlns:a16="http://schemas.microsoft.com/office/drawing/2014/main" id="{DEAD0467-BFCE-237E-72D7-DA08D308976A}"/>
              </a:ext>
            </a:extLst>
          </p:cNvPr>
          <p:cNvGrpSpPr/>
          <p:nvPr/>
        </p:nvGrpSpPr>
        <p:grpSpPr>
          <a:xfrm>
            <a:off x="10298703" y="5032185"/>
            <a:ext cx="609834" cy="230832"/>
            <a:chOff x="740793" y="5499416"/>
            <a:chExt cx="609834" cy="230832"/>
          </a:xfrm>
        </p:grpSpPr>
        <p:cxnSp>
          <p:nvCxnSpPr>
            <p:cNvPr id="159" name="직선 연결선 158">
              <a:extLst>
                <a:ext uri="{FF2B5EF4-FFF2-40B4-BE49-F238E27FC236}">
                  <a16:creationId xmlns:a16="http://schemas.microsoft.com/office/drawing/2014/main" id="{98F729B5-98CA-CD83-7C8A-FE8A83F8B336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09BB28FA-74F4-97D6-CF20-F380FBC8BD91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1" name="그룹 160">
            <a:extLst>
              <a:ext uri="{FF2B5EF4-FFF2-40B4-BE49-F238E27FC236}">
                <a16:creationId xmlns:a16="http://schemas.microsoft.com/office/drawing/2014/main" id="{05E6B257-AE09-CE0A-9570-DC83E7086F26}"/>
              </a:ext>
            </a:extLst>
          </p:cNvPr>
          <p:cNvGrpSpPr/>
          <p:nvPr/>
        </p:nvGrpSpPr>
        <p:grpSpPr>
          <a:xfrm>
            <a:off x="10298703" y="4781257"/>
            <a:ext cx="609834" cy="230832"/>
            <a:chOff x="740793" y="5499416"/>
            <a:chExt cx="609834" cy="230832"/>
          </a:xfrm>
        </p:grpSpPr>
        <p:cxnSp>
          <p:nvCxnSpPr>
            <p:cNvPr id="162" name="직선 연결선 161">
              <a:extLst>
                <a:ext uri="{FF2B5EF4-FFF2-40B4-BE49-F238E27FC236}">
                  <a16:creationId xmlns:a16="http://schemas.microsoft.com/office/drawing/2014/main" id="{D771B61C-6E31-2EA9-8CDC-7D6DDF746684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58563AB-3106-94AC-4590-EFCADE2C3EE8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4" name="그룹 163">
            <a:extLst>
              <a:ext uri="{FF2B5EF4-FFF2-40B4-BE49-F238E27FC236}">
                <a16:creationId xmlns:a16="http://schemas.microsoft.com/office/drawing/2014/main" id="{34135D44-63DF-483B-6D36-5D47F7514C0A}"/>
              </a:ext>
            </a:extLst>
          </p:cNvPr>
          <p:cNvGrpSpPr/>
          <p:nvPr/>
        </p:nvGrpSpPr>
        <p:grpSpPr>
          <a:xfrm>
            <a:off x="10298703" y="4605088"/>
            <a:ext cx="609834" cy="230832"/>
            <a:chOff x="740793" y="5499416"/>
            <a:chExt cx="609834" cy="230832"/>
          </a:xfrm>
        </p:grpSpPr>
        <p:cxnSp>
          <p:nvCxnSpPr>
            <p:cNvPr id="165" name="직선 연결선 164">
              <a:extLst>
                <a:ext uri="{FF2B5EF4-FFF2-40B4-BE49-F238E27FC236}">
                  <a16:creationId xmlns:a16="http://schemas.microsoft.com/office/drawing/2014/main" id="{0983FAC1-E71A-7563-24A8-00F5F751B29E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7ADC9749-9879-6EF0-45B2-C6B21204CF2F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63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8" name="그룹 167">
            <a:extLst>
              <a:ext uri="{FF2B5EF4-FFF2-40B4-BE49-F238E27FC236}">
                <a16:creationId xmlns:a16="http://schemas.microsoft.com/office/drawing/2014/main" id="{E5795583-EAB5-BE38-D6A2-141CDBE23756}"/>
              </a:ext>
            </a:extLst>
          </p:cNvPr>
          <p:cNvGrpSpPr/>
          <p:nvPr/>
        </p:nvGrpSpPr>
        <p:grpSpPr>
          <a:xfrm>
            <a:off x="10345024" y="1791042"/>
            <a:ext cx="609834" cy="230832"/>
            <a:chOff x="740793" y="5499416"/>
            <a:chExt cx="609834" cy="230832"/>
          </a:xfrm>
        </p:grpSpPr>
        <p:cxnSp>
          <p:nvCxnSpPr>
            <p:cNvPr id="169" name="직선 연결선 168">
              <a:extLst>
                <a:ext uri="{FF2B5EF4-FFF2-40B4-BE49-F238E27FC236}">
                  <a16:creationId xmlns:a16="http://schemas.microsoft.com/office/drawing/2014/main" id="{254C0EBB-0A54-6A73-A874-317EBD1F73A4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D2CAFE19-1611-E5B3-354E-765CFCC8020E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1" name="그룹 170">
            <a:extLst>
              <a:ext uri="{FF2B5EF4-FFF2-40B4-BE49-F238E27FC236}">
                <a16:creationId xmlns:a16="http://schemas.microsoft.com/office/drawing/2014/main" id="{81B9FD3C-8C82-DCAC-D5E3-EA65D68E4F1F}"/>
              </a:ext>
            </a:extLst>
          </p:cNvPr>
          <p:cNvGrpSpPr/>
          <p:nvPr/>
        </p:nvGrpSpPr>
        <p:grpSpPr>
          <a:xfrm>
            <a:off x="10333014" y="1043195"/>
            <a:ext cx="609834" cy="230832"/>
            <a:chOff x="740793" y="5499416"/>
            <a:chExt cx="609834" cy="230832"/>
          </a:xfrm>
        </p:grpSpPr>
        <p:cxnSp>
          <p:nvCxnSpPr>
            <p:cNvPr id="172" name="직선 연결선 171">
              <a:extLst>
                <a:ext uri="{FF2B5EF4-FFF2-40B4-BE49-F238E27FC236}">
                  <a16:creationId xmlns:a16="http://schemas.microsoft.com/office/drawing/2014/main" id="{A2568CB0-5E6D-2DA0-444B-C00DC353E527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3245B178-2DC7-8968-B319-DB2A314111D3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4" name="그룹 173">
            <a:extLst>
              <a:ext uri="{FF2B5EF4-FFF2-40B4-BE49-F238E27FC236}">
                <a16:creationId xmlns:a16="http://schemas.microsoft.com/office/drawing/2014/main" id="{7C6D5D9D-B556-5CC1-6C67-4A2399B871FA}"/>
              </a:ext>
            </a:extLst>
          </p:cNvPr>
          <p:cNvGrpSpPr/>
          <p:nvPr/>
        </p:nvGrpSpPr>
        <p:grpSpPr>
          <a:xfrm>
            <a:off x="10333014" y="921981"/>
            <a:ext cx="609834" cy="230832"/>
            <a:chOff x="740793" y="5499416"/>
            <a:chExt cx="609834" cy="230832"/>
          </a:xfrm>
        </p:grpSpPr>
        <p:cxnSp>
          <p:nvCxnSpPr>
            <p:cNvPr id="175" name="직선 연결선 174">
              <a:extLst>
                <a:ext uri="{FF2B5EF4-FFF2-40B4-BE49-F238E27FC236}">
                  <a16:creationId xmlns:a16="http://schemas.microsoft.com/office/drawing/2014/main" id="{9645B5A3-E2CC-FD32-9326-639777D389DB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D34C7128-A92C-AEDD-F42D-6BD9D8027C91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63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7" name="그룹 176">
            <a:extLst>
              <a:ext uri="{FF2B5EF4-FFF2-40B4-BE49-F238E27FC236}">
                <a16:creationId xmlns:a16="http://schemas.microsoft.com/office/drawing/2014/main" id="{49EF3385-A9DD-F0D2-A0F0-CCA798C8A7D2}"/>
              </a:ext>
            </a:extLst>
          </p:cNvPr>
          <p:cNvGrpSpPr/>
          <p:nvPr/>
        </p:nvGrpSpPr>
        <p:grpSpPr>
          <a:xfrm>
            <a:off x="10333014" y="1236142"/>
            <a:ext cx="609834" cy="230832"/>
            <a:chOff x="740793" y="5499416"/>
            <a:chExt cx="609834" cy="230832"/>
          </a:xfrm>
        </p:grpSpPr>
        <p:cxnSp>
          <p:nvCxnSpPr>
            <p:cNvPr id="178" name="직선 연결선 177">
              <a:extLst>
                <a:ext uri="{FF2B5EF4-FFF2-40B4-BE49-F238E27FC236}">
                  <a16:creationId xmlns:a16="http://schemas.microsoft.com/office/drawing/2014/main" id="{987DA019-6816-F771-A31B-57AE67571534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2DC35244-D2E5-8E2C-1808-519CAA25D85C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80" name="TextBox 179">
            <a:extLst>
              <a:ext uri="{FF2B5EF4-FFF2-40B4-BE49-F238E27FC236}">
                <a16:creationId xmlns:a16="http://schemas.microsoft.com/office/drawing/2014/main" id="{F27B979C-9E71-7C21-8931-A043171F5C6A}"/>
              </a:ext>
            </a:extLst>
          </p:cNvPr>
          <p:cNvSpPr txBox="1"/>
          <p:nvPr/>
        </p:nvSpPr>
        <p:spPr>
          <a:xfrm>
            <a:off x="6421121" y="6213672"/>
            <a:ext cx="9348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litinib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2D00BF7F-C853-2FE9-BBD6-6CC5B349ED29}"/>
              </a:ext>
            </a:extLst>
          </p:cNvPr>
          <p:cNvSpPr txBox="1"/>
          <p:nvPr/>
        </p:nvSpPr>
        <p:spPr>
          <a:xfrm>
            <a:off x="7340875" y="6213672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6A57E49A-900B-BFD3-0DB5-61BF74692506}"/>
              </a:ext>
            </a:extLst>
          </p:cNvPr>
          <p:cNvSpPr txBox="1"/>
          <p:nvPr/>
        </p:nvSpPr>
        <p:spPr>
          <a:xfrm>
            <a:off x="7510267" y="6213672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CABC43A5-A452-8E47-A1E7-4FEB3616ABC5}"/>
              </a:ext>
            </a:extLst>
          </p:cNvPr>
          <p:cNvSpPr txBox="1"/>
          <p:nvPr/>
        </p:nvSpPr>
        <p:spPr>
          <a:xfrm>
            <a:off x="7770339" y="6213672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D8821AD0-87AF-E1F0-DB64-CC6C7EA1655A}"/>
              </a:ext>
            </a:extLst>
          </p:cNvPr>
          <p:cNvSpPr txBox="1"/>
          <p:nvPr/>
        </p:nvSpPr>
        <p:spPr>
          <a:xfrm>
            <a:off x="8253598" y="6213672"/>
            <a:ext cx="9348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litinib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278EDB22-6927-B40B-0198-9365ADCD6BDF}"/>
              </a:ext>
            </a:extLst>
          </p:cNvPr>
          <p:cNvSpPr txBox="1"/>
          <p:nvPr/>
        </p:nvSpPr>
        <p:spPr>
          <a:xfrm>
            <a:off x="9173352" y="6213672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5BBC56AC-C4BE-2844-ADB0-52628C7AFCD0}"/>
              </a:ext>
            </a:extLst>
          </p:cNvPr>
          <p:cNvSpPr txBox="1"/>
          <p:nvPr/>
        </p:nvSpPr>
        <p:spPr>
          <a:xfrm>
            <a:off x="9342744" y="6213672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CD7BA53F-4E6F-70B3-6D50-FEE54BC0B503}"/>
              </a:ext>
            </a:extLst>
          </p:cNvPr>
          <p:cNvSpPr txBox="1"/>
          <p:nvPr/>
        </p:nvSpPr>
        <p:spPr>
          <a:xfrm>
            <a:off x="9602816" y="6213672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F4089F28-F109-AF8B-5441-D696C4EAC6A6}"/>
              </a:ext>
            </a:extLst>
          </p:cNvPr>
          <p:cNvSpPr txBox="1"/>
          <p:nvPr/>
        </p:nvSpPr>
        <p:spPr>
          <a:xfrm>
            <a:off x="10181014" y="6213672"/>
            <a:ext cx="9348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litinib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51DDBE6C-CDF9-0C64-C421-C09AEF8D9E17}"/>
              </a:ext>
            </a:extLst>
          </p:cNvPr>
          <p:cNvSpPr txBox="1"/>
          <p:nvPr/>
        </p:nvSpPr>
        <p:spPr>
          <a:xfrm>
            <a:off x="11100768" y="6213672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8DF27317-24A3-9402-8F47-8334EA1FEB7E}"/>
              </a:ext>
            </a:extLst>
          </p:cNvPr>
          <p:cNvSpPr txBox="1"/>
          <p:nvPr/>
        </p:nvSpPr>
        <p:spPr>
          <a:xfrm>
            <a:off x="11270160" y="6213672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0F4A8572-8F6D-A4A6-511A-2E6135A9E500}"/>
              </a:ext>
            </a:extLst>
          </p:cNvPr>
          <p:cNvSpPr txBox="1"/>
          <p:nvPr/>
        </p:nvSpPr>
        <p:spPr>
          <a:xfrm>
            <a:off x="11530232" y="6213672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grpSp>
        <p:nvGrpSpPr>
          <p:cNvPr id="192" name="그룹 191">
            <a:extLst>
              <a:ext uri="{FF2B5EF4-FFF2-40B4-BE49-F238E27FC236}">
                <a16:creationId xmlns:a16="http://schemas.microsoft.com/office/drawing/2014/main" id="{E56C6044-DE6F-873E-2974-88C1313142EC}"/>
              </a:ext>
            </a:extLst>
          </p:cNvPr>
          <p:cNvGrpSpPr/>
          <p:nvPr/>
        </p:nvGrpSpPr>
        <p:grpSpPr>
          <a:xfrm>
            <a:off x="8390389" y="1941843"/>
            <a:ext cx="609834" cy="230832"/>
            <a:chOff x="740793" y="5499416"/>
            <a:chExt cx="609834" cy="230832"/>
          </a:xfrm>
        </p:grpSpPr>
        <p:cxnSp>
          <p:nvCxnSpPr>
            <p:cNvPr id="193" name="직선 연결선 192">
              <a:extLst>
                <a:ext uri="{FF2B5EF4-FFF2-40B4-BE49-F238E27FC236}">
                  <a16:creationId xmlns:a16="http://schemas.microsoft.com/office/drawing/2014/main" id="{E591DD42-8598-7F23-0525-8C780B185F5D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4" name="TextBox 193">
              <a:extLst>
                <a:ext uri="{FF2B5EF4-FFF2-40B4-BE49-F238E27FC236}">
                  <a16:creationId xmlns:a16="http://schemas.microsoft.com/office/drawing/2014/main" id="{2F46E8D0-1E77-B549-5F7A-349AB8EA1AFA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5" name="그룹 194">
            <a:extLst>
              <a:ext uri="{FF2B5EF4-FFF2-40B4-BE49-F238E27FC236}">
                <a16:creationId xmlns:a16="http://schemas.microsoft.com/office/drawing/2014/main" id="{456B29F0-0E17-A9A9-266C-863339D5FF73}"/>
              </a:ext>
            </a:extLst>
          </p:cNvPr>
          <p:cNvGrpSpPr/>
          <p:nvPr/>
        </p:nvGrpSpPr>
        <p:grpSpPr>
          <a:xfrm>
            <a:off x="6629112" y="1807732"/>
            <a:ext cx="609834" cy="230832"/>
            <a:chOff x="740793" y="5499416"/>
            <a:chExt cx="609834" cy="230832"/>
          </a:xfrm>
        </p:grpSpPr>
        <p:cxnSp>
          <p:nvCxnSpPr>
            <p:cNvPr id="196" name="직선 연결선 195">
              <a:extLst>
                <a:ext uri="{FF2B5EF4-FFF2-40B4-BE49-F238E27FC236}">
                  <a16:creationId xmlns:a16="http://schemas.microsoft.com/office/drawing/2014/main" id="{51D5650D-A97C-899F-F3EF-19BDE8E51847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7" name="TextBox 196">
              <a:extLst>
                <a:ext uri="{FF2B5EF4-FFF2-40B4-BE49-F238E27FC236}">
                  <a16:creationId xmlns:a16="http://schemas.microsoft.com/office/drawing/2014/main" id="{A5E199F0-CA69-2222-B151-E312A44D4CD1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8" name="그룹 197">
            <a:extLst>
              <a:ext uri="{FF2B5EF4-FFF2-40B4-BE49-F238E27FC236}">
                <a16:creationId xmlns:a16="http://schemas.microsoft.com/office/drawing/2014/main" id="{C6F3A602-BC4A-A778-1DD3-B2C9EDB7BDF5}"/>
              </a:ext>
            </a:extLst>
          </p:cNvPr>
          <p:cNvGrpSpPr/>
          <p:nvPr/>
        </p:nvGrpSpPr>
        <p:grpSpPr>
          <a:xfrm>
            <a:off x="6629112" y="1556063"/>
            <a:ext cx="609834" cy="230832"/>
            <a:chOff x="740793" y="5499416"/>
            <a:chExt cx="609834" cy="230832"/>
          </a:xfrm>
        </p:grpSpPr>
        <p:cxnSp>
          <p:nvCxnSpPr>
            <p:cNvPr id="199" name="직선 연결선 198">
              <a:extLst>
                <a:ext uri="{FF2B5EF4-FFF2-40B4-BE49-F238E27FC236}">
                  <a16:creationId xmlns:a16="http://schemas.microsoft.com/office/drawing/2014/main" id="{85F90758-70F7-727C-1A70-A7FBDDD1CAC2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id="{A8E474C5-CC1E-E258-C9BF-D63BABAC3FC8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63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201" name="그림 200">
            <a:extLst>
              <a:ext uri="{FF2B5EF4-FFF2-40B4-BE49-F238E27FC236}">
                <a16:creationId xmlns:a16="http://schemas.microsoft.com/office/drawing/2014/main" id="{47049E27-4892-6795-4355-87874D44ABF6}"/>
              </a:ext>
            </a:extLst>
          </p:cNvPr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10908537" y="4608959"/>
            <a:ext cx="877900" cy="634039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BC40FC6C-76C1-C8CA-C544-FD467811B84B}"/>
              </a:ext>
            </a:extLst>
          </p:cNvPr>
          <p:cNvPicPr>
            <a:picLocks noChangeAspect="1"/>
          </p:cNvPicPr>
          <p:nvPr/>
        </p:nvPicPr>
        <p:blipFill>
          <a:blip r:embed="rId34"/>
          <a:stretch>
            <a:fillRect/>
          </a:stretch>
        </p:blipFill>
        <p:spPr>
          <a:xfrm>
            <a:off x="10947739" y="5552422"/>
            <a:ext cx="871804" cy="615749"/>
          </a:xfrm>
          <a:prstGeom prst="rect">
            <a:avLst/>
          </a:prstGeom>
        </p:spPr>
      </p:pic>
      <p:graphicFrame>
        <p:nvGraphicFramePr>
          <p:cNvPr id="18" name="개체 17">
            <a:extLst>
              <a:ext uri="{FF2B5EF4-FFF2-40B4-BE49-F238E27FC236}">
                <a16:creationId xmlns:a16="http://schemas.microsoft.com/office/drawing/2014/main" id="{36884718-33C9-0564-BC65-5004AFDB35F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64091335"/>
              </p:ext>
            </p:extLst>
          </p:nvPr>
        </p:nvGraphicFramePr>
        <p:xfrm>
          <a:off x="10898208" y="3802702"/>
          <a:ext cx="887223" cy="774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20" name="Image" r:id="rId35" imgW="1104480" imgH="774360" progId="Photoshop.Image.13">
                  <p:embed/>
                </p:oleObj>
              </mc:Choice>
              <mc:Fallback>
                <p:oleObj name="Image" r:id="rId35" imgW="1104480" imgH="774360" progId="Photoshop.Image.13">
                  <p:embed/>
                  <p:pic>
                    <p:nvPicPr>
                      <p:cNvPr id="18" name="개체 17">
                        <a:extLst>
                          <a:ext uri="{FF2B5EF4-FFF2-40B4-BE49-F238E27FC236}">
                            <a16:creationId xmlns:a16="http://schemas.microsoft.com/office/drawing/2014/main" id="{36884718-33C9-0564-BC65-5004AFDB35F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6"/>
                      <a:stretch>
                        <a:fillRect/>
                      </a:stretch>
                    </p:blipFill>
                    <p:spPr>
                      <a:xfrm>
                        <a:off x="10898208" y="3802702"/>
                        <a:ext cx="887223" cy="774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개체 19">
            <a:extLst>
              <a:ext uri="{FF2B5EF4-FFF2-40B4-BE49-F238E27FC236}">
                <a16:creationId xmlns:a16="http://schemas.microsoft.com/office/drawing/2014/main" id="{B46E16E5-91A6-D0B5-CD50-D2E0D3EF90D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79910820"/>
              </p:ext>
            </p:extLst>
          </p:nvPr>
        </p:nvGraphicFramePr>
        <p:xfrm>
          <a:off x="10954858" y="976003"/>
          <a:ext cx="847265" cy="4106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21" name="Image" r:id="rId37" imgW="415800" imgH="200880" progId="Photoshop.Image.13">
                  <p:embed/>
                </p:oleObj>
              </mc:Choice>
              <mc:Fallback>
                <p:oleObj name="Image" r:id="rId37" imgW="415800" imgH="200880" progId="Photoshop.Image.13">
                  <p:embed/>
                  <p:pic>
                    <p:nvPicPr>
                      <p:cNvPr id="20" name="개체 19">
                        <a:extLst>
                          <a:ext uri="{FF2B5EF4-FFF2-40B4-BE49-F238E27FC236}">
                            <a16:creationId xmlns:a16="http://schemas.microsoft.com/office/drawing/2014/main" id="{B46E16E5-91A6-D0B5-CD50-D2E0D3EF90D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8"/>
                      <a:stretch>
                        <a:fillRect/>
                      </a:stretch>
                    </p:blipFill>
                    <p:spPr>
                      <a:xfrm>
                        <a:off x="10954858" y="976003"/>
                        <a:ext cx="847265" cy="41069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3" name="직사각형 202">
            <a:extLst>
              <a:ext uri="{FF2B5EF4-FFF2-40B4-BE49-F238E27FC236}">
                <a16:creationId xmlns:a16="http://schemas.microsoft.com/office/drawing/2014/main" id="{2E65909C-50CA-4F70-BA38-E24B903E14ED}"/>
              </a:ext>
            </a:extLst>
          </p:cNvPr>
          <p:cNvSpPr/>
          <p:nvPr/>
        </p:nvSpPr>
        <p:spPr>
          <a:xfrm>
            <a:off x="7349007" y="1004765"/>
            <a:ext cx="730462" cy="200069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4" name="직사각형 203">
            <a:extLst>
              <a:ext uri="{FF2B5EF4-FFF2-40B4-BE49-F238E27FC236}">
                <a16:creationId xmlns:a16="http://schemas.microsoft.com/office/drawing/2014/main" id="{D60BDB12-F164-435D-ABBC-30AD267154A2}"/>
              </a:ext>
            </a:extLst>
          </p:cNvPr>
          <p:cNvSpPr/>
          <p:nvPr/>
        </p:nvSpPr>
        <p:spPr>
          <a:xfrm>
            <a:off x="7373719" y="1699506"/>
            <a:ext cx="623938" cy="197074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5" name="직사각형 204">
            <a:extLst>
              <a:ext uri="{FF2B5EF4-FFF2-40B4-BE49-F238E27FC236}">
                <a16:creationId xmlns:a16="http://schemas.microsoft.com/office/drawing/2014/main" id="{2BE1F4EF-D9AA-48AA-9BE3-185AF398EC45}"/>
              </a:ext>
            </a:extLst>
          </p:cNvPr>
          <p:cNvSpPr/>
          <p:nvPr/>
        </p:nvSpPr>
        <p:spPr>
          <a:xfrm>
            <a:off x="7313349" y="2568513"/>
            <a:ext cx="684308" cy="197074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6" name="직사각형 205">
            <a:extLst>
              <a:ext uri="{FF2B5EF4-FFF2-40B4-BE49-F238E27FC236}">
                <a16:creationId xmlns:a16="http://schemas.microsoft.com/office/drawing/2014/main" id="{76716A2F-C302-44BF-9153-E145E1319624}"/>
              </a:ext>
            </a:extLst>
          </p:cNvPr>
          <p:cNvSpPr/>
          <p:nvPr/>
        </p:nvSpPr>
        <p:spPr>
          <a:xfrm>
            <a:off x="7313349" y="3435354"/>
            <a:ext cx="684308" cy="197074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7" name="직사각형 206">
            <a:extLst>
              <a:ext uri="{FF2B5EF4-FFF2-40B4-BE49-F238E27FC236}">
                <a16:creationId xmlns:a16="http://schemas.microsoft.com/office/drawing/2014/main" id="{D3BA3817-8C39-4A7D-9AA7-57DAC3F00228}"/>
              </a:ext>
            </a:extLst>
          </p:cNvPr>
          <p:cNvSpPr/>
          <p:nvPr/>
        </p:nvSpPr>
        <p:spPr>
          <a:xfrm>
            <a:off x="7345243" y="4121329"/>
            <a:ext cx="630642" cy="176294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10" name="직사각형 209">
            <a:extLst>
              <a:ext uri="{FF2B5EF4-FFF2-40B4-BE49-F238E27FC236}">
                <a16:creationId xmlns:a16="http://schemas.microsoft.com/office/drawing/2014/main" id="{C8467664-08BD-484D-90C5-A22F48A825BC}"/>
              </a:ext>
            </a:extLst>
          </p:cNvPr>
          <p:cNvSpPr/>
          <p:nvPr/>
        </p:nvSpPr>
        <p:spPr>
          <a:xfrm>
            <a:off x="7328578" y="4813709"/>
            <a:ext cx="666537" cy="194360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11" name="직사각형 210">
            <a:extLst>
              <a:ext uri="{FF2B5EF4-FFF2-40B4-BE49-F238E27FC236}">
                <a16:creationId xmlns:a16="http://schemas.microsoft.com/office/drawing/2014/main" id="{E765F1B8-997B-4C6E-B1CA-512FD212EBC6}"/>
              </a:ext>
            </a:extLst>
          </p:cNvPr>
          <p:cNvSpPr/>
          <p:nvPr/>
        </p:nvSpPr>
        <p:spPr>
          <a:xfrm>
            <a:off x="7291237" y="5613074"/>
            <a:ext cx="744266" cy="168703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8E17352-9254-47BF-23E0-3C6ECAFA1E40}"/>
              </a:ext>
            </a:extLst>
          </p:cNvPr>
          <p:cNvSpPr txBox="1"/>
          <p:nvPr/>
        </p:nvSpPr>
        <p:spPr>
          <a:xfrm>
            <a:off x="34923" y="41837"/>
            <a:ext cx="4696467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Arial" panose="020B0604020202020204" pitchFamily="34" charset="0"/>
                <a:cs typeface="Arial" panose="020B0604020202020204" pitchFamily="34" charset="0"/>
              </a:rPr>
              <a:t>Original gel images of Supplementary Figure 3</a:t>
            </a:r>
            <a:r>
              <a:rPr lang="en-US" altLang="ko-KR" sz="1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endParaRPr lang="en-US" altLang="ko-KR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ll experiments were performed in triplicates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The red boxes indicate the figures in the main text.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4024586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개체 3">
            <a:extLst>
              <a:ext uri="{FF2B5EF4-FFF2-40B4-BE49-F238E27FC236}">
                <a16:creationId xmlns:a16="http://schemas.microsoft.com/office/drawing/2014/main" id="{BF05105C-9D9B-438B-E4EB-2485DFAB97E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13374350"/>
              </p:ext>
            </p:extLst>
          </p:nvPr>
        </p:nvGraphicFramePr>
        <p:xfrm>
          <a:off x="3991389" y="1984914"/>
          <a:ext cx="884173" cy="6265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4" name="Image" r:id="rId3" imgW="1917360" imgH="1358640" progId="Photoshop.Image.13">
                  <p:embed/>
                </p:oleObj>
              </mc:Choice>
              <mc:Fallback>
                <p:oleObj name="Image" r:id="rId3" imgW="1917360" imgH="1358640" progId="Photoshop.Image.13">
                  <p:embed/>
                  <p:pic>
                    <p:nvPicPr>
                      <p:cNvPr id="4" name="개체 3">
                        <a:extLst>
                          <a:ext uri="{FF2B5EF4-FFF2-40B4-BE49-F238E27FC236}">
                            <a16:creationId xmlns:a16="http://schemas.microsoft.com/office/drawing/2014/main" id="{BF05105C-9D9B-438B-E4EB-2485DFAB97E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991389" y="1984914"/>
                        <a:ext cx="884173" cy="626534"/>
                      </a:xfrm>
                      <a:prstGeom prst="rect">
                        <a:avLst/>
                      </a:prstGeom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개체 4">
            <a:extLst>
              <a:ext uri="{FF2B5EF4-FFF2-40B4-BE49-F238E27FC236}">
                <a16:creationId xmlns:a16="http://schemas.microsoft.com/office/drawing/2014/main" id="{0089C1DB-8615-A080-CD90-B166EF3687F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25209463"/>
              </p:ext>
            </p:extLst>
          </p:nvPr>
        </p:nvGraphicFramePr>
        <p:xfrm>
          <a:off x="3991389" y="2680924"/>
          <a:ext cx="884174" cy="8583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5" name="Image" r:id="rId5" imgW="1739520" imgH="1688760" progId="Photoshop.Image.13">
                  <p:embed/>
                </p:oleObj>
              </mc:Choice>
              <mc:Fallback>
                <p:oleObj name="Image" r:id="rId5" imgW="1739520" imgH="1688760" progId="Photoshop.Image.13">
                  <p:embed/>
                  <p:pic>
                    <p:nvPicPr>
                      <p:cNvPr id="5" name="개체 4">
                        <a:extLst>
                          <a:ext uri="{FF2B5EF4-FFF2-40B4-BE49-F238E27FC236}">
                            <a16:creationId xmlns:a16="http://schemas.microsoft.com/office/drawing/2014/main" id="{0089C1DB-8615-A080-CD90-B166EF3687F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991389" y="2680924"/>
                        <a:ext cx="884174" cy="858359"/>
                      </a:xfrm>
                      <a:prstGeom prst="rect">
                        <a:avLst/>
                      </a:prstGeom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개체 5">
            <a:extLst>
              <a:ext uri="{FF2B5EF4-FFF2-40B4-BE49-F238E27FC236}">
                <a16:creationId xmlns:a16="http://schemas.microsoft.com/office/drawing/2014/main" id="{0C1FCAAE-CEBC-7A4C-7B28-AC3D70E980A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58715847"/>
              </p:ext>
            </p:extLst>
          </p:nvPr>
        </p:nvGraphicFramePr>
        <p:xfrm>
          <a:off x="3991389" y="3609090"/>
          <a:ext cx="884174" cy="7512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6" name="Image" r:id="rId7" imgW="1688760" imgH="1434600" progId="Photoshop.Image.13">
                  <p:embed/>
                </p:oleObj>
              </mc:Choice>
              <mc:Fallback>
                <p:oleObj name="Image" r:id="rId7" imgW="1688760" imgH="1434600" progId="Photoshop.Image.13">
                  <p:embed/>
                  <p:pic>
                    <p:nvPicPr>
                      <p:cNvPr id="6" name="개체 5">
                        <a:extLst>
                          <a:ext uri="{FF2B5EF4-FFF2-40B4-BE49-F238E27FC236}">
                            <a16:creationId xmlns:a16="http://schemas.microsoft.com/office/drawing/2014/main" id="{0C1FCAAE-CEBC-7A4C-7B28-AC3D70E980A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991389" y="3609090"/>
                        <a:ext cx="884174" cy="751216"/>
                      </a:xfrm>
                      <a:prstGeom prst="rect">
                        <a:avLst/>
                      </a:prstGeom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33627F22-6455-3DE3-827F-7A090393D7E7}"/>
              </a:ext>
            </a:extLst>
          </p:cNvPr>
          <p:cNvSpPr txBox="1"/>
          <p:nvPr/>
        </p:nvSpPr>
        <p:spPr>
          <a:xfrm>
            <a:off x="2414772" y="2940970"/>
            <a:ext cx="10711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kt (55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C913E59-4C07-36A8-653A-5769ABA21C8B}"/>
              </a:ext>
            </a:extLst>
          </p:cNvPr>
          <p:cNvSpPr txBox="1"/>
          <p:nvPr/>
        </p:nvSpPr>
        <p:spPr>
          <a:xfrm>
            <a:off x="2271038" y="2147311"/>
            <a:ext cx="12170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p-Akt (55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0FBBA55-E2EA-23C7-580A-9F8CB5D91FE9}"/>
              </a:ext>
            </a:extLst>
          </p:cNvPr>
          <p:cNvSpPr txBox="1"/>
          <p:nvPr/>
        </p:nvSpPr>
        <p:spPr>
          <a:xfrm>
            <a:off x="2156689" y="3844761"/>
            <a:ext cx="1329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 (41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개체 9">
            <a:extLst>
              <a:ext uri="{FF2B5EF4-FFF2-40B4-BE49-F238E27FC236}">
                <a16:creationId xmlns:a16="http://schemas.microsoft.com/office/drawing/2014/main" id="{F43FC7DA-C6A8-1958-AB96-8D0AD9587D4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27004986"/>
              </p:ext>
            </p:extLst>
          </p:nvPr>
        </p:nvGraphicFramePr>
        <p:xfrm>
          <a:off x="5738474" y="3480896"/>
          <a:ext cx="864001" cy="5709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7" name="Image" r:id="rId9" imgW="2171160" imgH="1434600" progId="Photoshop.Image.13">
                  <p:embed/>
                </p:oleObj>
              </mc:Choice>
              <mc:Fallback>
                <p:oleObj name="Image" r:id="rId9" imgW="2171160" imgH="1434600" progId="Photoshop.Image.13">
                  <p:embed/>
                  <p:pic>
                    <p:nvPicPr>
                      <p:cNvPr id="10" name="개체 9">
                        <a:extLst>
                          <a:ext uri="{FF2B5EF4-FFF2-40B4-BE49-F238E27FC236}">
                            <a16:creationId xmlns:a16="http://schemas.microsoft.com/office/drawing/2014/main" id="{F43FC7DA-C6A8-1958-AB96-8D0AD9587D4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738474" y="3480896"/>
                        <a:ext cx="864001" cy="570948"/>
                      </a:xfrm>
                      <a:prstGeom prst="rect">
                        <a:avLst/>
                      </a:prstGeom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개체 10">
            <a:extLst>
              <a:ext uri="{FF2B5EF4-FFF2-40B4-BE49-F238E27FC236}">
                <a16:creationId xmlns:a16="http://schemas.microsoft.com/office/drawing/2014/main" id="{04D51BB0-EB63-AC0B-A30A-5320BA98DDE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04273455"/>
              </p:ext>
            </p:extLst>
          </p:nvPr>
        </p:nvGraphicFramePr>
        <p:xfrm>
          <a:off x="5738474" y="2741187"/>
          <a:ext cx="864001" cy="5355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8" name="Image" r:id="rId11" imgW="2171160" imgH="1345680" progId="Photoshop.Image.13">
                  <p:embed/>
                </p:oleObj>
              </mc:Choice>
              <mc:Fallback>
                <p:oleObj name="Image" r:id="rId11" imgW="2171160" imgH="1345680" progId="Photoshop.Image.13">
                  <p:embed/>
                  <p:pic>
                    <p:nvPicPr>
                      <p:cNvPr id="11" name="개체 10">
                        <a:extLst>
                          <a:ext uri="{FF2B5EF4-FFF2-40B4-BE49-F238E27FC236}">
                            <a16:creationId xmlns:a16="http://schemas.microsoft.com/office/drawing/2014/main" id="{04D51BB0-EB63-AC0B-A30A-5320BA98DDE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5738474" y="2741187"/>
                        <a:ext cx="864001" cy="5355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개체 11">
            <a:extLst>
              <a:ext uri="{FF2B5EF4-FFF2-40B4-BE49-F238E27FC236}">
                <a16:creationId xmlns:a16="http://schemas.microsoft.com/office/drawing/2014/main" id="{EA39D1E7-EB71-566B-1AFD-20FA2B49293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94144620"/>
              </p:ext>
            </p:extLst>
          </p:nvPr>
        </p:nvGraphicFramePr>
        <p:xfrm>
          <a:off x="5721009" y="1984012"/>
          <a:ext cx="881466" cy="5323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9" name="Image" r:id="rId13" imgW="1955520" imgH="1180800" progId="Photoshop.Image.13">
                  <p:embed/>
                </p:oleObj>
              </mc:Choice>
              <mc:Fallback>
                <p:oleObj name="Image" r:id="rId13" imgW="1955520" imgH="1180800" progId="Photoshop.Image.13">
                  <p:embed/>
                  <p:pic>
                    <p:nvPicPr>
                      <p:cNvPr id="12" name="개체 11">
                        <a:extLst>
                          <a:ext uri="{FF2B5EF4-FFF2-40B4-BE49-F238E27FC236}">
                            <a16:creationId xmlns:a16="http://schemas.microsoft.com/office/drawing/2014/main" id="{EA39D1E7-EB71-566B-1AFD-20FA2B49293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5721009" y="1984012"/>
                        <a:ext cx="881466" cy="5323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2" name="그림 41" descr="텍스트이(가) 표시된 사진&#10;&#10;자동 생성된 설명">
            <a:extLst>
              <a:ext uri="{FF2B5EF4-FFF2-40B4-BE49-F238E27FC236}">
                <a16:creationId xmlns:a16="http://schemas.microsoft.com/office/drawing/2014/main" id="{FC154256-48EA-A9C3-2380-017BE06FAE2C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798" t="37762" r="44978" b="41296"/>
          <a:stretch/>
        </p:blipFill>
        <p:spPr>
          <a:xfrm>
            <a:off x="7652190" y="1984012"/>
            <a:ext cx="864001" cy="610641"/>
          </a:xfrm>
          <a:prstGeom prst="rect">
            <a:avLst/>
          </a:prstGeom>
        </p:spPr>
      </p:pic>
      <p:pic>
        <p:nvPicPr>
          <p:cNvPr id="45" name="그림 44">
            <a:extLst>
              <a:ext uri="{FF2B5EF4-FFF2-40B4-BE49-F238E27FC236}">
                <a16:creationId xmlns:a16="http://schemas.microsoft.com/office/drawing/2014/main" id="{647D5698-B308-67E7-C2D8-366B9DE2E71A}"/>
              </a:ext>
            </a:extLst>
          </p:cNvPr>
          <p:cNvPicPr>
            <a:picLocks noChangeAspect="1"/>
          </p:cNvPicPr>
          <p:nvPr/>
        </p:nvPicPr>
        <p:blipFill>
          <a:blip r:embed="rId17">
            <a:lum bright="-20000"/>
          </a:blip>
          <a:stretch>
            <a:fillRect/>
          </a:stretch>
        </p:blipFill>
        <p:spPr>
          <a:xfrm>
            <a:off x="7652190" y="2785924"/>
            <a:ext cx="864001" cy="798124"/>
          </a:xfrm>
          <a:prstGeom prst="rect">
            <a:avLst/>
          </a:prstGeom>
        </p:spPr>
      </p:pic>
      <p:grpSp>
        <p:nvGrpSpPr>
          <p:cNvPr id="19" name="그룹 18">
            <a:extLst>
              <a:ext uri="{FF2B5EF4-FFF2-40B4-BE49-F238E27FC236}">
                <a16:creationId xmlns:a16="http://schemas.microsoft.com/office/drawing/2014/main" id="{9A351ABC-1711-1DE0-A8BA-49A8722CD6DC}"/>
              </a:ext>
            </a:extLst>
          </p:cNvPr>
          <p:cNvGrpSpPr/>
          <p:nvPr/>
        </p:nvGrpSpPr>
        <p:grpSpPr>
          <a:xfrm>
            <a:off x="3402185" y="3909567"/>
            <a:ext cx="609834" cy="230832"/>
            <a:chOff x="740793" y="5499416"/>
            <a:chExt cx="609834" cy="230832"/>
          </a:xfrm>
        </p:grpSpPr>
        <p:cxnSp>
          <p:nvCxnSpPr>
            <p:cNvPr id="40" name="직선 연결선 39">
              <a:extLst>
                <a:ext uri="{FF2B5EF4-FFF2-40B4-BE49-F238E27FC236}">
                  <a16:creationId xmlns:a16="http://schemas.microsoft.com/office/drawing/2014/main" id="{635651FF-E417-87DA-A813-B2FF7C9E3EA5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99965A74-605E-A106-A9C5-3C75D2F16200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4" name="TextBox 43">
            <a:extLst>
              <a:ext uri="{FF2B5EF4-FFF2-40B4-BE49-F238E27FC236}">
                <a16:creationId xmlns:a16="http://schemas.microsoft.com/office/drawing/2014/main" id="{9F187500-BBC7-46AF-D5DD-9C86A22C2F7E}"/>
              </a:ext>
            </a:extLst>
          </p:cNvPr>
          <p:cNvSpPr txBox="1"/>
          <p:nvPr/>
        </p:nvSpPr>
        <p:spPr>
          <a:xfrm>
            <a:off x="4068310" y="1671492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86F361C-6683-87A8-F359-81B95D1EA460}"/>
              </a:ext>
            </a:extLst>
          </p:cNvPr>
          <p:cNvSpPr txBox="1"/>
          <p:nvPr/>
        </p:nvSpPr>
        <p:spPr>
          <a:xfrm>
            <a:off x="5780856" y="1671492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97FFE7C9-6A4D-F2AB-DF61-CFFD2B93B0A1}"/>
              </a:ext>
            </a:extLst>
          </p:cNvPr>
          <p:cNvSpPr txBox="1"/>
          <p:nvPr/>
        </p:nvSpPr>
        <p:spPr>
          <a:xfrm>
            <a:off x="7693935" y="1677949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3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D18D640-1872-E42A-D7D9-D749FDB2833B}"/>
              </a:ext>
            </a:extLst>
          </p:cNvPr>
          <p:cNvSpPr txBox="1"/>
          <p:nvPr/>
        </p:nvSpPr>
        <p:spPr>
          <a:xfrm>
            <a:off x="1983780" y="1416339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2" name="그룹 51">
            <a:extLst>
              <a:ext uri="{FF2B5EF4-FFF2-40B4-BE49-F238E27FC236}">
                <a16:creationId xmlns:a16="http://schemas.microsoft.com/office/drawing/2014/main" id="{97FA10F6-50FD-5F62-7B61-3C274909E688}"/>
              </a:ext>
            </a:extLst>
          </p:cNvPr>
          <p:cNvGrpSpPr/>
          <p:nvPr/>
        </p:nvGrpSpPr>
        <p:grpSpPr>
          <a:xfrm>
            <a:off x="7028893" y="3102553"/>
            <a:ext cx="609834" cy="230832"/>
            <a:chOff x="740793" y="5499416"/>
            <a:chExt cx="609834" cy="230832"/>
          </a:xfrm>
        </p:grpSpPr>
        <p:cxnSp>
          <p:nvCxnSpPr>
            <p:cNvPr id="53" name="직선 연결선 52">
              <a:extLst>
                <a:ext uri="{FF2B5EF4-FFF2-40B4-BE49-F238E27FC236}">
                  <a16:creationId xmlns:a16="http://schemas.microsoft.com/office/drawing/2014/main" id="{2D43FCAF-1673-E8C3-03C0-3C844FD10B70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35205C68-9A5C-904F-C96E-1DB4516FEF7E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63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5" name="그룹 54">
            <a:extLst>
              <a:ext uri="{FF2B5EF4-FFF2-40B4-BE49-F238E27FC236}">
                <a16:creationId xmlns:a16="http://schemas.microsoft.com/office/drawing/2014/main" id="{136915EE-39D7-6DDD-9AF7-254FDACC09D6}"/>
              </a:ext>
            </a:extLst>
          </p:cNvPr>
          <p:cNvGrpSpPr/>
          <p:nvPr/>
        </p:nvGrpSpPr>
        <p:grpSpPr>
          <a:xfrm>
            <a:off x="7028893" y="3226628"/>
            <a:ext cx="609834" cy="230832"/>
            <a:chOff x="740793" y="5499416"/>
            <a:chExt cx="609834" cy="230832"/>
          </a:xfrm>
        </p:grpSpPr>
        <p:cxnSp>
          <p:nvCxnSpPr>
            <p:cNvPr id="56" name="직선 연결선 55">
              <a:extLst>
                <a:ext uri="{FF2B5EF4-FFF2-40B4-BE49-F238E27FC236}">
                  <a16:creationId xmlns:a16="http://schemas.microsoft.com/office/drawing/2014/main" id="{C1E69BD4-7371-3969-1A6D-A4285E84AC8E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6FD0C279-4FA1-D5DF-2F99-2B3E56DF1258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8" name="그룹 57">
            <a:extLst>
              <a:ext uri="{FF2B5EF4-FFF2-40B4-BE49-F238E27FC236}">
                <a16:creationId xmlns:a16="http://schemas.microsoft.com/office/drawing/2014/main" id="{485F5F51-DF7B-2E26-7B31-3B2C14344FCB}"/>
              </a:ext>
            </a:extLst>
          </p:cNvPr>
          <p:cNvGrpSpPr/>
          <p:nvPr/>
        </p:nvGrpSpPr>
        <p:grpSpPr>
          <a:xfrm>
            <a:off x="5123893" y="2731078"/>
            <a:ext cx="609834" cy="230832"/>
            <a:chOff x="740793" y="5499416"/>
            <a:chExt cx="609834" cy="230832"/>
          </a:xfrm>
        </p:grpSpPr>
        <p:cxnSp>
          <p:nvCxnSpPr>
            <p:cNvPr id="59" name="직선 연결선 58">
              <a:extLst>
                <a:ext uri="{FF2B5EF4-FFF2-40B4-BE49-F238E27FC236}">
                  <a16:creationId xmlns:a16="http://schemas.microsoft.com/office/drawing/2014/main" id="{C4BC3730-CC34-E31A-B71B-7AACB9AB4803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484B0FDD-157D-5EDC-11DC-B90BB0BAE935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63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1" name="그룹 60">
            <a:extLst>
              <a:ext uri="{FF2B5EF4-FFF2-40B4-BE49-F238E27FC236}">
                <a16:creationId xmlns:a16="http://schemas.microsoft.com/office/drawing/2014/main" id="{35CD8331-641E-BFB3-B0EC-7B6AD3D4772A}"/>
              </a:ext>
            </a:extLst>
          </p:cNvPr>
          <p:cNvGrpSpPr/>
          <p:nvPr/>
        </p:nvGrpSpPr>
        <p:grpSpPr>
          <a:xfrm>
            <a:off x="5123893" y="2855153"/>
            <a:ext cx="609834" cy="230832"/>
            <a:chOff x="740793" y="5499416"/>
            <a:chExt cx="609834" cy="230832"/>
          </a:xfrm>
        </p:grpSpPr>
        <p:cxnSp>
          <p:nvCxnSpPr>
            <p:cNvPr id="62" name="직선 연결선 61">
              <a:extLst>
                <a:ext uri="{FF2B5EF4-FFF2-40B4-BE49-F238E27FC236}">
                  <a16:creationId xmlns:a16="http://schemas.microsoft.com/office/drawing/2014/main" id="{DA54DAD7-7708-EF3F-DF85-8B610C0C9687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8D57CE3B-1084-A250-5D1B-EEDD515C7E06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4" name="그룹 63">
            <a:extLst>
              <a:ext uri="{FF2B5EF4-FFF2-40B4-BE49-F238E27FC236}">
                <a16:creationId xmlns:a16="http://schemas.microsoft.com/office/drawing/2014/main" id="{2D60F953-C31F-CE37-2588-394BBE5BC72E}"/>
              </a:ext>
            </a:extLst>
          </p:cNvPr>
          <p:cNvGrpSpPr/>
          <p:nvPr/>
        </p:nvGrpSpPr>
        <p:grpSpPr>
          <a:xfrm>
            <a:off x="3380818" y="2902528"/>
            <a:ext cx="609834" cy="230832"/>
            <a:chOff x="740793" y="5499416"/>
            <a:chExt cx="609834" cy="230832"/>
          </a:xfrm>
        </p:grpSpPr>
        <p:cxnSp>
          <p:nvCxnSpPr>
            <p:cNvPr id="65" name="직선 연결선 64">
              <a:extLst>
                <a:ext uri="{FF2B5EF4-FFF2-40B4-BE49-F238E27FC236}">
                  <a16:creationId xmlns:a16="http://schemas.microsoft.com/office/drawing/2014/main" id="{38484654-BB1A-FA39-2658-3C3D3B274202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18E7B0C5-390D-571A-7F57-39E3BF85FBD1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63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7" name="그룹 66">
            <a:extLst>
              <a:ext uri="{FF2B5EF4-FFF2-40B4-BE49-F238E27FC236}">
                <a16:creationId xmlns:a16="http://schemas.microsoft.com/office/drawing/2014/main" id="{0B3ECE0F-9C33-B413-274C-41A4C270948C}"/>
              </a:ext>
            </a:extLst>
          </p:cNvPr>
          <p:cNvGrpSpPr/>
          <p:nvPr/>
        </p:nvGrpSpPr>
        <p:grpSpPr>
          <a:xfrm>
            <a:off x="3380818" y="3026603"/>
            <a:ext cx="609834" cy="230832"/>
            <a:chOff x="740793" y="5499416"/>
            <a:chExt cx="609834" cy="230832"/>
          </a:xfrm>
        </p:grpSpPr>
        <p:cxnSp>
          <p:nvCxnSpPr>
            <p:cNvPr id="68" name="직선 연결선 67">
              <a:extLst>
                <a:ext uri="{FF2B5EF4-FFF2-40B4-BE49-F238E27FC236}">
                  <a16:creationId xmlns:a16="http://schemas.microsoft.com/office/drawing/2014/main" id="{51E125F9-09DE-BAC8-4702-C53C271003FB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599B4BC2-3A30-B930-4B25-D80AC2F174C1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0" name="그룹 69">
            <a:extLst>
              <a:ext uri="{FF2B5EF4-FFF2-40B4-BE49-F238E27FC236}">
                <a16:creationId xmlns:a16="http://schemas.microsoft.com/office/drawing/2014/main" id="{DDF15CD2-0637-548F-BF2D-B8DB5831F7CF}"/>
              </a:ext>
            </a:extLst>
          </p:cNvPr>
          <p:cNvGrpSpPr/>
          <p:nvPr/>
        </p:nvGrpSpPr>
        <p:grpSpPr>
          <a:xfrm>
            <a:off x="7047943" y="2083378"/>
            <a:ext cx="609834" cy="230832"/>
            <a:chOff x="740793" y="5499416"/>
            <a:chExt cx="609834" cy="230832"/>
          </a:xfrm>
        </p:grpSpPr>
        <p:cxnSp>
          <p:nvCxnSpPr>
            <p:cNvPr id="71" name="직선 연결선 70">
              <a:extLst>
                <a:ext uri="{FF2B5EF4-FFF2-40B4-BE49-F238E27FC236}">
                  <a16:creationId xmlns:a16="http://schemas.microsoft.com/office/drawing/2014/main" id="{179D8EE6-231F-10B2-0899-2A4F6C094F63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38400BF4-65CE-0E17-7634-54019DA1F027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63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3" name="그룹 72">
            <a:extLst>
              <a:ext uri="{FF2B5EF4-FFF2-40B4-BE49-F238E27FC236}">
                <a16:creationId xmlns:a16="http://schemas.microsoft.com/office/drawing/2014/main" id="{5EAFB51A-8FA3-5FA9-84DF-C50C1608C974}"/>
              </a:ext>
            </a:extLst>
          </p:cNvPr>
          <p:cNvGrpSpPr/>
          <p:nvPr/>
        </p:nvGrpSpPr>
        <p:grpSpPr>
          <a:xfrm>
            <a:off x="7047943" y="2266132"/>
            <a:ext cx="609834" cy="230832"/>
            <a:chOff x="740793" y="5499416"/>
            <a:chExt cx="609834" cy="230832"/>
          </a:xfrm>
        </p:grpSpPr>
        <p:cxnSp>
          <p:nvCxnSpPr>
            <p:cNvPr id="74" name="직선 연결선 73">
              <a:extLst>
                <a:ext uri="{FF2B5EF4-FFF2-40B4-BE49-F238E27FC236}">
                  <a16:creationId xmlns:a16="http://schemas.microsoft.com/office/drawing/2014/main" id="{1D523379-C210-BA8B-A890-8CD22A90135F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BD10027F-581F-52DA-2118-9B3A2B35D577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6" name="그룹 75">
            <a:extLst>
              <a:ext uri="{FF2B5EF4-FFF2-40B4-BE49-F238E27FC236}">
                <a16:creationId xmlns:a16="http://schemas.microsoft.com/office/drawing/2014/main" id="{DC6566F7-E266-FAFB-2C5C-CFC88FF8CFF5}"/>
              </a:ext>
            </a:extLst>
          </p:cNvPr>
          <p:cNvGrpSpPr/>
          <p:nvPr/>
        </p:nvGrpSpPr>
        <p:grpSpPr>
          <a:xfrm>
            <a:off x="5114368" y="2083378"/>
            <a:ext cx="609834" cy="230832"/>
            <a:chOff x="740793" y="5499416"/>
            <a:chExt cx="609834" cy="230832"/>
          </a:xfrm>
        </p:grpSpPr>
        <p:cxnSp>
          <p:nvCxnSpPr>
            <p:cNvPr id="77" name="직선 연결선 76">
              <a:extLst>
                <a:ext uri="{FF2B5EF4-FFF2-40B4-BE49-F238E27FC236}">
                  <a16:creationId xmlns:a16="http://schemas.microsoft.com/office/drawing/2014/main" id="{2AC82EC4-F9A5-544F-6E08-0EAD03C9BF21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F08644D9-21BE-AC9B-904C-0CCB10878A76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63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9" name="그룹 78">
            <a:extLst>
              <a:ext uri="{FF2B5EF4-FFF2-40B4-BE49-F238E27FC236}">
                <a16:creationId xmlns:a16="http://schemas.microsoft.com/office/drawing/2014/main" id="{CDA9CD78-6EC9-7B82-B3E9-D08BC80FA2B7}"/>
              </a:ext>
            </a:extLst>
          </p:cNvPr>
          <p:cNvGrpSpPr/>
          <p:nvPr/>
        </p:nvGrpSpPr>
        <p:grpSpPr>
          <a:xfrm>
            <a:off x="5114368" y="2266132"/>
            <a:ext cx="609834" cy="230832"/>
            <a:chOff x="740793" y="5499416"/>
            <a:chExt cx="609834" cy="230832"/>
          </a:xfrm>
        </p:grpSpPr>
        <p:cxnSp>
          <p:nvCxnSpPr>
            <p:cNvPr id="80" name="직선 연결선 79">
              <a:extLst>
                <a:ext uri="{FF2B5EF4-FFF2-40B4-BE49-F238E27FC236}">
                  <a16:creationId xmlns:a16="http://schemas.microsoft.com/office/drawing/2014/main" id="{179BBECD-9B65-BE95-24ED-F27EA3A38E99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D1CA12B3-6E53-AD7C-C234-86FABA8EA74F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8" name="그룹 87">
            <a:extLst>
              <a:ext uri="{FF2B5EF4-FFF2-40B4-BE49-F238E27FC236}">
                <a16:creationId xmlns:a16="http://schemas.microsoft.com/office/drawing/2014/main" id="{5D2349A1-AEE8-8754-7CB2-EA8ADFDE3717}"/>
              </a:ext>
            </a:extLst>
          </p:cNvPr>
          <p:cNvGrpSpPr/>
          <p:nvPr/>
        </p:nvGrpSpPr>
        <p:grpSpPr>
          <a:xfrm>
            <a:off x="3389553" y="2140840"/>
            <a:ext cx="609834" cy="230832"/>
            <a:chOff x="740793" y="5499416"/>
            <a:chExt cx="609834" cy="230832"/>
          </a:xfrm>
        </p:grpSpPr>
        <p:cxnSp>
          <p:nvCxnSpPr>
            <p:cNvPr id="89" name="직선 연결선 88">
              <a:extLst>
                <a:ext uri="{FF2B5EF4-FFF2-40B4-BE49-F238E27FC236}">
                  <a16:creationId xmlns:a16="http://schemas.microsoft.com/office/drawing/2014/main" id="{1B98D737-ACA7-DE80-2C0E-E2FDCA7A53B3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640C9C9E-F0CC-B854-24F0-8F0CE64CC3DF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63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1" name="그룹 90">
            <a:extLst>
              <a:ext uri="{FF2B5EF4-FFF2-40B4-BE49-F238E27FC236}">
                <a16:creationId xmlns:a16="http://schemas.microsoft.com/office/drawing/2014/main" id="{828D6122-0953-907A-D9AD-E7E0374D9A3E}"/>
              </a:ext>
            </a:extLst>
          </p:cNvPr>
          <p:cNvGrpSpPr/>
          <p:nvPr/>
        </p:nvGrpSpPr>
        <p:grpSpPr>
          <a:xfrm>
            <a:off x="3389553" y="2323594"/>
            <a:ext cx="609834" cy="230832"/>
            <a:chOff x="740793" y="5499416"/>
            <a:chExt cx="609834" cy="230832"/>
          </a:xfrm>
        </p:grpSpPr>
        <p:cxnSp>
          <p:nvCxnSpPr>
            <p:cNvPr id="92" name="직선 연결선 91">
              <a:extLst>
                <a:ext uri="{FF2B5EF4-FFF2-40B4-BE49-F238E27FC236}">
                  <a16:creationId xmlns:a16="http://schemas.microsoft.com/office/drawing/2014/main" id="{E5E576BF-A292-CDDD-8146-DB7B52840877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46A4203D-69DF-35F8-7A28-48C11AAF5A4B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4" name="그룹 93">
            <a:extLst>
              <a:ext uri="{FF2B5EF4-FFF2-40B4-BE49-F238E27FC236}">
                <a16:creationId xmlns:a16="http://schemas.microsoft.com/office/drawing/2014/main" id="{233BD14F-F9BF-C6B8-98A0-E990B8569078}"/>
              </a:ext>
            </a:extLst>
          </p:cNvPr>
          <p:cNvGrpSpPr/>
          <p:nvPr/>
        </p:nvGrpSpPr>
        <p:grpSpPr>
          <a:xfrm>
            <a:off x="5111175" y="3699463"/>
            <a:ext cx="609834" cy="230832"/>
            <a:chOff x="740793" y="5499416"/>
            <a:chExt cx="609834" cy="230832"/>
          </a:xfrm>
        </p:grpSpPr>
        <p:cxnSp>
          <p:nvCxnSpPr>
            <p:cNvPr id="95" name="직선 연결선 94">
              <a:extLst>
                <a:ext uri="{FF2B5EF4-FFF2-40B4-BE49-F238E27FC236}">
                  <a16:creationId xmlns:a16="http://schemas.microsoft.com/office/drawing/2014/main" id="{223F5A1B-9D67-32CE-354F-91F7210BD6A3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D6ADB3F3-89BC-592A-9AEA-A7B9EAE1DD8F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8" name="그룹 97">
            <a:extLst>
              <a:ext uri="{FF2B5EF4-FFF2-40B4-BE49-F238E27FC236}">
                <a16:creationId xmlns:a16="http://schemas.microsoft.com/office/drawing/2014/main" id="{89704667-FE66-19C9-1DC4-8BC991FCC8EA}"/>
              </a:ext>
            </a:extLst>
          </p:cNvPr>
          <p:cNvGrpSpPr/>
          <p:nvPr/>
        </p:nvGrpSpPr>
        <p:grpSpPr>
          <a:xfrm>
            <a:off x="7028893" y="3927186"/>
            <a:ext cx="609834" cy="230832"/>
            <a:chOff x="740793" y="5499416"/>
            <a:chExt cx="609834" cy="230832"/>
          </a:xfrm>
        </p:grpSpPr>
        <p:cxnSp>
          <p:nvCxnSpPr>
            <p:cNvPr id="99" name="직선 연결선 98">
              <a:extLst>
                <a:ext uri="{FF2B5EF4-FFF2-40B4-BE49-F238E27FC236}">
                  <a16:creationId xmlns:a16="http://schemas.microsoft.com/office/drawing/2014/main" id="{E9232D4D-F523-2B80-8CB0-29D1D3F9486C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CB55B530-D4A8-EA10-E4B1-13AD8565014C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1" name="그룹 100">
            <a:extLst>
              <a:ext uri="{FF2B5EF4-FFF2-40B4-BE49-F238E27FC236}">
                <a16:creationId xmlns:a16="http://schemas.microsoft.com/office/drawing/2014/main" id="{51FF40E1-F8B5-BED1-B4DA-507BFBF312C0}"/>
              </a:ext>
            </a:extLst>
          </p:cNvPr>
          <p:cNvGrpSpPr/>
          <p:nvPr/>
        </p:nvGrpSpPr>
        <p:grpSpPr>
          <a:xfrm>
            <a:off x="7028893" y="3766370"/>
            <a:ext cx="609834" cy="230832"/>
            <a:chOff x="740793" y="5499416"/>
            <a:chExt cx="609834" cy="230832"/>
          </a:xfrm>
        </p:grpSpPr>
        <p:cxnSp>
          <p:nvCxnSpPr>
            <p:cNvPr id="102" name="직선 연결선 101">
              <a:extLst>
                <a:ext uri="{FF2B5EF4-FFF2-40B4-BE49-F238E27FC236}">
                  <a16:creationId xmlns:a16="http://schemas.microsoft.com/office/drawing/2014/main" id="{4A891330-B2D5-64D1-7FED-2F0F5A984CA8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0D81DF1B-A55E-B1D9-33B6-32347312A1F5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6" name="TextBox 105">
            <a:extLst>
              <a:ext uri="{FF2B5EF4-FFF2-40B4-BE49-F238E27FC236}">
                <a16:creationId xmlns:a16="http://schemas.microsoft.com/office/drawing/2014/main" id="{C1EF9931-2546-AC8F-0B0C-B83C984EFD59}"/>
              </a:ext>
            </a:extLst>
          </p:cNvPr>
          <p:cNvSpPr txBox="1"/>
          <p:nvPr/>
        </p:nvSpPr>
        <p:spPr>
          <a:xfrm>
            <a:off x="3213800" y="4428550"/>
            <a:ext cx="9348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litinib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EBC04D24-5D77-35C9-1CB9-546F1877AA1B}"/>
              </a:ext>
            </a:extLst>
          </p:cNvPr>
          <p:cNvSpPr txBox="1"/>
          <p:nvPr/>
        </p:nvSpPr>
        <p:spPr>
          <a:xfrm>
            <a:off x="4133554" y="4428550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FDBB0F2E-076E-EAB1-7660-4D32E90035C7}"/>
              </a:ext>
            </a:extLst>
          </p:cNvPr>
          <p:cNvSpPr txBox="1"/>
          <p:nvPr/>
        </p:nvSpPr>
        <p:spPr>
          <a:xfrm>
            <a:off x="4302946" y="442855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75303A05-97F8-1884-1512-9D3B7B118125}"/>
              </a:ext>
            </a:extLst>
          </p:cNvPr>
          <p:cNvSpPr txBox="1"/>
          <p:nvPr/>
        </p:nvSpPr>
        <p:spPr>
          <a:xfrm>
            <a:off x="4563018" y="4428550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659C8966-8EBE-D72B-57FE-96C4B01BC442}"/>
              </a:ext>
            </a:extLst>
          </p:cNvPr>
          <p:cNvSpPr txBox="1"/>
          <p:nvPr/>
        </p:nvSpPr>
        <p:spPr>
          <a:xfrm>
            <a:off x="4978460" y="4428550"/>
            <a:ext cx="9348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litinib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7A89B51F-E1CC-E13F-4A21-AD0F133657AF}"/>
              </a:ext>
            </a:extLst>
          </p:cNvPr>
          <p:cNvSpPr txBox="1"/>
          <p:nvPr/>
        </p:nvSpPr>
        <p:spPr>
          <a:xfrm>
            <a:off x="5898214" y="4428550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401BB952-422F-4D46-145B-83044A74EBF8}"/>
              </a:ext>
            </a:extLst>
          </p:cNvPr>
          <p:cNvSpPr txBox="1"/>
          <p:nvPr/>
        </p:nvSpPr>
        <p:spPr>
          <a:xfrm>
            <a:off x="6067606" y="442855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D4A0349F-3A57-776F-CC54-A380F88F4012}"/>
              </a:ext>
            </a:extLst>
          </p:cNvPr>
          <p:cNvSpPr txBox="1"/>
          <p:nvPr/>
        </p:nvSpPr>
        <p:spPr>
          <a:xfrm>
            <a:off x="6327678" y="4428550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EFE3DF51-3268-996E-8BC6-9CFD4C730AD1}"/>
              </a:ext>
            </a:extLst>
          </p:cNvPr>
          <p:cNvSpPr txBox="1"/>
          <p:nvPr/>
        </p:nvSpPr>
        <p:spPr>
          <a:xfrm>
            <a:off x="6829908" y="4428550"/>
            <a:ext cx="9348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litinib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451B6B45-BD0B-D358-EDA4-F83775A100EA}"/>
              </a:ext>
            </a:extLst>
          </p:cNvPr>
          <p:cNvSpPr txBox="1"/>
          <p:nvPr/>
        </p:nvSpPr>
        <p:spPr>
          <a:xfrm>
            <a:off x="7749662" y="4428550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99818E8E-000F-7184-76DD-2416ED128791}"/>
              </a:ext>
            </a:extLst>
          </p:cNvPr>
          <p:cNvSpPr txBox="1"/>
          <p:nvPr/>
        </p:nvSpPr>
        <p:spPr>
          <a:xfrm>
            <a:off x="7919054" y="442855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0CE75AAF-E128-713D-AA10-6EECF0C63042}"/>
              </a:ext>
            </a:extLst>
          </p:cNvPr>
          <p:cNvSpPr txBox="1"/>
          <p:nvPr/>
        </p:nvSpPr>
        <p:spPr>
          <a:xfrm>
            <a:off x="8179126" y="4428550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855F57CB-DAFA-D470-1CEE-C287DDD510CA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7661072" y="3663280"/>
            <a:ext cx="865707" cy="609653"/>
          </a:xfrm>
          <a:prstGeom prst="rect">
            <a:avLst/>
          </a:prstGeom>
        </p:spPr>
      </p:pic>
      <p:sp>
        <p:nvSpPr>
          <p:cNvPr id="82" name="직사각형 81">
            <a:extLst>
              <a:ext uri="{FF2B5EF4-FFF2-40B4-BE49-F238E27FC236}">
                <a16:creationId xmlns:a16="http://schemas.microsoft.com/office/drawing/2014/main" id="{32246E10-567A-4E55-8748-055DE1C309D2}"/>
              </a:ext>
            </a:extLst>
          </p:cNvPr>
          <p:cNvSpPr/>
          <p:nvPr/>
        </p:nvSpPr>
        <p:spPr>
          <a:xfrm>
            <a:off x="4072617" y="2236309"/>
            <a:ext cx="730462" cy="149035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3" name="직사각형 82">
            <a:extLst>
              <a:ext uri="{FF2B5EF4-FFF2-40B4-BE49-F238E27FC236}">
                <a16:creationId xmlns:a16="http://schemas.microsoft.com/office/drawing/2014/main" id="{CDFBBDD5-8065-4A9F-9CC2-7B0C9A0C1B96}"/>
              </a:ext>
            </a:extLst>
          </p:cNvPr>
          <p:cNvSpPr/>
          <p:nvPr/>
        </p:nvSpPr>
        <p:spPr>
          <a:xfrm>
            <a:off x="4063798" y="2973610"/>
            <a:ext cx="745600" cy="200540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4" name="직사각형 83">
            <a:extLst>
              <a:ext uri="{FF2B5EF4-FFF2-40B4-BE49-F238E27FC236}">
                <a16:creationId xmlns:a16="http://schemas.microsoft.com/office/drawing/2014/main" id="{21D8D01B-FAA1-47EC-9912-63C97EF7D06C}"/>
              </a:ext>
            </a:extLst>
          </p:cNvPr>
          <p:cNvSpPr/>
          <p:nvPr/>
        </p:nvSpPr>
        <p:spPr>
          <a:xfrm>
            <a:off x="4035117" y="3844760"/>
            <a:ext cx="796716" cy="201643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FA5E4A6-384E-F1D4-0063-71DFBF9E4EC9}"/>
              </a:ext>
            </a:extLst>
          </p:cNvPr>
          <p:cNvSpPr txBox="1"/>
          <p:nvPr/>
        </p:nvSpPr>
        <p:spPr>
          <a:xfrm>
            <a:off x="34923" y="41837"/>
            <a:ext cx="4696467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Arial" panose="020B0604020202020204" pitchFamily="34" charset="0"/>
                <a:cs typeface="Arial" panose="020B0604020202020204" pitchFamily="34" charset="0"/>
              </a:rPr>
              <a:t>Original gel images of Supplementary Figure 3</a:t>
            </a:r>
            <a:r>
              <a:rPr lang="en-US" altLang="ko-KR" sz="1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endParaRPr lang="en-US" altLang="ko-KR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ll experiments were performed in triplicates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The red boxes indicate the figures in the main text.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173234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개체 4">
            <a:extLst>
              <a:ext uri="{FF2B5EF4-FFF2-40B4-BE49-F238E27FC236}">
                <a16:creationId xmlns:a16="http://schemas.microsoft.com/office/drawing/2014/main" id="{840184D4-46E4-4D3D-BF0B-7D18A42DC88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22979686"/>
              </p:ext>
            </p:extLst>
          </p:nvPr>
        </p:nvGraphicFramePr>
        <p:xfrm>
          <a:off x="8203747" y="1144073"/>
          <a:ext cx="864000" cy="3875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8" name="Image" r:id="rId3" imgW="2717280" imgH="1218960" progId="Photoshop.Image.13">
                  <p:embed/>
                </p:oleObj>
              </mc:Choice>
              <mc:Fallback>
                <p:oleObj name="Image" r:id="rId3" imgW="2717280" imgH="1218960" progId="Photoshop.Image.13">
                  <p:embed/>
                  <p:pic>
                    <p:nvPicPr>
                      <p:cNvPr id="5" name="개체 4">
                        <a:extLst>
                          <a:ext uri="{FF2B5EF4-FFF2-40B4-BE49-F238E27FC236}">
                            <a16:creationId xmlns:a16="http://schemas.microsoft.com/office/drawing/2014/main" id="{840184D4-46E4-4D3D-BF0B-7D18A42DC88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203747" y="1144073"/>
                        <a:ext cx="864000" cy="3875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개체 5">
            <a:extLst>
              <a:ext uri="{FF2B5EF4-FFF2-40B4-BE49-F238E27FC236}">
                <a16:creationId xmlns:a16="http://schemas.microsoft.com/office/drawing/2014/main" id="{0ABF5247-D50E-4AE3-A9C7-CEA68C33CFC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36403427"/>
              </p:ext>
            </p:extLst>
          </p:nvPr>
        </p:nvGraphicFramePr>
        <p:xfrm>
          <a:off x="10075318" y="1144073"/>
          <a:ext cx="864000" cy="3875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9" name="Image" r:id="rId5" imgW="2717280" imgH="1218960" progId="Photoshop.Image.13">
                  <p:embed/>
                </p:oleObj>
              </mc:Choice>
              <mc:Fallback>
                <p:oleObj name="Image" r:id="rId5" imgW="2717280" imgH="1218960" progId="Photoshop.Image.13">
                  <p:embed/>
                  <p:pic>
                    <p:nvPicPr>
                      <p:cNvPr id="6" name="개체 5">
                        <a:extLst>
                          <a:ext uri="{FF2B5EF4-FFF2-40B4-BE49-F238E27FC236}">
                            <a16:creationId xmlns:a16="http://schemas.microsoft.com/office/drawing/2014/main" id="{0ABF5247-D50E-4AE3-A9C7-CEA68C33CFC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0075318" y="1144073"/>
                        <a:ext cx="864000" cy="3875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6639D5B2-514D-4C11-BD27-1EE927DC6EBD}"/>
              </a:ext>
            </a:extLst>
          </p:cNvPr>
          <p:cNvSpPr txBox="1"/>
          <p:nvPr/>
        </p:nvSpPr>
        <p:spPr>
          <a:xfrm>
            <a:off x="6491201" y="860617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9AABE49-F714-4F54-A879-687A36682180}"/>
              </a:ext>
            </a:extLst>
          </p:cNvPr>
          <p:cNvSpPr txBox="1"/>
          <p:nvPr/>
        </p:nvSpPr>
        <p:spPr>
          <a:xfrm>
            <a:off x="8203747" y="860617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831C146-FE05-4F31-AB24-347BD66638CB}"/>
              </a:ext>
            </a:extLst>
          </p:cNvPr>
          <p:cNvSpPr txBox="1"/>
          <p:nvPr/>
        </p:nvSpPr>
        <p:spPr>
          <a:xfrm>
            <a:off x="10116826" y="867074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BA4997A-599D-47E1-94DE-FCDDA54B66BB}"/>
              </a:ext>
            </a:extLst>
          </p:cNvPr>
          <p:cNvSpPr txBox="1"/>
          <p:nvPr/>
        </p:nvSpPr>
        <p:spPr>
          <a:xfrm>
            <a:off x="4293885" y="1105614"/>
            <a:ext cx="12921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Twist1 (21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1079608-355F-46AD-A3D5-05D28F0654F1}"/>
              </a:ext>
            </a:extLst>
          </p:cNvPr>
          <p:cNvSpPr txBox="1"/>
          <p:nvPr/>
        </p:nvSpPr>
        <p:spPr>
          <a:xfrm>
            <a:off x="4258862" y="1662101"/>
            <a:ext cx="1329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 (41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F7BE992-47A7-4118-9351-B74D86970DF1}"/>
              </a:ext>
            </a:extLst>
          </p:cNvPr>
          <p:cNvSpPr txBox="1"/>
          <p:nvPr/>
        </p:nvSpPr>
        <p:spPr>
          <a:xfrm>
            <a:off x="7123002" y="2194400"/>
            <a:ext cx="108074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litinib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P600125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66665C9-7A95-4C21-BBF4-8FA7C4E53CB8}"/>
              </a:ext>
            </a:extLst>
          </p:cNvPr>
          <p:cNvSpPr txBox="1"/>
          <p:nvPr/>
        </p:nvSpPr>
        <p:spPr>
          <a:xfrm>
            <a:off x="8221994" y="2194400"/>
            <a:ext cx="2279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D190280-31D9-44E4-B8B2-C83E1807D372}"/>
              </a:ext>
            </a:extLst>
          </p:cNvPr>
          <p:cNvSpPr txBox="1"/>
          <p:nvPr/>
        </p:nvSpPr>
        <p:spPr>
          <a:xfrm>
            <a:off x="8353959" y="2194400"/>
            <a:ext cx="255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B785225-0F50-4D46-9E70-10981A2DA21E}"/>
              </a:ext>
            </a:extLst>
          </p:cNvPr>
          <p:cNvSpPr txBox="1"/>
          <p:nvPr/>
        </p:nvSpPr>
        <p:spPr>
          <a:xfrm>
            <a:off x="8550157" y="2194400"/>
            <a:ext cx="255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901FFD9-B4BB-4C5B-B302-55D3D0071094}"/>
              </a:ext>
            </a:extLst>
          </p:cNvPr>
          <p:cNvSpPr txBox="1"/>
          <p:nvPr/>
        </p:nvSpPr>
        <p:spPr>
          <a:xfrm>
            <a:off x="8688812" y="2194400"/>
            <a:ext cx="3257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graphicFrame>
        <p:nvGraphicFramePr>
          <p:cNvPr id="34" name="개체 33">
            <a:extLst>
              <a:ext uri="{FF2B5EF4-FFF2-40B4-BE49-F238E27FC236}">
                <a16:creationId xmlns:a16="http://schemas.microsoft.com/office/drawing/2014/main" id="{6383F1C3-B674-4FD0-88E9-4B670480261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95569767"/>
              </p:ext>
            </p:extLst>
          </p:nvPr>
        </p:nvGraphicFramePr>
        <p:xfrm>
          <a:off x="8203747" y="1662101"/>
          <a:ext cx="864000" cy="4018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80" name="Image" r:id="rId7" imgW="2729880" imgH="1269720" progId="Photoshop.Image.13">
                  <p:embed/>
                </p:oleObj>
              </mc:Choice>
              <mc:Fallback>
                <p:oleObj name="Image" r:id="rId7" imgW="2729880" imgH="1269720" progId="Photoshop.Image.13">
                  <p:embed/>
                  <p:pic>
                    <p:nvPicPr>
                      <p:cNvPr id="34" name="개체 33">
                        <a:extLst>
                          <a:ext uri="{FF2B5EF4-FFF2-40B4-BE49-F238E27FC236}">
                            <a16:creationId xmlns:a16="http://schemas.microsoft.com/office/drawing/2014/main" id="{6383F1C3-B674-4FD0-88E9-4B670480261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203747" y="1662101"/>
                        <a:ext cx="864000" cy="4018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개체 34">
            <a:extLst>
              <a:ext uri="{FF2B5EF4-FFF2-40B4-BE49-F238E27FC236}">
                <a16:creationId xmlns:a16="http://schemas.microsoft.com/office/drawing/2014/main" id="{EB4F41A9-F9E2-4F6D-8884-67B072513BA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08683141"/>
              </p:ext>
            </p:extLst>
          </p:nvPr>
        </p:nvGraphicFramePr>
        <p:xfrm>
          <a:off x="10075318" y="1654224"/>
          <a:ext cx="864000" cy="4018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81" name="Image" r:id="rId9" imgW="2729880" imgH="1269720" progId="Photoshop.Image.13">
                  <p:embed/>
                </p:oleObj>
              </mc:Choice>
              <mc:Fallback>
                <p:oleObj name="Image" r:id="rId9" imgW="2729880" imgH="1269720" progId="Photoshop.Image.13">
                  <p:embed/>
                  <p:pic>
                    <p:nvPicPr>
                      <p:cNvPr id="35" name="개체 34">
                        <a:extLst>
                          <a:ext uri="{FF2B5EF4-FFF2-40B4-BE49-F238E27FC236}">
                            <a16:creationId xmlns:a16="http://schemas.microsoft.com/office/drawing/2014/main" id="{EB4F41A9-F9E2-4F6D-8884-67B072513BA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0075318" y="1654224"/>
                        <a:ext cx="864000" cy="4018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1" name="TextBox 40">
            <a:extLst>
              <a:ext uri="{FF2B5EF4-FFF2-40B4-BE49-F238E27FC236}">
                <a16:creationId xmlns:a16="http://schemas.microsoft.com/office/drawing/2014/main" id="{0CD5F5F5-1407-4503-BD2B-0DF68806D6E6}"/>
              </a:ext>
            </a:extLst>
          </p:cNvPr>
          <p:cNvSpPr txBox="1"/>
          <p:nvPr/>
        </p:nvSpPr>
        <p:spPr>
          <a:xfrm>
            <a:off x="9036081" y="2194400"/>
            <a:ext cx="108074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litinib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P600125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E21B975-0041-499F-88EA-C45F46BF15E1}"/>
              </a:ext>
            </a:extLst>
          </p:cNvPr>
          <p:cNvSpPr txBox="1"/>
          <p:nvPr/>
        </p:nvSpPr>
        <p:spPr>
          <a:xfrm>
            <a:off x="10135073" y="2194400"/>
            <a:ext cx="2279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A08EA38E-54B4-4F38-8A20-AD5F9723D8AA}"/>
              </a:ext>
            </a:extLst>
          </p:cNvPr>
          <p:cNvSpPr txBox="1"/>
          <p:nvPr/>
        </p:nvSpPr>
        <p:spPr>
          <a:xfrm>
            <a:off x="10267038" y="2194400"/>
            <a:ext cx="255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118A10F-57DA-4C08-ADDE-31ED37AD5392}"/>
              </a:ext>
            </a:extLst>
          </p:cNvPr>
          <p:cNvSpPr txBox="1"/>
          <p:nvPr/>
        </p:nvSpPr>
        <p:spPr>
          <a:xfrm>
            <a:off x="10463236" y="2194400"/>
            <a:ext cx="255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60EC9EF-5050-4621-812B-EFE4352E38DD}"/>
              </a:ext>
            </a:extLst>
          </p:cNvPr>
          <p:cNvSpPr txBox="1"/>
          <p:nvPr/>
        </p:nvSpPr>
        <p:spPr>
          <a:xfrm>
            <a:off x="10601891" y="2194400"/>
            <a:ext cx="3257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graphicFrame>
        <p:nvGraphicFramePr>
          <p:cNvPr id="46" name="개체 45">
            <a:extLst>
              <a:ext uri="{FF2B5EF4-FFF2-40B4-BE49-F238E27FC236}">
                <a16:creationId xmlns:a16="http://schemas.microsoft.com/office/drawing/2014/main" id="{5D34EFC3-9269-483D-A72E-BF20B12BBDB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17202203"/>
              </p:ext>
            </p:extLst>
          </p:nvPr>
        </p:nvGraphicFramePr>
        <p:xfrm>
          <a:off x="8190688" y="2777805"/>
          <a:ext cx="836937" cy="3387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82" name="Image" r:id="rId11" imgW="2666520" imgH="1079280" progId="Photoshop.Image.13">
                  <p:embed/>
                </p:oleObj>
              </mc:Choice>
              <mc:Fallback>
                <p:oleObj name="Image" r:id="rId11" imgW="2666520" imgH="1079280" progId="Photoshop.Image.13">
                  <p:embed/>
                  <p:pic>
                    <p:nvPicPr>
                      <p:cNvPr id="46" name="개체 45">
                        <a:extLst>
                          <a:ext uri="{FF2B5EF4-FFF2-40B4-BE49-F238E27FC236}">
                            <a16:creationId xmlns:a16="http://schemas.microsoft.com/office/drawing/2014/main" id="{5D34EFC3-9269-483D-A72E-BF20B12BBDB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8190688" y="2777805"/>
                        <a:ext cx="836937" cy="3387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" name="개체 46">
            <a:extLst>
              <a:ext uri="{FF2B5EF4-FFF2-40B4-BE49-F238E27FC236}">
                <a16:creationId xmlns:a16="http://schemas.microsoft.com/office/drawing/2014/main" id="{04DCC1D6-5762-418F-8C69-51872A1BA1F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64378318"/>
              </p:ext>
            </p:extLst>
          </p:nvPr>
        </p:nvGraphicFramePr>
        <p:xfrm>
          <a:off x="10075318" y="2777805"/>
          <a:ext cx="864000" cy="3497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83" name="Image" r:id="rId13" imgW="2666520" imgH="1079280" progId="Photoshop.Image.13">
                  <p:embed/>
                </p:oleObj>
              </mc:Choice>
              <mc:Fallback>
                <p:oleObj name="Image" r:id="rId13" imgW="2666520" imgH="1079280" progId="Photoshop.Image.13">
                  <p:embed/>
                  <p:pic>
                    <p:nvPicPr>
                      <p:cNvPr id="47" name="개체 46">
                        <a:extLst>
                          <a:ext uri="{FF2B5EF4-FFF2-40B4-BE49-F238E27FC236}">
                            <a16:creationId xmlns:a16="http://schemas.microsoft.com/office/drawing/2014/main" id="{04DCC1D6-5762-418F-8C69-51872A1BA1F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0075318" y="2777805"/>
                        <a:ext cx="864000" cy="3497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" name="개체 47">
            <a:extLst>
              <a:ext uri="{FF2B5EF4-FFF2-40B4-BE49-F238E27FC236}">
                <a16:creationId xmlns:a16="http://schemas.microsoft.com/office/drawing/2014/main" id="{C6D58CBB-F56B-4708-A157-8BE9E18BDED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63511687"/>
              </p:ext>
            </p:extLst>
          </p:nvPr>
        </p:nvGraphicFramePr>
        <p:xfrm>
          <a:off x="8190688" y="3326880"/>
          <a:ext cx="823855" cy="3909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84" name="Image" r:id="rId15" imgW="2488680" imgH="1180800" progId="Photoshop.Image.13">
                  <p:embed/>
                </p:oleObj>
              </mc:Choice>
              <mc:Fallback>
                <p:oleObj name="Image" r:id="rId15" imgW="2488680" imgH="1180800" progId="Photoshop.Image.13">
                  <p:embed/>
                  <p:pic>
                    <p:nvPicPr>
                      <p:cNvPr id="48" name="개체 47">
                        <a:extLst>
                          <a:ext uri="{FF2B5EF4-FFF2-40B4-BE49-F238E27FC236}">
                            <a16:creationId xmlns:a16="http://schemas.microsoft.com/office/drawing/2014/main" id="{C6D58CBB-F56B-4708-A157-8BE9E18BDED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8190688" y="3326880"/>
                        <a:ext cx="823855" cy="3909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" name="개체 48">
            <a:extLst>
              <a:ext uri="{FF2B5EF4-FFF2-40B4-BE49-F238E27FC236}">
                <a16:creationId xmlns:a16="http://schemas.microsoft.com/office/drawing/2014/main" id="{3251BFA8-8D1A-4BA2-A806-2AD988A4D67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89383711"/>
              </p:ext>
            </p:extLst>
          </p:nvPr>
        </p:nvGraphicFramePr>
        <p:xfrm>
          <a:off x="10075318" y="3316231"/>
          <a:ext cx="852304" cy="4044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85" name="Image" r:id="rId17" imgW="2488680" imgH="1180800" progId="Photoshop.Image.13">
                  <p:embed/>
                </p:oleObj>
              </mc:Choice>
              <mc:Fallback>
                <p:oleObj name="Image" r:id="rId17" imgW="2488680" imgH="1180800" progId="Photoshop.Image.13">
                  <p:embed/>
                  <p:pic>
                    <p:nvPicPr>
                      <p:cNvPr id="49" name="개체 48">
                        <a:extLst>
                          <a:ext uri="{FF2B5EF4-FFF2-40B4-BE49-F238E27FC236}">
                            <a16:creationId xmlns:a16="http://schemas.microsoft.com/office/drawing/2014/main" id="{3251BFA8-8D1A-4BA2-A806-2AD988A4D67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10075318" y="3316231"/>
                        <a:ext cx="852304" cy="4044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0" name="TextBox 49">
            <a:extLst>
              <a:ext uri="{FF2B5EF4-FFF2-40B4-BE49-F238E27FC236}">
                <a16:creationId xmlns:a16="http://schemas.microsoft.com/office/drawing/2014/main" id="{EB79B205-6B0B-494F-9E7B-AFEAC0121F37}"/>
              </a:ext>
            </a:extLst>
          </p:cNvPr>
          <p:cNvSpPr txBox="1"/>
          <p:nvPr/>
        </p:nvSpPr>
        <p:spPr>
          <a:xfrm>
            <a:off x="4293885" y="2814162"/>
            <a:ext cx="12921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Twist1 (21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D271BF81-401D-4ECA-B151-6C433C60D487}"/>
              </a:ext>
            </a:extLst>
          </p:cNvPr>
          <p:cNvSpPr txBox="1"/>
          <p:nvPr/>
        </p:nvSpPr>
        <p:spPr>
          <a:xfrm>
            <a:off x="4258862" y="3334292"/>
            <a:ext cx="1329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 (41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58A540C-0B5A-47AD-9247-F84E3F62B029}"/>
              </a:ext>
            </a:extLst>
          </p:cNvPr>
          <p:cNvSpPr txBox="1"/>
          <p:nvPr/>
        </p:nvSpPr>
        <p:spPr>
          <a:xfrm>
            <a:off x="1926014" y="5148366"/>
            <a:ext cx="12921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Twist1 (21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7DBE299E-BC76-42DA-B1F5-3B804687BB18}"/>
              </a:ext>
            </a:extLst>
          </p:cNvPr>
          <p:cNvSpPr txBox="1"/>
          <p:nvPr/>
        </p:nvSpPr>
        <p:spPr>
          <a:xfrm>
            <a:off x="1890991" y="5704853"/>
            <a:ext cx="1329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 (41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graphicFrame>
        <p:nvGraphicFramePr>
          <p:cNvPr id="54" name="개체 53">
            <a:extLst>
              <a:ext uri="{FF2B5EF4-FFF2-40B4-BE49-F238E27FC236}">
                <a16:creationId xmlns:a16="http://schemas.microsoft.com/office/drawing/2014/main" id="{68BFD53F-C51A-49FA-A1B9-ACFB4724264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54693949"/>
              </p:ext>
            </p:extLst>
          </p:nvPr>
        </p:nvGraphicFramePr>
        <p:xfrm>
          <a:off x="6419486" y="2766851"/>
          <a:ext cx="864000" cy="3497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86" name="Image" r:id="rId19" imgW="2196720" imgH="1041120" progId="Photoshop.Image.13">
                  <p:embed/>
                </p:oleObj>
              </mc:Choice>
              <mc:Fallback>
                <p:oleObj name="Image" r:id="rId19" imgW="2196720" imgH="1041120" progId="Photoshop.Image.13">
                  <p:embed/>
                  <p:pic>
                    <p:nvPicPr>
                      <p:cNvPr id="54" name="개체 53">
                        <a:extLst>
                          <a:ext uri="{FF2B5EF4-FFF2-40B4-BE49-F238E27FC236}">
                            <a16:creationId xmlns:a16="http://schemas.microsoft.com/office/drawing/2014/main" id="{68BFD53F-C51A-49FA-A1B9-ACFB4724264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6419486" y="2766851"/>
                        <a:ext cx="864000" cy="3497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5" name="개체 54">
            <a:extLst>
              <a:ext uri="{FF2B5EF4-FFF2-40B4-BE49-F238E27FC236}">
                <a16:creationId xmlns:a16="http://schemas.microsoft.com/office/drawing/2014/main" id="{18270A36-DE22-4228-8776-0B47F28B56F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81656328"/>
              </p:ext>
            </p:extLst>
          </p:nvPr>
        </p:nvGraphicFramePr>
        <p:xfrm>
          <a:off x="6400747" y="1152832"/>
          <a:ext cx="864000" cy="4095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87" name="Image" r:id="rId21" imgW="2196720" imgH="1041120" progId="Photoshop.Image.13">
                  <p:embed/>
                </p:oleObj>
              </mc:Choice>
              <mc:Fallback>
                <p:oleObj name="Image" r:id="rId21" imgW="2196720" imgH="1041120" progId="Photoshop.Image.13">
                  <p:embed/>
                  <p:pic>
                    <p:nvPicPr>
                      <p:cNvPr id="55" name="개체 54">
                        <a:extLst>
                          <a:ext uri="{FF2B5EF4-FFF2-40B4-BE49-F238E27FC236}">
                            <a16:creationId xmlns:a16="http://schemas.microsoft.com/office/drawing/2014/main" id="{18270A36-DE22-4228-8776-0B47F28B56F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6400747" y="1152832"/>
                        <a:ext cx="864000" cy="4095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6" name="개체 55">
            <a:extLst>
              <a:ext uri="{FF2B5EF4-FFF2-40B4-BE49-F238E27FC236}">
                <a16:creationId xmlns:a16="http://schemas.microsoft.com/office/drawing/2014/main" id="{0897EC74-A745-4CFA-B6BC-B38BF7BFBF0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00794335"/>
              </p:ext>
            </p:extLst>
          </p:nvPr>
        </p:nvGraphicFramePr>
        <p:xfrm>
          <a:off x="6419486" y="3316231"/>
          <a:ext cx="864000" cy="3909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88" name="Image" r:id="rId23" imgW="2476080" imgH="1371240" progId="Photoshop.Image.13">
                  <p:embed/>
                </p:oleObj>
              </mc:Choice>
              <mc:Fallback>
                <p:oleObj name="Image" r:id="rId23" imgW="2476080" imgH="1371240" progId="Photoshop.Image.13">
                  <p:embed/>
                  <p:pic>
                    <p:nvPicPr>
                      <p:cNvPr id="56" name="개체 55">
                        <a:extLst>
                          <a:ext uri="{FF2B5EF4-FFF2-40B4-BE49-F238E27FC236}">
                            <a16:creationId xmlns:a16="http://schemas.microsoft.com/office/drawing/2014/main" id="{0897EC74-A745-4CFA-B6BC-B38BF7BFBF0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6419486" y="3316231"/>
                        <a:ext cx="864000" cy="3909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9" name="개체 58">
            <a:extLst>
              <a:ext uri="{FF2B5EF4-FFF2-40B4-BE49-F238E27FC236}">
                <a16:creationId xmlns:a16="http://schemas.microsoft.com/office/drawing/2014/main" id="{D94A1948-5F56-4E11-BDF7-C2268F9FEBF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72164907"/>
              </p:ext>
            </p:extLst>
          </p:nvPr>
        </p:nvGraphicFramePr>
        <p:xfrm>
          <a:off x="6390242" y="1618888"/>
          <a:ext cx="864000" cy="4785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89" name="Image" r:id="rId25" imgW="2476080" imgH="1371240" progId="Photoshop.Image.13">
                  <p:embed/>
                </p:oleObj>
              </mc:Choice>
              <mc:Fallback>
                <p:oleObj name="Image" r:id="rId25" imgW="2476080" imgH="1371240" progId="Photoshop.Image.13">
                  <p:embed/>
                  <p:pic>
                    <p:nvPicPr>
                      <p:cNvPr id="59" name="개체 58">
                        <a:extLst>
                          <a:ext uri="{FF2B5EF4-FFF2-40B4-BE49-F238E27FC236}">
                            <a16:creationId xmlns:a16="http://schemas.microsoft.com/office/drawing/2014/main" id="{D94A1948-5F56-4E11-BDF7-C2268F9FEBF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6390242" y="1618888"/>
                        <a:ext cx="864000" cy="4785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0" name="TextBox 59">
            <a:extLst>
              <a:ext uri="{FF2B5EF4-FFF2-40B4-BE49-F238E27FC236}">
                <a16:creationId xmlns:a16="http://schemas.microsoft.com/office/drawing/2014/main" id="{4AA43AB2-06D7-4B71-BCB1-7EF9DC85A439}"/>
              </a:ext>
            </a:extLst>
          </p:cNvPr>
          <p:cNvSpPr txBox="1"/>
          <p:nvPr/>
        </p:nvSpPr>
        <p:spPr>
          <a:xfrm>
            <a:off x="5309497" y="2194400"/>
            <a:ext cx="108074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litinib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P600125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2216BD34-84F9-429F-91B7-504AF6679256}"/>
              </a:ext>
            </a:extLst>
          </p:cNvPr>
          <p:cNvSpPr txBox="1"/>
          <p:nvPr/>
        </p:nvSpPr>
        <p:spPr>
          <a:xfrm>
            <a:off x="6408489" y="2194400"/>
            <a:ext cx="2279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D3A90B22-53CB-45D8-94D0-893FF1C2D6C2}"/>
              </a:ext>
            </a:extLst>
          </p:cNvPr>
          <p:cNvSpPr txBox="1"/>
          <p:nvPr/>
        </p:nvSpPr>
        <p:spPr>
          <a:xfrm>
            <a:off x="6540454" y="2194400"/>
            <a:ext cx="255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C85654CA-5D5B-43B0-B7DA-CDB09B936F0F}"/>
              </a:ext>
            </a:extLst>
          </p:cNvPr>
          <p:cNvSpPr txBox="1"/>
          <p:nvPr/>
        </p:nvSpPr>
        <p:spPr>
          <a:xfrm>
            <a:off x="6736652" y="2194400"/>
            <a:ext cx="255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A8FE9B97-4436-4E7B-B930-054F0C53E804}"/>
              </a:ext>
            </a:extLst>
          </p:cNvPr>
          <p:cNvSpPr txBox="1"/>
          <p:nvPr/>
        </p:nvSpPr>
        <p:spPr>
          <a:xfrm>
            <a:off x="6875307" y="2194400"/>
            <a:ext cx="3257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4048734-E38F-4368-B2E9-52E61217A4D7}"/>
              </a:ext>
            </a:extLst>
          </p:cNvPr>
          <p:cNvSpPr txBox="1"/>
          <p:nvPr/>
        </p:nvSpPr>
        <p:spPr>
          <a:xfrm>
            <a:off x="7268876" y="3860960"/>
            <a:ext cx="93487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litinib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U0126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C75D275A-6570-416E-8E16-057B2A5FC766}"/>
              </a:ext>
            </a:extLst>
          </p:cNvPr>
          <p:cNvSpPr txBox="1"/>
          <p:nvPr/>
        </p:nvSpPr>
        <p:spPr>
          <a:xfrm>
            <a:off x="8221994" y="3860960"/>
            <a:ext cx="2279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88A3587E-A3ED-4284-8B0C-87FEAC788609}"/>
              </a:ext>
            </a:extLst>
          </p:cNvPr>
          <p:cNvSpPr txBox="1"/>
          <p:nvPr/>
        </p:nvSpPr>
        <p:spPr>
          <a:xfrm>
            <a:off x="8353959" y="3860960"/>
            <a:ext cx="255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8FB2EA6E-CEF2-40D1-8442-7CD164A1D81F}"/>
              </a:ext>
            </a:extLst>
          </p:cNvPr>
          <p:cNvSpPr txBox="1"/>
          <p:nvPr/>
        </p:nvSpPr>
        <p:spPr>
          <a:xfrm>
            <a:off x="8550157" y="3860960"/>
            <a:ext cx="255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AF965266-CD8A-4C52-9D4D-F317B9FF22F7}"/>
              </a:ext>
            </a:extLst>
          </p:cNvPr>
          <p:cNvSpPr txBox="1"/>
          <p:nvPr/>
        </p:nvSpPr>
        <p:spPr>
          <a:xfrm>
            <a:off x="8688812" y="3860960"/>
            <a:ext cx="3257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31BA0D13-727A-49DE-8080-9D5EF3668501}"/>
              </a:ext>
            </a:extLst>
          </p:cNvPr>
          <p:cNvSpPr txBox="1"/>
          <p:nvPr/>
        </p:nvSpPr>
        <p:spPr>
          <a:xfrm>
            <a:off x="9181955" y="3860960"/>
            <a:ext cx="93487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litinib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U0126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70BD9E26-7042-4D3E-9726-434E1BA59159}"/>
              </a:ext>
            </a:extLst>
          </p:cNvPr>
          <p:cNvSpPr txBox="1"/>
          <p:nvPr/>
        </p:nvSpPr>
        <p:spPr>
          <a:xfrm>
            <a:off x="10135073" y="3860960"/>
            <a:ext cx="2279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9809DDC0-2B75-46FE-945A-101BC2E5D119}"/>
              </a:ext>
            </a:extLst>
          </p:cNvPr>
          <p:cNvSpPr txBox="1"/>
          <p:nvPr/>
        </p:nvSpPr>
        <p:spPr>
          <a:xfrm>
            <a:off x="10267038" y="3860960"/>
            <a:ext cx="255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38F2AD26-D681-4B2F-988E-94305B3D3F8B}"/>
              </a:ext>
            </a:extLst>
          </p:cNvPr>
          <p:cNvSpPr txBox="1"/>
          <p:nvPr/>
        </p:nvSpPr>
        <p:spPr>
          <a:xfrm>
            <a:off x="10463236" y="3860960"/>
            <a:ext cx="255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03540A90-D578-4767-A957-8AB776C7DAD9}"/>
              </a:ext>
            </a:extLst>
          </p:cNvPr>
          <p:cNvSpPr txBox="1"/>
          <p:nvPr/>
        </p:nvSpPr>
        <p:spPr>
          <a:xfrm>
            <a:off x="10601891" y="3860960"/>
            <a:ext cx="3257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5E365A64-391E-4198-B6DE-22B4F528D46E}"/>
              </a:ext>
            </a:extLst>
          </p:cNvPr>
          <p:cNvSpPr txBox="1"/>
          <p:nvPr/>
        </p:nvSpPr>
        <p:spPr>
          <a:xfrm>
            <a:off x="5455371" y="3860960"/>
            <a:ext cx="93487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litinib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U0126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035837C5-0987-4A58-B533-441027BD969C}"/>
              </a:ext>
            </a:extLst>
          </p:cNvPr>
          <p:cNvSpPr txBox="1"/>
          <p:nvPr/>
        </p:nvSpPr>
        <p:spPr>
          <a:xfrm>
            <a:off x="6408489" y="3860960"/>
            <a:ext cx="2279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057D79AE-E52D-46D5-9C3F-3E84711FBEA6}"/>
              </a:ext>
            </a:extLst>
          </p:cNvPr>
          <p:cNvSpPr txBox="1"/>
          <p:nvPr/>
        </p:nvSpPr>
        <p:spPr>
          <a:xfrm>
            <a:off x="6540454" y="3860960"/>
            <a:ext cx="255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35A784AF-1A2D-447F-B0AB-EDD2685C1356}"/>
              </a:ext>
            </a:extLst>
          </p:cNvPr>
          <p:cNvSpPr txBox="1"/>
          <p:nvPr/>
        </p:nvSpPr>
        <p:spPr>
          <a:xfrm>
            <a:off x="6736652" y="3860960"/>
            <a:ext cx="255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A58491E6-E68C-441E-9B60-8B0DEF28331F}"/>
              </a:ext>
            </a:extLst>
          </p:cNvPr>
          <p:cNvSpPr txBox="1"/>
          <p:nvPr/>
        </p:nvSpPr>
        <p:spPr>
          <a:xfrm>
            <a:off x="6875307" y="3860960"/>
            <a:ext cx="3257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graphicFrame>
        <p:nvGraphicFramePr>
          <p:cNvPr id="80" name="개체 79">
            <a:extLst>
              <a:ext uri="{FF2B5EF4-FFF2-40B4-BE49-F238E27FC236}">
                <a16:creationId xmlns:a16="http://schemas.microsoft.com/office/drawing/2014/main" id="{32CF3A12-61EA-409C-AC0E-967A791563C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3323520"/>
              </p:ext>
            </p:extLst>
          </p:nvPr>
        </p:nvGraphicFramePr>
        <p:xfrm>
          <a:off x="3777178" y="5762813"/>
          <a:ext cx="2461966" cy="48386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90" name="Image" r:id="rId27" imgW="7237800" imgH="1422000" progId="Photoshop.Image.13">
                  <p:embed/>
                </p:oleObj>
              </mc:Choice>
              <mc:Fallback>
                <p:oleObj name="Image" r:id="rId27" imgW="7237800" imgH="1422000" progId="Photoshop.Image.13">
                  <p:embed/>
                  <p:pic>
                    <p:nvPicPr>
                      <p:cNvPr id="80" name="개체 79">
                        <a:extLst>
                          <a:ext uri="{FF2B5EF4-FFF2-40B4-BE49-F238E27FC236}">
                            <a16:creationId xmlns:a16="http://schemas.microsoft.com/office/drawing/2014/main" id="{32CF3A12-61EA-409C-AC0E-967A791563C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3777178" y="5762813"/>
                        <a:ext cx="2461966" cy="48386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1" name="개체 80">
            <a:extLst>
              <a:ext uri="{FF2B5EF4-FFF2-40B4-BE49-F238E27FC236}">
                <a16:creationId xmlns:a16="http://schemas.microsoft.com/office/drawing/2014/main" id="{4D8052F3-2BB4-4BAF-87EC-60668AB0116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2377338"/>
              </p:ext>
            </p:extLst>
          </p:nvPr>
        </p:nvGraphicFramePr>
        <p:xfrm>
          <a:off x="3776867" y="5081224"/>
          <a:ext cx="2493962" cy="533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91" name="Image" r:id="rId29" imgW="6831720" imgH="1460160" progId="Photoshop.Image.13">
                  <p:embed/>
                </p:oleObj>
              </mc:Choice>
              <mc:Fallback>
                <p:oleObj name="Image" r:id="rId29" imgW="6831720" imgH="1460160" progId="Photoshop.Image.13">
                  <p:embed/>
                  <p:pic>
                    <p:nvPicPr>
                      <p:cNvPr id="81" name="개체 80">
                        <a:extLst>
                          <a:ext uri="{FF2B5EF4-FFF2-40B4-BE49-F238E27FC236}">
                            <a16:creationId xmlns:a16="http://schemas.microsoft.com/office/drawing/2014/main" id="{4D8052F3-2BB4-4BAF-87EC-60668AB0116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3776867" y="5081224"/>
                        <a:ext cx="2493962" cy="533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2" name="개체 81">
            <a:extLst>
              <a:ext uri="{FF2B5EF4-FFF2-40B4-BE49-F238E27FC236}">
                <a16:creationId xmlns:a16="http://schemas.microsoft.com/office/drawing/2014/main" id="{54B9CC88-9128-42B8-87A2-393B777D56F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27988950"/>
              </p:ext>
            </p:extLst>
          </p:nvPr>
        </p:nvGraphicFramePr>
        <p:xfrm>
          <a:off x="8458121" y="5010594"/>
          <a:ext cx="2427268" cy="5132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92" name="Image" r:id="rId31" imgW="6907680" imgH="1460160" progId="Photoshop.Image.13">
                  <p:embed/>
                </p:oleObj>
              </mc:Choice>
              <mc:Fallback>
                <p:oleObj name="Image" r:id="rId31" imgW="6907680" imgH="1460160" progId="Photoshop.Image.13">
                  <p:embed/>
                  <p:pic>
                    <p:nvPicPr>
                      <p:cNvPr id="82" name="개체 81">
                        <a:extLst>
                          <a:ext uri="{FF2B5EF4-FFF2-40B4-BE49-F238E27FC236}">
                            <a16:creationId xmlns:a16="http://schemas.microsoft.com/office/drawing/2014/main" id="{54B9CC88-9128-42B8-87A2-393B777D56F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8458121" y="5010594"/>
                        <a:ext cx="2427268" cy="5132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3" name="개체 82">
            <a:extLst>
              <a:ext uri="{FF2B5EF4-FFF2-40B4-BE49-F238E27FC236}">
                <a16:creationId xmlns:a16="http://schemas.microsoft.com/office/drawing/2014/main" id="{4DEC6597-7FE1-4F15-8600-8401B5B999B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72863172"/>
              </p:ext>
            </p:extLst>
          </p:nvPr>
        </p:nvGraphicFramePr>
        <p:xfrm>
          <a:off x="8458121" y="5633708"/>
          <a:ext cx="2427268" cy="6069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93" name="Image" r:id="rId33" imgW="6958440" imgH="1739520" progId="Photoshop.Image.13">
                  <p:embed/>
                </p:oleObj>
              </mc:Choice>
              <mc:Fallback>
                <p:oleObj name="Image" r:id="rId33" imgW="6958440" imgH="1739520" progId="Photoshop.Image.13">
                  <p:embed/>
                  <p:pic>
                    <p:nvPicPr>
                      <p:cNvPr id="83" name="개체 82">
                        <a:extLst>
                          <a:ext uri="{FF2B5EF4-FFF2-40B4-BE49-F238E27FC236}">
                            <a16:creationId xmlns:a16="http://schemas.microsoft.com/office/drawing/2014/main" id="{4DEC6597-7FE1-4F15-8600-8401B5B999B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4"/>
                      <a:stretch>
                        <a:fillRect/>
                      </a:stretch>
                    </p:blipFill>
                    <p:spPr>
                      <a:xfrm>
                        <a:off x="8458121" y="5633708"/>
                        <a:ext cx="2427268" cy="6069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4" name="TextBox 83">
            <a:extLst>
              <a:ext uri="{FF2B5EF4-FFF2-40B4-BE49-F238E27FC236}">
                <a16:creationId xmlns:a16="http://schemas.microsoft.com/office/drawing/2014/main" id="{ADD71F78-A01C-488A-B8D2-A71B7A160527}"/>
              </a:ext>
            </a:extLst>
          </p:cNvPr>
          <p:cNvSpPr txBox="1"/>
          <p:nvPr/>
        </p:nvSpPr>
        <p:spPr>
          <a:xfrm>
            <a:off x="6580580" y="5125629"/>
            <a:ext cx="12921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Twist1 (21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ECA706CE-114E-4F48-A4E5-ECEF93C5C331}"/>
              </a:ext>
            </a:extLst>
          </p:cNvPr>
          <p:cNvSpPr txBox="1"/>
          <p:nvPr/>
        </p:nvSpPr>
        <p:spPr>
          <a:xfrm>
            <a:off x="6545557" y="5682116"/>
            <a:ext cx="1329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 (41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F77CAFFC-8350-4843-A749-D852F94EE3DA}"/>
              </a:ext>
            </a:extLst>
          </p:cNvPr>
          <p:cNvSpPr txBox="1"/>
          <p:nvPr/>
        </p:nvSpPr>
        <p:spPr>
          <a:xfrm>
            <a:off x="7344330" y="4531051"/>
            <a:ext cx="106631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litinib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LY294002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369A08A4-79CD-48E3-AE7D-3BF24FA84782}"/>
              </a:ext>
            </a:extLst>
          </p:cNvPr>
          <p:cNvSpPr txBox="1"/>
          <p:nvPr/>
        </p:nvSpPr>
        <p:spPr>
          <a:xfrm>
            <a:off x="8428895" y="4531051"/>
            <a:ext cx="2279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997A602E-7E41-497A-B7E6-EB97A5A161AC}"/>
              </a:ext>
            </a:extLst>
          </p:cNvPr>
          <p:cNvSpPr txBox="1"/>
          <p:nvPr/>
        </p:nvSpPr>
        <p:spPr>
          <a:xfrm>
            <a:off x="8560860" y="4531051"/>
            <a:ext cx="255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40F225B9-A54C-40FF-8CC9-40D2E3A1A14C}"/>
              </a:ext>
            </a:extLst>
          </p:cNvPr>
          <p:cNvSpPr txBox="1"/>
          <p:nvPr/>
        </p:nvSpPr>
        <p:spPr>
          <a:xfrm>
            <a:off x="8757058" y="4531051"/>
            <a:ext cx="255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438CAC2D-B154-4D5B-A2B3-247952748790}"/>
              </a:ext>
            </a:extLst>
          </p:cNvPr>
          <p:cNvSpPr txBox="1"/>
          <p:nvPr/>
        </p:nvSpPr>
        <p:spPr>
          <a:xfrm>
            <a:off x="8895713" y="4531051"/>
            <a:ext cx="3257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17B069F5-C4FA-49E6-9D15-105F05A0EE1E}"/>
              </a:ext>
            </a:extLst>
          </p:cNvPr>
          <p:cNvSpPr txBox="1"/>
          <p:nvPr/>
        </p:nvSpPr>
        <p:spPr>
          <a:xfrm>
            <a:off x="8437557" y="6346165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1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FF4AF975-195D-43B3-B4C0-B9518125CCEA}"/>
              </a:ext>
            </a:extLst>
          </p:cNvPr>
          <p:cNvSpPr txBox="1"/>
          <p:nvPr/>
        </p:nvSpPr>
        <p:spPr>
          <a:xfrm>
            <a:off x="9270385" y="6346165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2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397ACEA6-7A2D-4A90-A70A-7CAD33969DD4}"/>
              </a:ext>
            </a:extLst>
          </p:cNvPr>
          <p:cNvSpPr txBox="1"/>
          <p:nvPr/>
        </p:nvSpPr>
        <p:spPr>
          <a:xfrm>
            <a:off x="10053396" y="6352622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3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E26A6F38-F154-44FB-80DE-D0D2EB29348A}"/>
              </a:ext>
            </a:extLst>
          </p:cNvPr>
          <p:cNvSpPr txBox="1"/>
          <p:nvPr/>
        </p:nvSpPr>
        <p:spPr>
          <a:xfrm>
            <a:off x="3791196" y="6346165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1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555FE7CC-838D-4613-9F2D-71D5A47F5145}"/>
              </a:ext>
            </a:extLst>
          </p:cNvPr>
          <p:cNvSpPr txBox="1"/>
          <p:nvPr/>
        </p:nvSpPr>
        <p:spPr>
          <a:xfrm>
            <a:off x="4624024" y="6346165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2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EB1413FD-816C-43B0-BAD7-E05A845186BA}"/>
              </a:ext>
            </a:extLst>
          </p:cNvPr>
          <p:cNvSpPr txBox="1"/>
          <p:nvPr/>
        </p:nvSpPr>
        <p:spPr>
          <a:xfrm>
            <a:off x="5407035" y="6352622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3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AD6405C6-904B-495A-BF1C-550821FC1D48}"/>
              </a:ext>
            </a:extLst>
          </p:cNvPr>
          <p:cNvSpPr txBox="1"/>
          <p:nvPr/>
        </p:nvSpPr>
        <p:spPr>
          <a:xfrm>
            <a:off x="2749415" y="4531051"/>
            <a:ext cx="108074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litinib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B203580 (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63D6192C-FBE9-4F40-B6FC-868E829FEB02}"/>
              </a:ext>
            </a:extLst>
          </p:cNvPr>
          <p:cNvSpPr txBox="1"/>
          <p:nvPr/>
        </p:nvSpPr>
        <p:spPr>
          <a:xfrm>
            <a:off x="3848407" y="4531051"/>
            <a:ext cx="2279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7326446D-4B7A-449B-8FC1-2A5D84FEBD72}"/>
              </a:ext>
            </a:extLst>
          </p:cNvPr>
          <p:cNvSpPr txBox="1"/>
          <p:nvPr/>
        </p:nvSpPr>
        <p:spPr>
          <a:xfrm>
            <a:off x="3980372" y="4531051"/>
            <a:ext cx="255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F2F8D053-E791-491C-B73C-6A039927DF69}"/>
              </a:ext>
            </a:extLst>
          </p:cNvPr>
          <p:cNvSpPr txBox="1"/>
          <p:nvPr/>
        </p:nvSpPr>
        <p:spPr>
          <a:xfrm>
            <a:off x="4176570" y="4531051"/>
            <a:ext cx="255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A20D1910-B271-4EF2-86A2-E6E8DD66B5F6}"/>
              </a:ext>
            </a:extLst>
          </p:cNvPr>
          <p:cNvSpPr txBox="1"/>
          <p:nvPr/>
        </p:nvSpPr>
        <p:spPr>
          <a:xfrm>
            <a:off x="4315225" y="4531051"/>
            <a:ext cx="3257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9DE44535-F4BA-461C-80EC-AFD16BE07BEC}"/>
              </a:ext>
            </a:extLst>
          </p:cNvPr>
          <p:cNvSpPr txBox="1"/>
          <p:nvPr/>
        </p:nvSpPr>
        <p:spPr>
          <a:xfrm>
            <a:off x="9310659" y="4531051"/>
            <a:ext cx="2279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B62170E9-11A7-4EB9-BFB7-84FC21D89DF9}"/>
              </a:ext>
            </a:extLst>
          </p:cNvPr>
          <p:cNvSpPr txBox="1"/>
          <p:nvPr/>
        </p:nvSpPr>
        <p:spPr>
          <a:xfrm>
            <a:off x="9442624" y="4531051"/>
            <a:ext cx="255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9FF84C2B-ECE0-4D60-B1CF-1D422D281C09}"/>
              </a:ext>
            </a:extLst>
          </p:cNvPr>
          <p:cNvSpPr txBox="1"/>
          <p:nvPr/>
        </p:nvSpPr>
        <p:spPr>
          <a:xfrm>
            <a:off x="9638822" y="4531051"/>
            <a:ext cx="255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52C5E03F-B2B4-446E-AC38-F0BC310F51E1}"/>
              </a:ext>
            </a:extLst>
          </p:cNvPr>
          <p:cNvSpPr txBox="1"/>
          <p:nvPr/>
        </p:nvSpPr>
        <p:spPr>
          <a:xfrm>
            <a:off x="9777477" y="4531051"/>
            <a:ext cx="3257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C48763D1-0DE1-46F1-B297-B0E328379B8A}"/>
              </a:ext>
            </a:extLst>
          </p:cNvPr>
          <p:cNvSpPr txBox="1"/>
          <p:nvPr/>
        </p:nvSpPr>
        <p:spPr>
          <a:xfrm>
            <a:off x="10099881" y="4531051"/>
            <a:ext cx="2279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C1A4AEF9-E9B9-43D8-B059-0A5E92D1F46D}"/>
              </a:ext>
            </a:extLst>
          </p:cNvPr>
          <p:cNvSpPr txBox="1"/>
          <p:nvPr/>
        </p:nvSpPr>
        <p:spPr>
          <a:xfrm>
            <a:off x="10231846" y="4531051"/>
            <a:ext cx="255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3595B43B-1E57-49CC-95D3-D7DC0698B695}"/>
              </a:ext>
            </a:extLst>
          </p:cNvPr>
          <p:cNvSpPr txBox="1"/>
          <p:nvPr/>
        </p:nvSpPr>
        <p:spPr>
          <a:xfrm>
            <a:off x="10428044" y="4531051"/>
            <a:ext cx="255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E0B79257-CEF2-4E70-BE25-8E8661F86209}"/>
              </a:ext>
            </a:extLst>
          </p:cNvPr>
          <p:cNvSpPr txBox="1"/>
          <p:nvPr/>
        </p:nvSpPr>
        <p:spPr>
          <a:xfrm>
            <a:off x="10566699" y="4531051"/>
            <a:ext cx="3257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67D4EF80-9EEF-480B-A296-39D6A495FA0C}"/>
              </a:ext>
            </a:extLst>
          </p:cNvPr>
          <p:cNvSpPr txBox="1"/>
          <p:nvPr/>
        </p:nvSpPr>
        <p:spPr>
          <a:xfrm>
            <a:off x="4675428" y="4531051"/>
            <a:ext cx="2279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1280D87C-5B7F-4B1E-8F87-4EFDD4D0BB9F}"/>
              </a:ext>
            </a:extLst>
          </p:cNvPr>
          <p:cNvSpPr txBox="1"/>
          <p:nvPr/>
        </p:nvSpPr>
        <p:spPr>
          <a:xfrm>
            <a:off x="4807393" y="4531051"/>
            <a:ext cx="255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691FD583-B266-4E61-A4BB-5E2122CB81FC}"/>
              </a:ext>
            </a:extLst>
          </p:cNvPr>
          <p:cNvSpPr txBox="1"/>
          <p:nvPr/>
        </p:nvSpPr>
        <p:spPr>
          <a:xfrm>
            <a:off x="5003591" y="4531051"/>
            <a:ext cx="255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4C9F40AA-27CE-40F7-9360-D463C6917401}"/>
              </a:ext>
            </a:extLst>
          </p:cNvPr>
          <p:cNvSpPr txBox="1"/>
          <p:nvPr/>
        </p:nvSpPr>
        <p:spPr>
          <a:xfrm>
            <a:off x="5142246" y="4531051"/>
            <a:ext cx="3257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0D116A32-A601-4AC7-AB40-B14BFA3AA93B}"/>
              </a:ext>
            </a:extLst>
          </p:cNvPr>
          <p:cNvSpPr txBox="1"/>
          <p:nvPr/>
        </p:nvSpPr>
        <p:spPr>
          <a:xfrm>
            <a:off x="5533614" y="4531051"/>
            <a:ext cx="2279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0048B4B9-839A-4DC7-B732-0DA425150197}"/>
              </a:ext>
            </a:extLst>
          </p:cNvPr>
          <p:cNvSpPr txBox="1"/>
          <p:nvPr/>
        </p:nvSpPr>
        <p:spPr>
          <a:xfrm>
            <a:off x="5665579" y="4531051"/>
            <a:ext cx="255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7F798E72-EC33-4248-9904-19AB64202220}"/>
              </a:ext>
            </a:extLst>
          </p:cNvPr>
          <p:cNvSpPr txBox="1"/>
          <p:nvPr/>
        </p:nvSpPr>
        <p:spPr>
          <a:xfrm>
            <a:off x="5861777" y="4531051"/>
            <a:ext cx="255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6DE95585-A5BA-490F-AE63-E2EDF91F5286}"/>
              </a:ext>
            </a:extLst>
          </p:cNvPr>
          <p:cNvSpPr txBox="1"/>
          <p:nvPr/>
        </p:nvSpPr>
        <p:spPr>
          <a:xfrm>
            <a:off x="6000432" y="4531051"/>
            <a:ext cx="3257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grpSp>
        <p:nvGrpSpPr>
          <p:cNvPr id="118" name="그룹 117">
            <a:extLst>
              <a:ext uri="{FF2B5EF4-FFF2-40B4-BE49-F238E27FC236}">
                <a16:creationId xmlns:a16="http://schemas.microsoft.com/office/drawing/2014/main" id="{3B43B855-E210-4886-B1DF-D057DCE3C022}"/>
              </a:ext>
            </a:extLst>
          </p:cNvPr>
          <p:cNvGrpSpPr/>
          <p:nvPr/>
        </p:nvGrpSpPr>
        <p:grpSpPr>
          <a:xfrm>
            <a:off x="7848287" y="5889327"/>
            <a:ext cx="609834" cy="230832"/>
            <a:chOff x="740793" y="5499416"/>
            <a:chExt cx="609834" cy="230832"/>
          </a:xfrm>
        </p:grpSpPr>
        <p:cxnSp>
          <p:nvCxnSpPr>
            <p:cNvPr id="119" name="직선 연결선 118">
              <a:extLst>
                <a:ext uri="{FF2B5EF4-FFF2-40B4-BE49-F238E27FC236}">
                  <a16:creationId xmlns:a16="http://schemas.microsoft.com/office/drawing/2014/main" id="{D84D4F0B-D689-442A-A7AF-4FA67C0280E5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50638D53-F326-4DDF-A5AD-3A1C5603FFB1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1" name="그룹 120">
            <a:extLst>
              <a:ext uri="{FF2B5EF4-FFF2-40B4-BE49-F238E27FC236}">
                <a16:creationId xmlns:a16="http://schemas.microsoft.com/office/drawing/2014/main" id="{988908CC-1EAD-43C9-A886-6CD6F6361D69}"/>
              </a:ext>
            </a:extLst>
          </p:cNvPr>
          <p:cNvGrpSpPr/>
          <p:nvPr/>
        </p:nvGrpSpPr>
        <p:grpSpPr>
          <a:xfrm>
            <a:off x="3150787" y="5943115"/>
            <a:ext cx="609834" cy="230832"/>
            <a:chOff x="740793" y="5499416"/>
            <a:chExt cx="609834" cy="230832"/>
          </a:xfrm>
        </p:grpSpPr>
        <p:cxnSp>
          <p:nvCxnSpPr>
            <p:cNvPr id="122" name="직선 연결선 121">
              <a:extLst>
                <a:ext uri="{FF2B5EF4-FFF2-40B4-BE49-F238E27FC236}">
                  <a16:creationId xmlns:a16="http://schemas.microsoft.com/office/drawing/2014/main" id="{19183BA1-12C0-4D4C-9055-30D4D1B4DA90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97F1C47C-0607-4F9B-923B-5EA4C84BD8E2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4" name="그룹 123">
            <a:extLst>
              <a:ext uri="{FF2B5EF4-FFF2-40B4-BE49-F238E27FC236}">
                <a16:creationId xmlns:a16="http://schemas.microsoft.com/office/drawing/2014/main" id="{BD35C3C2-1672-48F3-A051-21DA543FEC13}"/>
              </a:ext>
            </a:extLst>
          </p:cNvPr>
          <p:cNvGrpSpPr/>
          <p:nvPr/>
        </p:nvGrpSpPr>
        <p:grpSpPr>
          <a:xfrm>
            <a:off x="9465484" y="1782708"/>
            <a:ext cx="609834" cy="230832"/>
            <a:chOff x="740793" y="5499416"/>
            <a:chExt cx="609834" cy="230832"/>
          </a:xfrm>
        </p:grpSpPr>
        <p:cxnSp>
          <p:nvCxnSpPr>
            <p:cNvPr id="125" name="직선 연결선 124">
              <a:extLst>
                <a:ext uri="{FF2B5EF4-FFF2-40B4-BE49-F238E27FC236}">
                  <a16:creationId xmlns:a16="http://schemas.microsoft.com/office/drawing/2014/main" id="{13640726-FE71-4E4F-93A0-3DC94835BE75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106AC13B-001A-431F-88EB-EA9C78470255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7" name="그룹 126">
            <a:extLst>
              <a:ext uri="{FF2B5EF4-FFF2-40B4-BE49-F238E27FC236}">
                <a16:creationId xmlns:a16="http://schemas.microsoft.com/office/drawing/2014/main" id="{470B834F-10DB-43F6-80E9-588DF8F26764}"/>
              </a:ext>
            </a:extLst>
          </p:cNvPr>
          <p:cNvGrpSpPr/>
          <p:nvPr/>
        </p:nvGrpSpPr>
        <p:grpSpPr>
          <a:xfrm>
            <a:off x="7567334" y="1800600"/>
            <a:ext cx="609834" cy="230832"/>
            <a:chOff x="740793" y="5499416"/>
            <a:chExt cx="609834" cy="230832"/>
          </a:xfrm>
        </p:grpSpPr>
        <p:cxnSp>
          <p:nvCxnSpPr>
            <p:cNvPr id="128" name="직선 연결선 127">
              <a:extLst>
                <a:ext uri="{FF2B5EF4-FFF2-40B4-BE49-F238E27FC236}">
                  <a16:creationId xmlns:a16="http://schemas.microsoft.com/office/drawing/2014/main" id="{8475249C-148F-490E-B21C-B22C8BA84B9B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313604BC-6450-4495-9B53-799F33497C34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0" name="그룹 129">
            <a:extLst>
              <a:ext uri="{FF2B5EF4-FFF2-40B4-BE49-F238E27FC236}">
                <a16:creationId xmlns:a16="http://schemas.microsoft.com/office/drawing/2014/main" id="{03B00038-EE64-45F7-A3DB-BBB8050E6A8A}"/>
              </a:ext>
            </a:extLst>
          </p:cNvPr>
          <p:cNvGrpSpPr/>
          <p:nvPr/>
        </p:nvGrpSpPr>
        <p:grpSpPr>
          <a:xfrm>
            <a:off x="5757184" y="1816424"/>
            <a:ext cx="609834" cy="230832"/>
            <a:chOff x="740793" y="5499416"/>
            <a:chExt cx="609834" cy="230832"/>
          </a:xfrm>
        </p:grpSpPr>
        <p:cxnSp>
          <p:nvCxnSpPr>
            <p:cNvPr id="131" name="직선 연결선 130">
              <a:extLst>
                <a:ext uri="{FF2B5EF4-FFF2-40B4-BE49-F238E27FC236}">
                  <a16:creationId xmlns:a16="http://schemas.microsoft.com/office/drawing/2014/main" id="{59D125E3-29E2-4DB0-B86C-86DC80EDACDA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004C17CD-73FF-4B42-A3C9-A4473A4B0474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3" name="그룹 132">
            <a:extLst>
              <a:ext uri="{FF2B5EF4-FFF2-40B4-BE49-F238E27FC236}">
                <a16:creationId xmlns:a16="http://schemas.microsoft.com/office/drawing/2014/main" id="{8C2C86AD-FC11-4D7A-BD3D-AEB5D138D70E}"/>
              </a:ext>
            </a:extLst>
          </p:cNvPr>
          <p:cNvGrpSpPr/>
          <p:nvPr/>
        </p:nvGrpSpPr>
        <p:grpSpPr>
          <a:xfrm>
            <a:off x="5798655" y="3449268"/>
            <a:ext cx="609834" cy="230832"/>
            <a:chOff x="740793" y="5499416"/>
            <a:chExt cx="609834" cy="230832"/>
          </a:xfrm>
        </p:grpSpPr>
        <p:cxnSp>
          <p:nvCxnSpPr>
            <p:cNvPr id="134" name="직선 연결선 133">
              <a:extLst>
                <a:ext uri="{FF2B5EF4-FFF2-40B4-BE49-F238E27FC236}">
                  <a16:creationId xmlns:a16="http://schemas.microsoft.com/office/drawing/2014/main" id="{9779B3B1-7630-42A3-A76B-FE1B49B3C4F9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5A44B604-5701-4DDC-B2CC-217461AA3B1C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6" name="그룹 135">
            <a:extLst>
              <a:ext uri="{FF2B5EF4-FFF2-40B4-BE49-F238E27FC236}">
                <a16:creationId xmlns:a16="http://schemas.microsoft.com/office/drawing/2014/main" id="{D7119146-B61A-40B8-BC76-8F6EA3297CCB}"/>
              </a:ext>
            </a:extLst>
          </p:cNvPr>
          <p:cNvGrpSpPr/>
          <p:nvPr/>
        </p:nvGrpSpPr>
        <p:grpSpPr>
          <a:xfrm>
            <a:off x="7575986" y="3466812"/>
            <a:ext cx="609834" cy="230832"/>
            <a:chOff x="740793" y="5499416"/>
            <a:chExt cx="609834" cy="230832"/>
          </a:xfrm>
        </p:grpSpPr>
        <p:cxnSp>
          <p:nvCxnSpPr>
            <p:cNvPr id="137" name="직선 연결선 136">
              <a:extLst>
                <a:ext uri="{FF2B5EF4-FFF2-40B4-BE49-F238E27FC236}">
                  <a16:creationId xmlns:a16="http://schemas.microsoft.com/office/drawing/2014/main" id="{25F14013-87E5-46FC-AD7B-666642AB3233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FF58D139-8144-42C0-B0E7-292C6CBE2006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9" name="그룹 138">
            <a:extLst>
              <a:ext uri="{FF2B5EF4-FFF2-40B4-BE49-F238E27FC236}">
                <a16:creationId xmlns:a16="http://schemas.microsoft.com/office/drawing/2014/main" id="{2B6CF2BC-66A6-4526-9804-2B9F00B5A7D2}"/>
              </a:ext>
            </a:extLst>
          </p:cNvPr>
          <p:cNvGrpSpPr/>
          <p:nvPr/>
        </p:nvGrpSpPr>
        <p:grpSpPr>
          <a:xfrm>
            <a:off x="9468696" y="3449268"/>
            <a:ext cx="609834" cy="230832"/>
            <a:chOff x="740793" y="5499416"/>
            <a:chExt cx="609834" cy="230832"/>
          </a:xfrm>
        </p:grpSpPr>
        <p:cxnSp>
          <p:nvCxnSpPr>
            <p:cNvPr id="140" name="직선 연결선 139">
              <a:extLst>
                <a:ext uri="{FF2B5EF4-FFF2-40B4-BE49-F238E27FC236}">
                  <a16:creationId xmlns:a16="http://schemas.microsoft.com/office/drawing/2014/main" id="{1FFE3625-E045-4CD4-81B8-ABBA08AE1400}"/>
                </a:ext>
              </a:extLst>
            </p:cNvPr>
            <p:cNvCxnSpPr/>
            <p:nvPr/>
          </p:nvCxnSpPr>
          <p:spPr>
            <a:xfrm>
              <a:off x="1224792" y="5618633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360723E0-8FBF-4059-8101-DA251A13BE55}"/>
                </a:ext>
              </a:extLst>
            </p:cNvPr>
            <p:cNvSpPr txBox="1"/>
            <p:nvPr/>
          </p:nvSpPr>
          <p:spPr>
            <a:xfrm>
              <a:off x="740793" y="549941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2" name="그룹 141">
            <a:extLst>
              <a:ext uri="{FF2B5EF4-FFF2-40B4-BE49-F238E27FC236}">
                <a16:creationId xmlns:a16="http://schemas.microsoft.com/office/drawing/2014/main" id="{8AF2A398-7603-4C70-9E6F-22EF70FFC437}"/>
              </a:ext>
            </a:extLst>
          </p:cNvPr>
          <p:cNvGrpSpPr/>
          <p:nvPr/>
        </p:nvGrpSpPr>
        <p:grpSpPr>
          <a:xfrm>
            <a:off x="5788921" y="1196635"/>
            <a:ext cx="601796" cy="230832"/>
            <a:chOff x="3173250" y="902249"/>
            <a:chExt cx="601796" cy="230832"/>
          </a:xfrm>
        </p:grpSpPr>
        <p:cxnSp>
          <p:nvCxnSpPr>
            <p:cNvPr id="143" name="직선 연결선 142">
              <a:extLst>
                <a:ext uri="{FF2B5EF4-FFF2-40B4-BE49-F238E27FC236}">
                  <a16:creationId xmlns:a16="http://schemas.microsoft.com/office/drawing/2014/main" id="{93B2FE2E-C9F7-447D-AEAF-0EA40C08BC88}"/>
                </a:ext>
              </a:extLst>
            </p:cNvPr>
            <p:cNvCxnSpPr/>
            <p:nvPr/>
          </p:nvCxnSpPr>
          <p:spPr>
            <a:xfrm>
              <a:off x="3649211" y="1021466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053A06A6-2E4D-4546-874C-FFE91FE8C1B2}"/>
                </a:ext>
              </a:extLst>
            </p:cNvPr>
            <p:cNvSpPr txBox="1"/>
            <p:nvPr/>
          </p:nvSpPr>
          <p:spPr>
            <a:xfrm>
              <a:off x="3173250" y="902249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5" name="그룹 144">
            <a:extLst>
              <a:ext uri="{FF2B5EF4-FFF2-40B4-BE49-F238E27FC236}">
                <a16:creationId xmlns:a16="http://schemas.microsoft.com/office/drawing/2014/main" id="{3B5F4C82-2DC2-4170-94FA-3ED8DF8ED841}"/>
              </a:ext>
            </a:extLst>
          </p:cNvPr>
          <p:cNvGrpSpPr/>
          <p:nvPr/>
        </p:nvGrpSpPr>
        <p:grpSpPr>
          <a:xfrm>
            <a:off x="7601951" y="1198096"/>
            <a:ext cx="601796" cy="230832"/>
            <a:chOff x="3173250" y="902249"/>
            <a:chExt cx="601796" cy="230832"/>
          </a:xfrm>
        </p:grpSpPr>
        <p:cxnSp>
          <p:nvCxnSpPr>
            <p:cNvPr id="146" name="직선 연결선 145">
              <a:extLst>
                <a:ext uri="{FF2B5EF4-FFF2-40B4-BE49-F238E27FC236}">
                  <a16:creationId xmlns:a16="http://schemas.microsoft.com/office/drawing/2014/main" id="{7E9AF892-2A0D-41B5-8481-2ED5C342698B}"/>
                </a:ext>
              </a:extLst>
            </p:cNvPr>
            <p:cNvCxnSpPr/>
            <p:nvPr/>
          </p:nvCxnSpPr>
          <p:spPr>
            <a:xfrm>
              <a:off x="3649211" y="1021466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68C32B19-EA19-4024-B1EA-5DD4201B9732}"/>
                </a:ext>
              </a:extLst>
            </p:cNvPr>
            <p:cNvSpPr txBox="1"/>
            <p:nvPr/>
          </p:nvSpPr>
          <p:spPr>
            <a:xfrm>
              <a:off x="3173250" y="902249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8" name="그룹 147">
            <a:extLst>
              <a:ext uri="{FF2B5EF4-FFF2-40B4-BE49-F238E27FC236}">
                <a16:creationId xmlns:a16="http://schemas.microsoft.com/office/drawing/2014/main" id="{149AC545-5AC9-4099-A701-24228D4E7E3B}"/>
              </a:ext>
            </a:extLst>
          </p:cNvPr>
          <p:cNvGrpSpPr/>
          <p:nvPr/>
        </p:nvGrpSpPr>
        <p:grpSpPr>
          <a:xfrm>
            <a:off x="9465484" y="1196635"/>
            <a:ext cx="601796" cy="230832"/>
            <a:chOff x="3173250" y="902249"/>
            <a:chExt cx="601796" cy="230832"/>
          </a:xfrm>
        </p:grpSpPr>
        <p:cxnSp>
          <p:nvCxnSpPr>
            <p:cNvPr id="149" name="직선 연결선 148">
              <a:extLst>
                <a:ext uri="{FF2B5EF4-FFF2-40B4-BE49-F238E27FC236}">
                  <a16:creationId xmlns:a16="http://schemas.microsoft.com/office/drawing/2014/main" id="{1F488A4C-3358-426E-87CC-18DFF1469001}"/>
                </a:ext>
              </a:extLst>
            </p:cNvPr>
            <p:cNvCxnSpPr/>
            <p:nvPr/>
          </p:nvCxnSpPr>
          <p:spPr>
            <a:xfrm>
              <a:off x="3649211" y="1021466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1170C8C2-1DF0-4319-A026-CFB5FFF995A4}"/>
                </a:ext>
              </a:extLst>
            </p:cNvPr>
            <p:cNvSpPr txBox="1"/>
            <p:nvPr/>
          </p:nvSpPr>
          <p:spPr>
            <a:xfrm>
              <a:off x="3173250" y="902249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1" name="그룹 150">
            <a:extLst>
              <a:ext uri="{FF2B5EF4-FFF2-40B4-BE49-F238E27FC236}">
                <a16:creationId xmlns:a16="http://schemas.microsoft.com/office/drawing/2014/main" id="{5DC450EE-38ED-4EA2-AB67-B323BAD08EB1}"/>
              </a:ext>
            </a:extLst>
          </p:cNvPr>
          <p:cNvGrpSpPr/>
          <p:nvPr/>
        </p:nvGrpSpPr>
        <p:grpSpPr>
          <a:xfrm>
            <a:off x="9465484" y="2791057"/>
            <a:ext cx="601796" cy="230832"/>
            <a:chOff x="3173250" y="902249"/>
            <a:chExt cx="601796" cy="230832"/>
          </a:xfrm>
        </p:grpSpPr>
        <p:cxnSp>
          <p:nvCxnSpPr>
            <p:cNvPr id="152" name="직선 연결선 151">
              <a:extLst>
                <a:ext uri="{FF2B5EF4-FFF2-40B4-BE49-F238E27FC236}">
                  <a16:creationId xmlns:a16="http://schemas.microsoft.com/office/drawing/2014/main" id="{BAE612A3-F5A6-446B-BA2F-E1105D74B206}"/>
                </a:ext>
              </a:extLst>
            </p:cNvPr>
            <p:cNvCxnSpPr/>
            <p:nvPr/>
          </p:nvCxnSpPr>
          <p:spPr>
            <a:xfrm>
              <a:off x="3649211" y="1021466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9D5FE025-AB23-487D-8C64-0FA1BE2A85D6}"/>
                </a:ext>
              </a:extLst>
            </p:cNvPr>
            <p:cNvSpPr txBox="1"/>
            <p:nvPr/>
          </p:nvSpPr>
          <p:spPr>
            <a:xfrm>
              <a:off x="3173250" y="902249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4" name="그룹 153">
            <a:extLst>
              <a:ext uri="{FF2B5EF4-FFF2-40B4-BE49-F238E27FC236}">
                <a16:creationId xmlns:a16="http://schemas.microsoft.com/office/drawing/2014/main" id="{830AEFE7-4439-4AE9-BC79-DE4571307FA9}"/>
              </a:ext>
            </a:extLst>
          </p:cNvPr>
          <p:cNvGrpSpPr/>
          <p:nvPr/>
        </p:nvGrpSpPr>
        <p:grpSpPr>
          <a:xfrm>
            <a:off x="7584024" y="2795921"/>
            <a:ext cx="601796" cy="230832"/>
            <a:chOff x="3173250" y="902249"/>
            <a:chExt cx="601796" cy="230832"/>
          </a:xfrm>
        </p:grpSpPr>
        <p:cxnSp>
          <p:nvCxnSpPr>
            <p:cNvPr id="155" name="직선 연결선 154">
              <a:extLst>
                <a:ext uri="{FF2B5EF4-FFF2-40B4-BE49-F238E27FC236}">
                  <a16:creationId xmlns:a16="http://schemas.microsoft.com/office/drawing/2014/main" id="{51869EF3-6005-46AF-B544-A2F5433D1878}"/>
                </a:ext>
              </a:extLst>
            </p:cNvPr>
            <p:cNvCxnSpPr/>
            <p:nvPr/>
          </p:nvCxnSpPr>
          <p:spPr>
            <a:xfrm>
              <a:off x="3649211" y="1021466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D983A4C1-52E2-4585-A913-4E1002EEE7E3}"/>
                </a:ext>
              </a:extLst>
            </p:cNvPr>
            <p:cNvSpPr txBox="1"/>
            <p:nvPr/>
          </p:nvSpPr>
          <p:spPr>
            <a:xfrm>
              <a:off x="3173250" y="902249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7" name="그룹 156">
            <a:extLst>
              <a:ext uri="{FF2B5EF4-FFF2-40B4-BE49-F238E27FC236}">
                <a16:creationId xmlns:a16="http://schemas.microsoft.com/office/drawing/2014/main" id="{6FCC1AFD-CE9A-4D4D-8236-C4DE1B8271A3}"/>
              </a:ext>
            </a:extLst>
          </p:cNvPr>
          <p:cNvGrpSpPr/>
          <p:nvPr/>
        </p:nvGrpSpPr>
        <p:grpSpPr>
          <a:xfrm>
            <a:off x="5808982" y="2797804"/>
            <a:ext cx="601796" cy="230832"/>
            <a:chOff x="3173250" y="902249"/>
            <a:chExt cx="601796" cy="230832"/>
          </a:xfrm>
        </p:grpSpPr>
        <p:cxnSp>
          <p:nvCxnSpPr>
            <p:cNvPr id="158" name="직선 연결선 157">
              <a:extLst>
                <a:ext uri="{FF2B5EF4-FFF2-40B4-BE49-F238E27FC236}">
                  <a16:creationId xmlns:a16="http://schemas.microsoft.com/office/drawing/2014/main" id="{86F58518-DA49-41A5-AA7E-DA47EA4C30DA}"/>
                </a:ext>
              </a:extLst>
            </p:cNvPr>
            <p:cNvCxnSpPr/>
            <p:nvPr/>
          </p:nvCxnSpPr>
          <p:spPr>
            <a:xfrm>
              <a:off x="3649211" y="1021466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C3F16E47-E755-480C-8EB4-3EAE40AEEA32}"/>
                </a:ext>
              </a:extLst>
            </p:cNvPr>
            <p:cNvSpPr txBox="1"/>
            <p:nvPr/>
          </p:nvSpPr>
          <p:spPr>
            <a:xfrm>
              <a:off x="3173250" y="902249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0" name="그룹 159">
            <a:extLst>
              <a:ext uri="{FF2B5EF4-FFF2-40B4-BE49-F238E27FC236}">
                <a16:creationId xmlns:a16="http://schemas.microsoft.com/office/drawing/2014/main" id="{2D9D52A9-421A-4A62-9812-7A143204B0EF}"/>
              </a:ext>
            </a:extLst>
          </p:cNvPr>
          <p:cNvGrpSpPr/>
          <p:nvPr/>
        </p:nvGrpSpPr>
        <p:grpSpPr>
          <a:xfrm>
            <a:off x="7840060" y="5056033"/>
            <a:ext cx="601796" cy="230832"/>
            <a:chOff x="3173250" y="902249"/>
            <a:chExt cx="601796" cy="230832"/>
          </a:xfrm>
        </p:grpSpPr>
        <p:cxnSp>
          <p:nvCxnSpPr>
            <p:cNvPr id="161" name="직선 연결선 160">
              <a:extLst>
                <a:ext uri="{FF2B5EF4-FFF2-40B4-BE49-F238E27FC236}">
                  <a16:creationId xmlns:a16="http://schemas.microsoft.com/office/drawing/2014/main" id="{8FB0FF13-7392-4203-A79E-22CA92418CED}"/>
                </a:ext>
              </a:extLst>
            </p:cNvPr>
            <p:cNvCxnSpPr/>
            <p:nvPr/>
          </p:nvCxnSpPr>
          <p:spPr>
            <a:xfrm>
              <a:off x="3649211" y="1021466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FA85DA64-2834-475A-83B4-F2715C921061}"/>
                </a:ext>
              </a:extLst>
            </p:cNvPr>
            <p:cNvSpPr txBox="1"/>
            <p:nvPr/>
          </p:nvSpPr>
          <p:spPr>
            <a:xfrm>
              <a:off x="3173250" y="902249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3" name="그룹 162">
            <a:extLst>
              <a:ext uri="{FF2B5EF4-FFF2-40B4-BE49-F238E27FC236}">
                <a16:creationId xmlns:a16="http://schemas.microsoft.com/office/drawing/2014/main" id="{D335BF3B-B02F-41AF-B048-25FB9AB8501C}"/>
              </a:ext>
            </a:extLst>
          </p:cNvPr>
          <p:cNvGrpSpPr/>
          <p:nvPr/>
        </p:nvGrpSpPr>
        <p:grpSpPr>
          <a:xfrm>
            <a:off x="3161124" y="5171796"/>
            <a:ext cx="601796" cy="230832"/>
            <a:chOff x="3173250" y="902249"/>
            <a:chExt cx="601796" cy="230832"/>
          </a:xfrm>
        </p:grpSpPr>
        <p:cxnSp>
          <p:nvCxnSpPr>
            <p:cNvPr id="164" name="직선 연결선 163">
              <a:extLst>
                <a:ext uri="{FF2B5EF4-FFF2-40B4-BE49-F238E27FC236}">
                  <a16:creationId xmlns:a16="http://schemas.microsoft.com/office/drawing/2014/main" id="{36C0C956-50C4-4087-92F8-D380686F3582}"/>
                </a:ext>
              </a:extLst>
            </p:cNvPr>
            <p:cNvCxnSpPr/>
            <p:nvPr/>
          </p:nvCxnSpPr>
          <p:spPr>
            <a:xfrm>
              <a:off x="3649211" y="1021466"/>
              <a:ext cx="125835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0D79AD50-E1A1-4FD9-BC3C-E88E8CC40300}"/>
                </a:ext>
              </a:extLst>
            </p:cNvPr>
            <p:cNvSpPr txBox="1"/>
            <p:nvPr/>
          </p:nvSpPr>
          <p:spPr>
            <a:xfrm>
              <a:off x="3173250" y="902249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6" name="TextBox 165">
            <a:extLst>
              <a:ext uri="{FF2B5EF4-FFF2-40B4-BE49-F238E27FC236}">
                <a16:creationId xmlns:a16="http://schemas.microsoft.com/office/drawing/2014/main" id="{A9796406-B0F6-45C4-BACF-07CA647872AD}"/>
              </a:ext>
            </a:extLst>
          </p:cNvPr>
          <p:cNvSpPr txBox="1"/>
          <p:nvPr/>
        </p:nvSpPr>
        <p:spPr>
          <a:xfrm>
            <a:off x="3881143" y="935025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직사각형 166">
            <a:extLst>
              <a:ext uri="{FF2B5EF4-FFF2-40B4-BE49-F238E27FC236}">
                <a16:creationId xmlns:a16="http://schemas.microsoft.com/office/drawing/2014/main" id="{E60789DE-7471-4AE9-8EB2-8D4446F40AC3}"/>
              </a:ext>
            </a:extLst>
          </p:cNvPr>
          <p:cNvSpPr/>
          <p:nvPr/>
        </p:nvSpPr>
        <p:spPr>
          <a:xfrm>
            <a:off x="6439764" y="1258045"/>
            <a:ext cx="774148" cy="182606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8" name="직사각형 167">
            <a:extLst>
              <a:ext uri="{FF2B5EF4-FFF2-40B4-BE49-F238E27FC236}">
                <a16:creationId xmlns:a16="http://schemas.microsoft.com/office/drawing/2014/main" id="{B1B881F4-783F-461B-8D9D-2E8134C770AD}"/>
              </a:ext>
            </a:extLst>
          </p:cNvPr>
          <p:cNvSpPr/>
          <p:nvPr/>
        </p:nvSpPr>
        <p:spPr>
          <a:xfrm>
            <a:off x="6413185" y="1776019"/>
            <a:ext cx="774148" cy="182606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9" name="직사각형 168">
            <a:extLst>
              <a:ext uri="{FF2B5EF4-FFF2-40B4-BE49-F238E27FC236}">
                <a16:creationId xmlns:a16="http://schemas.microsoft.com/office/drawing/2014/main" id="{28F8B662-0EDB-4A2A-871B-ADA9C289B56E}"/>
              </a:ext>
            </a:extLst>
          </p:cNvPr>
          <p:cNvSpPr/>
          <p:nvPr/>
        </p:nvSpPr>
        <p:spPr>
          <a:xfrm>
            <a:off x="6460155" y="2845483"/>
            <a:ext cx="774148" cy="182606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0" name="직사각형 169">
            <a:extLst>
              <a:ext uri="{FF2B5EF4-FFF2-40B4-BE49-F238E27FC236}">
                <a16:creationId xmlns:a16="http://schemas.microsoft.com/office/drawing/2014/main" id="{6DE88D1C-07C9-4A02-8F3E-73C77419A58C}"/>
              </a:ext>
            </a:extLst>
          </p:cNvPr>
          <p:cNvSpPr/>
          <p:nvPr/>
        </p:nvSpPr>
        <p:spPr>
          <a:xfrm>
            <a:off x="6480094" y="3415505"/>
            <a:ext cx="774148" cy="182606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1" name="직사각형 170">
            <a:extLst>
              <a:ext uri="{FF2B5EF4-FFF2-40B4-BE49-F238E27FC236}">
                <a16:creationId xmlns:a16="http://schemas.microsoft.com/office/drawing/2014/main" id="{0148184A-AEDD-4A64-BFA4-ADE0381A4940}"/>
              </a:ext>
            </a:extLst>
          </p:cNvPr>
          <p:cNvSpPr/>
          <p:nvPr/>
        </p:nvSpPr>
        <p:spPr>
          <a:xfrm>
            <a:off x="4656229" y="5220022"/>
            <a:ext cx="748779" cy="182606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2" name="직사각형 171">
            <a:extLst>
              <a:ext uri="{FF2B5EF4-FFF2-40B4-BE49-F238E27FC236}">
                <a16:creationId xmlns:a16="http://schemas.microsoft.com/office/drawing/2014/main" id="{66C198CA-AF47-4108-8C0E-E2BDD577BFA6}"/>
              </a:ext>
            </a:extLst>
          </p:cNvPr>
          <p:cNvSpPr/>
          <p:nvPr/>
        </p:nvSpPr>
        <p:spPr>
          <a:xfrm>
            <a:off x="4626837" y="5913440"/>
            <a:ext cx="748779" cy="182606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3" name="직사각형 172">
            <a:extLst>
              <a:ext uri="{FF2B5EF4-FFF2-40B4-BE49-F238E27FC236}">
                <a16:creationId xmlns:a16="http://schemas.microsoft.com/office/drawing/2014/main" id="{526D6F38-1F56-49E4-A720-889B70D63260}"/>
              </a:ext>
            </a:extLst>
          </p:cNvPr>
          <p:cNvSpPr/>
          <p:nvPr/>
        </p:nvSpPr>
        <p:spPr>
          <a:xfrm>
            <a:off x="9297452" y="5115483"/>
            <a:ext cx="748779" cy="182606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4" name="직사각형 173">
            <a:extLst>
              <a:ext uri="{FF2B5EF4-FFF2-40B4-BE49-F238E27FC236}">
                <a16:creationId xmlns:a16="http://schemas.microsoft.com/office/drawing/2014/main" id="{A569AAA3-CB7B-4304-84F1-806487D90257}"/>
              </a:ext>
            </a:extLst>
          </p:cNvPr>
          <p:cNvSpPr/>
          <p:nvPr/>
        </p:nvSpPr>
        <p:spPr>
          <a:xfrm>
            <a:off x="9286487" y="5843352"/>
            <a:ext cx="748779" cy="182606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CAC8DF1-8BBD-9E57-8D44-A4E9E23481FE}"/>
              </a:ext>
            </a:extLst>
          </p:cNvPr>
          <p:cNvSpPr txBox="1"/>
          <p:nvPr/>
        </p:nvSpPr>
        <p:spPr>
          <a:xfrm>
            <a:off x="90991" y="813655"/>
            <a:ext cx="3643332" cy="1184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altLang="ko-KR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ll experiments were performed in triplicates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The red boxes indicate the figures in the main text.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직사각형 2"/>
          <p:cNvSpPr/>
          <p:nvPr/>
        </p:nvSpPr>
        <p:spPr>
          <a:xfrm>
            <a:off x="115230" y="180794"/>
            <a:ext cx="419217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Original gel images of Supplementary Figure 3.</a:t>
            </a:r>
          </a:p>
        </p:txBody>
      </p:sp>
    </p:spTree>
    <p:extLst>
      <p:ext uri="{BB962C8B-B14F-4D97-AF65-F5344CB8AC3E}">
        <p14:creationId xmlns:p14="http://schemas.microsoft.com/office/powerpoint/2010/main" val="203388140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개체 3">
            <a:extLst>
              <a:ext uri="{FF2B5EF4-FFF2-40B4-BE49-F238E27FC236}">
                <a16:creationId xmlns:a16="http://schemas.microsoft.com/office/drawing/2014/main" id="{C7C7F4D6-4F09-4DBB-8B58-F6276E3B575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9551600"/>
              </p:ext>
            </p:extLst>
          </p:nvPr>
        </p:nvGraphicFramePr>
        <p:xfrm>
          <a:off x="6331313" y="2324100"/>
          <a:ext cx="672688" cy="4080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82" name="Image" r:id="rId3" imgW="1549080" imgH="939600" progId="Photoshop.Image.13">
                  <p:embed/>
                </p:oleObj>
              </mc:Choice>
              <mc:Fallback>
                <p:oleObj name="Image" r:id="rId3" imgW="1549080" imgH="939600" progId="Photoshop.Image.13">
                  <p:embed/>
                  <p:pic>
                    <p:nvPicPr>
                      <p:cNvPr id="4" name="개체 3">
                        <a:extLst>
                          <a:ext uri="{FF2B5EF4-FFF2-40B4-BE49-F238E27FC236}">
                            <a16:creationId xmlns:a16="http://schemas.microsoft.com/office/drawing/2014/main" id="{C7C7F4D6-4F09-4DBB-8B58-F6276E3B575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331313" y="2324100"/>
                        <a:ext cx="672688" cy="4080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개체 4">
            <a:extLst>
              <a:ext uri="{FF2B5EF4-FFF2-40B4-BE49-F238E27FC236}">
                <a16:creationId xmlns:a16="http://schemas.microsoft.com/office/drawing/2014/main" id="{5A1FF5CE-C961-468F-88D5-6520DE53945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80072185"/>
              </p:ext>
            </p:extLst>
          </p:nvPr>
        </p:nvGraphicFramePr>
        <p:xfrm>
          <a:off x="8355041" y="2322274"/>
          <a:ext cx="883104" cy="5356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83" name="Image" r:id="rId5" imgW="1549080" imgH="939600" progId="Photoshop.Image.13">
                  <p:embed/>
                </p:oleObj>
              </mc:Choice>
              <mc:Fallback>
                <p:oleObj name="Image" r:id="rId5" imgW="1549080" imgH="939600" progId="Photoshop.Image.13">
                  <p:embed/>
                  <p:pic>
                    <p:nvPicPr>
                      <p:cNvPr id="5" name="개체 4">
                        <a:extLst>
                          <a:ext uri="{FF2B5EF4-FFF2-40B4-BE49-F238E27FC236}">
                            <a16:creationId xmlns:a16="http://schemas.microsoft.com/office/drawing/2014/main" id="{5A1FF5CE-C961-468F-88D5-6520DE53945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355041" y="2322274"/>
                        <a:ext cx="883104" cy="5356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개체 5">
            <a:extLst>
              <a:ext uri="{FF2B5EF4-FFF2-40B4-BE49-F238E27FC236}">
                <a16:creationId xmlns:a16="http://schemas.microsoft.com/office/drawing/2014/main" id="{3DDE38AB-5F01-47D6-AB31-C76E0D873C8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21161246"/>
              </p:ext>
            </p:extLst>
          </p:nvPr>
        </p:nvGraphicFramePr>
        <p:xfrm>
          <a:off x="8355041" y="2972005"/>
          <a:ext cx="841223" cy="4874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84" name="Image" r:id="rId7" imgW="1358640" imgH="786960" progId="Photoshop.Image.13">
                  <p:embed/>
                </p:oleObj>
              </mc:Choice>
              <mc:Fallback>
                <p:oleObj name="Image" r:id="rId7" imgW="1358640" imgH="786960" progId="Photoshop.Image.13">
                  <p:embed/>
                  <p:pic>
                    <p:nvPicPr>
                      <p:cNvPr id="6" name="개체 5">
                        <a:extLst>
                          <a:ext uri="{FF2B5EF4-FFF2-40B4-BE49-F238E27FC236}">
                            <a16:creationId xmlns:a16="http://schemas.microsoft.com/office/drawing/2014/main" id="{3DDE38AB-5F01-47D6-AB31-C76E0D873C8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355041" y="2972005"/>
                        <a:ext cx="841223" cy="4874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개체 6">
            <a:extLst>
              <a:ext uri="{FF2B5EF4-FFF2-40B4-BE49-F238E27FC236}">
                <a16:creationId xmlns:a16="http://schemas.microsoft.com/office/drawing/2014/main" id="{EE404933-81B2-4481-AA64-91F73BA91AA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46928482"/>
              </p:ext>
            </p:extLst>
          </p:nvPr>
        </p:nvGraphicFramePr>
        <p:xfrm>
          <a:off x="6331313" y="2846202"/>
          <a:ext cx="672688" cy="4436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85" name="Image" r:id="rId9" imgW="1193400" imgH="786960" progId="Photoshop.Image.13">
                  <p:embed/>
                </p:oleObj>
              </mc:Choice>
              <mc:Fallback>
                <p:oleObj name="Image" r:id="rId9" imgW="1193400" imgH="786960" progId="Photoshop.Image.13">
                  <p:embed/>
                  <p:pic>
                    <p:nvPicPr>
                      <p:cNvPr id="7" name="개체 6">
                        <a:extLst>
                          <a:ext uri="{FF2B5EF4-FFF2-40B4-BE49-F238E27FC236}">
                            <a16:creationId xmlns:a16="http://schemas.microsoft.com/office/drawing/2014/main" id="{EE404933-81B2-4481-AA64-91F73BA91AA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331313" y="2846202"/>
                        <a:ext cx="672688" cy="4436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개체 7">
            <a:extLst>
              <a:ext uri="{FF2B5EF4-FFF2-40B4-BE49-F238E27FC236}">
                <a16:creationId xmlns:a16="http://schemas.microsoft.com/office/drawing/2014/main" id="{CA3033CC-A467-4C58-B3F1-EA2F15CE794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09071555"/>
              </p:ext>
            </p:extLst>
          </p:nvPr>
        </p:nvGraphicFramePr>
        <p:xfrm>
          <a:off x="4172810" y="2864449"/>
          <a:ext cx="827311" cy="3794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86" name="Image" r:id="rId11" imgW="1244160" imgH="749160" progId="Photoshop.Image.13">
                  <p:embed/>
                </p:oleObj>
              </mc:Choice>
              <mc:Fallback>
                <p:oleObj name="Image" r:id="rId11" imgW="1244160" imgH="749160" progId="Photoshop.Image.13">
                  <p:embed/>
                  <p:pic>
                    <p:nvPicPr>
                      <p:cNvPr id="8" name="개체 7">
                        <a:extLst>
                          <a:ext uri="{FF2B5EF4-FFF2-40B4-BE49-F238E27FC236}">
                            <a16:creationId xmlns:a16="http://schemas.microsoft.com/office/drawing/2014/main" id="{CA3033CC-A467-4C58-B3F1-EA2F15CE794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172810" y="2864449"/>
                        <a:ext cx="827311" cy="3794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개체 8">
            <a:extLst>
              <a:ext uri="{FF2B5EF4-FFF2-40B4-BE49-F238E27FC236}">
                <a16:creationId xmlns:a16="http://schemas.microsoft.com/office/drawing/2014/main" id="{DB54A451-E0AC-475E-B795-098746A58C2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87666244"/>
              </p:ext>
            </p:extLst>
          </p:nvPr>
        </p:nvGraphicFramePr>
        <p:xfrm>
          <a:off x="4022134" y="2300985"/>
          <a:ext cx="1185368" cy="4493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87" name="Image" r:id="rId13" imgW="1409400" imgH="990360" progId="Photoshop.Image.13">
                  <p:embed/>
                </p:oleObj>
              </mc:Choice>
              <mc:Fallback>
                <p:oleObj name="Image" r:id="rId13" imgW="1409400" imgH="990360" progId="Photoshop.Image.13">
                  <p:embed/>
                  <p:pic>
                    <p:nvPicPr>
                      <p:cNvPr id="9" name="개체 8">
                        <a:extLst>
                          <a:ext uri="{FF2B5EF4-FFF2-40B4-BE49-F238E27FC236}">
                            <a16:creationId xmlns:a16="http://schemas.microsoft.com/office/drawing/2014/main" id="{DB54A451-E0AC-475E-B795-098746A58C2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022134" y="2300985"/>
                        <a:ext cx="1185368" cy="4493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FA480F84-8B2D-4CA1-8E3D-D417E8FEF73A}"/>
              </a:ext>
            </a:extLst>
          </p:cNvPr>
          <p:cNvSpPr txBox="1"/>
          <p:nvPr/>
        </p:nvSpPr>
        <p:spPr>
          <a:xfrm>
            <a:off x="2110254" y="2333574"/>
            <a:ext cx="12921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Twist1 (21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DD7335F-493F-4DB4-90EA-42E122948641}"/>
              </a:ext>
            </a:extLst>
          </p:cNvPr>
          <p:cNvSpPr txBox="1"/>
          <p:nvPr/>
        </p:nvSpPr>
        <p:spPr>
          <a:xfrm>
            <a:off x="2075177" y="2921794"/>
            <a:ext cx="1329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 (41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직선 연결선 11">
            <a:extLst>
              <a:ext uri="{FF2B5EF4-FFF2-40B4-BE49-F238E27FC236}">
                <a16:creationId xmlns:a16="http://schemas.microsoft.com/office/drawing/2014/main" id="{C73B1445-E042-4528-95FA-B5E521405D8D}"/>
              </a:ext>
            </a:extLst>
          </p:cNvPr>
          <p:cNvCxnSpPr/>
          <p:nvPr/>
        </p:nvCxnSpPr>
        <p:spPr>
          <a:xfrm>
            <a:off x="3896820" y="2498958"/>
            <a:ext cx="12583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084553ED-AE32-4AB3-85FC-5CBF8AF74023}"/>
              </a:ext>
            </a:extLst>
          </p:cNvPr>
          <p:cNvSpPr txBox="1"/>
          <p:nvPr/>
        </p:nvSpPr>
        <p:spPr>
          <a:xfrm>
            <a:off x="3420859" y="2379741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직선 연결선 13">
            <a:extLst>
              <a:ext uri="{FF2B5EF4-FFF2-40B4-BE49-F238E27FC236}">
                <a16:creationId xmlns:a16="http://schemas.microsoft.com/office/drawing/2014/main" id="{1D2E7208-BD6E-4D68-89D9-ABDEBCD4B15F}"/>
              </a:ext>
            </a:extLst>
          </p:cNvPr>
          <p:cNvCxnSpPr/>
          <p:nvPr/>
        </p:nvCxnSpPr>
        <p:spPr>
          <a:xfrm>
            <a:off x="6222256" y="2522656"/>
            <a:ext cx="12583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F1D56813-EC4A-4112-BAD4-6F8A313FE9FD}"/>
              </a:ext>
            </a:extLst>
          </p:cNvPr>
          <p:cNvSpPr txBox="1"/>
          <p:nvPr/>
        </p:nvSpPr>
        <p:spPr>
          <a:xfrm>
            <a:off x="5746295" y="2403439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직선 연결선 15">
            <a:extLst>
              <a:ext uri="{FF2B5EF4-FFF2-40B4-BE49-F238E27FC236}">
                <a16:creationId xmlns:a16="http://schemas.microsoft.com/office/drawing/2014/main" id="{62FB6540-A0A8-415E-BCEA-A08845C84C22}"/>
              </a:ext>
            </a:extLst>
          </p:cNvPr>
          <p:cNvCxnSpPr/>
          <p:nvPr/>
        </p:nvCxnSpPr>
        <p:spPr>
          <a:xfrm>
            <a:off x="8225675" y="2581347"/>
            <a:ext cx="12583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68F8D982-4A82-4486-94B9-5C8DE0CE54B1}"/>
              </a:ext>
            </a:extLst>
          </p:cNvPr>
          <p:cNvSpPr txBox="1"/>
          <p:nvPr/>
        </p:nvSpPr>
        <p:spPr>
          <a:xfrm>
            <a:off x="7749714" y="2462130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직선 연결선 17">
            <a:extLst>
              <a:ext uri="{FF2B5EF4-FFF2-40B4-BE49-F238E27FC236}">
                <a16:creationId xmlns:a16="http://schemas.microsoft.com/office/drawing/2014/main" id="{3AA9CB92-25CC-4BAE-B658-F8C819CB579C}"/>
              </a:ext>
            </a:extLst>
          </p:cNvPr>
          <p:cNvCxnSpPr/>
          <p:nvPr/>
        </p:nvCxnSpPr>
        <p:spPr>
          <a:xfrm>
            <a:off x="8234064" y="2990539"/>
            <a:ext cx="12583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직선 연결선 18">
            <a:extLst>
              <a:ext uri="{FF2B5EF4-FFF2-40B4-BE49-F238E27FC236}">
                <a16:creationId xmlns:a16="http://schemas.microsoft.com/office/drawing/2014/main" id="{3B20DB4E-3BC0-4AFF-9292-4658996D502E}"/>
              </a:ext>
            </a:extLst>
          </p:cNvPr>
          <p:cNvCxnSpPr/>
          <p:nvPr/>
        </p:nvCxnSpPr>
        <p:spPr>
          <a:xfrm>
            <a:off x="8234064" y="3334487"/>
            <a:ext cx="12583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8FCB2B98-0A0D-4E9B-80A6-33B4D2888DC5}"/>
              </a:ext>
            </a:extLst>
          </p:cNvPr>
          <p:cNvSpPr txBox="1"/>
          <p:nvPr/>
        </p:nvSpPr>
        <p:spPr>
          <a:xfrm>
            <a:off x="7758103" y="3194942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DC7D730-B102-4190-AD8E-4792AD117B7D}"/>
              </a:ext>
            </a:extLst>
          </p:cNvPr>
          <p:cNvSpPr txBox="1"/>
          <p:nvPr/>
        </p:nvSpPr>
        <p:spPr>
          <a:xfrm>
            <a:off x="7758103" y="2892110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48 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직선 연결선 21">
            <a:extLst>
              <a:ext uri="{FF2B5EF4-FFF2-40B4-BE49-F238E27FC236}">
                <a16:creationId xmlns:a16="http://schemas.microsoft.com/office/drawing/2014/main" id="{4854F3F1-5793-49CE-891D-3BE712018A05}"/>
              </a:ext>
            </a:extLst>
          </p:cNvPr>
          <p:cNvCxnSpPr/>
          <p:nvPr/>
        </p:nvCxnSpPr>
        <p:spPr>
          <a:xfrm>
            <a:off x="6205478" y="3166739"/>
            <a:ext cx="12583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08FACFB2-7DB1-4C7C-9192-46041AC0EB5E}"/>
              </a:ext>
            </a:extLst>
          </p:cNvPr>
          <p:cNvSpPr txBox="1"/>
          <p:nvPr/>
        </p:nvSpPr>
        <p:spPr>
          <a:xfrm>
            <a:off x="5729517" y="3027194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B3EDED70-B634-4F7F-9EB3-E8AD10EFCAE9}"/>
              </a:ext>
            </a:extLst>
          </p:cNvPr>
          <p:cNvCxnSpPr/>
          <p:nvPr/>
        </p:nvCxnSpPr>
        <p:spPr>
          <a:xfrm>
            <a:off x="4039107" y="3126263"/>
            <a:ext cx="125835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5899CE33-365F-4934-B3A7-A6D67B96263D}"/>
              </a:ext>
            </a:extLst>
          </p:cNvPr>
          <p:cNvSpPr txBox="1"/>
          <p:nvPr/>
        </p:nvSpPr>
        <p:spPr>
          <a:xfrm>
            <a:off x="3563146" y="2986718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037F22A-1A0C-4A08-8AFA-E45D27CC1E64}"/>
              </a:ext>
            </a:extLst>
          </p:cNvPr>
          <p:cNvSpPr txBox="1"/>
          <p:nvPr/>
        </p:nvSpPr>
        <p:spPr>
          <a:xfrm>
            <a:off x="4257211" y="1973349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1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AC29942-BB85-4740-9E8C-E8A7E6D56809}"/>
              </a:ext>
            </a:extLst>
          </p:cNvPr>
          <p:cNvSpPr txBox="1"/>
          <p:nvPr/>
        </p:nvSpPr>
        <p:spPr>
          <a:xfrm>
            <a:off x="6264244" y="1988360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2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37A695C-CC4D-49FF-8A44-DBB246AE8F9B}"/>
              </a:ext>
            </a:extLst>
          </p:cNvPr>
          <p:cNvSpPr txBox="1"/>
          <p:nvPr/>
        </p:nvSpPr>
        <p:spPr>
          <a:xfrm>
            <a:off x="8364667" y="1992991"/>
            <a:ext cx="780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peat3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8458B2E-1A00-4142-BD4D-F002552D3086}"/>
              </a:ext>
            </a:extLst>
          </p:cNvPr>
          <p:cNvSpPr txBox="1"/>
          <p:nvPr/>
        </p:nvSpPr>
        <p:spPr>
          <a:xfrm>
            <a:off x="4305040" y="3328475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3369AE4-4883-4083-B74E-B35C1C1930FA}"/>
              </a:ext>
            </a:extLst>
          </p:cNvPr>
          <p:cNvSpPr txBox="1"/>
          <p:nvPr/>
        </p:nvSpPr>
        <p:spPr>
          <a:xfrm>
            <a:off x="4657346" y="3319066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38EE9CD-65DF-4B0F-B0FB-425D453C43CB}"/>
              </a:ext>
            </a:extLst>
          </p:cNvPr>
          <p:cNvSpPr txBox="1"/>
          <p:nvPr/>
        </p:nvSpPr>
        <p:spPr>
          <a:xfrm>
            <a:off x="3524876" y="3341438"/>
            <a:ext cx="6479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iTwist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B258029-0D4D-4AE7-A2D8-101FDB3CA444}"/>
              </a:ext>
            </a:extLst>
          </p:cNvPr>
          <p:cNvSpPr txBox="1"/>
          <p:nvPr/>
        </p:nvSpPr>
        <p:spPr>
          <a:xfrm>
            <a:off x="6376914" y="3328475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362F797A-858E-4B5F-B62B-AB19138B0BF6}"/>
              </a:ext>
            </a:extLst>
          </p:cNvPr>
          <p:cNvSpPr txBox="1"/>
          <p:nvPr/>
        </p:nvSpPr>
        <p:spPr>
          <a:xfrm>
            <a:off x="6729220" y="3319066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103141D-D1AC-414B-9979-897E873A328A}"/>
              </a:ext>
            </a:extLst>
          </p:cNvPr>
          <p:cNvSpPr txBox="1"/>
          <p:nvPr/>
        </p:nvSpPr>
        <p:spPr>
          <a:xfrm>
            <a:off x="5596750" y="3341438"/>
            <a:ext cx="6479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iTwist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9746329-A4A1-4537-AF60-2CDC4DA4A5B0}"/>
              </a:ext>
            </a:extLst>
          </p:cNvPr>
          <p:cNvSpPr txBox="1"/>
          <p:nvPr/>
        </p:nvSpPr>
        <p:spPr>
          <a:xfrm>
            <a:off x="8529878" y="3501245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188F338-4514-481F-AFFC-90DBA217B097}"/>
              </a:ext>
            </a:extLst>
          </p:cNvPr>
          <p:cNvSpPr txBox="1"/>
          <p:nvPr/>
        </p:nvSpPr>
        <p:spPr>
          <a:xfrm>
            <a:off x="8882184" y="3491836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676DE45-0342-48D3-B9AE-4BCD9B2FF21B}"/>
              </a:ext>
            </a:extLst>
          </p:cNvPr>
          <p:cNvSpPr txBox="1"/>
          <p:nvPr/>
        </p:nvSpPr>
        <p:spPr>
          <a:xfrm>
            <a:off x="7749714" y="3514208"/>
            <a:ext cx="6479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iTwist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직사각형 39">
            <a:extLst>
              <a:ext uri="{FF2B5EF4-FFF2-40B4-BE49-F238E27FC236}">
                <a16:creationId xmlns:a16="http://schemas.microsoft.com/office/drawing/2014/main" id="{52FAE5B3-FBD1-47F8-9E21-48508EFE6A9E}"/>
              </a:ext>
            </a:extLst>
          </p:cNvPr>
          <p:cNvSpPr/>
          <p:nvPr/>
        </p:nvSpPr>
        <p:spPr>
          <a:xfrm>
            <a:off x="4245710" y="2422204"/>
            <a:ext cx="730462" cy="206948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3" name="직사각형 42">
            <a:extLst>
              <a:ext uri="{FF2B5EF4-FFF2-40B4-BE49-F238E27FC236}">
                <a16:creationId xmlns:a16="http://schemas.microsoft.com/office/drawing/2014/main" id="{E97D63BA-2667-4C32-84D4-EB7AE7A66F21}"/>
              </a:ext>
            </a:extLst>
          </p:cNvPr>
          <p:cNvSpPr/>
          <p:nvPr/>
        </p:nvSpPr>
        <p:spPr>
          <a:xfrm>
            <a:off x="4310643" y="2950723"/>
            <a:ext cx="622722" cy="206948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285F35D-49DD-23F2-3CD5-D030983EC280}"/>
              </a:ext>
            </a:extLst>
          </p:cNvPr>
          <p:cNvSpPr txBox="1"/>
          <p:nvPr/>
        </p:nvSpPr>
        <p:spPr>
          <a:xfrm>
            <a:off x="34923" y="41837"/>
            <a:ext cx="4696467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Arial" panose="020B0604020202020204" pitchFamily="34" charset="0"/>
                <a:cs typeface="Arial" panose="020B0604020202020204" pitchFamily="34" charset="0"/>
              </a:rPr>
              <a:t>Original gel images of Supplementary Figure 4</a:t>
            </a:r>
            <a:r>
              <a:rPr lang="en-US" altLang="ko-KR" sz="1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endParaRPr lang="en-US" altLang="ko-KR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ll experiments were performed in triplicates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The red boxes indicate the figures in the main text.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60915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8</TotalTime>
  <Words>1103</Words>
  <Application>Microsoft Office PowerPoint</Application>
  <PresentationFormat>와이드스크린</PresentationFormat>
  <Paragraphs>464</Paragraphs>
  <Slides>8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8</vt:i4>
      </vt:variant>
    </vt:vector>
  </HeadingPairs>
  <TitlesOfParts>
    <vt:vector size="12" baseType="lpstr">
      <vt:lpstr>맑은 고딕</vt:lpstr>
      <vt:lpstr>Arial</vt:lpstr>
      <vt:lpstr>Office 테마</vt:lpstr>
      <vt:lpstr>Image</vt:lpstr>
      <vt:lpstr>Original uncropped gel images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MPCB</dc:creator>
  <cp:lastModifiedBy>MPCB</cp:lastModifiedBy>
  <cp:revision>33</cp:revision>
  <dcterms:created xsi:type="dcterms:W3CDTF">2022-11-25T02:25:34Z</dcterms:created>
  <dcterms:modified xsi:type="dcterms:W3CDTF">2023-01-26T07:36:59Z</dcterms:modified>
</cp:coreProperties>
</file>